
<file path=[Content_Types].xml><?xml version="1.0" encoding="utf-8"?>
<Types xmlns="http://schemas.openxmlformats.org/package/2006/content-types">
  <Default Extension="jpeg" ContentType="image/jpeg"/>
  <Default Extension="rels" ContentType="application/vnd.openxmlformats-package.relationships+xml"/>
  <Default Extension="tif" ContentType="image/tiff"/>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drawings/drawing1.xml" ContentType="application/vnd.openxmlformats-officedocument.drawingml.chartshape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6" r:id="rId2"/>
    <p:sldId id="257" r:id="rId3"/>
    <p:sldId id="258" r:id="rId4"/>
    <p:sldId id="259" r:id="rId5"/>
    <p:sldId id="260" r:id="rId6"/>
  </p:sldIdLst>
  <p:sldSz cx="6858000" cy="9906000" type="A4"/>
  <p:notesSz cx="7104063" cy="10234613"/>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671" userDrawn="1">
          <p15:clr>
            <a:srgbClr val="A4A3A4"/>
          </p15:clr>
        </p15:guide>
        <p15:guide id="2" pos="4224"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MONICA" initials="M" lastIdx="1" clrIdx="0">
    <p:extLst>
      <p:ext uri="{19B8F6BF-5375-455C-9EA6-DF929625EA0E}">
        <p15:presenceInfo xmlns:p15="http://schemas.microsoft.com/office/powerpoint/2012/main" userId="MONICA"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3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6655" autoAdjust="0"/>
    <p:restoredTop sz="94660"/>
  </p:normalViewPr>
  <p:slideViewPr>
    <p:cSldViewPr snapToGrid="0" showGuides="1">
      <p:cViewPr varScale="1">
        <p:scale>
          <a:sx n="81" d="100"/>
          <a:sy n="81" d="100"/>
        </p:scale>
        <p:origin x="3048" y="192"/>
      </p:cViewPr>
      <p:guideLst>
        <p:guide orient="horz" pos="671"/>
        <p:guide pos="4224"/>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commentAuthors" Target="commentAuthor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rts/_rels/chart1.xml.rels><?xml version="1.0" encoding="UTF-8" standalone="yes"?>
<Relationships xmlns="http://schemas.openxmlformats.org/package/2006/relationships"><Relationship Id="rId1" Type="http://schemas.openxmlformats.org/officeDocument/2006/relationships/oleObject" Target="file:///D:\Spain\Data\okkk%20n%20c%20pyd%20090419.xlsx" TargetMode="External"/></Relationships>
</file>

<file path=ppt/charts/_rels/chart2.xml.rels><?xml version="1.0" encoding="UTF-8" standalone="yes"?>
<Relationships xmlns="http://schemas.openxmlformats.org/package/2006/relationships"><Relationship Id="rId2" Type="http://schemas.openxmlformats.org/officeDocument/2006/relationships/chartUserShapes" Target="../drawings/drawing1.xml"/><Relationship Id="rId1" Type="http://schemas.openxmlformats.org/officeDocument/2006/relationships/oleObject" Target="file:///C:\Users\110\Desktop\Fluorescence\exel\Total%20fluorescence%20data.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2912528813534641"/>
          <c:y val="5.4147705568267313E-2"/>
          <c:w val="0.82252678206732344"/>
          <c:h val="0.76286769660200004"/>
        </c:manualLayout>
      </c:layout>
      <c:barChart>
        <c:barDir val="col"/>
        <c:grouping val="clustered"/>
        <c:varyColors val="0"/>
        <c:ser>
          <c:idx val="0"/>
          <c:order val="0"/>
          <c:tx>
            <c:v>N-PYD, C-PYD</c:v>
          </c:tx>
          <c:spPr>
            <a:solidFill>
              <a:schemeClr val="tx1"/>
            </a:solidFill>
            <a:ln>
              <a:solidFill>
                <a:schemeClr val="tx1"/>
              </a:solidFill>
            </a:ln>
          </c:spPr>
          <c:invertIfNegative val="0"/>
          <c:cat>
            <c:strRef>
              <c:f>Sheet3!$E$3:$E$87</c:f>
              <c:strCache>
                <c:ptCount val="85"/>
                <c:pt idx="0">
                  <c:v>N</c:v>
                </c:pt>
                <c:pt idx="1">
                  <c:v>C</c:v>
                </c:pt>
                <c:pt idx="2">
                  <c:v>C+N</c:v>
                </c:pt>
                <c:pt idx="3">
                  <c:v>C+ASC+N</c:v>
                </c:pt>
                <c:pt idx="4">
                  <c:v>C+BSA+N</c:v>
                </c:pt>
                <c:pt idx="5">
                  <c:v>1</c:v>
                </c:pt>
                <c:pt idx="6">
                  <c:v>2</c:v>
                </c:pt>
                <c:pt idx="7">
                  <c:v>3</c:v>
                </c:pt>
                <c:pt idx="8">
                  <c:v>4</c:v>
                </c:pt>
                <c:pt idx="9">
                  <c:v>5</c:v>
                </c:pt>
                <c:pt idx="10">
                  <c:v>6</c:v>
                </c:pt>
                <c:pt idx="11">
                  <c:v>7</c:v>
                </c:pt>
                <c:pt idx="12">
                  <c:v>8</c:v>
                </c:pt>
                <c:pt idx="13">
                  <c:v>9</c:v>
                </c:pt>
                <c:pt idx="14">
                  <c:v>10</c:v>
                </c:pt>
                <c:pt idx="15">
                  <c:v>11</c:v>
                </c:pt>
                <c:pt idx="16">
                  <c:v>12</c:v>
                </c:pt>
                <c:pt idx="17">
                  <c:v>13</c:v>
                </c:pt>
                <c:pt idx="18">
                  <c:v>14</c:v>
                </c:pt>
                <c:pt idx="19">
                  <c:v>15</c:v>
                </c:pt>
                <c:pt idx="20">
                  <c:v>16</c:v>
                </c:pt>
                <c:pt idx="21">
                  <c:v>17</c:v>
                </c:pt>
                <c:pt idx="22">
                  <c:v>18</c:v>
                </c:pt>
                <c:pt idx="23">
                  <c:v>19</c:v>
                </c:pt>
                <c:pt idx="24">
                  <c:v>20</c:v>
                </c:pt>
                <c:pt idx="25">
                  <c:v>21</c:v>
                </c:pt>
                <c:pt idx="26">
                  <c:v>22</c:v>
                </c:pt>
                <c:pt idx="27">
                  <c:v>23</c:v>
                </c:pt>
                <c:pt idx="28">
                  <c:v>24</c:v>
                </c:pt>
                <c:pt idx="29">
                  <c:v>25</c:v>
                </c:pt>
                <c:pt idx="30">
                  <c:v>26</c:v>
                </c:pt>
                <c:pt idx="31">
                  <c:v>27</c:v>
                </c:pt>
                <c:pt idx="32">
                  <c:v>28</c:v>
                </c:pt>
                <c:pt idx="33">
                  <c:v>29</c:v>
                </c:pt>
                <c:pt idx="34">
                  <c:v>30</c:v>
                </c:pt>
                <c:pt idx="35">
                  <c:v>31</c:v>
                </c:pt>
                <c:pt idx="36">
                  <c:v>32</c:v>
                </c:pt>
                <c:pt idx="37">
                  <c:v>33</c:v>
                </c:pt>
                <c:pt idx="38">
                  <c:v>34</c:v>
                </c:pt>
                <c:pt idx="39">
                  <c:v>35</c:v>
                </c:pt>
                <c:pt idx="40">
                  <c:v>36</c:v>
                </c:pt>
                <c:pt idx="41">
                  <c:v>37</c:v>
                </c:pt>
                <c:pt idx="42">
                  <c:v>38</c:v>
                </c:pt>
                <c:pt idx="43">
                  <c:v>39</c:v>
                </c:pt>
                <c:pt idx="44">
                  <c:v>40</c:v>
                </c:pt>
                <c:pt idx="45">
                  <c:v>41</c:v>
                </c:pt>
                <c:pt idx="46">
                  <c:v>42</c:v>
                </c:pt>
                <c:pt idx="47">
                  <c:v>43</c:v>
                </c:pt>
                <c:pt idx="48">
                  <c:v>44</c:v>
                </c:pt>
                <c:pt idx="49">
                  <c:v>45</c:v>
                </c:pt>
                <c:pt idx="50">
                  <c:v>46</c:v>
                </c:pt>
                <c:pt idx="51">
                  <c:v>47</c:v>
                </c:pt>
                <c:pt idx="52">
                  <c:v>48</c:v>
                </c:pt>
                <c:pt idx="53">
                  <c:v>49</c:v>
                </c:pt>
                <c:pt idx="54">
                  <c:v>50</c:v>
                </c:pt>
                <c:pt idx="55">
                  <c:v>51</c:v>
                </c:pt>
                <c:pt idx="56">
                  <c:v>52</c:v>
                </c:pt>
                <c:pt idx="57">
                  <c:v>53</c:v>
                </c:pt>
                <c:pt idx="58">
                  <c:v>54</c:v>
                </c:pt>
                <c:pt idx="59">
                  <c:v>55</c:v>
                </c:pt>
                <c:pt idx="60">
                  <c:v>56</c:v>
                </c:pt>
                <c:pt idx="61">
                  <c:v>57</c:v>
                </c:pt>
                <c:pt idx="62">
                  <c:v>58</c:v>
                </c:pt>
                <c:pt idx="63">
                  <c:v>59</c:v>
                </c:pt>
                <c:pt idx="64">
                  <c:v>60</c:v>
                </c:pt>
                <c:pt idx="65">
                  <c:v>61</c:v>
                </c:pt>
                <c:pt idx="66">
                  <c:v>62</c:v>
                </c:pt>
                <c:pt idx="67">
                  <c:v>63</c:v>
                </c:pt>
                <c:pt idx="68">
                  <c:v>64</c:v>
                </c:pt>
                <c:pt idx="69">
                  <c:v>65</c:v>
                </c:pt>
                <c:pt idx="70">
                  <c:v>66</c:v>
                </c:pt>
                <c:pt idx="71">
                  <c:v>67</c:v>
                </c:pt>
                <c:pt idx="72">
                  <c:v>68</c:v>
                </c:pt>
                <c:pt idx="73">
                  <c:v>69</c:v>
                </c:pt>
                <c:pt idx="74">
                  <c:v>70</c:v>
                </c:pt>
                <c:pt idx="75">
                  <c:v>71</c:v>
                </c:pt>
                <c:pt idx="76">
                  <c:v>72</c:v>
                </c:pt>
                <c:pt idx="77">
                  <c:v>73</c:v>
                </c:pt>
                <c:pt idx="78">
                  <c:v>74</c:v>
                </c:pt>
                <c:pt idx="79">
                  <c:v>75</c:v>
                </c:pt>
                <c:pt idx="80">
                  <c:v>76</c:v>
                </c:pt>
                <c:pt idx="81">
                  <c:v>77</c:v>
                </c:pt>
                <c:pt idx="82">
                  <c:v>78</c:v>
                </c:pt>
                <c:pt idx="83">
                  <c:v>79</c:v>
                </c:pt>
                <c:pt idx="84">
                  <c:v>80</c:v>
                </c:pt>
              </c:strCache>
            </c:strRef>
          </c:cat>
          <c:val>
            <c:numRef>
              <c:f>Sheet3!$F$3:$F$87</c:f>
              <c:numCache>
                <c:formatCode>General</c:formatCode>
                <c:ptCount val="85"/>
                <c:pt idx="0">
                  <c:v>622.5</c:v>
                </c:pt>
                <c:pt idx="1">
                  <c:v>623.75</c:v>
                </c:pt>
                <c:pt idx="2">
                  <c:v>18799.25</c:v>
                </c:pt>
                <c:pt idx="3">
                  <c:v>10059</c:v>
                </c:pt>
                <c:pt idx="4">
                  <c:v>15261.999999999998</c:v>
                </c:pt>
                <c:pt idx="5">
                  <c:v>14313</c:v>
                </c:pt>
                <c:pt idx="6">
                  <c:v>19318</c:v>
                </c:pt>
                <c:pt idx="7">
                  <c:v>12836.000000000002</c:v>
                </c:pt>
                <c:pt idx="8">
                  <c:v>8388</c:v>
                </c:pt>
                <c:pt idx="9">
                  <c:v>12067</c:v>
                </c:pt>
                <c:pt idx="10">
                  <c:v>13551</c:v>
                </c:pt>
                <c:pt idx="11">
                  <c:v>16199</c:v>
                </c:pt>
                <c:pt idx="12">
                  <c:v>4845</c:v>
                </c:pt>
                <c:pt idx="13">
                  <c:v>15873</c:v>
                </c:pt>
                <c:pt idx="14">
                  <c:v>17668</c:v>
                </c:pt>
                <c:pt idx="15">
                  <c:v>14602</c:v>
                </c:pt>
                <c:pt idx="16">
                  <c:v>16247</c:v>
                </c:pt>
                <c:pt idx="17">
                  <c:v>3504</c:v>
                </c:pt>
                <c:pt idx="18">
                  <c:v>20123</c:v>
                </c:pt>
                <c:pt idx="19">
                  <c:v>13128</c:v>
                </c:pt>
                <c:pt idx="20">
                  <c:v>17211</c:v>
                </c:pt>
                <c:pt idx="21">
                  <c:v>15705</c:v>
                </c:pt>
                <c:pt idx="22">
                  <c:v>20090</c:v>
                </c:pt>
                <c:pt idx="23">
                  <c:v>15691.000000000002</c:v>
                </c:pt>
                <c:pt idx="24">
                  <c:v>17195</c:v>
                </c:pt>
                <c:pt idx="25">
                  <c:v>22230</c:v>
                </c:pt>
                <c:pt idx="26">
                  <c:v>21268</c:v>
                </c:pt>
                <c:pt idx="27">
                  <c:v>11541.000000000002</c:v>
                </c:pt>
                <c:pt idx="28">
                  <c:v>11105</c:v>
                </c:pt>
                <c:pt idx="29">
                  <c:v>17931</c:v>
                </c:pt>
                <c:pt idx="30">
                  <c:v>27346</c:v>
                </c:pt>
                <c:pt idx="31">
                  <c:v>19679</c:v>
                </c:pt>
                <c:pt idx="32">
                  <c:v>23444</c:v>
                </c:pt>
                <c:pt idx="33">
                  <c:v>21730</c:v>
                </c:pt>
                <c:pt idx="34">
                  <c:v>19987</c:v>
                </c:pt>
                <c:pt idx="35">
                  <c:v>15837</c:v>
                </c:pt>
                <c:pt idx="36">
                  <c:v>15074</c:v>
                </c:pt>
                <c:pt idx="37">
                  <c:v>10170</c:v>
                </c:pt>
                <c:pt idx="38">
                  <c:v>17043</c:v>
                </c:pt>
                <c:pt idx="39">
                  <c:v>9853</c:v>
                </c:pt>
                <c:pt idx="40">
                  <c:v>18807</c:v>
                </c:pt>
                <c:pt idx="41">
                  <c:v>20609</c:v>
                </c:pt>
                <c:pt idx="42">
                  <c:v>15579</c:v>
                </c:pt>
                <c:pt idx="43">
                  <c:v>20864</c:v>
                </c:pt>
                <c:pt idx="44">
                  <c:v>15878.999999999998</c:v>
                </c:pt>
                <c:pt idx="45">
                  <c:v>5435</c:v>
                </c:pt>
                <c:pt idx="46">
                  <c:v>16868</c:v>
                </c:pt>
                <c:pt idx="47">
                  <c:v>18424</c:v>
                </c:pt>
                <c:pt idx="48">
                  <c:v>25874</c:v>
                </c:pt>
                <c:pt idx="49">
                  <c:v>10291.000000000002</c:v>
                </c:pt>
                <c:pt idx="50">
                  <c:v>17146</c:v>
                </c:pt>
                <c:pt idx="51">
                  <c:v>16486</c:v>
                </c:pt>
                <c:pt idx="52">
                  <c:v>14688</c:v>
                </c:pt>
                <c:pt idx="53">
                  <c:v>18422.999999999996</c:v>
                </c:pt>
                <c:pt idx="54">
                  <c:v>12271.000000000002</c:v>
                </c:pt>
                <c:pt idx="55">
                  <c:v>747</c:v>
                </c:pt>
                <c:pt idx="56">
                  <c:v>15608</c:v>
                </c:pt>
                <c:pt idx="57">
                  <c:v>9363</c:v>
                </c:pt>
                <c:pt idx="58">
                  <c:v>17221</c:v>
                </c:pt>
                <c:pt idx="59">
                  <c:v>4334</c:v>
                </c:pt>
                <c:pt idx="60">
                  <c:v>11350</c:v>
                </c:pt>
                <c:pt idx="61">
                  <c:v>17039</c:v>
                </c:pt>
                <c:pt idx="62">
                  <c:v>14102</c:v>
                </c:pt>
                <c:pt idx="63">
                  <c:v>11613</c:v>
                </c:pt>
                <c:pt idx="64">
                  <c:v>22249</c:v>
                </c:pt>
                <c:pt idx="65">
                  <c:v>3444</c:v>
                </c:pt>
                <c:pt idx="66">
                  <c:v>2216</c:v>
                </c:pt>
                <c:pt idx="67">
                  <c:v>6796</c:v>
                </c:pt>
                <c:pt idx="68">
                  <c:v>18489.999999999996</c:v>
                </c:pt>
                <c:pt idx="69">
                  <c:v>18427</c:v>
                </c:pt>
                <c:pt idx="70">
                  <c:v>16856</c:v>
                </c:pt>
                <c:pt idx="71">
                  <c:v>18694</c:v>
                </c:pt>
                <c:pt idx="72">
                  <c:v>24121</c:v>
                </c:pt>
                <c:pt idx="73">
                  <c:v>20231</c:v>
                </c:pt>
                <c:pt idx="74">
                  <c:v>24838</c:v>
                </c:pt>
                <c:pt idx="75">
                  <c:v>22606.000000000004</c:v>
                </c:pt>
                <c:pt idx="76">
                  <c:v>12967</c:v>
                </c:pt>
                <c:pt idx="77">
                  <c:v>852</c:v>
                </c:pt>
                <c:pt idx="78">
                  <c:v>15519</c:v>
                </c:pt>
                <c:pt idx="79">
                  <c:v>12008</c:v>
                </c:pt>
                <c:pt idx="80">
                  <c:v>14776</c:v>
                </c:pt>
                <c:pt idx="81">
                  <c:v>837</c:v>
                </c:pt>
                <c:pt idx="82">
                  <c:v>19402</c:v>
                </c:pt>
                <c:pt idx="83">
                  <c:v>22518.999999999996</c:v>
                </c:pt>
                <c:pt idx="84">
                  <c:v>6660</c:v>
                </c:pt>
              </c:numCache>
            </c:numRef>
          </c:val>
          <c:extLst>
            <c:ext xmlns:c16="http://schemas.microsoft.com/office/drawing/2014/chart" uri="{C3380CC4-5D6E-409C-BE32-E72D297353CC}">
              <c16:uniqueId val="{00000000-E1C8-B747-94F3-EFD1C9600E51}"/>
            </c:ext>
          </c:extLst>
        </c:ser>
        <c:dLbls>
          <c:showLegendKey val="0"/>
          <c:showVal val="0"/>
          <c:showCatName val="0"/>
          <c:showSerName val="0"/>
          <c:showPercent val="0"/>
          <c:showBubbleSize val="0"/>
        </c:dLbls>
        <c:gapWidth val="150"/>
        <c:axId val="112156728"/>
        <c:axId val="8310400"/>
      </c:barChart>
      <c:catAx>
        <c:axId val="112156728"/>
        <c:scaling>
          <c:orientation val="minMax"/>
        </c:scaling>
        <c:delete val="0"/>
        <c:axPos val="b"/>
        <c:numFmt formatCode="General" sourceLinked="0"/>
        <c:majorTickMark val="out"/>
        <c:minorTickMark val="none"/>
        <c:tickLblPos val="nextTo"/>
        <c:txPr>
          <a:bodyPr/>
          <a:lstStyle/>
          <a:p>
            <a:pPr>
              <a:defRPr sz="900" b="1">
                <a:latin typeface="Arial" panose="020B0604020202020204" pitchFamily="34" charset="0"/>
                <a:cs typeface="Arial" panose="020B0604020202020204" pitchFamily="34" charset="0"/>
              </a:defRPr>
            </a:pPr>
            <a:endParaRPr lang="en-ES"/>
          </a:p>
        </c:txPr>
        <c:crossAx val="8310400"/>
        <c:crosses val="autoZero"/>
        <c:auto val="1"/>
        <c:lblAlgn val="ctr"/>
        <c:lblOffset val="100"/>
        <c:noMultiLvlLbl val="0"/>
      </c:catAx>
      <c:valAx>
        <c:axId val="8310400"/>
        <c:scaling>
          <c:orientation val="minMax"/>
        </c:scaling>
        <c:delete val="0"/>
        <c:axPos val="l"/>
        <c:numFmt formatCode="General" sourceLinked="0"/>
        <c:majorTickMark val="out"/>
        <c:minorTickMark val="none"/>
        <c:tickLblPos val="nextTo"/>
        <c:spPr>
          <a:ln w="28575">
            <a:solidFill>
              <a:schemeClr val="tx1"/>
            </a:solidFill>
          </a:ln>
          <a:effectLst>
            <a:outerShdw blurRad="50800" dist="50800" dir="5400000" algn="ctr" rotWithShape="0">
              <a:schemeClr val="bg1"/>
            </a:outerShdw>
          </a:effectLst>
        </c:spPr>
        <c:txPr>
          <a:bodyPr/>
          <a:lstStyle/>
          <a:p>
            <a:pPr>
              <a:defRPr sz="1100" b="1">
                <a:latin typeface="Arial" panose="020B0604020202020204" pitchFamily="34" charset="0"/>
                <a:cs typeface="Arial" panose="020B0604020202020204" pitchFamily="34" charset="0"/>
              </a:defRPr>
            </a:pPr>
            <a:endParaRPr lang="en-ES"/>
          </a:p>
        </c:txPr>
        <c:crossAx val="112156728"/>
        <c:crosses val="autoZero"/>
        <c:crossBetween val="between"/>
        <c:majorUnit val="10000"/>
      </c:valAx>
      <c:spPr>
        <a:ln w="15875">
          <a:noFill/>
        </a:ln>
      </c:spPr>
    </c:plotArea>
    <c:plotVisOnly val="1"/>
    <c:dispBlanksAs val="gap"/>
    <c:showDLblsOverMax val="0"/>
  </c:chart>
  <c:spPr>
    <a:solidFill>
      <a:schemeClr val="bg1"/>
    </a:solidFill>
    <a:ln>
      <a:noFill/>
    </a:ln>
  </c:sp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9852544529055846"/>
          <c:y val="3.0075682456230695E-2"/>
          <c:w val="0.69606502833652184"/>
          <c:h val="0.73145626027515787"/>
        </c:manualLayout>
      </c:layout>
      <c:scatterChart>
        <c:scatterStyle val="smoothMarker"/>
        <c:varyColors val="0"/>
        <c:ser>
          <c:idx val="0"/>
          <c:order val="0"/>
          <c:tx>
            <c:strRef>
              <c:f>Sheet1!$C$3:$C$4</c:f>
              <c:strCache>
                <c:ptCount val="1"/>
                <c:pt idx="0">
                  <c:v>2μM</c:v>
                </c:pt>
              </c:strCache>
            </c:strRef>
          </c:tx>
          <c:spPr>
            <a:ln w="19050">
              <a:solidFill>
                <a:srgbClr val="C00000"/>
              </a:solidFill>
            </a:ln>
          </c:spPr>
          <c:marker>
            <c:symbol val="none"/>
          </c:marker>
          <c:xVal>
            <c:numRef>
              <c:f>Sheet1!$B$5:$B$505</c:f>
              <c:numCache>
                <c:formatCode>General</c:formatCode>
                <c:ptCount val="501"/>
                <c:pt idx="31">
                  <c:v>306</c:v>
                </c:pt>
                <c:pt idx="32">
                  <c:v>306.2</c:v>
                </c:pt>
                <c:pt idx="33">
                  <c:v>306.39999999999998</c:v>
                </c:pt>
                <c:pt idx="34">
                  <c:v>306.60000000000002</c:v>
                </c:pt>
                <c:pt idx="35">
                  <c:v>306.8</c:v>
                </c:pt>
                <c:pt idx="36">
                  <c:v>307</c:v>
                </c:pt>
                <c:pt idx="37">
                  <c:v>307.39999999999998</c:v>
                </c:pt>
                <c:pt idx="38">
                  <c:v>307.60000000000002</c:v>
                </c:pt>
                <c:pt idx="39">
                  <c:v>307.8</c:v>
                </c:pt>
                <c:pt idx="40">
                  <c:v>308</c:v>
                </c:pt>
                <c:pt idx="41">
                  <c:v>308.2</c:v>
                </c:pt>
                <c:pt idx="42">
                  <c:v>308.39999999999998</c:v>
                </c:pt>
                <c:pt idx="43">
                  <c:v>308.60000000000002</c:v>
                </c:pt>
                <c:pt idx="44">
                  <c:v>308.8</c:v>
                </c:pt>
                <c:pt idx="45">
                  <c:v>309</c:v>
                </c:pt>
                <c:pt idx="46">
                  <c:v>309.2</c:v>
                </c:pt>
                <c:pt idx="47">
                  <c:v>309.39999999999998</c:v>
                </c:pt>
                <c:pt idx="48">
                  <c:v>309.60000000000002</c:v>
                </c:pt>
                <c:pt idx="49">
                  <c:v>309.8</c:v>
                </c:pt>
                <c:pt idx="50">
                  <c:v>310</c:v>
                </c:pt>
                <c:pt idx="51">
                  <c:v>310.2</c:v>
                </c:pt>
                <c:pt idx="52">
                  <c:v>310.39999999999998</c:v>
                </c:pt>
                <c:pt idx="53">
                  <c:v>310.60000000000002</c:v>
                </c:pt>
                <c:pt idx="54">
                  <c:v>310.8</c:v>
                </c:pt>
                <c:pt idx="55">
                  <c:v>311</c:v>
                </c:pt>
                <c:pt idx="56">
                  <c:v>311.2</c:v>
                </c:pt>
                <c:pt idx="57">
                  <c:v>311.39999999999998</c:v>
                </c:pt>
                <c:pt idx="58">
                  <c:v>311.60000000000002</c:v>
                </c:pt>
                <c:pt idx="59">
                  <c:v>311.8</c:v>
                </c:pt>
                <c:pt idx="60">
                  <c:v>312</c:v>
                </c:pt>
                <c:pt idx="61">
                  <c:v>312.2</c:v>
                </c:pt>
                <c:pt idx="62">
                  <c:v>312.39999999999998</c:v>
                </c:pt>
                <c:pt idx="63">
                  <c:v>312.60000000000002</c:v>
                </c:pt>
                <c:pt idx="64">
                  <c:v>312.8</c:v>
                </c:pt>
                <c:pt idx="65">
                  <c:v>313</c:v>
                </c:pt>
                <c:pt idx="66">
                  <c:v>313.2</c:v>
                </c:pt>
                <c:pt idx="67">
                  <c:v>313.39999999999998</c:v>
                </c:pt>
                <c:pt idx="68">
                  <c:v>313.60000000000002</c:v>
                </c:pt>
                <c:pt idx="69">
                  <c:v>313.8</c:v>
                </c:pt>
                <c:pt idx="70">
                  <c:v>314</c:v>
                </c:pt>
                <c:pt idx="71">
                  <c:v>314.2</c:v>
                </c:pt>
                <c:pt idx="72">
                  <c:v>314.39999999999998</c:v>
                </c:pt>
                <c:pt idx="73">
                  <c:v>314.60000000000002</c:v>
                </c:pt>
                <c:pt idx="74">
                  <c:v>314.8</c:v>
                </c:pt>
                <c:pt idx="75">
                  <c:v>315</c:v>
                </c:pt>
                <c:pt idx="76">
                  <c:v>315.2</c:v>
                </c:pt>
                <c:pt idx="77">
                  <c:v>315.39999999999998</c:v>
                </c:pt>
                <c:pt idx="78">
                  <c:v>315.60000000000002</c:v>
                </c:pt>
                <c:pt idx="79">
                  <c:v>315.8</c:v>
                </c:pt>
                <c:pt idx="80">
                  <c:v>316</c:v>
                </c:pt>
                <c:pt idx="81">
                  <c:v>316.2</c:v>
                </c:pt>
                <c:pt idx="82">
                  <c:v>316.39999999999998</c:v>
                </c:pt>
                <c:pt idx="83">
                  <c:v>316.60000000000002</c:v>
                </c:pt>
                <c:pt idx="84">
                  <c:v>316.8</c:v>
                </c:pt>
                <c:pt idx="85">
                  <c:v>317</c:v>
                </c:pt>
                <c:pt idx="86">
                  <c:v>317.2</c:v>
                </c:pt>
                <c:pt idx="87">
                  <c:v>317.39999999999998</c:v>
                </c:pt>
                <c:pt idx="88">
                  <c:v>317.60000000000002</c:v>
                </c:pt>
                <c:pt idx="89">
                  <c:v>317.8</c:v>
                </c:pt>
                <c:pt idx="90">
                  <c:v>318</c:v>
                </c:pt>
                <c:pt idx="91">
                  <c:v>318.2</c:v>
                </c:pt>
                <c:pt idx="92">
                  <c:v>318.39999999999998</c:v>
                </c:pt>
                <c:pt idx="93">
                  <c:v>318.60000000000002</c:v>
                </c:pt>
                <c:pt idx="94">
                  <c:v>318.8</c:v>
                </c:pt>
                <c:pt idx="95">
                  <c:v>319</c:v>
                </c:pt>
                <c:pt idx="96">
                  <c:v>319.2</c:v>
                </c:pt>
                <c:pt idx="97">
                  <c:v>319.39999999999998</c:v>
                </c:pt>
                <c:pt idx="98">
                  <c:v>319.60000000000002</c:v>
                </c:pt>
                <c:pt idx="99">
                  <c:v>319.8</c:v>
                </c:pt>
                <c:pt idx="100">
                  <c:v>320</c:v>
                </c:pt>
                <c:pt idx="101">
                  <c:v>320.2</c:v>
                </c:pt>
                <c:pt idx="102">
                  <c:v>320.39999999999998</c:v>
                </c:pt>
                <c:pt idx="103">
                  <c:v>320.60000000000002</c:v>
                </c:pt>
                <c:pt idx="104">
                  <c:v>320.8</c:v>
                </c:pt>
                <c:pt idx="105">
                  <c:v>321</c:v>
                </c:pt>
                <c:pt idx="106">
                  <c:v>321.2</c:v>
                </c:pt>
                <c:pt idx="107">
                  <c:v>321.39999999999998</c:v>
                </c:pt>
                <c:pt idx="108">
                  <c:v>321.60000000000002</c:v>
                </c:pt>
                <c:pt idx="109">
                  <c:v>321.8</c:v>
                </c:pt>
                <c:pt idx="110">
                  <c:v>322</c:v>
                </c:pt>
                <c:pt idx="111">
                  <c:v>322.2</c:v>
                </c:pt>
                <c:pt idx="112">
                  <c:v>322.39999999999998</c:v>
                </c:pt>
                <c:pt idx="113">
                  <c:v>322.60000000000002</c:v>
                </c:pt>
                <c:pt idx="114">
                  <c:v>322.8</c:v>
                </c:pt>
                <c:pt idx="115">
                  <c:v>323</c:v>
                </c:pt>
                <c:pt idx="116">
                  <c:v>323.2</c:v>
                </c:pt>
                <c:pt idx="117">
                  <c:v>323.39999999999998</c:v>
                </c:pt>
                <c:pt idx="118">
                  <c:v>323.60000000000002</c:v>
                </c:pt>
                <c:pt idx="119">
                  <c:v>323.8</c:v>
                </c:pt>
                <c:pt idx="120">
                  <c:v>324</c:v>
                </c:pt>
                <c:pt idx="121">
                  <c:v>324.2</c:v>
                </c:pt>
                <c:pt idx="122">
                  <c:v>324.39999999999998</c:v>
                </c:pt>
                <c:pt idx="123">
                  <c:v>324.60000000000002</c:v>
                </c:pt>
                <c:pt idx="124">
                  <c:v>324.8</c:v>
                </c:pt>
                <c:pt idx="125">
                  <c:v>325</c:v>
                </c:pt>
                <c:pt idx="126">
                  <c:v>325.2</c:v>
                </c:pt>
                <c:pt idx="127">
                  <c:v>325.39999999999998</c:v>
                </c:pt>
                <c:pt idx="128">
                  <c:v>325.60000000000002</c:v>
                </c:pt>
                <c:pt idx="129">
                  <c:v>325.8</c:v>
                </c:pt>
                <c:pt idx="130">
                  <c:v>326</c:v>
                </c:pt>
                <c:pt idx="131">
                  <c:v>326.2</c:v>
                </c:pt>
                <c:pt idx="132">
                  <c:v>326.39999999999998</c:v>
                </c:pt>
                <c:pt idx="133">
                  <c:v>326.60000000000002</c:v>
                </c:pt>
                <c:pt idx="134">
                  <c:v>326.8</c:v>
                </c:pt>
                <c:pt idx="135">
                  <c:v>327</c:v>
                </c:pt>
                <c:pt idx="136">
                  <c:v>327.2</c:v>
                </c:pt>
                <c:pt idx="137">
                  <c:v>327.39999999999998</c:v>
                </c:pt>
                <c:pt idx="138">
                  <c:v>327.60000000000002</c:v>
                </c:pt>
                <c:pt idx="139">
                  <c:v>327.8</c:v>
                </c:pt>
                <c:pt idx="140">
                  <c:v>328</c:v>
                </c:pt>
                <c:pt idx="141">
                  <c:v>328.2</c:v>
                </c:pt>
                <c:pt idx="142">
                  <c:v>328.4</c:v>
                </c:pt>
                <c:pt idx="143">
                  <c:v>328.6</c:v>
                </c:pt>
                <c:pt idx="144">
                  <c:v>328.8</c:v>
                </c:pt>
                <c:pt idx="145">
                  <c:v>329</c:v>
                </c:pt>
                <c:pt idx="146">
                  <c:v>329.2</c:v>
                </c:pt>
                <c:pt idx="147">
                  <c:v>329.4</c:v>
                </c:pt>
                <c:pt idx="148">
                  <c:v>329.6</c:v>
                </c:pt>
                <c:pt idx="149">
                  <c:v>329.8</c:v>
                </c:pt>
                <c:pt idx="150">
                  <c:v>330</c:v>
                </c:pt>
                <c:pt idx="151">
                  <c:v>330.2</c:v>
                </c:pt>
                <c:pt idx="152">
                  <c:v>330.4</c:v>
                </c:pt>
                <c:pt idx="153">
                  <c:v>330.6</c:v>
                </c:pt>
                <c:pt idx="154">
                  <c:v>330.8</c:v>
                </c:pt>
                <c:pt idx="155">
                  <c:v>331</c:v>
                </c:pt>
                <c:pt idx="156">
                  <c:v>331.2</c:v>
                </c:pt>
                <c:pt idx="157">
                  <c:v>331.4</c:v>
                </c:pt>
                <c:pt idx="158">
                  <c:v>331.6</c:v>
                </c:pt>
                <c:pt idx="159">
                  <c:v>331.8</c:v>
                </c:pt>
                <c:pt idx="160">
                  <c:v>332</c:v>
                </c:pt>
                <c:pt idx="161">
                  <c:v>332.2</c:v>
                </c:pt>
                <c:pt idx="162">
                  <c:v>332.4</c:v>
                </c:pt>
                <c:pt idx="163">
                  <c:v>332.6</c:v>
                </c:pt>
                <c:pt idx="164">
                  <c:v>332.8</c:v>
                </c:pt>
                <c:pt idx="165">
                  <c:v>333</c:v>
                </c:pt>
                <c:pt idx="166">
                  <c:v>333.2</c:v>
                </c:pt>
                <c:pt idx="167">
                  <c:v>333.4</c:v>
                </c:pt>
                <c:pt idx="168">
                  <c:v>333.6</c:v>
                </c:pt>
                <c:pt idx="169">
                  <c:v>333.8</c:v>
                </c:pt>
                <c:pt idx="170">
                  <c:v>334</c:v>
                </c:pt>
                <c:pt idx="171">
                  <c:v>334.2</c:v>
                </c:pt>
                <c:pt idx="172">
                  <c:v>334.4</c:v>
                </c:pt>
                <c:pt idx="173">
                  <c:v>334.6</c:v>
                </c:pt>
                <c:pt idx="174">
                  <c:v>334.8</c:v>
                </c:pt>
                <c:pt idx="175">
                  <c:v>335</c:v>
                </c:pt>
                <c:pt idx="176">
                  <c:v>335.2</c:v>
                </c:pt>
                <c:pt idx="177">
                  <c:v>335.4</c:v>
                </c:pt>
                <c:pt idx="178">
                  <c:v>335.6</c:v>
                </c:pt>
                <c:pt idx="179">
                  <c:v>335.8</c:v>
                </c:pt>
                <c:pt idx="180">
                  <c:v>336</c:v>
                </c:pt>
                <c:pt idx="181">
                  <c:v>336.2</c:v>
                </c:pt>
                <c:pt idx="182">
                  <c:v>336.4</c:v>
                </c:pt>
                <c:pt idx="183">
                  <c:v>336.6</c:v>
                </c:pt>
                <c:pt idx="184">
                  <c:v>336.8</c:v>
                </c:pt>
                <c:pt idx="185">
                  <c:v>337</c:v>
                </c:pt>
                <c:pt idx="186">
                  <c:v>337.2</c:v>
                </c:pt>
                <c:pt idx="187">
                  <c:v>337.4</c:v>
                </c:pt>
                <c:pt idx="188">
                  <c:v>337.6</c:v>
                </c:pt>
                <c:pt idx="189">
                  <c:v>337.8</c:v>
                </c:pt>
                <c:pt idx="190">
                  <c:v>338</c:v>
                </c:pt>
                <c:pt idx="191">
                  <c:v>338.2</c:v>
                </c:pt>
                <c:pt idx="192">
                  <c:v>338.4</c:v>
                </c:pt>
                <c:pt idx="193">
                  <c:v>338.6</c:v>
                </c:pt>
                <c:pt idx="194">
                  <c:v>338.8</c:v>
                </c:pt>
                <c:pt idx="195">
                  <c:v>339</c:v>
                </c:pt>
                <c:pt idx="196">
                  <c:v>339.2</c:v>
                </c:pt>
                <c:pt idx="197">
                  <c:v>339.4</c:v>
                </c:pt>
                <c:pt idx="198">
                  <c:v>339.6</c:v>
                </c:pt>
                <c:pt idx="199">
                  <c:v>339.8</c:v>
                </c:pt>
                <c:pt idx="200">
                  <c:v>340</c:v>
                </c:pt>
                <c:pt idx="201">
                  <c:v>340.2</c:v>
                </c:pt>
                <c:pt idx="202">
                  <c:v>340.4</c:v>
                </c:pt>
                <c:pt idx="203">
                  <c:v>340.6</c:v>
                </c:pt>
                <c:pt idx="204">
                  <c:v>340.8</c:v>
                </c:pt>
                <c:pt idx="205">
                  <c:v>341</c:v>
                </c:pt>
                <c:pt idx="206">
                  <c:v>341.2</c:v>
                </c:pt>
                <c:pt idx="207">
                  <c:v>341.4</c:v>
                </c:pt>
                <c:pt idx="208">
                  <c:v>341.6</c:v>
                </c:pt>
                <c:pt idx="209">
                  <c:v>341.8</c:v>
                </c:pt>
                <c:pt idx="210">
                  <c:v>342</c:v>
                </c:pt>
                <c:pt idx="211">
                  <c:v>342.2</c:v>
                </c:pt>
                <c:pt idx="212">
                  <c:v>342.4</c:v>
                </c:pt>
                <c:pt idx="213">
                  <c:v>342.6</c:v>
                </c:pt>
                <c:pt idx="214">
                  <c:v>342.8</c:v>
                </c:pt>
                <c:pt idx="215">
                  <c:v>343</c:v>
                </c:pt>
                <c:pt idx="216">
                  <c:v>343.2</c:v>
                </c:pt>
                <c:pt idx="217">
                  <c:v>343.4</c:v>
                </c:pt>
                <c:pt idx="218">
                  <c:v>343.6</c:v>
                </c:pt>
                <c:pt idx="219">
                  <c:v>343.8</c:v>
                </c:pt>
                <c:pt idx="220">
                  <c:v>344</c:v>
                </c:pt>
                <c:pt idx="221">
                  <c:v>344.2</c:v>
                </c:pt>
                <c:pt idx="222">
                  <c:v>344.4</c:v>
                </c:pt>
                <c:pt idx="223">
                  <c:v>344.6</c:v>
                </c:pt>
                <c:pt idx="224">
                  <c:v>344.8</c:v>
                </c:pt>
                <c:pt idx="225">
                  <c:v>345</c:v>
                </c:pt>
                <c:pt idx="226">
                  <c:v>345.2</c:v>
                </c:pt>
                <c:pt idx="227">
                  <c:v>345.4</c:v>
                </c:pt>
                <c:pt idx="228">
                  <c:v>345.6</c:v>
                </c:pt>
                <c:pt idx="229">
                  <c:v>345.8</c:v>
                </c:pt>
                <c:pt idx="230">
                  <c:v>346</c:v>
                </c:pt>
                <c:pt idx="231">
                  <c:v>346.2</c:v>
                </c:pt>
                <c:pt idx="232">
                  <c:v>346.4</c:v>
                </c:pt>
                <c:pt idx="233">
                  <c:v>346.6</c:v>
                </c:pt>
                <c:pt idx="234">
                  <c:v>346.8</c:v>
                </c:pt>
                <c:pt idx="235">
                  <c:v>347</c:v>
                </c:pt>
                <c:pt idx="236">
                  <c:v>347.2</c:v>
                </c:pt>
                <c:pt idx="237">
                  <c:v>347.4</c:v>
                </c:pt>
                <c:pt idx="238">
                  <c:v>347.6</c:v>
                </c:pt>
                <c:pt idx="239">
                  <c:v>347.8</c:v>
                </c:pt>
                <c:pt idx="240">
                  <c:v>348</c:v>
                </c:pt>
                <c:pt idx="241">
                  <c:v>348.2</c:v>
                </c:pt>
                <c:pt idx="242">
                  <c:v>348.4</c:v>
                </c:pt>
                <c:pt idx="243">
                  <c:v>348.6</c:v>
                </c:pt>
                <c:pt idx="244">
                  <c:v>348.8</c:v>
                </c:pt>
                <c:pt idx="245">
                  <c:v>349</c:v>
                </c:pt>
                <c:pt idx="246">
                  <c:v>349.2</c:v>
                </c:pt>
                <c:pt idx="247">
                  <c:v>349.4</c:v>
                </c:pt>
                <c:pt idx="248">
                  <c:v>349.6</c:v>
                </c:pt>
                <c:pt idx="249">
                  <c:v>349.8</c:v>
                </c:pt>
                <c:pt idx="250">
                  <c:v>350</c:v>
                </c:pt>
                <c:pt idx="251">
                  <c:v>350.2</c:v>
                </c:pt>
                <c:pt idx="252">
                  <c:v>350.4</c:v>
                </c:pt>
                <c:pt idx="253">
                  <c:v>350.6</c:v>
                </c:pt>
                <c:pt idx="254">
                  <c:v>350.8</c:v>
                </c:pt>
                <c:pt idx="255">
                  <c:v>351</c:v>
                </c:pt>
                <c:pt idx="256">
                  <c:v>351.2</c:v>
                </c:pt>
                <c:pt idx="257">
                  <c:v>351.4</c:v>
                </c:pt>
                <c:pt idx="258">
                  <c:v>351.6</c:v>
                </c:pt>
                <c:pt idx="259">
                  <c:v>351.8</c:v>
                </c:pt>
                <c:pt idx="260">
                  <c:v>352</c:v>
                </c:pt>
                <c:pt idx="261">
                  <c:v>352.2</c:v>
                </c:pt>
                <c:pt idx="262">
                  <c:v>352.4</c:v>
                </c:pt>
                <c:pt idx="263">
                  <c:v>352.6</c:v>
                </c:pt>
                <c:pt idx="264">
                  <c:v>352.8</c:v>
                </c:pt>
                <c:pt idx="265">
                  <c:v>353</c:v>
                </c:pt>
                <c:pt idx="266">
                  <c:v>353.2</c:v>
                </c:pt>
                <c:pt idx="267">
                  <c:v>353.4</c:v>
                </c:pt>
                <c:pt idx="268">
                  <c:v>353.6</c:v>
                </c:pt>
                <c:pt idx="269">
                  <c:v>353.8</c:v>
                </c:pt>
                <c:pt idx="270">
                  <c:v>354</c:v>
                </c:pt>
                <c:pt idx="271">
                  <c:v>354.2</c:v>
                </c:pt>
                <c:pt idx="272">
                  <c:v>354.4</c:v>
                </c:pt>
                <c:pt idx="273">
                  <c:v>354.6</c:v>
                </c:pt>
                <c:pt idx="274">
                  <c:v>354.8</c:v>
                </c:pt>
                <c:pt idx="275">
                  <c:v>355</c:v>
                </c:pt>
                <c:pt idx="276">
                  <c:v>355.2</c:v>
                </c:pt>
                <c:pt idx="277">
                  <c:v>355.4</c:v>
                </c:pt>
                <c:pt idx="278">
                  <c:v>355.6</c:v>
                </c:pt>
                <c:pt idx="279">
                  <c:v>355.8</c:v>
                </c:pt>
                <c:pt idx="280">
                  <c:v>356</c:v>
                </c:pt>
                <c:pt idx="281">
                  <c:v>356.2</c:v>
                </c:pt>
                <c:pt idx="282">
                  <c:v>356.4</c:v>
                </c:pt>
                <c:pt idx="283">
                  <c:v>356.6</c:v>
                </c:pt>
                <c:pt idx="284">
                  <c:v>356.8</c:v>
                </c:pt>
                <c:pt idx="285">
                  <c:v>357</c:v>
                </c:pt>
                <c:pt idx="286">
                  <c:v>357.2</c:v>
                </c:pt>
                <c:pt idx="287">
                  <c:v>357.4</c:v>
                </c:pt>
                <c:pt idx="288">
                  <c:v>357.6</c:v>
                </c:pt>
                <c:pt idx="289">
                  <c:v>357.8</c:v>
                </c:pt>
                <c:pt idx="290">
                  <c:v>358</c:v>
                </c:pt>
                <c:pt idx="291">
                  <c:v>358.2</c:v>
                </c:pt>
                <c:pt idx="292">
                  <c:v>358.4</c:v>
                </c:pt>
                <c:pt idx="293">
                  <c:v>358.6</c:v>
                </c:pt>
                <c:pt idx="294">
                  <c:v>358.8</c:v>
                </c:pt>
                <c:pt idx="295">
                  <c:v>359</c:v>
                </c:pt>
                <c:pt idx="296">
                  <c:v>359.2</c:v>
                </c:pt>
                <c:pt idx="297">
                  <c:v>359.4</c:v>
                </c:pt>
                <c:pt idx="298">
                  <c:v>359.6</c:v>
                </c:pt>
                <c:pt idx="299">
                  <c:v>359.8</c:v>
                </c:pt>
                <c:pt idx="300">
                  <c:v>360</c:v>
                </c:pt>
                <c:pt idx="301">
                  <c:v>360.2</c:v>
                </c:pt>
                <c:pt idx="302">
                  <c:v>360.4</c:v>
                </c:pt>
                <c:pt idx="303">
                  <c:v>360.6</c:v>
                </c:pt>
                <c:pt idx="304">
                  <c:v>360.8</c:v>
                </c:pt>
                <c:pt idx="305">
                  <c:v>361</c:v>
                </c:pt>
                <c:pt idx="306">
                  <c:v>361.2</c:v>
                </c:pt>
                <c:pt idx="307">
                  <c:v>361.4</c:v>
                </c:pt>
                <c:pt idx="308">
                  <c:v>361.6</c:v>
                </c:pt>
                <c:pt idx="309">
                  <c:v>361.8</c:v>
                </c:pt>
                <c:pt idx="310">
                  <c:v>362</c:v>
                </c:pt>
                <c:pt idx="311">
                  <c:v>362.2</c:v>
                </c:pt>
                <c:pt idx="312">
                  <c:v>362.4</c:v>
                </c:pt>
                <c:pt idx="313">
                  <c:v>362.6</c:v>
                </c:pt>
                <c:pt idx="314">
                  <c:v>362.8</c:v>
                </c:pt>
                <c:pt idx="315">
                  <c:v>363</c:v>
                </c:pt>
                <c:pt idx="316">
                  <c:v>363.2</c:v>
                </c:pt>
                <c:pt idx="317">
                  <c:v>363.4</c:v>
                </c:pt>
                <c:pt idx="318">
                  <c:v>363.6</c:v>
                </c:pt>
                <c:pt idx="319">
                  <c:v>363.8</c:v>
                </c:pt>
                <c:pt idx="320">
                  <c:v>364</c:v>
                </c:pt>
                <c:pt idx="321">
                  <c:v>364.2</c:v>
                </c:pt>
                <c:pt idx="322">
                  <c:v>364.4</c:v>
                </c:pt>
                <c:pt idx="323">
                  <c:v>364.6</c:v>
                </c:pt>
                <c:pt idx="324">
                  <c:v>364.8</c:v>
                </c:pt>
                <c:pt idx="325">
                  <c:v>365</c:v>
                </c:pt>
                <c:pt idx="326">
                  <c:v>365.2</c:v>
                </c:pt>
                <c:pt idx="327">
                  <c:v>365.4</c:v>
                </c:pt>
                <c:pt idx="328">
                  <c:v>365.6</c:v>
                </c:pt>
                <c:pt idx="329">
                  <c:v>365.8</c:v>
                </c:pt>
                <c:pt idx="330">
                  <c:v>366</c:v>
                </c:pt>
                <c:pt idx="331">
                  <c:v>366.2</c:v>
                </c:pt>
                <c:pt idx="332">
                  <c:v>366.4</c:v>
                </c:pt>
                <c:pt idx="333">
                  <c:v>366.6</c:v>
                </c:pt>
                <c:pt idx="334">
                  <c:v>366.8</c:v>
                </c:pt>
                <c:pt idx="335">
                  <c:v>367</c:v>
                </c:pt>
                <c:pt idx="336">
                  <c:v>367.2</c:v>
                </c:pt>
                <c:pt idx="337">
                  <c:v>367.4</c:v>
                </c:pt>
                <c:pt idx="338">
                  <c:v>367.6</c:v>
                </c:pt>
                <c:pt idx="339">
                  <c:v>367.8</c:v>
                </c:pt>
                <c:pt idx="340">
                  <c:v>368</c:v>
                </c:pt>
                <c:pt idx="341">
                  <c:v>368.2</c:v>
                </c:pt>
                <c:pt idx="342">
                  <c:v>368.4</c:v>
                </c:pt>
                <c:pt idx="343">
                  <c:v>368.6</c:v>
                </c:pt>
                <c:pt idx="344">
                  <c:v>368.8</c:v>
                </c:pt>
                <c:pt idx="345">
                  <c:v>369</c:v>
                </c:pt>
                <c:pt idx="346">
                  <c:v>369.2</c:v>
                </c:pt>
                <c:pt idx="347">
                  <c:v>369.4</c:v>
                </c:pt>
                <c:pt idx="348">
                  <c:v>369.6</c:v>
                </c:pt>
                <c:pt idx="349">
                  <c:v>369.8</c:v>
                </c:pt>
                <c:pt idx="350">
                  <c:v>370</c:v>
                </c:pt>
                <c:pt idx="351">
                  <c:v>370.2</c:v>
                </c:pt>
                <c:pt idx="352">
                  <c:v>370.4</c:v>
                </c:pt>
                <c:pt idx="353">
                  <c:v>370.6</c:v>
                </c:pt>
                <c:pt idx="354">
                  <c:v>370.8</c:v>
                </c:pt>
                <c:pt idx="355">
                  <c:v>371</c:v>
                </c:pt>
                <c:pt idx="356">
                  <c:v>371.2</c:v>
                </c:pt>
                <c:pt idx="357">
                  <c:v>371.4</c:v>
                </c:pt>
                <c:pt idx="358">
                  <c:v>371.6</c:v>
                </c:pt>
                <c:pt idx="359">
                  <c:v>371.8</c:v>
                </c:pt>
                <c:pt idx="360">
                  <c:v>372</c:v>
                </c:pt>
                <c:pt idx="361">
                  <c:v>372.2</c:v>
                </c:pt>
                <c:pt idx="362">
                  <c:v>372.4</c:v>
                </c:pt>
                <c:pt idx="363">
                  <c:v>372.6</c:v>
                </c:pt>
                <c:pt idx="364">
                  <c:v>372.8</c:v>
                </c:pt>
                <c:pt idx="365">
                  <c:v>373</c:v>
                </c:pt>
                <c:pt idx="366">
                  <c:v>373.2</c:v>
                </c:pt>
                <c:pt idx="367">
                  <c:v>373.4</c:v>
                </c:pt>
                <c:pt idx="368">
                  <c:v>373.6</c:v>
                </c:pt>
                <c:pt idx="369">
                  <c:v>373.8</c:v>
                </c:pt>
                <c:pt idx="370">
                  <c:v>374</c:v>
                </c:pt>
                <c:pt idx="371">
                  <c:v>374.2</c:v>
                </c:pt>
                <c:pt idx="372">
                  <c:v>374.4</c:v>
                </c:pt>
                <c:pt idx="373">
                  <c:v>374.6</c:v>
                </c:pt>
                <c:pt idx="374">
                  <c:v>374.8</c:v>
                </c:pt>
                <c:pt idx="375">
                  <c:v>375</c:v>
                </c:pt>
                <c:pt idx="376">
                  <c:v>375.2</c:v>
                </c:pt>
                <c:pt idx="377">
                  <c:v>375.4</c:v>
                </c:pt>
                <c:pt idx="378">
                  <c:v>375.6</c:v>
                </c:pt>
                <c:pt idx="379">
                  <c:v>375.8</c:v>
                </c:pt>
                <c:pt idx="380">
                  <c:v>376</c:v>
                </c:pt>
                <c:pt idx="381">
                  <c:v>376.2</c:v>
                </c:pt>
                <c:pt idx="382">
                  <c:v>376.4</c:v>
                </c:pt>
                <c:pt idx="383">
                  <c:v>376.6</c:v>
                </c:pt>
                <c:pt idx="384">
                  <c:v>376.8</c:v>
                </c:pt>
                <c:pt idx="385">
                  <c:v>377</c:v>
                </c:pt>
                <c:pt idx="386">
                  <c:v>377.2</c:v>
                </c:pt>
                <c:pt idx="387">
                  <c:v>377.4</c:v>
                </c:pt>
                <c:pt idx="388">
                  <c:v>377.6</c:v>
                </c:pt>
                <c:pt idx="389">
                  <c:v>377.8</c:v>
                </c:pt>
                <c:pt idx="390">
                  <c:v>378</c:v>
                </c:pt>
                <c:pt idx="391">
                  <c:v>378.2</c:v>
                </c:pt>
                <c:pt idx="392">
                  <c:v>378.4</c:v>
                </c:pt>
                <c:pt idx="393">
                  <c:v>378.6</c:v>
                </c:pt>
                <c:pt idx="394">
                  <c:v>378.8</c:v>
                </c:pt>
                <c:pt idx="395">
                  <c:v>379</c:v>
                </c:pt>
                <c:pt idx="396">
                  <c:v>379.2</c:v>
                </c:pt>
                <c:pt idx="397">
                  <c:v>379.4</c:v>
                </c:pt>
                <c:pt idx="398">
                  <c:v>379.6</c:v>
                </c:pt>
                <c:pt idx="399">
                  <c:v>379.8</c:v>
                </c:pt>
                <c:pt idx="400">
                  <c:v>380</c:v>
                </c:pt>
                <c:pt idx="401">
                  <c:v>380.2</c:v>
                </c:pt>
                <c:pt idx="402">
                  <c:v>380.4</c:v>
                </c:pt>
                <c:pt idx="403">
                  <c:v>380.6</c:v>
                </c:pt>
                <c:pt idx="404">
                  <c:v>380.8</c:v>
                </c:pt>
                <c:pt idx="405">
                  <c:v>381</c:v>
                </c:pt>
                <c:pt idx="406">
                  <c:v>381.2</c:v>
                </c:pt>
                <c:pt idx="407">
                  <c:v>381.4</c:v>
                </c:pt>
                <c:pt idx="408">
                  <c:v>381.6</c:v>
                </c:pt>
                <c:pt idx="409">
                  <c:v>381.8</c:v>
                </c:pt>
                <c:pt idx="410">
                  <c:v>382</c:v>
                </c:pt>
                <c:pt idx="411">
                  <c:v>382.2</c:v>
                </c:pt>
                <c:pt idx="412">
                  <c:v>382.4</c:v>
                </c:pt>
                <c:pt idx="413">
                  <c:v>382.6</c:v>
                </c:pt>
                <c:pt idx="414">
                  <c:v>382.8</c:v>
                </c:pt>
                <c:pt idx="415">
                  <c:v>383</c:v>
                </c:pt>
                <c:pt idx="416">
                  <c:v>383.2</c:v>
                </c:pt>
                <c:pt idx="417">
                  <c:v>383.4</c:v>
                </c:pt>
                <c:pt idx="418">
                  <c:v>383.6</c:v>
                </c:pt>
                <c:pt idx="419">
                  <c:v>383.8</c:v>
                </c:pt>
                <c:pt idx="420">
                  <c:v>384</c:v>
                </c:pt>
                <c:pt idx="421">
                  <c:v>384.2</c:v>
                </c:pt>
                <c:pt idx="422">
                  <c:v>384.4</c:v>
                </c:pt>
                <c:pt idx="423">
                  <c:v>384.6</c:v>
                </c:pt>
                <c:pt idx="424">
                  <c:v>384.8</c:v>
                </c:pt>
                <c:pt idx="425">
                  <c:v>385</c:v>
                </c:pt>
                <c:pt idx="426">
                  <c:v>385.2</c:v>
                </c:pt>
                <c:pt idx="427">
                  <c:v>385.4</c:v>
                </c:pt>
                <c:pt idx="428">
                  <c:v>385.6</c:v>
                </c:pt>
                <c:pt idx="429">
                  <c:v>385.8</c:v>
                </c:pt>
                <c:pt idx="430">
                  <c:v>386</c:v>
                </c:pt>
                <c:pt idx="431">
                  <c:v>386.2</c:v>
                </c:pt>
                <c:pt idx="432">
                  <c:v>386.4</c:v>
                </c:pt>
                <c:pt idx="433">
                  <c:v>386.6</c:v>
                </c:pt>
                <c:pt idx="434">
                  <c:v>386.8</c:v>
                </c:pt>
                <c:pt idx="435">
                  <c:v>387</c:v>
                </c:pt>
                <c:pt idx="436">
                  <c:v>387.2</c:v>
                </c:pt>
                <c:pt idx="437">
                  <c:v>387.4</c:v>
                </c:pt>
                <c:pt idx="438">
                  <c:v>387.6</c:v>
                </c:pt>
                <c:pt idx="439">
                  <c:v>387.8</c:v>
                </c:pt>
                <c:pt idx="440">
                  <c:v>388</c:v>
                </c:pt>
                <c:pt idx="441">
                  <c:v>388.2</c:v>
                </c:pt>
                <c:pt idx="442">
                  <c:v>388.4</c:v>
                </c:pt>
                <c:pt idx="443">
                  <c:v>388.6</c:v>
                </c:pt>
                <c:pt idx="444">
                  <c:v>388.8</c:v>
                </c:pt>
                <c:pt idx="445">
                  <c:v>389</c:v>
                </c:pt>
                <c:pt idx="446">
                  <c:v>389.2</c:v>
                </c:pt>
                <c:pt idx="447">
                  <c:v>389.4</c:v>
                </c:pt>
                <c:pt idx="448">
                  <c:v>389.6</c:v>
                </c:pt>
                <c:pt idx="449">
                  <c:v>389.8</c:v>
                </c:pt>
                <c:pt idx="450">
                  <c:v>390</c:v>
                </c:pt>
                <c:pt idx="451">
                  <c:v>390.2</c:v>
                </c:pt>
                <c:pt idx="452">
                  <c:v>390.4</c:v>
                </c:pt>
                <c:pt idx="453">
                  <c:v>390.6</c:v>
                </c:pt>
                <c:pt idx="454">
                  <c:v>390.8</c:v>
                </c:pt>
                <c:pt idx="455">
                  <c:v>391</c:v>
                </c:pt>
                <c:pt idx="456">
                  <c:v>391.2</c:v>
                </c:pt>
                <c:pt idx="457">
                  <c:v>391.4</c:v>
                </c:pt>
                <c:pt idx="458">
                  <c:v>391.6</c:v>
                </c:pt>
                <c:pt idx="459">
                  <c:v>391.8</c:v>
                </c:pt>
                <c:pt idx="460">
                  <c:v>392</c:v>
                </c:pt>
                <c:pt idx="461">
                  <c:v>392.2</c:v>
                </c:pt>
                <c:pt idx="462">
                  <c:v>392.4</c:v>
                </c:pt>
                <c:pt idx="463">
                  <c:v>392.6</c:v>
                </c:pt>
                <c:pt idx="464">
                  <c:v>392.8</c:v>
                </c:pt>
                <c:pt idx="465">
                  <c:v>393</c:v>
                </c:pt>
                <c:pt idx="466">
                  <c:v>393.2</c:v>
                </c:pt>
                <c:pt idx="467">
                  <c:v>393.4</c:v>
                </c:pt>
                <c:pt idx="468">
                  <c:v>393.6</c:v>
                </c:pt>
                <c:pt idx="469">
                  <c:v>393.8</c:v>
                </c:pt>
                <c:pt idx="470">
                  <c:v>394</c:v>
                </c:pt>
                <c:pt idx="471">
                  <c:v>394.2</c:v>
                </c:pt>
                <c:pt idx="472">
                  <c:v>394.4</c:v>
                </c:pt>
                <c:pt idx="473">
                  <c:v>394.6</c:v>
                </c:pt>
                <c:pt idx="474">
                  <c:v>394.8</c:v>
                </c:pt>
                <c:pt idx="475">
                  <c:v>395</c:v>
                </c:pt>
                <c:pt idx="476">
                  <c:v>395.2</c:v>
                </c:pt>
                <c:pt idx="477">
                  <c:v>395.4</c:v>
                </c:pt>
                <c:pt idx="478">
                  <c:v>395.6</c:v>
                </c:pt>
                <c:pt idx="479">
                  <c:v>395.8</c:v>
                </c:pt>
                <c:pt idx="480">
                  <c:v>396</c:v>
                </c:pt>
                <c:pt idx="481">
                  <c:v>396.2</c:v>
                </c:pt>
                <c:pt idx="482">
                  <c:v>396.4</c:v>
                </c:pt>
                <c:pt idx="483">
                  <c:v>396.6</c:v>
                </c:pt>
                <c:pt idx="484">
                  <c:v>396.8</c:v>
                </c:pt>
                <c:pt idx="485">
                  <c:v>397</c:v>
                </c:pt>
                <c:pt idx="486">
                  <c:v>397.2</c:v>
                </c:pt>
                <c:pt idx="487">
                  <c:v>397.4</c:v>
                </c:pt>
                <c:pt idx="488">
                  <c:v>397.6</c:v>
                </c:pt>
                <c:pt idx="489">
                  <c:v>397.8</c:v>
                </c:pt>
                <c:pt idx="490">
                  <c:v>398</c:v>
                </c:pt>
                <c:pt idx="491">
                  <c:v>398.2</c:v>
                </c:pt>
                <c:pt idx="492">
                  <c:v>398.4</c:v>
                </c:pt>
                <c:pt idx="493">
                  <c:v>398.6</c:v>
                </c:pt>
                <c:pt idx="494">
                  <c:v>398.8</c:v>
                </c:pt>
                <c:pt idx="495">
                  <c:v>399</c:v>
                </c:pt>
                <c:pt idx="496">
                  <c:v>399.2</c:v>
                </c:pt>
                <c:pt idx="497">
                  <c:v>399.4</c:v>
                </c:pt>
                <c:pt idx="498">
                  <c:v>399.6</c:v>
                </c:pt>
                <c:pt idx="499">
                  <c:v>399.8</c:v>
                </c:pt>
                <c:pt idx="500">
                  <c:v>400</c:v>
                </c:pt>
              </c:numCache>
            </c:numRef>
          </c:xVal>
          <c:yVal>
            <c:numRef>
              <c:f>Sheet1!$C$5:$C$505</c:f>
              <c:numCache>
                <c:formatCode>General</c:formatCode>
                <c:ptCount val="501"/>
                <c:pt idx="31">
                  <c:v>385.78500000000003</c:v>
                </c:pt>
                <c:pt idx="32">
                  <c:v>391.11</c:v>
                </c:pt>
                <c:pt idx="33">
                  <c:v>397.33100000000002</c:v>
                </c:pt>
                <c:pt idx="34">
                  <c:v>404.22</c:v>
                </c:pt>
                <c:pt idx="35">
                  <c:v>411.62900000000002</c:v>
                </c:pt>
                <c:pt idx="36">
                  <c:v>419.48399999999998</c:v>
                </c:pt>
                <c:pt idx="37">
                  <c:v>436.214</c:v>
                </c:pt>
                <c:pt idx="38">
                  <c:v>444.95699999999999</c:v>
                </c:pt>
                <c:pt idx="39">
                  <c:v>453.75400000000002</c:v>
                </c:pt>
                <c:pt idx="40">
                  <c:v>462.69600000000003</c:v>
                </c:pt>
                <c:pt idx="41">
                  <c:v>471.83600000000001</c:v>
                </c:pt>
                <c:pt idx="42">
                  <c:v>481.06700000000001</c:v>
                </c:pt>
                <c:pt idx="43">
                  <c:v>490.35500000000002</c:v>
                </c:pt>
                <c:pt idx="44">
                  <c:v>499.67599999999999</c:v>
                </c:pt>
                <c:pt idx="45">
                  <c:v>509.08300000000003</c:v>
                </c:pt>
                <c:pt idx="46">
                  <c:v>518.61099999999999</c:v>
                </c:pt>
                <c:pt idx="47">
                  <c:v>528.26400000000001</c:v>
                </c:pt>
                <c:pt idx="48">
                  <c:v>538.02</c:v>
                </c:pt>
                <c:pt idx="49">
                  <c:v>547.76</c:v>
                </c:pt>
                <c:pt idx="50">
                  <c:v>557.57100000000003</c:v>
                </c:pt>
                <c:pt idx="51">
                  <c:v>567.48800000000006</c:v>
                </c:pt>
                <c:pt idx="52">
                  <c:v>577.43799999999999</c:v>
                </c:pt>
                <c:pt idx="53">
                  <c:v>587.37400000000002</c:v>
                </c:pt>
                <c:pt idx="54">
                  <c:v>597.40099999999995</c:v>
                </c:pt>
                <c:pt idx="55">
                  <c:v>607.57100000000003</c:v>
                </c:pt>
                <c:pt idx="56">
                  <c:v>617.81700000000001</c:v>
                </c:pt>
                <c:pt idx="57">
                  <c:v>628.15599999999995</c:v>
                </c:pt>
                <c:pt idx="58">
                  <c:v>638.63</c:v>
                </c:pt>
                <c:pt idx="59">
                  <c:v>649.17200000000003</c:v>
                </c:pt>
                <c:pt idx="60">
                  <c:v>659.71</c:v>
                </c:pt>
                <c:pt idx="61">
                  <c:v>670.24699999999996</c:v>
                </c:pt>
                <c:pt idx="62">
                  <c:v>680.78200000000004</c:v>
                </c:pt>
                <c:pt idx="63">
                  <c:v>691.32500000000005</c:v>
                </c:pt>
                <c:pt idx="64">
                  <c:v>701.904</c:v>
                </c:pt>
                <c:pt idx="65">
                  <c:v>712.55</c:v>
                </c:pt>
                <c:pt idx="66">
                  <c:v>723.226</c:v>
                </c:pt>
                <c:pt idx="67">
                  <c:v>733.97699999999998</c:v>
                </c:pt>
                <c:pt idx="68">
                  <c:v>744.82100000000003</c:v>
                </c:pt>
                <c:pt idx="69">
                  <c:v>755.78099999999995</c:v>
                </c:pt>
                <c:pt idx="70">
                  <c:v>766.76099999999997</c:v>
                </c:pt>
                <c:pt idx="71">
                  <c:v>777.75099999999998</c:v>
                </c:pt>
                <c:pt idx="72">
                  <c:v>788.72199999999998</c:v>
                </c:pt>
                <c:pt idx="73">
                  <c:v>799.68799999999999</c:v>
                </c:pt>
                <c:pt idx="74">
                  <c:v>810.73500000000001</c:v>
                </c:pt>
                <c:pt idx="75">
                  <c:v>821.86</c:v>
                </c:pt>
                <c:pt idx="76">
                  <c:v>832.98900000000003</c:v>
                </c:pt>
                <c:pt idx="77">
                  <c:v>844.12300000000005</c:v>
                </c:pt>
                <c:pt idx="78">
                  <c:v>855.26400000000001</c:v>
                </c:pt>
                <c:pt idx="79">
                  <c:v>866.41200000000003</c:v>
                </c:pt>
                <c:pt idx="80">
                  <c:v>877.54100000000005</c:v>
                </c:pt>
                <c:pt idx="81">
                  <c:v>888.55700000000002</c:v>
                </c:pt>
                <c:pt idx="82">
                  <c:v>899.553</c:v>
                </c:pt>
                <c:pt idx="83">
                  <c:v>910.48299999999995</c:v>
                </c:pt>
                <c:pt idx="84">
                  <c:v>921.38900000000001</c:v>
                </c:pt>
                <c:pt idx="85">
                  <c:v>932.31200000000001</c:v>
                </c:pt>
                <c:pt idx="86">
                  <c:v>943.32600000000002</c:v>
                </c:pt>
                <c:pt idx="87">
                  <c:v>954.327</c:v>
                </c:pt>
                <c:pt idx="88">
                  <c:v>965.45299999999997</c:v>
                </c:pt>
                <c:pt idx="89">
                  <c:v>976.76700000000005</c:v>
                </c:pt>
                <c:pt idx="90">
                  <c:v>987.95699999999999</c:v>
                </c:pt>
                <c:pt idx="91">
                  <c:v>999.06799999999998</c:v>
                </c:pt>
                <c:pt idx="92">
                  <c:v>1010.24</c:v>
                </c:pt>
                <c:pt idx="93">
                  <c:v>1021.49</c:v>
                </c:pt>
                <c:pt idx="94">
                  <c:v>1032.8599999999999</c:v>
                </c:pt>
                <c:pt idx="95">
                  <c:v>1044.42</c:v>
                </c:pt>
                <c:pt idx="96">
                  <c:v>1055.79</c:v>
                </c:pt>
                <c:pt idx="97">
                  <c:v>1066.98</c:v>
                </c:pt>
                <c:pt idx="98">
                  <c:v>1078.19</c:v>
                </c:pt>
                <c:pt idx="99">
                  <c:v>1089.42</c:v>
                </c:pt>
                <c:pt idx="100">
                  <c:v>1100.76</c:v>
                </c:pt>
                <c:pt idx="101">
                  <c:v>1112.22</c:v>
                </c:pt>
                <c:pt idx="102">
                  <c:v>1123.75</c:v>
                </c:pt>
                <c:pt idx="103">
                  <c:v>1135.3399999999999</c:v>
                </c:pt>
                <c:pt idx="104">
                  <c:v>1146.8800000000001</c:v>
                </c:pt>
                <c:pt idx="105">
                  <c:v>1158.51</c:v>
                </c:pt>
                <c:pt idx="106">
                  <c:v>1170.26</c:v>
                </c:pt>
                <c:pt idx="107">
                  <c:v>1181.93</c:v>
                </c:pt>
                <c:pt idx="108">
                  <c:v>1193.73</c:v>
                </c:pt>
                <c:pt idx="109">
                  <c:v>1205.6300000000001</c:v>
                </c:pt>
                <c:pt idx="110">
                  <c:v>1217.4000000000001</c:v>
                </c:pt>
                <c:pt idx="111">
                  <c:v>1229.01</c:v>
                </c:pt>
                <c:pt idx="112">
                  <c:v>1240.75</c:v>
                </c:pt>
                <c:pt idx="113">
                  <c:v>1252.58</c:v>
                </c:pt>
                <c:pt idx="114">
                  <c:v>1264.3399999999999</c:v>
                </c:pt>
                <c:pt idx="115">
                  <c:v>1276.17</c:v>
                </c:pt>
                <c:pt idx="116">
                  <c:v>1288.06</c:v>
                </c:pt>
                <c:pt idx="117">
                  <c:v>1299.8</c:v>
                </c:pt>
                <c:pt idx="118">
                  <c:v>1311.27</c:v>
                </c:pt>
                <c:pt idx="119">
                  <c:v>1322.58</c:v>
                </c:pt>
                <c:pt idx="120">
                  <c:v>1333.56</c:v>
                </c:pt>
                <c:pt idx="121">
                  <c:v>1344.68</c:v>
                </c:pt>
                <c:pt idx="122">
                  <c:v>1356.05</c:v>
                </c:pt>
                <c:pt idx="123">
                  <c:v>1367.26</c:v>
                </c:pt>
                <c:pt idx="124">
                  <c:v>1378.2</c:v>
                </c:pt>
                <c:pt idx="125">
                  <c:v>1388.86</c:v>
                </c:pt>
                <c:pt idx="126">
                  <c:v>1399.41</c:v>
                </c:pt>
                <c:pt idx="127">
                  <c:v>1409.83</c:v>
                </c:pt>
                <c:pt idx="128">
                  <c:v>1420.1</c:v>
                </c:pt>
                <c:pt idx="129">
                  <c:v>1430.33</c:v>
                </c:pt>
                <c:pt idx="130">
                  <c:v>1440.51</c:v>
                </c:pt>
                <c:pt idx="131">
                  <c:v>1450.48</c:v>
                </c:pt>
                <c:pt idx="132">
                  <c:v>1460.16</c:v>
                </c:pt>
                <c:pt idx="133">
                  <c:v>1469.6</c:v>
                </c:pt>
                <c:pt idx="134">
                  <c:v>1478.92</c:v>
                </c:pt>
                <c:pt idx="135">
                  <c:v>1488.03</c:v>
                </c:pt>
                <c:pt idx="136">
                  <c:v>1496.97</c:v>
                </c:pt>
                <c:pt idx="137">
                  <c:v>1505.79</c:v>
                </c:pt>
                <c:pt idx="138">
                  <c:v>1514.3</c:v>
                </c:pt>
                <c:pt idx="139">
                  <c:v>1522.37</c:v>
                </c:pt>
                <c:pt idx="140">
                  <c:v>1530.19</c:v>
                </c:pt>
                <c:pt idx="141">
                  <c:v>1537.77</c:v>
                </c:pt>
                <c:pt idx="142">
                  <c:v>1545.08</c:v>
                </c:pt>
                <c:pt idx="143">
                  <c:v>1552.39</c:v>
                </c:pt>
                <c:pt idx="144">
                  <c:v>1559.58</c:v>
                </c:pt>
                <c:pt idx="145">
                  <c:v>1566.67</c:v>
                </c:pt>
                <c:pt idx="146">
                  <c:v>1573.66</c:v>
                </c:pt>
                <c:pt idx="147">
                  <c:v>1580.37</c:v>
                </c:pt>
                <c:pt idx="148">
                  <c:v>1586.91</c:v>
                </c:pt>
                <c:pt idx="149">
                  <c:v>1593.46</c:v>
                </c:pt>
                <c:pt idx="150">
                  <c:v>1599.77</c:v>
                </c:pt>
                <c:pt idx="151">
                  <c:v>1605.92</c:v>
                </c:pt>
                <c:pt idx="152">
                  <c:v>1612.07</c:v>
                </c:pt>
                <c:pt idx="153">
                  <c:v>1618</c:v>
                </c:pt>
                <c:pt idx="154">
                  <c:v>1623.59</c:v>
                </c:pt>
                <c:pt idx="155">
                  <c:v>1628.98</c:v>
                </c:pt>
                <c:pt idx="156">
                  <c:v>1634.31</c:v>
                </c:pt>
                <c:pt idx="157">
                  <c:v>1639.54</c:v>
                </c:pt>
                <c:pt idx="158">
                  <c:v>1644.51</c:v>
                </c:pt>
                <c:pt idx="159">
                  <c:v>1649.28</c:v>
                </c:pt>
                <c:pt idx="160">
                  <c:v>1654.17</c:v>
                </c:pt>
                <c:pt idx="161">
                  <c:v>1659.08</c:v>
                </c:pt>
                <c:pt idx="162">
                  <c:v>1663.73</c:v>
                </c:pt>
                <c:pt idx="163">
                  <c:v>1668.23</c:v>
                </c:pt>
                <c:pt idx="164">
                  <c:v>1672.83</c:v>
                </c:pt>
                <c:pt idx="165">
                  <c:v>1677.4</c:v>
                </c:pt>
                <c:pt idx="166">
                  <c:v>1681.98</c:v>
                </c:pt>
                <c:pt idx="167">
                  <c:v>1686.49</c:v>
                </c:pt>
                <c:pt idx="168">
                  <c:v>1690.77</c:v>
                </c:pt>
                <c:pt idx="169">
                  <c:v>1694.92</c:v>
                </c:pt>
                <c:pt idx="170">
                  <c:v>1698.99</c:v>
                </c:pt>
                <c:pt idx="171">
                  <c:v>1702.98</c:v>
                </c:pt>
                <c:pt idx="172">
                  <c:v>1706.77</c:v>
                </c:pt>
                <c:pt idx="173">
                  <c:v>1710.44</c:v>
                </c:pt>
                <c:pt idx="174">
                  <c:v>1714.16</c:v>
                </c:pt>
                <c:pt idx="175">
                  <c:v>1717.92</c:v>
                </c:pt>
                <c:pt idx="176">
                  <c:v>1721.58</c:v>
                </c:pt>
                <c:pt idx="177">
                  <c:v>1724.9</c:v>
                </c:pt>
                <c:pt idx="178">
                  <c:v>1728.1</c:v>
                </c:pt>
                <c:pt idx="179">
                  <c:v>1731.37</c:v>
                </c:pt>
                <c:pt idx="180">
                  <c:v>1734.43</c:v>
                </c:pt>
                <c:pt idx="181">
                  <c:v>1737.39</c:v>
                </c:pt>
                <c:pt idx="182">
                  <c:v>1740.5</c:v>
                </c:pt>
                <c:pt idx="183">
                  <c:v>1743.65</c:v>
                </c:pt>
                <c:pt idx="184">
                  <c:v>1746.65</c:v>
                </c:pt>
                <c:pt idx="185">
                  <c:v>1749.52</c:v>
                </c:pt>
                <c:pt idx="186">
                  <c:v>1752.27</c:v>
                </c:pt>
                <c:pt idx="187">
                  <c:v>1754.81</c:v>
                </c:pt>
                <c:pt idx="188">
                  <c:v>1757.3</c:v>
                </c:pt>
                <c:pt idx="189">
                  <c:v>1759.76</c:v>
                </c:pt>
                <c:pt idx="190">
                  <c:v>1761.96</c:v>
                </c:pt>
                <c:pt idx="191">
                  <c:v>1763.94</c:v>
                </c:pt>
                <c:pt idx="192">
                  <c:v>1765.96</c:v>
                </c:pt>
                <c:pt idx="193">
                  <c:v>1767.94</c:v>
                </c:pt>
                <c:pt idx="194">
                  <c:v>1769.79</c:v>
                </c:pt>
                <c:pt idx="195">
                  <c:v>1771.52</c:v>
                </c:pt>
                <c:pt idx="196">
                  <c:v>1773.09</c:v>
                </c:pt>
                <c:pt idx="197">
                  <c:v>1774.57</c:v>
                </c:pt>
                <c:pt idx="198">
                  <c:v>1775.98</c:v>
                </c:pt>
                <c:pt idx="199">
                  <c:v>1777.24</c:v>
                </c:pt>
                <c:pt idx="200">
                  <c:v>1778.42</c:v>
                </c:pt>
                <c:pt idx="201">
                  <c:v>1779.26</c:v>
                </c:pt>
                <c:pt idx="202">
                  <c:v>1780.03</c:v>
                </c:pt>
                <c:pt idx="203">
                  <c:v>1780.83</c:v>
                </c:pt>
                <c:pt idx="204">
                  <c:v>1781.57</c:v>
                </c:pt>
                <c:pt idx="205">
                  <c:v>1782.4</c:v>
                </c:pt>
                <c:pt idx="206">
                  <c:v>1783.1</c:v>
                </c:pt>
                <c:pt idx="207">
                  <c:v>1783.62</c:v>
                </c:pt>
                <c:pt idx="208">
                  <c:v>1783.92</c:v>
                </c:pt>
                <c:pt idx="209">
                  <c:v>1784.1</c:v>
                </c:pt>
                <c:pt idx="210">
                  <c:v>1784.2</c:v>
                </c:pt>
                <c:pt idx="211">
                  <c:v>1784.17</c:v>
                </c:pt>
                <c:pt idx="212">
                  <c:v>1784.09</c:v>
                </c:pt>
                <c:pt idx="213">
                  <c:v>1783.87</c:v>
                </c:pt>
                <c:pt idx="214">
                  <c:v>1783.45</c:v>
                </c:pt>
                <c:pt idx="215">
                  <c:v>1783.1</c:v>
                </c:pt>
                <c:pt idx="216">
                  <c:v>1782.68</c:v>
                </c:pt>
                <c:pt idx="217">
                  <c:v>1782.16</c:v>
                </c:pt>
                <c:pt idx="218">
                  <c:v>1781.72</c:v>
                </c:pt>
                <c:pt idx="219">
                  <c:v>1781.13</c:v>
                </c:pt>
                <c:pt idx="220">
                  <c:v>1780.48</c:v>
                </c:pt>
                <c:pt idx="221">
                  <c:v>1779.84</c:v>
                </c:pt>
                <c:pt idx="222">
                  <c:v>1779.16</c:v>
                </c:pt>
                <c:pt idx="223">
                  <c:v>1778.47</c:v>
                </c:pt>
                <c:pt idx="224">
                  <c:v>1777.61</c:v>
                </c:pt>
                <c:pt idx="225">
                  <c:v>1776.51</c:v>
                </c:pt>
                <c:pt idx="226">
                  <c:v>1775.32</c:v>
                </c:pt>
                <c:pt idx="227">
                  <c:v>1774.09</c:v>
                </c:pt>
                <c:pt idx="228">
                  <c:v>1772.79</c:v>
                </c:pt>
                <c:pt idx="229">
                  <c:v>1771.26</c:v>
                </c:pt>
                <c:pt idx="230">
                  <c:v>1769.49</c:v>
                </c:pt>
                <c:pt idx="231">
                  <c:v>1767.72</c:v>
                </c:pt>
                <c:pt idx="232">
                  <c:v>1766.02</c:v>
                </c:pt>
                <c:pt idx="233">
                  <c:v>1764.32</c:v>
                </c:pt>
                <c:pt idx="234">
                  <c:v>1762.63</c:v>
                </c:pt>
                <c:pt idx="235">
                  <c:v>1760.98</c:v>
                </c:pt>
                <c:pt idx="236">
                  <c:v>1759.31</c:v>
                </c:pt>
                <c:pt idx="237">
                  <c:v>1757.56</c:v>
                </c:pt>
                <c:pt idx="238">
                  <c:v>1755.76</c:v>
                </c:pt>
                <c:pt idx="239">
                  <c:v>1753.84</c:v>
                </c:pt>
                <c:pt idx="240">
                  <c:v>1751.74</c:v>
                </c:pt>
                <c:pt idx="241">
                  <c:v>1749.7</c:v>
                </c:pt>
                <c:pt idx="242">
                  <c:v>1747.58</c:v>
                </c:pt>
                <c:pt idx="243">
                  <c:v>1745.19</c:v>
                </c:pt>
                <c:pt idx="244">
                  <c:v>1742.79</c:v>
                </c:pt>
                <c:pt idx="245">
                  <c:v>1740.54</c:v>
                </c:pt>
                <c:pt idx="246">
                  <c:v>1738.14</c:v>
                </c:pt>
                <c:pt idx="247">
                  <c:v>1735.54</c:v>
                </c:pt>
                <c:pt idx="248">
                  <c:v>1732.82</c:v>
                </c:pt>
                <c:pt idx="249">
                  <c:v>1729.98</c:v>
                </c:pt>
                <c:pt idx="250">
                  <c:v>1727.13</c:v>
                </c:pt>
                <c:pt idx="251">
                  <c:v>1724.17</c:v>
                </c:pt>
                <c:pt idx="252">
                  <c:v>1721.08</c:v>
                </c:pt>
                <c:pt idx="253">
                  <c:v>1718</c:v>
                </c:pt>
                <c:pt idx="254">
                  <c:v>1715.13</c:v>
                </c:pt>
                <c:pt idx="255">
                  <c:v>1712.25</c:v>
                </c:pt>
                <c:pt idx="256">
                  <c:v>1709.16</c:v>
                </c:pt>
                <c:pt idx="257">
                  <c:v>1706.02</c:v>
                </c:pt>
                <c:pt idx="258">
                  <c:v>1702.79</c:v>
                </c:pt>
                <c:pt idx="259">
                  <c:v>1699.49</c:v>
                </c:pt>
                <c:pt idx="260">
                  <c:v>1696.14</c:v>
                </c:pt>
                <c:pt idx="261">
                  <c:v>1692.69</c:v>
                </c:pt>
                <c:pt idx="262">
                  <c:v>1689.17</c:v>
                </c:pt>
                <c:pt idx="263">
                  <c:v>1685.51</c:v>
                </c:pt>
                <c:pt idx="264">
                  <c:v>1681.95</c:v>
                </c:pt>
                <c:pt idx="265">
                  <c:v>1678.48</c:v>
                </c:pt>
                <c:pt idx="266">
                  <c:v>1674.88</c:v>
                </c:pt>
                <c:pt idx="267">
                  <c:v>1671.22</c:v>
                </c:pt>
                <c:pt idx="268">
                  <c:v>1667.6</c:v>
                </c:pt>
                <c:pt idx="269">
                  <c:v>1663.94</c:v>
                </c:pt>
                <c:pt idx="270">
                  <c:v>1659.83</c:v>
                </c:pt>
                <c:pt idx="271">
                  <c:v>1655.63</c:v>
                </c:pt>
                <c:pt idx="272">
                  <c:v>1651.66</c:v>
                </c:pt>
                <c:pt idx="273">
                  <c:v>1647.6</c:v>
                </c:pt>
                <c:pt idx="274">
                  <c:v>1643.46</c:v>
                </c:pt>
                <c:pt idx="275">
                  <c:v>1639.41</c:v>
                </c:pt>
                <c:pt idx="276">
                  <c:v>1635.45</c:v>
                </c:pt>
                <c:pt idx="277">
                  <c:v>1631.55</c:v>
                </c:pt>
                <c:pt idx="278">
                  <c:v>1627.53</c:v>
                </c:pt>
                <c:pt idx="279">
                  <c:v>1623.3</c:v>
                </c:pt>
                <c:pt idx="280">
                  <c:v>1619.02</c:v>
                </c:pt>
                <c:pt idx="281">
                  <c:v>1614.68</c:v>
                </c:pt>
                <c:pt idx="282">
                  <c:v>1610.16</c:v>
                </c:pt>
                <c:pt idx="283">
                  <c:v>1605.75</c:v>
                </c:pt>
                <c:pt idx="284">
                  <c:v>1601.19</c:v>
                </c:pt>
                <c:pt idx="285">
                  <c:v>1596.21</c:v>
                </c:pt>
                <c:pt idx="286">
                  <c:v>1591.16</c:v>
                </c:pt>
                <c:pt idx="287">
                  <c:v>1586.16</c:v>
                </c:pt>
                <c:pt idx="288">
                  <c:v>1581.23</c:v>
                </c:pt>
                <c:pt idx="289">
                  <c:v>1574.21</c:v>
                </c:pt>
                <c:pt idx="290">
                  <c:v>1567.35</c:v>
                </c:pt>
                <c:pt idx="291">
                  <c:v>1560.46</c:v>
                </c:pt>
                <c:pt idx="292">
                  <c:v>1553.34</c:v>
                </c:pt>
                <c:pt idx="293">
                  <c:v>1546.14</c:v>
                </c:pt>
                <c:pt idx="294">
                  <c:v>1538.92</c:v>
                </c:pt>
                <c:pt idx="295">
                  <c:v>1531.67</c:v>
                </c:pt>
                <c:pt idx="296">
                  <c:v>1524.4</c:v>
                </c:pt>
                <c:pt idx="297">
                  <c:v>1517</c:v>
                </c:pt>
                <c:pt idx="298">
                  <c:v>1509.7</c:v>
                </c:pt>
                <c:pt idx="299">
                  <c:v>1502.43</c:v>
                </c:pt>
                <c:pt idx="300">
                  <c:v>1494.97</c:v>
                </c:pt>
                <c:pt idx="301">
                  <c:v>1487.45</c:v>
                </c:pt>
                <c:pt idx="302">
                  <c:v>1479.98</c:v>
                </c:pt>
                <c:pt idx="303">
                  <c:v>1472.55</c:v>
                </c:pt>
                <c:pt idx="304">
                  <c:v>1465.07</c:v>
                </c:pt>
                <c:pt idx="305">
                  <c:v>1457.61</c:v>
                </c:pt>
                <c:pt idx="306">
                  <c:v>1450.09</c:v>
                </c:pt>
                <c:pt idx="307">
                  <c:v>1442.5</c:v>
                </c:pt>
                <c:pt idx="308">
                  <c:v>1434.84</c:v>
                </c:pt>
                <c:pt idx="309">
                  <c:v>1427.32</c:v>
                </c:pt>
                <c:pt idx="310">
                  <c:v>1419.98</c:v>
                </c:pt>
                <c:pt idx="311">
                  <c:v>1412.53</c:v>
                </c:pt>
                <c:pt idx="312">
                  <c:v>1404.95</c:v>
                </c:pt>
                <c:pt idx="313">
                  <c:v>1397.26</c:v>
                </c:pt>
                <c:pt idx="314">
                  <c:v>1391.65</c:v>
                </c:pt>
                <c:pt idx="315">
                  <c:v>1385.77</c:v>
                </c:pt>
                <c:pt idx="316">
                  <c:v>1379.84</c:v>
                </c:pt>
                <c:pt idx="317">
                  <c:v>1374.18</c:v>
                </c:pt>
                <c:pt idx="318">
                  <c:v>1368.57</c:v>
                </c:pt>
                <c:pt idx="319">
                  <c:v>1362.89</c:v>
                </c:pt>
                <c:pt idx="320">
                  <c:v>1357.36</c:v>
                </c:pt>
                <c:pt idx="321">
                  <c:v>1351.78</c:v>
                </c:pt>
                <c:pt idx="322">
                  <c:v>1346.11</c:v>
                </c:pt>
                <c:pt idx="323">
                  <c:v>1340.36</c:v>
                </c:pt>
                <c:pt idx="324">
                  <c:v>1334.57</c:v>
                </c:pt>
                <c:pt idx="325">
                  <c:v>1328.93</c:v>
                </c:pt>
                <c:pt idx="326">
                  <c:v>1323.34</c:v>
                </c:pt>
                <c:pt idx="327">
                  <c:v>1317.4</c:v>
                </c:pt>
                <c:pt idx="328">
                  <c:v>1311.4</c:v>
                </c:pt>
                <c:pt idx="329">
                  <c:v>1305.5899999999999</c:v>
                </c:pt>
                <c:pt idx="330">
                  <c:v>1299.67</c:v>
                </c:pt>
                <c:pt idx="331">
                  <c:v>1293.82</c:v>
                </c:pt>
                <c:pt idx="332">
                  <c:v>1288.03</c:v>
                </c:pt>
                <c:pt idx="333">
                  <c:v>1282.21</c:v>
                </c:pt>
                <c:pt idx="334">
                  <c:v>1276.28</c:v>
                </c:pt>
                <c:pt idx="335">
                  <c:v>1270.28</c:v>
                </c:pt>
                <c:pt idx="336">
                  <c:v>1264.26</c:v>
                </c:pt>
                <c:pt idx="337">
                  <c:v>1258.25</c:v>
                </c:pt>
                <c:pt idx="338">
                  <c:v>1252.3499999999999</c:v>
                </c:pt>
                <c:pt idx="339">
                  <c:v>1246.3800000000001</c:v>
                </c:pt>
                <c:pt idx="340">
                  <c:v>1240.45</c:v>
                </c:pt>
                <c:pt idx="341">
                  <c:v>1234.58</c:v>
                </c:pt>
                <c:pt idx="342">
                  <c:v>1228.5999999999999</c:v>
                </c:pt>
                <c:pt idx="343">
                  <c:v>1222.47</c:v>
                </c:pt>
                <c:pt idx="344">
                  <c:v>1216.32</c:v>
                </c:pt>
                <c:pt idx="345">
                  <c:v>1210.27</c:v>
                </c:pt>
                <c:pt idx="346">
                  <c:v>1204.32</c:v>
                </c:pt>
                <c:pt idx="347">
                  <c:v>1198.31</c:v>
                </c:pt>
                <c:pt idx="348">
                  <c:v>1192.3399999999999</c:v>
                </c:pt>
                <c:pt idx="349">
                  <c:v>1186.47</c:v>
                </c:pt>
                <c:pt idx="350">
                  <c:v>1180.46</c:v>
                </c:pt>
                <c:pt idx="351">
                  <c:v>1174.42</c:v>
                </c:pt>
                <c:pt idx="352">
                  <c:v>1168.5999999999999</c:v>
                </c:pt>
                <c:pt idx="353">
                  <c:v>1162.73</c:v>
                </c:pt>
                <c:pt idx="354">
                  <c:v>1156.67</c:v>
                </c:pt>
                <c:pt idx="355">
                  <c:v>1150.56</c:v>
                </c:pt>
                <c:pt idx="356">
                  <c:v>1144.5999999999999</c:v>
                </c:pt>
                <c:pt idx="357">
                  <c:v>1138.7</c:v>
                </c:pt>
                <c:pt idx="358">
                  <c:v>1132.69</c:v>
                </c:pt>
                <c:pt idx="359">
                  <c:v>1126.68</c:v>
                </c:pt>
                <c:pt idx="360">
                  <c:v>1120.74</c:v>
                </c:pt>
                <c:pt idx="361">
                  <c:v>1114.8699999999999</c:v>
                </c:pt>
                <c:pt idx="362">
                  <c:v>1109.04</c:v>
                </c:pt>
                <c:pt idx="363">
                  <c:v>1103.18</c:v>
                </c:pt>
                <c:pt idx="364">
                  <c:v>1097.3800000000001</c:v>
                </c:pt>
                <c:pt idx="365">
                  <c:v>1091.55</c:v>
                </c:pt>
                <c:pt idx="366">
                  <c:v>1085.56</c:v>
                </c:pt>
                <c:pt idx="367">
                  <c:v>1079.56</c:v>
                </c:pt>
                <c:pt idx="368">
                  <c:v>1073.6400000000001</c:v>
                </c:pt>
                <c:pt idx="369">
                  <c:v>1067.78</c:v>
                </c:pt>
                <c:pt idx="370">
                  <c:v>1061.82</c:v>
                </c:pt>
                <c:pt idx="371">
                  <c:v>1055.74</c:v>
                </c:pt>
                <c:pt idx="372">
                  <c:v>1049.75</c:v>
                </c:pt>
                <c:pt idx="373">
                  <c:v>1043.73</c:v>
                </c:pt>
                <c:pt idx="374">
                  <c:v>1037.73</c:v>
                </c:pt>
                <c:pt idx="375">
                  <c:v>1031.8499999999999</c:v>
                </c:pt>
                <c:pt idx="376">
                  <c:v>1025.93</c:v>
                </c:pt>
                <c:pt idx="377">
                  <c:v>1020.03</c:v>
                </c:pt>
                <c:pt idx="378">
                  <c:v>1014.22</c:v>
                </c:pt>
                <c:pt idx="379">
                  <c:v>1008.48</c:v>
                </c:pt>
                <c:pt idx="380">
                  <c:v>1002.78</c:v>
                </c:pt>
                <c:pt idx="381">
                  <c:v>996.84799999999996</c:v>
                </c:pt>
                <c:pt idx="382">
                  <c:v>990.798</c:v>
                </c:pt>
                <c:pt idx="383">
                  <c:v>984.92499999999995</c:v>
                </c:pt>
                <c:pt idx="384">
                  <c:v>979.13300000000004</c:v>
                </c:pt>
                <c:pt idx="385">
                  <c:v>973.34900000000005</c:v>
                </c:pt>
                <c:pt idx="386">
                  <c:v>967.61300000000006</c:v>
                </c:pt>
                <c:pt idx="387">
                  <c:v>961.96</c:v>
                </c:pt>
                <c:pt idx="388">
                  <c:v>956.28</c:v>
                </c:pt>
                <c:pt idx="389">
                  <c:v>950.51900000000001</c:v>
                </c:pt>
                <c:pt idx="390">
                  <c:v>944.81600000000003</c:v>
                </c:pt>
                <c:pt idx="391">
                  <c:v>939.202</c:v>
                </c:pt>
                <c:pt idx="392">
                  <c:v>933.69600000000003</c:v>
                </c:pt>
                <c:pt idx="393">
                  <c:v>928.25199999999995</c:v>
                </c:pt>
                <c:pt idx="394">
                  <c:v>922.75099999999998</c:v>
                </c:pt>
                <c:pt idx="395">
                  <c:v>917.27099999999996</c:v>
                </c:pt>
                <c:pt idx="396">
                  <c:v>911.88699999999994</c:v>
                </c:pt>
                <c:pt idx="397">
                  <c:v>906.55899999999997</c:v>
                </c:pt>
                <c:pt idx="398">
                  <c:v>901.24599999999998</c:v>
                </c:pt>
                <c:pt idx="399">
                  <c:v>895.79700000000003</c:v>
                </c:pt>
                <c:pt idx="400">
                  <c:v>890.29399999999998</c:v>
                </c:pt>
                <c:pt idx="401">
                  <c:v>884.84699999999998</c:v>
                </c:pt>
                <c:pt idx="402">
                  <c:v>879.46199999999999</c:v>
                </c:pt>
                <c:pt idx="403">
                  <c:v>874.15099999999995</c:v>
                </c:pt>
                <c:pt idx="404">
                  <c:v>868.779</c:v>
                </c:pt>
                <c:pt idx="405">
                  <c:v>863.46299999999997</c:v>
                </c:pt>
                <c:pt idx="406">
                  <c:v>858.34100000000001</c:v>
                </c:pt>
                <c:pt idx="407">
                  <c:v>853.27599999999995</c:v>
                </c:pt>
                <c:pt idx="408">
                  <c:v>848.17100000000005</c:v>
                </c:pt>
                <c:pt idx="409">
                  <c:v>843.04200000000003</c:v>
                </c:pt>
                <c:pt idx="410">
                  <c:v>837.94500000000005</c:v>
                </c:pt>
                <c:pt idx="411">
                  <c:v>832.85900000000004</c:v>
                </c:pt>
                <c:pt idx="412">
                  <c:v>827.66300000000001</c:v>
                </c:pt>
                <c:pt idx="413">
                  <c:v>822.52300000000002</c:v>
                </c:pt>
                <c:pt idx="414">
                  <c:v>817.51</c:v>
                </c:pt>
                <c:pt idx="415">
                  <c:v>812.46</c:v>
                </c:pt>
                <c:pt idx="416">
                  <c:v>807.33500000000004</c:v>
                </c:pt>
                <c:pt idx="417">
                  <c:v>802.14599999999996</c:v>
                </c:pt>
                <c:pt idx="418">
                  <c:v>796.96600000000001</c:v>
                </c:pt>
                <c:pt idx="419">
                  <c:v>791.87599999999998</c:v>
                </c:pt>
                <c:pt idx="420">
                  <c:v>786.82799999999997</c:v>
                </c:pt>
                <c:pt idx="421">
                  <c:v>781.76300000000003</c:v>
                </c:pt>
                <c:pt idx="422">
                  <c:v>776.71299999999997</c:v>
                </c:pt>
                <c:pt idx="423">
                  <c:v>771.72500000000002</c:v>
                </c:pt>
                <c:pt idx="424">
                  <c:v>766.94899999999996</c:v>
                </c:pt>
                <c:pt idx="425">
                  <c:v>762.26499999999999</c:v>
                </c:pt>
                <c:pt idx="426">
                  <c:v>757.57100000000003</c:v>
                </c:pt>
                <c:pt idx="427">
                  <c:v>752.83799999999997</c:v>
                </c:pt>
                <c:pt idx="428">
                  <c:v>747.99199999999996</c:v>
                </c:pt>
                <c:pt idx="429">
                  <c:v>743.15300000000002</c:v>
                </c:pt>
                <c:pt idx="430">
                  <c:v>738.33799999999997</c:v>
                </c:pt>
                <c:pt idx="431">
                  <c:v>733.44799999999998</c:v>
                </c:pt>
                <c:pt idx="432">
                  <c:v>728.51400000000001</c:v>
                </c:pt>
                <c:pt idx="433">
                  <c:v>723.63900000000001</c:v>
                </c:pt>
                <c:pt idx="434">
                  <c:v>718.88199999999995</c:v>
                </c:pt>
                <c:pt idx="435">
                  <c:v>714.18600000000004</c:v>
                </c:pt>
                <c:pt idx="436">
                  <c:v>709.53200000000004</c:v>
                </c:pt>
                <c:pt idx="437">
                  <c:v>704.98199999999997</c:v>
                </c:pt>
                <c:pt idx="438">
                  <c:v>700.40200000000004</c:v>
                </c:pt>
                <c:pt idx="439">
                  <c:v>695.74400000000003</c:v>
                </c:pt>
                <c:pt idx="440">
                  <c:v>691.10599999999999</c:v>
                </c:pt>
                <c:pt idx="441">
                  <c:v>686.53300000000002</c:v>
                </c:pt>
                <c:pt idx="442">
                  <c:v>681.98699999999997</c:v>
                </c:pt>
                <c:pt idx="443">
                  <c:v>677.47299999999996</c:v>
                </c:pt>
                <c:pt idx="444">
                  <c:v>672.95</c:v>
                </c:pt>
                <c:pt idx="445">
                  <c:v>668.47400000000005</c:v>
                </c:pt>
                <c:pt idx="446">
                  <c:v>664.05</c:v>
                </c:pt>
                <c:pt idx="447">
                  <c:v>659.59400000000005</c:v>
                </c:pt>
                <c:pt idx="448">
                  <c:v>655.22400000000005</c:v>
                </c:pt>
                <c:pt idx="449">
                  <c:v>650.77099999999996</c:v>
                </c:pt>
                <c:pt idx="450">
                  <c:v>646.23500000000001</c:v>
                </c:pt>
                <c:pt idx="451">
                  <c:v>641.81200000000001</c:v>
                </c:pt>
                <c:pt idx="452">
                  <c:v>637.49300000000005</c:v>
                </c:pt>
                <c:pt idx="453">
                  <c:v>633.23900000000003</c:v>
                </c:pt>
                <c:pt idx="454">
                  <c:v>628.99900000000002</c:v>
                </c:pt>
                <c:pt idx="455">
                  <c:v>624.81200000000001</c:v>
                </c:pt>
                <c:pt idx="456">
                  <c:v>620.79</c:v>
                </c:pt>
                <c:pt idx="457">
                  <c:v>616.83799999999997</c:v>
                </c:pt>
                <c:pt idx="458">
                  <c:v>612.76</c:v>
                </c:pt>
                <c:pt idx="459">
                  <c:v>608.51900000000001</c:v>
                </c:pt>
                <c:pt idx="460">
                  <c:v>604.298</c:v>
                </c:pt>
                <c:pt idx="461">
                  <c:v>600.101</c:v>
                </c:pt>
                <c:pt idx="462">
                  <c:v>595.97299999999996</c:v>
                </c:pt>
                <c:pt idx="463">
                  <c:v>591.92700000000002</c:v>
                </c:pt>
                <c:pt idx="464">
                  <c:v>587.85799999999995</c:v>
                </c:pt>
                <c:pt idx="465">
                  <c:v>583.87900000000002</c:v>
                </c:pt>
                <c:pt idx="466">
                  <c:v>579.98299999999995</c:v>
                </c:pt>
                <c:pt idx="467">
                  <c:v>576.072</c:v>
                </c:pt>
                <c:pt idx="468">
                  <c:v>572.18700000000001</c:v>
                </c:pt>
                <c:pt idx="469">
                  <c:v>568.40800000000002</c:v>
                </c:pt>
                <c:pt idx="470">
                  <c:v>564.673</c:v>
                </c:pt>
                <c:pt idx="471">
                  <c:v>560.86500000000001</c:v>
                </c:pt>
                <c:pt idx="472">
                  <c:v>557.029</c:v>
                </c:pt>
                <c:pt idx="473">
                  <c:v>553.221</c:v>
                </c:pt>
                <c:pt idx="474">
                  <c:v>549.41</c:v>
                </c:pt>
                <c:pt idx="475">
                  <c:v>545.65499999999997</c:v>
                </c:pt>
                <c:pt idx="476">
                  <c:v>541.89599999999996</c:v>
                </c:pt>
                <c:pt idx="477">
                  <c:v>538.01800000000003</c:v>
                </c:pt>
                <c:pt idx="478">
                  <c:v>534.14</c:v>
                </c:pt>
                <c:pt idx="479">
                  <c:v>530.39400000000001</c:v>
                </c:pt>
                <c:pt idx="480">
                  <c:v>526.71</c:v>
                </c:pt>
                <c:pt idx="481">
                  <c:v>522.99900000000002</c:v>
                </c:pt>
                <c:pt idx="482">
                  <c:v>519.29399999999998</c:v>
                </c:pt>
                <c:pt idx="483">
                  <c:v>515.63300000000004</c:v>
                </c:pt>
                <c:pt idx="484">
                  <c:v>512.09100000000001</c:v>
                </c:pt>
                <c:pt idx="485">
                  <c:v>508.55700000000002</c:v>
                </c:pt>
                <c:pt idx="486">
                  <c:v>505.01299999999998</c:v>
                </c:pt>
                <c:pt idx="487">
                  <c:v>501.47399999999999</c:v>
                </c:pt>
                <c:pt idx="488">
                  <c:v>497.88299999999998</c:v>
                </c:pt>
                <c:pt idx="489">
                  <c:v>494.51900000000001</c:v>
                </c:pt>
                <c:pt idx="490">
                  <c:v>491.25700000000001</c:v>
                </c:pt>
                <c:pt idx="491">
                  <c:v>488.13799999999998</c:v>
                </c:pt>
                <c:pt idx="492">
                  <c:v>485.20600000000002</c:v>
                </c:pt>
                <c:pt idx="493">
                  <c:v>482.37299999999999</c:v>
                </c:pt>
                <c:pt idx="494">
                  <c:v>479.64800000000002</c:v>
                </c:pt>
                <c:pt idx="495">
                  <c:v>477.03300000000002</c:v>
                </c:pt>
                <c:pt idx="496">
                  <c:v>474.62200000000001</c:v>
                </c:pt>
                <c:pt idx="497">
                  <c:v>472.43599999999998</c:v>
                </c:pt>
                <c:pt idx="498">
                  <c:v>470.32400000000001</c:v>
                </c:pt>
                <c:pt idx="499">
                  <c:v>468.37299999999999</c:v>
                </c:pt>
                <c:pt idx="500">
                  <c:v>466.56900000000002</c:v>
                </c:pt>
              </c:numCache>
            </c:numRef>
          </c:yVal>
          <c:smooth val="1"/>
          <c:extLst>
            <c:ext xmlns:c16="http://schemas.microsoft.com/office/drawing/2014/chart" uri="{C3380CC4-5D6E-409C-BE32-E72D297353CC}">
              <c16:uniqueId val="{00000000-5D61-3449-9667-58588BDF454C}"/>
            </c:ext>
          </c:extLst>
        </c:ser>
        <c:ser>
          <c:idx val="2"/>
          <c:order val="1"/>
          <c:tx>
            <c:strRef>
              <c:f>Sheet1!$E$3:$E$4</c:f>
              <c:strCache>
                <c:ptCount val="1"/>
                <c:pt idx="0">
                  <c:v>10 μM</c:v>
                </c:pt>
              </c:strCache>
            </c:strRef>
          </c:tx>
          <c:spPr>
            <a:ln w="19050">
              <a:solidFill>
                <a:srgbClr val="00B050"/>
              </a:solidFill>
            </a:ln>
          </c:spPr>
          <c:marker>
            <c:symbol val="none"/>
          </c:marker>
          <c:xVal>
            <c:numRef>
              <c:f>Sheet1!$B$5:$B$505</c:f>
              <c:numCache>
                <c:formatCode>General</c:formatCode>
                <c:ptCount val="501"/>
                <c:pt idx="31">
                  <c:v>306</c:v>
                </c:pt>
                <c:pt idx="32">
                  <c:v>306.2</c:v>
                </c:pt>
                <c:pt idx="33">
                  <c:v>306.39999999999998</c:v>
                </c:pt>
                <c:pt idx="34">
                  <c:v>306.60000000000002</c:v>
                </c:pt>
                <c:pt idx="35">
                  <c:v>306.8</c:v>
                </c:pt>
                <c:pt idx="36">
                  <c:v>307</c:v>
                </c:pt>
                <c:pt idx="37">
                  <c:v>307.39999999999998</c:v>
                </c:pt>
                <c:pt idx="38">
                  <c:v>307.60000000000002</c:v>
                </c:pt>
                <c:pt idx="39">
                  <c:v>307.8</c:v>
                </c:pt>
                <c:pt idx="40">
                  <c:v>308</c:v>
                </c:pt>
                <c:pt idx="41">
                  <c:v>308.2</c:v>
                </c:pt>
                <c:pt idx="42">
                  <c:v>308.39999999999998</c:v>
                </c:pt>
                <c:pt idx="43">
                  <c:v>308.60000000000002</c:v>
                </c:pt>
                <c:pt idx="44">
                  <c:v>308.8</c:v>
                </c:pt>
                <c:pt idx="45">
                  <c:v>309</c:v>
                </c:pt>
                <c:pt idx="46">
                  <c:v>309.2</c:v>
                </c:pt>
                <c:pt idx="47">
                  <c:v>309.39999999999998</c:v>
                </c:pt>
                <c:pt idx="48">
                  <c:v>309.60000000000002</c:v>
                </c:pt>
                <c:pt idx="49">
                  <c:v>309.8</c:v>
                </c:pt>
                <c:pt idx="50">
                  <c:v>310</c:v>
                </c:pt>
                <c:pt idx="51">
                  <c:v>310.2</c:v>
                </c:pt>
                <c:pt idx="52">
                  <c:v>310.39999999999998</c:v>
                </c:pt>
                <c:pt idx="53">
                  <c:v>310.60000000000002</c:v>
                </c:pt>
                <c:pt idx="54">
                  <c:v>310.8</c:v>
                </c:pt>
                <c:pt idx="55">
                  <c:v>311</c:v>
                </c:pt>
                <c:pt idx="56">
                  <c:v>311.2</c:v>
                </c:pt>
                <c:pt idx="57">
                  <c:v>311.39999999999998</c:v>
                </c:pt>
                <c:pt idx="58">
                  <c:v>311.60000000000002</c:v>
                </c:pt>
                <c:pt idx="59">
                  <c:v>311.8</c:v>
                </c:pt>
                <c:pt idx="60">
                  <c:v>312</c:v>
                </c:pt>
                <c:pt idx="61">
                  <c:v>312.2</c:v>
                </c:pt>
                <c:pt idx="62">
                  <c:v>312.39999999999998</c:v>
                </c:pt>
                <c:pt idx="63">
                  <c:v>312.60000000000002</c:v>
                </c:pt>
                <c:pt idx="64">
                  <c:v>312.8</c:v>
                </c:pt>
                <c:pt idx="65">
                  <c:v>313</c:v>
                </c:pt>
                <c:pt idx="66">
                  <c:v>313.2</c:v>
                </c:pt>
                <c:pt idx="67">
                  <c:v>313.39999999999998</c:v>
                </c:pt>
                <c:pt idx="68">
                  <c:v>313.60000000000002</c:v>
                </c:pt>
                <c:pt idx="69">
                  <c:v>313.8</c:v>
                </c:pt>
                <c:pt idx="70">
                  <c:v>314</c:v>
                </c:pt>
                <c:pt idx="71">
                  <c:v>314.2</c:v>
                </c:pt>
                <c:pt idx="72">
                  <c:v>314.39999999999998</c:v>
                </c:pt>
                <c:pt idx="73">
                  <c:v>314.60000000000002</c:v>
                </c:pt>
                <c:pt idx="74">
                  <c:v>314.8</c:v>
                </c:pt>
                <c:pt idx="75">
                  <c:v>315</c:v>
                </c:pt>
                <c:pt idx="76">
                  <c:v>315.2</c:v>
                </c:pt>
                <c:pt idx="77">
                  <c:v>315.39999999999998</c:v>
                </c:pt>
                <c:pt idx="78">
                  <c:v>315.60000000000002</c:v>
                </c:pt>
                <c:pt idx="79">
                  <c:v>315.8</c:v>
                </c:pt>
                <c:pt idx="80">
                  <c:v>316</c:v>
                </c:pt>
                <c:pt idx="81">
                  <c:v>316.2</c:v>
                </c:pt>
                <c:pt idx="82">
                  <c:v>316.39999999999998</c:v>
                </c:pt>
                <c:pt idx="83">
                  <c:v>316.60000000000002</c:v>
                </c:pt>
                <c:pt idx="84">
                  <c:v>316.8</c:v>
                </c:pt>
                <c:pt idx="85">
                  <c:v>317</c:v>
                </c:pt>
                <c:pt idx="86">
                  <c:v>317.2</c:v>
                </c:pt>
                <c:pt idx="87">
                  <c:v>317.39999999999998</c:v>
                </c:pt>
                <c:pt idx="88">
                  <c:v>317.60000000000002</c:v>
                </c:pt>
                <c:pt idx="89">
                  <c:v>317.8</c:v>
                </c:pt>
                <c:pt idx="90">
                  <c:v>318</c:v>
                </c:pt>
                <c:pt idx="91">
                  <c:v>318.2</c:v>
                </c:pt>
                <c:pt idx="92">
                  <c:v>318.39999999999998</c:v>
                </c:pt>
                <c:pt idx="93">
                  <c:v>318.60000000000002</c:v>
                </c:pt>
                <c:pt idx="94">
                  <c:v>318.8</c:v>
                </c:pt>
                <c:pt idx="95">
                  <c:v>319</c:v>
                </c:pt>
                <c:pt idx="96">
                  <c:v>319.2</c:v>
                </c:pt>
                <c:pt idx="97">
                  <c:v>319.39999999999998</c:v>
                </c:pt>
                <c:pt idx="98">
                  <c:v>319.60000000000002</c:v>
                </c:pt>
                <c:pt idx="99">
                  <c:v>319.8</c:v>
                </c:pt>
                <c:pt idx="100">
                  <c:v>320</c:v>
                </c:pt>
                <c:pt idx="101">
                  <c:v>320.2</c:v>
                </c:pt>
                <c:pt idx="102">
                  <c:v>320.39999999999998</c:v>
                </c:pt>
                <c:pt idx="103">
                  <c:v>320.60000000000002</c:v>
                </c:pt>
                <c:pt idx="104">
                  <c:v>320.8</c:v>
                </c:pt>
                <c:pt idx="105">
                  <c:v>321</c:v>
                </c:pt>
                <c:pt idx="106">
                  <c:v>321.2</c:v>
                </c:pt>
                <c:pt idx="107">
                  <c:v>321.39999999999998</c:v>
                </c:pt>
                <c:pt idx="108">
                  <c:v>321.60000000000002</c:v>
                </c:pt>
                <c:pt idx="109">
                  <c:v>321.8</c:v>
                </c:pt>
                <c:pt idx="110">
                  <c:v>322</c:v>
                </c:pt>
                <c:pt idx="111">
                  <c:v>322.2</c:v>
                </c:pt>
                <c:pt idx="112">
                  <c:v>322.39999999999998</c:v>
                </c:pt>
                <c:pt idx="113">
                  <c:v>322.60000000000002</c:v>
                </c:pt>
                <c:pt idx="114">
                  <c:v>322.8</c:v>
                </c:pt>
                <c:pt idx="115">
                  <c:v>323</c:v>
                </c:pt>
                <c:pt idx="116">
                  <c:v>323.2</c:v>
                </c:pt>
                <c:pt idx="117">
                  <c:v>323.39999999999998</c:v>
                </c:pt>
                <c:pt idx="118">
                  <c:v>323.60000000000002</c:v>
                </c:pt>
                <c:pt idx="119">
                  <c:v>323.8</c:v>
                </c:pt>
                <c:pt idx="120">
                  <c:v>324</c:v>
                </c:pt>
                <c:pt idx="121">
                  <c:v>324.2</c:v>
                </c:pt>
                <c:pt idx="122">
                  <c:v>324.39999999999998</c:v>
                </c:pt>
                <c:pt idx="123">
                  <c:v>324.60000000000002</c:v>
                </c:pt>
                <c:pt idx="124">
                  <c:v>324.8</c:v>
                </c:pt>
                <c:pt idx="125">
                  <c:v>325</c:v>
                </c:pt>
                <c:pt idx="126">
                  <c:v>325.2</c:v>
                </c:pt>
                <c:pt idx="127">
                  <c:v>325.39999999999998</c:v>
                </c:pt>
                <c:pt idx="128">
                  <c:v>325.60000000000002</c:v>
                </c:pt>
                <c:pt idx="129">
                  <c:v>325.8</c:v>
                </c:pt>
                <c:pt idx="130">
                  <c:v>326</c:v>
                </c:pt>
                <c:pt idx="131">
                  <c:v>326.2</c:v>
                </c:pt>
                <c:pt idx="132">
                  <c:v>326.39999999999998</c:v>
                </c:pt>
                <c:pt idx="133">
                  <c:v>326.60000000000002</c:v>
                </c:pt>
                <c:pt idx="134">
                  <c:v>326.8</c:v>
                </c:pt>
                <c:pt idx="135">
                  <c:v>327</c:v>
                </c:pt>
                <c:pt idx="136">
                  <c:v>327.2</c:v>
                </c:pt>
                <c:pt idx="137">
                  <c:v>327.39999999999998</c:v>
                </c:pt>
                <c:pt idx="138">
                  <c:v>327.60000000000002</c:v>
                </c:pt>
                <c:pt idx="139">
                  <c:v>327.8</c:v>
                </c:pt>
                <c:pt idx="140">
                  <c:v>328</c:v>
                </c:pt>
                <c:pt idx="141">
                  <c:v>328.2</c:v>
                </c:pt>
                <c:pt idx="142">
                  <c:v>328.4</c:v>
                </c:pt>
                <c:pt idx="143">
                  <c:v>328.6</c:v>
                </c:pt>
                <c:pt idx="144">
                  <c:v>328.8</c:v>
                </c:pt>
                <c:pt idx="145">
                  <c:v>329</c:v>
                </c:pt>
                <c:pt idx="146">
                  <c:v>329.2</c:v>
                </c:pt>
                <c:pt idx="147">
                  <c:v>329.4</c:v>
                </c:pt>
                <c:pt idx="148">
                  <c:v>329.6</c:v>
                </c:pt>
                <c:pt idx="149">
                  <c:v>329.8</c:v>
                </c:pt>
                <c:pt idx="150">
                  <c:v>330</c:v>
                </c:pt>
                <c:pt idx="151">
                  <c:v>330.2</c:v>
                </c:pt>
                <c:pt idx="152">
                  <c:v>330.4</c:v>
                </c:pt>
                <c:pt idx="153">
                  <c:v>330.6</c:v>
                </c:pt>
                <c:pt idx="154">
                  <c:v>330.8</c:v>
                </c:pt>
                <c:pt idx="155">
                  <c:v>331</c:v>
                </c:pt>
                <c:pt idx="156">
                  <c:v>331.2</c:v>
                </c:pt>
                <c:pt idx="157">
                  <c:v>331.4</c:v>
                </c:pt>
                <c:pt idx="158">
                  <c:v>331.6</c:v>
                </c:pt>
                <c:pt idx="159">
                  <c:v>331.8</c:v>
                </c:pt>
                <c:pt idx="160">
                  <c:v>332</c:v>
                </c:pt>
                <c:pt idx="161">
                  <c:v>332.2</c:v>
                </c:pt>
                <c:pt idx="162">
                  <c:v>332.4</c:v>
                </c:pt>
                <c:pt idx="163">
                  <c:v>332.6</c:v>
                </c:pt>
                <c:pt idx="164">
                  <c:v>332.8</c:v>
                </c:pt>
                <c:pt idx="165">
                  <c:v>333</c:v>
                </c:pt>
                <c:pt idx="166">
                  <c:v>333.2</c:v>
                </c:pt>
                <c:pt idx="167">
                  <c:v>333.4</c:v>
                </c:pt>
                <c:pt idx="168">
                  <c:v>333.6</c:v>
                </c:pt>
                <c:pt idx="169">
                  <c:v>333.8</c:v>
                </c:pt>
                <c:pt idx="170">
                  <c:v>334</c:v>
                </c:pt>
                <c:pt idx="171">
                  <c:v>334.2</c:v>
                </c:pt>
                <c:pt idx="172">
                  <c:v>334.4</c:v>
                </c:pt>
                <c:pt idx="173">
                  <c:v>334.6</c:v>
                </c:pt>
                <c:pt idx="174">
                  <c:v>334.8</c:v>
                </c:pt>
                <c:pt idx="175">
                  <c:v>335</c:v>
                </c:pt>
                <c:pt idx="176">
                  <c:v>335.2</c:v>
                </c:pt>
                <c:pt idx="177">
                  <c:v>335.4</c:v>
                </c:pt>
                <c:pt idx="178">
                  <c:v>335.6</c:v>
                </c:pt>
                <c:pt idx="179">
                  <c:v>335.8</c:v>
                </c:pt>
                <c:pt idx="180">
                  <c:v>336</c:v>
                </c:pt>
                <c:pt idx="181">
                  <c:v>336.2</c:v>
                </c:pt>
                <c:pt idx="182">
                  <c:v>336.4</c:v>
                </c:pt>
                <c:pt idx="183">
                  <c:v>336.6</c:v>
                </c:pt>
                <c:pt idx="184">
                  <c:v>336.8</c:v>
                </c:pt>
                <c:pt idx="185">
                  <c:v>337</c:v>
                </c:pt>
                <c:pt idx="186">
                  <c:v>337.2</c:v>
                </c:pt>
                <c:pt idx="187">
                  <c:v>337.4</c:v>
                </c:pt>
                <c:pt idx="188">
                  <c:v>337.6</c:v>
                </c:pt>
                <c:pt idx="189">
                  <c:v>337.8</c:v>
                </c:pt>
                <c:pt idx="190">
                  <c:v>338</c:v>
                </c:pt>
                <c:pt idx="191">
                  <c:v>338.2</c:v>
                </c:pt>
                <c:pt idx="192">
                  <c:v>338.4</c:v>
                </c:pt>
                <c:pt idx="193">
                  <c:v>338.6</c:v>
                </c:pt>
                <c:pt idx="194">
                  <c:v>338.8</c:v>
                </c:pt>
                <c:pt idx="195">
                  <c:v>339</c:v>
                </c:pt>
                <c:pt idx="196">
                  <c:v>339.2</c:v>
                </c:pt>
                <c:pt idx="197">
                  <c:v>339.4</c:v>
                </c:pt>
                <c:pt idx="198">
                  <c:v>339.6</c:v>
                </c:pt>
                <c:pt idx="199">
                  <c:v>339.8</c:v>
                </c:pt>
                <c:pt idx="200">
                  <c:v>340</c:v>
                </c:pt>
                <c:pt idx="201">
                  <c:v>340.2</c:v>
                </c:pt>
                <c:pt idx="202">
                  <c:v>340.4</c:v>
                </c:pt>
                <c:pt idx="203">
                  <c:v>340.6</c:v>
                </c:pt>
                <c:pt idx="204">
                  <c:v>340.8</c:v>
                </c:pt>
                <c:pt idx="205">
                  <c:v>341</c:v>
                </c:pt>
                <c:pt idx="206">
                  <c:v>341.2</c:v>
                </c:pt>
                <c:pt idx="207">
                  <c:v>341.4</c:v>
                </c:pt>
                <c:pt idx="208">
                  <c:v>341.6</c:v>
                </c:pt>
                <c:pt idx="209">
                  <c:v>341.8</c:v>
                </c:pt>
                <c:pt idx="210">
                  <c:v>342</c:v>
                </c:pt>
                <c:pt idx="211">
                  <c:v>342.2</c:v>
                </c:pt>
                <c:pt idx="212">
                  <c:v>342.4</c:v>
                </c:pt>
                <c:pt idx="213">
                  <c:v>342.6</c:v>
                </c:pt>
                <c:pt idx="214">
                  <c:v>342.8</c:v>
                </c:pt>
                <c:pt idx="215">
                  <c:v>343</c:v>
                </c:pt>
                <c:pt idx="216">
                  <c:v>343.2</c:v>
                </c:pt>
                <c:pt idx="217">
                  <c:v>343.4</c:v>
                </c:pt>
                <c:pt idx="218">
                  <c:v>343.6</c:v>
                </c:pt>
                <c:pt idx="219">
                  <c:v>343.8</c:v>
                </c:pt>
                <c:pt idx="220">
                  <c:v>344</c:v>
                </c:pt>
                <c:pt idx="221">
                  <c:v>344.2</c:v>
                </c:pt>
                <c:pt idx="222">
                  <c:v>344.4</c:v>
                </c:pt>
                <c:pt idx="223">
                  <c:v>344.6</c:v>
                </c:pt>
                <c:pt idx="224">
                  <c:v>344.8</c:v>
                </c:pt>
                <c:pt idx="225">
                  <c:v>345</c:v>
                </c:pt>
                <c:pt idx="226">
                  <c:v>345.2</c:v>
                </c:pt>
                <c:pt idx="227">
                  <c:v>345.4</c:v>
                </c:pt>
                <c:pt idx="228">
                  <c:v>345.6</c:v>
                </c:pt>
                <c:pt idx="229">
                  <c:v>345.8</c:v>
                </c:pt>
                <c:pt idx="230">
                  <c:v>346</c:v>
                </c:pt>
                <c:pt idx="231">
                  <c:v>346.2</c:v>
                </c:pt>
                <c:pt idx="232">
                  <c:v>346.4</c:v>
                </c:pt>
                <c:pt idx="233">
                  <c:v>346.6</c:v>
                </c:pt>
                <c:pt idx="234">
                  <c:v>346.8</c:v>
                </c:pt>
                <c:pt idx="235">
                  <c:v>347</c:v>
                </c:pt>
                <c:pt idx="236">
                  <c:v>347.2</c:v>
                </c:pt>
                <c:pt idx="237">
                  <c:v>347.4</c:v>
                </c:pt>
                <c:pt idx="238">
                  <c:v>347.6</c:v>
                </c:pt>
                <c:pt idx="239">
                  <c:v>347.8</c:v>
                </c:pt>
                <c:pt idx="240">
                  <c:v>348</c:v>
                </c:pt>
                <c:pt idx="241">
                  <c:v>348.2</c:v>
                </c:pt>
                <c:pt idx="242">
                  <c:v>348.4</c:v>
                </c:pt>
                <c:pt idx="243">
                  <c:v>348.6</c:v>
                </c:pt>
                <c:pt idx="244">
                  <c:v>348.8</c:v>
                </c:pt>
                <c:pt idx="245">
                  <c:v>349</c:v>
                </c:pt>
                <c:pt idx="246">
                  <c:v>349.2</c:v>
                </c:pt>
                <c:pt idx="247">
                  <c:v>349.4</c:v>
                </c:pt>
                <c:pt idx="248">
                  <c:v>349.6</c:v>
                </c:pt>
                <c:pt idx="249">
                  <c:v>349.8</c:v>
                </c:pt>
                <c:pt idx="250">
                  <c:v>350</c:v>
                </c:pt>
                <c:pt idx="251">
                  <c:v>350.2</c:v>
                </c:pt>
                <c:pt idx="252">
                  <c:v>350.4</c:v>
                </c:pt>
                <c:pt idx="253">
                  <c:v>350.6</c:v>
                </c:pt>
                <c:pt idx="254">
                  <c:v>350.8</c:v>
                </c:pt>
                <c:pt idx="255">
                  <c:v>351</c:v>
                </c:pt>
                <c:pt idx="256">
                  <c:v>351.2</c:v>
                </c:pt>
                <c:pt idx="257">
                  <c:v>351.4</c:v>
                </c:pt>
                <c:pt idx="258">
                  <c:v>351.6</c:v>
                </c:pt>
                <c:pt idx="259">
                  <c:v>351.8</c:v>
                </c:pt>
                <c:pt idx="260">
                  <c:v>352</c:v>
                </c:pt>
                <c:pt idx="261">
                  <c:v>352.2</c:v>
                </c:pt>
                <c:pt idx="262">
                  <c:v>352.4</c:v>
                </c:pt>
                <c:pt idx="263">
                  <c:v>352.6</c:v>
                </c:pt>
                <c:pt idx="264">
                  <c:v>352.8</c:v>
                </c:pt>
                <c:pt idx="265">
                  <c:v>353</c:v>
                </c:pt>
                <c:pt idx="266">
                  <c:v>353.2</c:v>
                </c:pt>
                <c:pt idx="267">
                  <c:v>353.4</c:v>
                </c:pt>
                <c:pt idx="268">
                  <c:v>353.6</c:v>
                </c:pt>
                <c:pt idx="269">
                  <c:v>353.8</c:v>
                </c:pt>
                <c:pt idx="270">
                  <c:v>354</c:v>
                </c:pt>
                <c:pt idx="271">
                  <c:v>354.2</c:v>
                </c:pt>
                <c:pt idx="272">
                  <c:v>354.4</c:v>
                </c:pt>
                <c:pt idx="273">
                  <c:v>354.6</c:v>
                </c:pt>
                <c:pt idx="274">
                  <c:v>354.8</c:v>
                </c:pt>
                <c:pt idx="275">
                  <c:v>355</c:v>
                </c:pt>
                <c:pt idx="276">
                  <c:v>355.2</c:v>
                </c:pt>
                <c:pt idx="277">
                  <c:v>355.4</c:v>
                </c:pt>
                <c:pt idx="278">
                  <c:v>355.6</c:v>
                </c:pt>
                <c:pt idx="279">
                  <c:v>355.8</c:v>
                </c:pt>
                <c:pt idx="280">
                  <c:v>356</c:v>
                </c:pt>
                <c:pt idx="281">
                  <c:v>356.2</c:v>
                </c:pt>
                <c:pt idx="282">
                  <c:v>356.4</c:v>
                </c:pt>
                <c:pt idx="283">
                  <c:v>356.6</c:v>
                </c:pt>
                <c:pt idx="284">
                  <c:v>356.8</c:v>
                </c:pt>
                <c:pt idx="285">
                  <c:v>357</c:v>
                </c:pt>
                <c:pt idx="286">
                  <c:v>357.2</c:v>
                </c:pt>
                <c:pt idx="287">
                  <c:v>357.4</c:v>
                </c:pt>
                <c:pt idx="288">
                  <c:v>357.6</c:v>
                </c:pt>
                <c:pt idx="289">
                  <c:v>357.8</c:v>
                </c:pt>
                <c:pt idx="290">
                  <c:v>358</c:v>
                </c:pt>
                <c:pt idx="291">
                  <c:v>358.2</c:v>
                </c:pt>
                <c:pt idx="292">
                  <c:v>358.4</c:v>
                </c:pt>
                <c:pt idx="293">
                  <c:v>358.6</c:v>
                </c:pt>
                <c:pt idx="294">
                  <c:v>358.8</c:v>
                </c:pt>
                <c:pt idx="295">
                  <c:v>359</c:v>
                </c:pt>
                <c:pt idx="296">
                  <c:v>359.2</c:v>
                </c:pt>
                <c:pt idx="297">
                  <c:v>359.4</c:v>
                </c:pt>
                <c:pt idx="298">
                  <c:v>359.6</c:v>
                </c:pt>
                <c:pt idx="299">
                  <c:v>359.8</c:v>
                </c:pt>
                <c:pt idx="300">
                  <c:v>360</c:v>
                </c:pt>
                <c:pt idx="301">
                  <c:v>360.2</c:v>
                </c:pt>
                <c:pt idx="302">
                  <c:v>360.4</c:v>
                </c:pt>
                <c:pt idx="303">
                  <c:v>360.6</c:v>
                </c:pt>
                <c:pt idx="304">
                  <c:v>360.8</c:v>
                </c:pt>
                <c:pt idx="305">
                  <c:v>361</c:v>
                </c:pt>
                <c:pt idx="306">
                  <c:v>361.2</c:v>
                </c:pt>
                <c:pt idx="307">
                  <c:v>361.4</c:v>
                </c:pt>
                <c:pt idx="308">
                  <c:v>361.6</c:v>
                </c:pt>
                <c:pt idx="309">
                  <c:v>361.8</c:v>
                </c:pt>
                <c:pt idx="310">
                  <c:v>362</c:v>
                </c:pt>
                <c:pt idx="311">
                  <c:v>362.2</c:v>
                </c:pt>
                <c:pt idx="312">
                  <c:v>362.4</c:v>
                </c:pt>
                <c:pt idx="313">
                  <c:v>362.6</c:v>
                </c:pt>
                <c:pt idx="314">
                  <c:v>362.8</c:v>
                </c:pt>
                <c:pt idx="315">
                  <c:v>363</c:v>
                </c:pt>
                <c:pt idx="316">
                  <c:v>363.2</c:v>
                </c:pt>
                <c:pt idx="317">
                  <c:v>363.4</c:v>
                </c:pt>
                <c:pt idx="318">
                  <c:v>363.6</c:v>
                </c:pt>
                <c:pt idx="319">
                  <c:v>363.8</c:v>
                </c:pt>
                <c:pt idx="320">
                  <c:v>364</c:v>
                </c:pt>
                <c:pt idx="321">
                  <c:v>364.2</c:v>
                </c:pt>
                <c:pt idx="322">
                  <c:v>364.4</c:v>
                </c:pt>
                <c:pt idx="323">
                  <c:v>364.6</c:v>
                </c:pt>
                <c:pt idx="324">
                  <c:v>364.8</c:v>
                </c:pt>
                <c:pt idx="325">
                  <c:v>365</c:v>
                </c:pt>
                <c:pt idx="326">
                  <c:v>365.2</c:v>
                </c:pt>
                <c:pt idx="327">
                  <c:v>365.4</c:v>
                </c:pt>
                <c:pt idx="328">
                  <c:v>365.6</c:v>
                </c:pt>
                <c:pt idx="329">
                  <c:v>365.8</c:v>
                </c:pt>
                <c:pt idx="330">
                  <c:v>366</c:v>
                </c:pt>
                <c:pt idx="331">
                  <c:v>366.2</c:v>
                </c:pt>
                <c:pt idx="332">
                  <c:v>366.4</c:v>
                </c:pt>
                <c:pt idx="333">
                  <c:v>366.6</c:v>
                </c:pt>
                <c:pt idx="334">
                  <c:v>366.8</c:v>
                </c:pt>
                <c:pt idx="335">
                  <c:v>367</c:v>
                </c:pt>
                <c:pt idx="336">
                  <c:v>367.2</c:v>
                </c:pt>
                <c:pt idx="337">
                  <c:v>367.4</c:v>
                </c:pt>
                <c:pt idx="338">
                  <c:v>367.6</c:v>
                </c:pt>
                <c:pt idx="339">
                  <c:v>367.8</c:v>
                </c:pt>
                <c:pt idx="340">
                  <c:v>368</c:v>
                </c:pt>
                <c:pt idx="341">
                  <c:v>368.2</c:v>
                </c:pt>
                <c:pt idx="342">
                  <c:v>368.4</c:v>
                </c:pt>
                <c:pt idx="343">
                  <c:v>368.6</c:v>
                </c:pt>
                <c:pt idx="344">
                  <c:v>368.8</c:v>
                </c:pt>
                <c:pt idx="345">
                  <c:v>369</c:v>
                </c:pt>
                <c:pt idx="346">
                  <c:v>369.2</c:v>
                </c:pt>
                <c:pt idx="347">
                  <c:v>369.4</c:v>
                </c:pt>
                <c:pt idx="348">
                  <c:v>369.6</c:v>
                </c:pt>
                <c:pt idx="349">
                  <c:v>369.8</c:v>
                </c:pt>
                <c:pt idx="350">
                  <c:v>370</c:v>
                </c:pt>
                <c:pt idx="351">
                  <c:v>370.2</c:v>
                </c:pt>
                <c:pt idx="352">
                  <c:v>370.4</c:v>
                </c:pt>
                <c:pt idx="353">
                  <c:v>370.6</c:v>
                </c:pt>
                <c:pt idx="354">
                  <c:v>370.8</c:v>
                </c:pt>
                <c:pt idx="355">
                  <c:v>371</c:v>
                </c:pt>
                <c:pt idx="356">
                  <c:v>371.2</c:v>
                </c:pt>
                <c:pt idx="357">
                  <c:v>371.4</c:v>
                </c:pt>
                <c:pt idx="358">
                  <c:v>371.6</c:v>
                </c:pt>
                <c:pt idx="359">
                  <c:v>371.8</c:v>
                </c:pt>
                <c:pt idx="360">
                  <c:v>372</c:v>
                </c:pt>
                <c:pt idx="361">
                  <c:v>372.2</c:v>
                </c:pt>
                <c:pt idx="362">
                  <c:v>372.4</c:v>
                </c:pt>
                <c:pt idx="363">
                  <c:v>372.6</c:v>
                </c:pt>
                <c:pt idx="364">
                  <c:v>372.8</c:v>
                </c:pt>
                <c:pt idx="365">
                  <c:v>373</c:v>
                </c:pt>
                <c:pt idx="366">
                  <c:v>373.2</c:v>
                </c:pt>
                <c:pt idx="367">
                  <c:v>373.4</c:v>
                </c:pt>
                <c:pt idx="368">
                  <c:v>373.6</c:v>
                </c:pt>
                <c:pt idx="369">
                  <c:v>373.8</c:v>
                </c:pt>
                <c:pt idx="370">
                  <c:v>374</c:v>
                </c:pt>
                <c:pt idx="371">
                  <c:v>374.2</c:v>
                </c:pt>
                <c:pt idx="372">
                  <c:v>374.4</c:v>
                </c:pt>
                <c:pt idx="373">
                  <c:v>374.6</c:v>
                </c:pt>
                <c:pt idx="374">
                  <c:v>374.8</c:v>
                </c:pt>
                <c:pt idx="375">
                  <c:v>375</c:v>
                </c:pt>
                <c:pt idx="376">
                  <c:v>375.2</c:v>
                </c:pt>
                <c:pt idx="377">
                  <c:v>375.4</c:v>
                </c:pt>
                <c:pt idx="378">
                  <c:v>375.6</c:v>
                </c:pt>
                <c:pt idx="379">
                  <c:v>375.8</c:v>
                </c:pt>
                <c:pt idx="380">
                  <c:v>376</c:v>
                </c:pt>
                <c:pt idx="381">
                  <c:v>376.2</c:v>
                </c:pt>
                <c:pt idx="382">
                  <c:v>376.4</c:v>
                </c:pt>
                <c:pt idx="383">
                  <c:v>376.6</c:v>
                </c:pt>
                <c:pt idx="384">
                  <c:v>376.8</c:v>
                </c:pt>
                <c:pt idx="385">
                  <c:v>377</c:v>
                </c:pt>
                <c:pt idx="386">
                  <c:v>377.2</c:v>
                </c:pt>
                <c:pt idx="387">
                  <c:v>377.4</c:v>
                </c:pt>
                <c:pt idx="388">
                  <c:v>377.6</c:v>
                </c:pt>
                <c:pt idx="389">
                  <c:v>377.8</c:v>
                </c:pt>
                <c:pt idx="390">
                  <c:v>378</c:v>
                </c:pt>
                <c:pt idx="391">
                  <c:v>378.2</c:v>
                </c:pt>
                <c:pt idx="392">
                  <c:v>378.4</c:v>
                </c:pt>
                <c:pt idx="393">
                  <c:v>378.6</c:v>
                </c:pt>
                <c:pt idx="394">
                  <c:v>378.8</c:v>
                </c:pt>
                <c:pt idx="395">
                  <c:v>379</c:v>
                </c:pt>
                <c:pt idx="396">
                  <c:v>379.2</c:v>
                </c:pt>
                <c:pt idx="397">
                  <c:v>379.4</c:v>
                </c:pt>
                <c:pt idx="398">
                  <c:v>379.6</c:v>
                </c:pt>
                <c:pt idx="399">
                  <c:v>379.8</c:v>
                </c:pt>
                <c:pt idx="400">
                  <c:v>380</c:v>
                </c:pt>
                <c:pt idx="401">
                  <c:v>380.2</c:v>
                </c:pt>
                <c:pt idx="402">
                  <c:v>380.4</c:v>
                </c:pt>
                <c:pt idx="403">
                  <c:v>380.6</c:v>
                </c:pt>
                <c:pt idx="404">
                  <c:v>380.8</c:v>
                </c:pt>
                <c:pt idx="405">
                  <c:v>381</c:v>
                </c:pt>
                <c:pt idx="406">
                  <c:v>381.2</c:v>
                </c:pt>
                <c:pt idx="407">
                  <c:v>381.4</c:v>
                </c:pt>
                <c:pt idx="408">
                  <c:v>381.6</c:v>
                </c:pt>
                <c:pt idx="409">
                  <c:v>381.8</c:v>
                </c:pt>
                <c:pt idx="410">
                  <c:v>382</c:v>
                </c:pt>
                <c:pt idx="411">
                  <c:v>382.2</c:v>
                </c:pt>
                <c:pt idx="412">
                  <c:v>382.4</c:v>
                </c:pt>
                <c:pt idx="413">
                  <c:v>382.6</c:v>
                </c:pt>
                <c:pt idx="414">
                  <c:v>382.8</c:v>
                </c:pt>
                <c:pt idx="415">
                  <c:v>383</c:v>
                </c:pt>
                <c:pt idx="416">
                  <c:v>383.2</c:v>
                </c:pt>
                <c:pt idx="417">
                  <c:v>383.4</c:v>
                </c:pt>
                <c:pt idx="418">
                  <c:v>383.6</c:v>
                </c:pt>
                <c:pt idx="419">
                  <c:v>383.8</c:v>
                </c:pt>
                <c:pt idx="420">
                  <c:v>384</c:v>
                </c:pt>
                <c:pt idx="421">
                  <c:v>384.2</c:v>
                </c:pt>
                <c:pt idx="422">
                  <c:v>384.4</c:v>
                </c:pt>
                <c:pt idx="423">
                  <c:v>384.6</c:v>
                </c:pt>
                <c:pt idx="424">
                  <c:v>384.8</c:v>
                </c:pt>
                <c:pt idx="425">
                  <c:v>385</c:v>
                </c:pt>
                <c:pt idx="426">
                  <c:v>385.2</c:v>
                </c:pt>
                <c:pt idx="427">
                  <c:v>385.4</c:v>
                </c:pt>
                <c:pt idx="428">
                  <c:v>385.6</c:v>
                </c:pt>
                <c:pt idx="429">
                  <c:v>385.8</c:v>
                </c:pt>
                <c:pt idx="430">
                  <c:v>386</c:v>
                </c:pt>
                <c:pt idx="431">
                  <c:v>386.2</c:v>
                </c:pt>
                <c:pt idx="432">
                  <c:v>386.4</c:v>
                </c:pt>
                <c:pt idx="433">
                  <c:v>386.6</c:v>
                </c:pt>
                <c:pt idx="434">
                  <c:v>386.8</c:v>
                </c:pt>
                <c:pt idx="435">
                  <c:v>387</c:v>
                </c:pt>
                <c:pt idx="436">
                  <c:v>387.2</c:v>
                </c:pt>
                <c:pt idx="437">
                  <c:v>387.4</c:v>
                </c:pt>
                <c:pt idx="438">
                  <c:v>387.6</c:v>
                </c:pt>
                <c:pt idx="439">
                  <c:v>387.8</c:v>
                </c:pt>
                <c:pt idx="440">
                  <c:v>388</c:v>
                </c:pt>
                <c:pt idx="441">
                  <c:v>388.2</c:v>
                </c:pt>
                <c:pt idx="442">
                  <c:v>388.4</c:v>
                </c:pt>
                <c:pt idx="443">
                  <c:v>388.6</c:v>
                </c:pt>
                <c:pt idx="444">
                  <c:v>388.8</c:v>
                </c:pt>
                <c:pt idx="445">
                  <c:v>389</c:v>
                </c:pt>
                <c:pt idx="446">
                  <c:v>389.2</c:v>
                </c:pt>
                <c:pt idx="447">
                  <c:v>389.4</c:v>
                </c:pt>
                <c:pt idx="448">
                  <c:v>389.6</c:v>
                </c:pt>
                <c:pt idx="449">
                  <c:v>389.8</c:v>
                </c:pt>
                <c:pt idx="450">
                  <c:v>390</c:v>
                </c:pt>
                <c:pt idx="451">
                  <c:v>390.2</c:v>
                </c:pt>
                <c:pt idx="452">
                  <c:v>390.4</c:v>
                </c:pt>
                <c:pt idx="453">
                  <c:v>390.6</c:v>
                </c:pt>
                <c:pt idx="454">
                  <c:v>390.8</c:v>
                </c:pt>
                <c:pt idx="455">
                  <c:v>391</c:v>
                </c:pt>
                <c:pt idx="456">
                  <c:v>391.2</c:v>
                </c:pt>
                <c:pt idx="457">
                  <c:v>391.4</c:v>
                </c:pt>
                <c:pt idx="458">
                  <c:v>391.6</c:v>
                </c:pt>
                <c:pt idx="459">
                  <c:v>391.8</c:v>
                </c:pt>
                <c:pt idx="460">
                  <c:v>392</c:v>
                </c:pt>
                <c:pt idx="461">
                  <c:v>392.2</c:v>
                </c:pt>
                <c:pt idx="462">
                  <c:v>392.4</c:v>
                </c:pt>
                <c:pt idx="463">
                  <c:v>392.6</c:v>
                </c:pt>
                <c:pt idx="464">
                  <c:v>392.8</c:v>
                </c:pt>
                <c:pt idx="465">
                  <c:v>393</c:v>
                </c:pt>
                <c:pt idx="466">
                  <c:v>393.2</c:v>
                </c:pt>
                <c:pt idx="467">
                  <c:v>393.4</c:v>
                </c:pt>
                <c:pt idx="468">
                  <c:v>393.6</c:v>
                </c:pt>
                <c:pt idx="469">
                  <c:v>393.8</c:v>
                </c:pt>
                <c:pt idx="470">
                  <c:v>394</c:v>
                </c:pt>
                <c:pt idx="471">
                  <c:v>394.2</c:v>
                </c:pt>
                <c:pt idx="472">
                  <c:v>394.4</c:v>
                </c:pt>
                <c:pt idx="473">
                  <c:v>394.6</c:v>
                </c:pt>
                <c:pt idx="474">
                  <c:v>394.8</c:v>
                </c:pt>
                <c:pt idx="475">
                  <c:v>395</c:v>
                </c:pt>
                <c:pt idx="476">
                  <c:v>395.2</c:v>
                </c:pt>
                <c:pt idx="477">
                  <c:v>395.4</c:v>
                </c:pt>
                <c:pt idx="478">
                  <c:v>395.6</c:v>
                </c:pt>
                <c:pt idx="479">
                  <c:v>395.8</c:v>
                </c:pt>
                <c:pt idx="480">
                  <c:v>396</c:v>
                </c:pt>
                <c:pt idx="481">
                  <c:v>396.2</c:v>
                </c:pt>
                <c:pt idx="482">
                  <c:v>396.4</c:v>
                </c:pt>
                <c:pt idx="483">
                  <c:v>396.6</c:v>
                </c:pt>
                <c:pt idx="484">
                  <c:v>396.8</c:v>
                </c:pt>
                <c:pt idx="485">
                  <c:v>397</c:v>
                </c:pt>
                <c:pt idx="486">
                  <c:v>397.2</c:v>
                </c:pt>
                <c:pt idx="487">
                  <c:v>397.4</c:v>
                </c:pt>
                <c:pt idx="488">
                  <c:v>397.6</c:v>
                </c:pt>
                <c:pt idx="489">
                  <c:v>397.8</c:v>
                </c:pt>
                <c:pt idx="490">
                  <c:v>398</c:v>
                </c:pt>
                <c:pt idx="491">
                  <c:v>398.2</c:v>
                </c:pt>
                <c:pt idx="492">
                  <c:v>398.4</c:v>
                </c:pt>
                <c:pt idx="493">
                  <c:v>398.6</c:v>
                </c:pt>
                <c:pt idx="494">
                  <c:v>398.8</c:v>
                </c:pt>
                <c:pt idx="495">
                  <c:v>399</c:v>
                </c:pt>
                <c:pt idx="496">
                  <c:v>399.2</c:v>
                </c:pt>
                <c:pt idx="497">
                  <c:v>399.4</c:v>
                </c:pt>
                <c:pt idx="498">
                  <c:v>399.6</c:v>
                </c:pt>
                <c:pt idx="499">
                  <c:v>399.8</c:v>
                </c:pt>
                <c:pt idx="500">
                  <c:v>400</c:v>
                </c:pt>
              </c:numCache>
            </c:numRef>
          </c:xVal>
          <c:yVal>
            <c:numRef>
              <c:f>Sheet1!$E$5:$E$505</c:f>
              <c:numCache>
                <c:formatCode>General</c:formatCode>
                <c:ptCount val="501"/>
                <c:pt idx="31">
                  <c:v>341.411</c:v>
                </c:pt>
                <c:pt idx="32">
                  <c:v>343.02300000000002</c:v>
                </c:pt>
                <c:pt idx="33">
                  <c:v>346.13200000000001</c:v>
                </c:pt>
                <c:pt idx="34">
                  <c:v>350.25400000000002</c:v>
                </c:pt>
                <c:pt idx="35">
                  <c:v>355.21899999999999</c:v>
                </c:pt>
                <c:pt idx="36">
                  <c:v>361.024</c:v>
                </c:pt>
                <c:pt idx="37">
                  <c:v>373.96100000000001</c:v>
                </c:pt>
                <c:pt idx="38">
                  <c:v>380.86200000000002</c:v>
                </c:pt>
                <c:pt idx="39">
                  <c:v>388.01400000000001</c:v>
                </c:pt>
                <c:pt idx="40">
                  <c:v>395.322</c:v>
                </c:pt>
                <c:pt idx="41">
                  <c:v>402.745</c:v>
                </c:pt>
                <c:pt idx="42">
                  <c:v>410.37099999999998</c:v>
                </c:pt>
                <c:pt idx="43">
                  <c:v>418.17700000000002</c:v>
                </c:pt>
                <c:pt idx="44">
                  <c:v>426.11500000000001</c:v>
                </c:pt>
                <c:pt idx="45">
                  <c:v>434.065</c:v>
                </c:pt>
                <c:pt idx="46">
                  <c:v>442.03399999999999</c:v>
                </c:pt>
                <c:pt idx="47">
                  <c:v>450.09699999999998</c:v>
                </c:pt>
                <c:pt idx="48">
                  <c:v>458.21800000000002</c:v>
                </c:pt>
                <c:pt idx="49">
                  <c:v>466.44400000000002</c:v>
                </c:pt>
                <c:pt idx="50">
                  <c:v>474.62900000000002</c:v>
                </c:pt>
                <c:pt idx="51">
                  <c:v>482.80799999999999</c:v>
                </c:pt>
                <c:pt idx="52">
                  <c:v>491.12799999999999</c:v>
                </c:pt>
                <c:pt idx="53">
                  <c:v>499.52800000000002</c:v>
                </c:pt>
                <c:pt idx="54">
                  <c:v>507.98200000000003</c:v>
                </c:pt>
                <c:pt idx="55">
                  <c:v>516.52800000000002</c:v>
                </c:pt>
                <c:pt idx="56">
                  <c:v>525.096</c:v>
                </c:pt>
                <c:pt idx="57">
                  <c:v>533.63400000000001</c:v>
                </c:pt>
                <c:pt idx="58">
                  <c:v>542.37</c:v>
                </c:pt>
                <c:pt idx="59">
                  <c:v>551.15099999999995</c:v>
                </c:pt>
                <c:pt idx="60">
                  <c:v>559.83900000000006</c:v>
                </c:pt>
                <c:pt idx="61">
                  <c:v>568.57899999999995</c:v>
                </c:pt>
                <c:pt idx="62">
                  <c:v>577.399</c:v>
                </c:pt>
                <c:pt idx="63">
                  <c:v>586.26599999999996</c:v>
                </c:pt>
                <c:pt idx="64">
                  <c:v>595.03599999999994</c:v>
                </c:pt>
                <c:pt idx="65">
                  <c:v>603.87199999999996</c:v>
                </c:pt>
                <c:pt idx="66">
                  <c:v>612.827</c:v>
                </c:pt>
                <c:pt idx="67">
                  <c:v>621.77</c:v>
                </c:pt>
                <c:pt idx="68">
                  <c:v>630.67100000000005</c:v>
                </c:pt>
                <c:pt idx="69">
                  <c:v>639.58199999999999</c:v>
                </c:pt>
                <c:pt idx="70">
                  <c:v>648.56100000000004</c:v>
                </c:pt>
                <c:pt idx="71">
                  <c:v>657.57100000000003</c:v>
                </c:pt>
                <c:pt idx="72">
                  <c:v>666.64099999999996</c:v>
                </c:pt>
                <c:pt idx="73">
                  <c:v>675.71699999999998</c:v>
                </c:pt>
                <c:pt idx="74">
                  <c:v>684.72699999999998</c:v>
                </c:pt>
                <c:pt idx="75">
                  <c:v>693.93399999999997</c:v>
                </c:pt>
                <c:pt idx="76">
                  <c:v>703.255</c:v>
                </c:pt>
                <c:pt idx="77">
                  <c:v>712.41399999999999</c:v>
                </c:pt>
                <c:pt idx="78">
                  <c:v>721.56299999999999</c:v>
                </c:pt>
                <c:pt idx="79">
                  <c:v>730.76400000000001</c:v>
                </c:pt>
                <c:pt idx="80">
                  <c:v>739.99</c:v>
                </c:pt>
                <c:pt idx="81">
                  <c:v>749.23800000000006</c:v>
                </c:pt>
                <c:pt idx="82">
                  <c:v>758.42700000000002</c:v>
                </c:pt>
                <c:pt idx="83">
                  <c:v>767.399</c:v>
                </c:pt>
                <c:pt idx="84">
                  <c:v>776.44799999999998</c:v>
                </c:pt>
                <c:pt idx="85">
                  <c:v>785.702</c:v>
                </c:pt>
                <c:pt idx="86">
                  <c:v>795.01300000000003</c:v>
                </c:pt>
                <c:pt idx="87">
                  <c:v>804.35199999999998</c:v>
                </c:pt>
                <c:pt idx="88">
                  <c:v>813.60599999999999</c:v>
                </c:pt>
                <c:pt idx="89">
                  <c:v>822.98199999999997</c:v>
                </c:pt>
                <c:pt idx="90">
                  <c:v>832.42100000000005</c:v>
                </c:pt>
                <c:pt idx="91">
                  <c:v>841.85299999999995</c:v>
                </c:pt>
                <c:pt idx="92">
                  <c:v>851.29899999999998</c:v>
                </c:pt>
                <c:pt idx="93">
                  <c:v>860.71400000000006</c:v>
                </c:pt>
                <c:pt idx="94">
                  <c:v>870.21299999999997</c:v>
                </c:pt>
                <c:pt idx="95">
                  <c:v>879.73900000000003</c:v>
                </c:pt>
                <c:pt idx="96">
                  <c:v>889.31299999999999</c:v>
                </c:pt>
                <c:pt idx="97">
                  <c:v>898.904</c:v>
                </c:pt>
                <c:pt idx="98">
                  <c:v>908.50300000000004</c:v>
                </c:pt>
                <c:pt idx="99">
                  <c:v>918.25300000000004</c:v>
                </c:pt>
                <c:pt idx="100">
                  <c:v>927.976</c:v>
                </c:pt>
                <c:pt idx="101">
                  <c:v>937.64300000000003</c:v>
                </c:pt>
                <c:pt idx="102">
                  <c:v>947.35400000000004</c:v>
                </c:pt>
                <c:pt idx="103">
                  <c:v>957.05399999999997</c:v>
                </c:pt>
                <c:pt idx="104">
                  <c:v>966.81299999999999</c:v>
                </c:pt>
                <c:pt idx="105">
                  <c:v>976.55</c:v>
                </c:pt>
                <c:pt idx="106">
                  <c:v>986.31200000000001</c:v>
                </c:pt>
                <c:pt idx="107">
                  <c:v>996.27599999999995</c:v>
                </c:pt>
                <c:pt idx="108">
                  <c:v>1006.59</c:v>
                </c:pt>
                <c:pt idx="109">
                  <c:v>1016.96</c:v>
                </c:pt>
                <c:pt idx="110">
                  <c:v>1027.0999999999999</c:v>
                </c:pt>
                <c:pt idx="111">
                  <c:v>1037.22</c:v>
                </c:pt>
                <c:pt idx="112">
                  <c:v>1047.42</c:v>
                </c:pt>
                <c:pt idx="113">
                  <c:v>1057.6600000000001</c:v>
                </c:pt>
                <c:pt idx="114">
                  <c:v>1067.8800000000001</c:v>
                </c:pt>
                <c:pt idx="115">
                  <c:v>1078.1400000000001</c:v>
                </c:pt>
                <c:pt idx="116">
                  <c:v>1088.42</c:v>
                </c:pt>
                <c:pt idx="117">
                  <c:v>1098.6400000000001</c:v>
                </c:pt>
                <c:pt idx="118">
                  <c:v>1108.92</c:v>
                </c:pt>
                <c:pt idx="119">
                  <c:v>1119.02</c:v>
                </c:pt>
                <c:pt idx="120">
                  <c:v>1129.05</c:v>
                </c:pt>
                <c:pt idx="121">
                  <c:v>1139.05</c:v>
                </c:pt>
                <c:pt idx="122">
                  <c:v>1148.8800000000001</c:v>
                </c:pt>
                <c:pt idx="123">
                  <c:v>1158.6099999999999</c:v>
                </c:pt>
                <c:pt idx="124">
                  <c:v>1168.2</c:v>
                </c:pt>
                <c:pt idx="125">
                  <c:v>1177.6500000000001</c:v>
                </c:pt>
                <c:pt idx="126">
                  <c:v>1187.05</c:v>
                </c:pt>
                <c:pt idx="127">
                  <c:v>1196.68</c:v>
                </c:pt>
                <c:pt idx="128">
                  <c:v>1206.3</c:v>
                </c:pt>
                <c:pt idx="129">
                  <c:v>1215.6300000000001</c:v>
                </c:pt>
                <c:pt idx="130">
                  <c:v>1224.78</c:v>
                </c:pt>
                <c:pt idx="131">
                  <c:v>1233.8399999999999</c:v>
                </c:pt>
                <c:pt idx="132">
                  <c:v>1242.79</c:v>
                </c:pt>
                <c:pt idx="133">
                  <c:v>1251.27</c:v>
                </c:pt>
                <c:pt idx="134">
                  <c:v>1259.3399999999999</c:v>
                </c:pt>
                <c:pt idx="135">
                  <c:v>1267.3599999999999</c:v>
                </c:pt>
                <c:pt idx="136">
                  <c:v>1275.18</c:v>
                </c:pt>
                <c:pt idx="137">
                  <c:v>1282.78</c:v>
                </c:pt>
                <c:pt idx="138">
                  <c:v>1290.24</c:v>
                </c:pt>
                <c:pt idx="139">
                  <c:v>1297.54</c:v>
                </c:pt>
                <c:pt idx="140">
                  <c:v>1304.76</c:v>
                </c:pt>
                <c:pt idx="141">
                  <c:v>1311.89</c:v>
                </c:pt>
                <c:pt idx="142">
                  <c:v>1318.71</c:v>
                </c:pt>
                <c:pt idx="143">
                  <c:v>1325.22</c:v>
                </c:pt>
                <c:pt idx="144">
                  <c:v>1331.69</c:v>
                </c:pt>
                <c:pt idx="145">
                  <c:v>1337.96</c:v>
                </c:pt>
                <c:pt idx="146">
                  <c:v>1343.94</c:v>
                </c:pt>
                <c:pt idx="147">
                  <c:v>1349.86</c:v>
                </c:pt>
                <c:pt idx="148">
                  <c:v>1355.63</c:v>
                </c:pt>
                <c:pt idx="149">
                  <c:v>1361.3</c:v>
                </c:pt>
                <c:pt idx="150">
                  <c:v>1367.08</c:v>
                </c:pt>
                <c:pt idx="151">
                  <c:v>1372.68</c:v>
                </c:pt>
                <c:pt idx="152">
                  <c:v>1377.89</c:v>
                </c:pt>
                <c:pt idx="153">
                  <c:v>1382.83</c:v>
                </c:pt>
                <c:pt idx="154">
                  <c:v>1387.68</c:v>
                </c:pt>
                <c:pt idx="155">
                  <c:v>1392.53</c:v>
                </c:pt>
                <c:pt idx="156">
                  <c:v>1397.33</c:v>
                </c:pt>
                <c:pt idx="157">
                  <c:v>1401.89</c:v>
                </c:pt>
                <c:pt idx="158">
                  <c:v>1406.46</c:v>
                </c:pt>
                <c:pt idx="159">
                  <c:v>1411.23</c:v>
                </c:pt>
                <c:pt idx="160">
                  <c:v>1415.89</c:v>
                </c:pt>
                <c:pt idx="161">
                  <c:v>1420.51</c:v>
                </c:pt>
                <c:pt idx="162">
                  <c:v>1425.05</c:v>
                </c:pt>
                <c:pt idx="163">
                  <c:v>1429.36</c:v>
                </c:pt>
                <c:pt idx="164">
                  <c:v>1433.46</c:v>
                </c:pt>
                <c:pt idx="165">
                  <c:v>1437.46</c:v>
                </c:pt>
                <c:pt idx="166">
                  <c:v>1441.33</c:v>
                </c:pt>
                <c:pt idx="167">
                  <c:v>1445.19</c:v>
                </c:pt>
                <c:pt idx="168">
                  <c:v>1449.11</c:v>
                </c:pt>
                <c:pt idx="169">
                  <c:v>1453.04</c:v>
                </c:pt>
                <c:pt idx="170">
                  <c:v>1456.95</c:v>
                </c:pt>
                <c:pt idx="171">
                  <c:v>1461.01</c:v>
                </c:pt>
                <c:pt idx="172">
                  <c:v>1465.07</c:v>
                </c:pt>
                <c:pt idx="173">
                  <c:v>1469.06</c:v>
                </c:pt>
                <c:pt idx="174">
                  <c:v>1472.9</c:v>
                </c:pt>
                <c:pt idx="175">
                  <c:v>1476.47</c:v>
                </c:pt>
                <c:pt idx="176">
                  <c:v>1480.06</c:v>
                </c:pt>
                <c:pt idx="177">
                  <c:v>1483.5</c:v>
                </c:pt>
                <c:pt idx="178">
                  <c:v>1486.9</c:v>
                </c:pt>
                <c:pt idx="179">
                  <c:v>1490.3</c:v>
                </c:pt>
                <c:pt idx="180">
                  <c:v>1493.59</c:v>
                </c:pt>
                <c:pt idx="181">
                  <c:v>1496.78</c:v>
                </c:pt>
                <c:pt idx="182">
                  <c:v>1499.95</c:v>
                </c:pt>
                <c:pt idx="183">
                  <c:v>1503.14</c:v>
                </c:pt>
                <c:pt idx="184">
                  <c:v>1506.16</c:v>
                </c:pt>
                <c:pt idx="185">
                  <c:v>1509.13</c:v>
                </c:pt>
                <c:pt idx="186">
                  <c:v>1512.03</c:v>
                </c:pt>
                <c:pt idx="187">
                  <c:v>1514.7</c:v>
                </c:pt>
                <c:pt idx="188">
                  <c:v>1517.39</c:v>
                </c:pt>
                <c:pt idx="189">
                  <c:v>1520.26</c:v>
                </c:pt>
                <c:pt idx="190">
                  <c:v>1523.02</c:v>
                </c:pt>
                <c:pt idx="191">
                  <c:v>1525.47</c:v>
                </c:pt>
                <c:pt idx="192">
                  <c:v>1527.84</c:v>
                </c:pt>
                <c:pt idx="193">
                  <c:v>1530.2</c:v>
                </c:pt>
                <c:pt idx="194">
                  <c:v>1532.18</c:v>
                </c:pt>
                <c:pt idx="195">
                  <c:v>1533.94</c:v>
                </c:pt>
                <c:pt idx="196">
                  <c:v>1535.6</c:v>
                </c:pt>
                <c:pt idx="197">
                  <c:v>1537.05</c:v>
                </c:pt>
                <c:pt idx="198">
                  <c:v>1538.43</c:v>
                </c:pt>
                <c:pt idx="199">
                  <c:v>1539.72</c:v>
                </c:pt>
                <c:pt idx="200">
                  <c:v>1541.02</c:v>
                </c:pt>
                <c:pt idx="201">
                  <c:v>1542.31</c:v>
                </c:pt>
                <c:pt idx="202">
                  <c:v>1543.59</c:v>
                </c:pt>
                <c:pt idx="203">
                  <c:v>1544.86</c:v>
                </c:pt>
                <c:pt idx="204">
                  <c:v>1546.07</c:v>
                </c:pt>
                <c:pt idx="205">
                  <c:v>1547.14</c:v>
                </c:pt>
                <c:pt idx="206">
                  <c:v>1547.94</c:v>
                </c:pt>
                <c:pt idx="207">
                  <c:v>1548.55</c:v>
                </c:pt>
                <c:pt idx="208">
                  <c:v>1549.02</c:v>
                </c:pt>
                <c:pt idx="209">
                  <c:v>1549.4</c:v>
                </c:pt>
                <c:pt idx="210">
                  <c:v>1549.69</c:v>
                </c:pt>
                <c:pt idx="211">
                  <c:v>1549.9</c:v>
                </c:pt>
                <c:pt idx="212">
                  <c:v>1550.06</c:v>
                </c:pt>
                <c:pt idx="213">
                  <c:v>1550.16</c:v>
                </c:pt>
                <c:pt idx="214">
                  <c:v>1550.09</c:v>
                </c:pt>
                <c:pt idx="215">
                  <c:v>1549.74</c:v>
                </c:pt>
                <c:pt idx="216">
                  <c:v>1549.49</c:v>
                </c:pt>
                <c:pt idx="217">
                  <c:v>1549.33</c:v>
                </c:pt>
                <c:pt idx="218">
                  <c:v>1548.97</c:v>
                </c:pt>
                <c:pt idx="219">
                  <c:v>1548.66</c:v>
                </c:pt>
                <c:pt idx="220">
                  <c:v>1548.37</c:v>
                </c:pt>
                <c:pt idx="221">
                  <c:v>1547.96</c:v>
                </c:pt>
                <c:pt idx="222">
                  <c:v>1547.5</c:v>
                </c:pt>
                <c:pt idx="223">
                  <c:v>1547</c:v>
                </c:pt>
                <c:pt idx="224">
                  <c:v>1546.45</c:v>
                </c:pt>
                <c:pt idx="225">
                  <c:v>1545.75</c:v>
                </c:pt>
                <c:pt idx="226">
                  <c:v>1544.93</c:v>
                </c:pt>
                <c:pt idx="227">
                  <c:v>1544.12</c:v>
                </c:pt>
                <c:pt idx="228">
                  <c:v>1543.14</c:v>
                </c:pt>
                <c:pt idx="229">
                  <c:v>1542.01</c:v>
                </c:pt>
                <c:pt idx="230">
                  <c:v>1540.84</c:v>
                </c:pt>
                <c:pt idx="231">
                  <c:v>1539.67</c:v>
                </c:pt>
                <c:pt idx="232">
                  <c:v>1538.44</c:v>
                </c:pt>
                <c:pt idx="233">
                  <c:v>1537.08</c:v>
                </c:pt>
                <c:pt idx="234">
                  <c:v>1535.78</c:v>
                </c:pt>
                <c:pt idx="235">
                  <c:v>1534.42</c:v>
                </c:pt>
                <c:pt idx="236">
                  <c:v>1532.89</c:v>
                </c:pt>
                <c:pt idx="237">
                  <c:v>1531.42</c:v>
                </c:pt>
                <c:pt idx="238">
                  <c:v>1530</c:v>
                </c:pt>
                <c:pt idx="239">
                  <c:v>1528.47</c:v>
                </c:pt>
                <c:pt idx="240">
                  <c:v>1526.89</c:v>
                </c:pt>
                <c:pt idx="241">
                  <c:v>1525.28</c:v>
                </c:pt>
                <c:pt idx="242">
                  <c:v>1523.5</c:v>
                </c:pt>
                <c:pt idx="243">
                  <c:v>1521.67</c:v>
                </c:pt>
                <c:pt idx="244">
                  <c:v>1519.8</c:v>
                </c:pt>
                <c:pt idx="245">
                  <c:v>1517.93</c:v>
                </c:pt>
                <c:pt idx="246">
                  <c:v>1516.03</c:v>
                </c:pt>
                <c:pt idx="247">
                  <c:v>1514.1</c:v>
                </c:pt>
                <c:pt idx="248">
                  <c:v>1512.17</c:v>
                </c:pt>
                <c:pt idx="249">
                  <c:v>1510.1</c:v>
                </c:pt>
                <c:pt idx="250">
                  <c:v>1507.9</c:v>
                </c:pt>
                <c:pt idx="251">
                  <c:v>1505.62</c:v>
                </c:pt>
                <c:pt idx="252">
                  <c:v>1503.17</c:v>
                </c:pt>
                <c:pt idx="253">
                  <c:v>1500.68</c:v>
                </c:pt>
                <c:pt idx="254">
                  <c:v>1498.28</c:v>
                </c:pt>
                <c:pt idx="255">
                  <c:v>1495.87</c:v>
                </c:pt>
                <c:pt idx="256">
                  <c:v>1493.47</c:v>
                </c:pt>
                <c:pt idx="257">
                  <c:v>1491.12</c:v>
                </c:pt>
                <c:pt idx="258">
                  <c:v>1488.72</c:v>
                </c:pt>
                <c:pt idx="259">
                  <c:v>1486.06</c:v>
                </c:pt>
                <c:pt idx="260">
                  <c:v>1483.21</c:v>
                </c:pt>
                <c:pt idx="261">
                  <c:v>1480.31</c:v>
                </c:pt>
                <c:pt idx="262">
                  <c:v>1477.4</c:v>
                </c:pt>
                <c:pt idx="263">
                  <c:v>1474.46</c:v>
                </c:pt>
                <c:pt idx="264">
                  <c:v>1471.5</c:v>
                </c:pt>
                <c:pt idx="265">
                  <c:v>1468.56</c:v>
                </c:pt>
                <c:pt idx="266">
                  <c:v>1465.49</c:v>
                </c:pt>
                <c:pt idx="267">
                  <c:v>1462.34</c:v>
                </c:pt>
                <c:pt idx="268">
                  <c:v>1459.3</c:v>
                </c:pt>
                <c:pt idx="269">
                  <c:v>1456.37</c:v>
                </c:pt>
                <c:pt idx="270">
                  <c:v>1453.28</c:v>
                </c:pt>
                <c:pt idx="271">
                  <c:v>1450.01</c:v>
                </c:pt>
                <c:pt idx="272">
                  <c:v>1446.54</c:v>
                </c:pt>
                <c:pt idx="273">
                  <c:v>1442.92</c:v>
                </c:pt>
                <c:pt idx="274">
                  <c:v>1439.43</c:v>
                </c:pt>
                <c:pt idx="275">
                  <c:v>1435.94</c:v>
                </c:pt>
                <c:pt idx="276">
                  <c:v>1432.38</c:v>
                </c:pt>
                <c:pt idx="277">
                  <c:v>1428.78</c:v>
                </c:pt>
                <c:pt idx="278">
                  <c:v>1425.23</c:v>
                </c:pt>
                <c:pt idx="279">
                  <c:v>1421.57</c:v>
                </c:pt>
                <c:pt idx="280">
                  <c:v>1417.77</c:v>
                </c:pt>
                <c:pt idx="281">
                  <c:v>1414.01</c:v>
                </c:pt>
                <c:pt idx="282">
                  <c:v>1410.16</c:v>
                </c:pt>
                <c:pt idx="283">
                  <c:v>1406.26</c:v>
                </c:pt>
                <c:pt idx="284">
                  <c:v>1402.36</c:v>
                </c:pt>
                <c:pt idx="285">
                  <c:v>1398.67</c:v>
                </c:pt>
                <c:pt idx="286">
                  <c:v>1395</c:v>
                </c:pt>
                <c:pt idx="287">
                  <c:v>1391.04</c:v>
                </c:pt>
                <c:pt idx="288">
                  <c:v>1386.95</c:v>
                </c:pt>
                <c:pt idx="289">
                  <c:v>1381.02</c:v>
                </c:pt>
                <c:pt idx="290">
                  <c:v>1375</c:v>
                </c:pt>
                <c:pt idx="291">
                  <c:v>1369.07</c:v>
                </c:pt>
                <c:pt idx="292">
                  <c:v>1363.15</c:v>
                </c:pt>
                <c:pt idx="293">
                  <c:v>1357.16</c:v>
                </c:pt>
                <c:pt idx="294">
                  <c:v>1351.04</c:v>
                </c:pt>
                <c:pt idx="295">
                  <c:v>1344.84</c:v>
                </c:pt>
                <c:pt idx="296">
                  <c:v>1338.64</c:v>
                </c:pt>
                <c:pt idx="297">
                  <c:v>1332.53</c:v>
                </c:pt>
                <c:pt idx="298">
                  <c:v>1326.42</c:v>
                </c:pt>
                <c:pt idx="299">
                  <c:v>1320.2</c:v>
                </c:pt>
                <c:pt idx="300">
                  <c:v>1313.88</c:v>
                </c:pt>
                <c:pt idx="301">
                  <c:v>1307.53</c:v>
                </c:pt>
                <c:pt idx="302">
                  <c:v>1301.3</c:v>
                </c:pt>
                <c:pt idx="303">
                  <c:v>1294.9100000000001</c:v>
                </c:pt>
                <c:pt idx="304">
                  <c:v>1288.43</c:v>
                </c:pt>
                <c:pt idx="305">
                  <c:v>1282.03</c:v>
                </c:pt>
                <c:pt idx="306">
                  <c:v>1275.47</c:v>
                </c:pt>
                <c:pt idx="307">
                  <c:v>1268.8699999999999</c:v>
                </c:pt>
                <c:pt idx="308">
                  <c:v>1262.32</c:v>
                </c:pt>
                <c:pt idx="309">
                  <c:v>1255.79</c:v>
                </c:pt>
                <c:pt idx="310">
                  <c:v>1249.2</c:v>
                </c:pt>
                <c:pt idx="311">
                  <c:v>1242.6199999999999</c:v>
                </c:pt>
                <c:pt idx="312">
                  <c:v>1236.25</c:v>
                </c:pt>
                <c:pt idx="313">
                  <c:v>1229.8699999999999</c:v>
                </c:pt>
                <c:pt idx="314">
                  <c:v>1225.1300000000001</c:v>
                </c:pt>
                <c:pt idx="315">
                  <c:v>1220.4000000000001</c:v>
                </c:pt>
                <c:pt idx="316">
                  <c:v>1215.54</c:v>
                </c:pt>
                <c:pt idx="317">
                  <c:v>1210.57</c:v>
                </c:pt>
                <c:pt idx="318">
                  <c:v>1205.57</c:v>
                </c:pt>
                <c:pt idx="319">
                  <c:v>1200.6400000000001</c:v>
                </c:pt>
                <c:pt idx="320">
                  <c:v>1195.8599999999999</c:v>
                </c:pt>
                <c:pt idx="321">
                  <c:v>1191.1300000000001</c:v>
                </c:pt>
                <c:pt idx="322">
                  <c:v>1186.27</c:v>
                </c:pt>
                <c:pt idx="323">
                  <c:v>1181.3</c:v>
                </c:pt>
                <c:pt idx="324">
                  <c:v>1176.3699999999999</c:v>
                </c:pt>
                <c:pt idx="325">
                  <c:v>1171.5999999999999</c:v>
                </c:pt>
                <c:pt idx="326">
                  <c:v>1166.8900000000001</c:v>
                </c:pt>
                <c:pt idx="327">
                  <c:v>1162.07</c:v>
                </c:pt>
                <c:pt idx="328">
                  <c:v>1157.31</c:v>
                </c:pt>
                <c:pt idx="329">
                  <c:v>1152.56</c:v>
                </c:pt>
                <c:pt idx="330">
                  <c:v>1147.5999999999999</c:v>
                </c:pt>
                <c:pt idx="331">
                  <c:v>1142.6600000000001</c:v>
                </c:pt>
                <c:pt idx="332">
                  <c:v>1137.76</c:v>
                </c:pt>
                <c:pt idx="333">
                  <c:v>1132.8</c:v>
                </c:pt>
                <c:pt idx="334">
                  <c:v>1127.83</c:v>
                </c:pt>
                <c:pt idx="335">
                  <c:v>1122.8800000000001</c:v>
                </c:pt>
                <c:pt idx="336">
                  <c:v>1117.8900000000001</c:v>
                </c:pt>
                <c:pt idx="337">
                  <c:v>1112.78</c:v>
                </c:pt>
                <c:pt idx="338">
                  <c:v>1107.73</c:v>
                </c:pt>
                <c:pt idx="339">
                  <c:v>1102.9100000000001</c:v>
                </c:pt>
                <c:pt idx="340">
                  <c:v>1098.1600000000001</c:v>
                </c:pt>
                <c:pt idx="341">
                  <c:v>1093.44</c:v>
                </c:pt>
                <c:pt idx="342">
                  <c:v>1088.78</c:v>
                </c:pt>
                <c:pt idx="343">
                  <c:v>1083.9000000000001</c:v>
                </c:pt>
                <c:pt idx="344">
                  <c:v>1078.82</c:v>
                </c:pt>
                <c:pt idx="345">
                  <c:v>1073.7</c:v>
                </c:pt>
                <c:pt idx="346">
                  <c:v>1068.53</c:v>
                </c:pt>
                <c:pt idx="347">
                  <c:v>1063.54</c:v>
                </c:pt>
                <c:pt idx="348">
                  <c:v>1058.71</c:v>
                </c:pt>
                <c:pt idx="349">
                  <c:v>1053.8800000000001</c:v>
                </c:pt>
                <c:pt idx="350">
                  <c:v>1048.92</c:v>
                </c:pt>
                <c:pt idx="351">
                  <c:v>1043.93</c:v>
                </c:pt>
                <c:pt idx="352">
                  <c:v>1039.04</c:v>
                </c:pt>
                <c:pt idx="353">
                  <c:v>1034.08</c:v>
                </c:pt>
                <c:pt idx="354">
                  <c:v>1029.06</c:v>
                </c:pt>
                <c:pt idx="355">
                  <c:v>1024.0999999999999</c:v>
                </c:pt>
                <c:pt idx="356">
                  <c:v>1019.2</c:v>
                </c:pt>
                <c:pt idx="357">
                  <c:v>1014.32</c:v>
                </c:pt>
                <c:pt idx="358">
                  <c:v>1009.5</c:v>
                </c:pt>
                <c:pt idx="359">
                  <c:v>1004.7</c:v>
                </c:pt>
                <c:pt idx="360">
                  <c:v>999.75800000000004</c:v>
                </c:pt>
                <c:pt idx="361">
                  <c:v>994.83399999999995</c:v>
                </c:pt>
                <c:pt idx="362">
                  <c:v>989.928</c:v>
                </c:pt>
                <c:pt idx="363">
                  <c:v>984.92600000000004</c:v>
                </c:pt>
                <c:pt idx="364">
                  <c:v>979.93299999999999</c:v>
                </c:pt>
                <c:pt idx="365">
                  <c:v>975.01499999999999</c:v>
                </c:pt>
                <c:pt idx="366">
                  <c:v>970.11599999999999</c:v>
                </c:pt>
                <c:pt idx="367">
                  <c:v>965.15</c:v>
                </c:pt>
                <c:pt idx="368">
                  <c:v>960.26599999999996</c:v>
                </c:pt>
                <c:pt idx="369">
                  <c:v>955.49</c:v>
                </c:pt>
                <c:pt idx="370">
                  <c:v>950.74300000000005</c:v>
                </c:pt>
                <c:pt idx="371">
                  <c:v>946.00199999999995</c:v>
                </c:pt>
                <c:pt idx="372">
                  <c:v>941.21699999999998</c:v>
                </c:pt>
                <c:pt idx="373">
                  <c:v>936.37</c:v>
                </c:pt>
                <c:pt idx="374">
                  <c:v>931.60299999999995</c:v>
                </c:pt>
                <c:pt idx="375">
                  <c:v>926.92899999999997</c:v>
                </c:pt>
                <c:pt idx="376">
                  <c:v>922.22799999999995</c:v>
                </c:pt>
                <c:pt idx="377">
                  <c:v>917.41899999999998</c:v>
                </c:pt>
                <c:pt idx="378">
                  <c:v>912.55899999999997</c:v>
                </c:pt>
                <c:pt idx="379">
                  <c:v>907.77099999999996</c:v>
                </c:pt>
                <c:pt idx="380">
                  <c:v>903.06</c:v>
                </c:pt>
                <c:pt idx="381">
                  <c:v>898.41600000000005</c:v>
                </c:pt>
                <c:pt idx="382">
                  <c:v>893.71400000000006</c:v>
                </c:pt>
                <c:pt idx="383">
                  <c:v>889.06700000000001</c:v>
                </c:pt>
                <c:pt idx="384">
                  <c:v>884.44200000000001</c:v>
                </c:pt>
                <c:pt idx="385">
                  <c:v>879.73199999999997</c:v>
                </c:pt>
                <c:pt idx="386">
                  <c:v>875.01599999999996</c:v>
                </c:pt>
                <c:pt idx="387">
                  <c:v>870.40599999999995</c:v>
                </c:pt>
                <c:pt idx="388">
                  <c:v>865.90700000000004</c:v>
                </c:pt>
                <c:pt idx="389">
                  <c:v>861.36900000000003</c:v>
                </c:pt>
                <c:pt idx="390">
                  <c:v>856.69600000000003</c:v>
                </c:pt>
                <c:pt idx="391">
                  <c:v>851.89700000000005</c:v>
                </c:pt>
                <c:pt idx="392">
                  <c:v>847.23</c:v>
                </c:pt>
                <c:pt idx="393">
                  <c:v>842.67499999999995</c:v>
                </c:pt>
                <c:pt idx="394">
                  <c:v>838.19500000000005</c:v>
                </c:pt>
                <c:pt idx="395">
                  <c:v>833.72</c:v>
                </c:pt>
                <c:pt idx="396">
                  <c:v>829.25199999999995</c:v>
                </c:pt>
                <c:pt idx="397">
                  <c:v>824.83</c:v>
                </c:pt>
                <c:pt idx="398">
                  <c:v>820.42100000000005</c:v>
                </c:pt>
                <c:pt idx="399">
                  <c:v>815.88499999999999</c:v>
                </c:pt>
                <c:pt idx="400">
                  <c:v>811.31700000000001</c:v>
                </c:pt>
                <c:pt idx="401">
                  <c:v>806.82500000000005</c:v>
                </c:pt>
                <c:pt idx="402">
                  <c:v>802.34900000000005</c:v>
                </c:pt>
                <c:pt idx="403">
                  <c:v>798.05499999999995</c:v>
                </c:pt>
                <c:pt idx="404">
                  <c:v>793.75599999999997</c:v>
                </c:pt>
                <c:pt idx="405">
                  <c:v>789.39400000000001</c:v>
                </c:pt>
                <c:pt idx="406">
                  <c:v>785.00699999999995</c:v>
                </c:pt>
                <c:pt idx="407">
                  <c:v>780.70899999999995</c:v>
                </c:pt>
                <c:pt idx="408">
                  <c:v>776.34799999999996</c:v>
                </c:pt>
                <c:pt idx="409">
                  <c:v>771.86300000000006</c:v>
                </c:pt>
                <c:pt idx="410">
                  <c:v>767.56600000000003</c:v>
                </c:pt>
                <c:pt idx="411">
                  <c:v>763.40800000000002</c:v>
                </c:pt>
                <c:pt idx="412">
                  <c:v>759.20399999999995</c:v>
                </c:pt>
                <c:pt idx="413">
                  <c:v>754.97199999999998</c:v>
                </c:pt>
                <c:pt idx="414">
                  <c:v>750.78300000000002</c:v>
                </c:pt>
                <c:pt idx="415">
                  <c:v>746.56700000000001</c:v>
                </c:pt>
                <c:pt idx="416">
                  <c:v>742.46</c:v>
                </c:pt>
                <c:pt idx="417">
                  <c:v>738.36699999999996</c:v>
                </c:pt>
                <c:pt idx="418">
                  <c:v>734.20399999999995</c:v>
                </c:pt>
                <c:pt idx="419">
                  <c:v>730.096</c:v>
                </c:pt>
                <c:pt idx="420">
                  <c:v>725.99599999999998</c:v>
                </c:pt>
                <c:pt idx="421">
                  <c:v>721.86</c:v>
                </c:pt>
                <c:pt idx="422">
                  <c:v>717.68899999999996</c:v>
                </c:pt>
                <c:pt idx="423">
                  <c:v>713.58100000000002</c:v>
                </c:pt>
                <c:pt idx="424">
                  <c:v>709.52</c:v>
                </c:pt>
                <c:pt idx="425">
                  <c:v>705.44600000000003</c:v>
                </c:pt>
                <c:pt idx="426">
                  <c:v>701.38800000000003</c:v>
                </c:pt>
                <c:pt idx="427">
                  <c:v>697.39</c:v>
                </c:pt>
                <c:pt idx="428">
                  <c:v>693.34699999999998</c:v>
                </c:pt>
                <c:pt idx="429">
                  <c:v>689.29700000000003</c:v>
                </c:pt>
                <c:pt idx="430">
                  <c:v>685.40800000000002</c:v>
                </c:pt>
                <c:pt idx="431">
                  <c:v>681.56799999999998</c:v>
                </c:pt>
                <c:pt idx="432">
                  <c:v>677.63800000000003</c:v>
                </c:pt>
                <c:pt idx="433">
                  <c:v>673.74300000000005</c:v>
                </c:pt>
                <c:pt idx="434">
                  <c:v>669.98199999999997</c:v>
                </c:pt>
                <c:pt idx="435">
                  <c:v>666.21900000000005</c:v>
                </c:pt>
                <c:pt idx="436">
                  <c:v>662.48599999999999</c:v>
                </c:pt>
                <c:pt idx="437">
                  <c:v>658.81700000000001</c:v>
                </c:pt>
                <c:pt idx="438">
                  <c:v>655.05600000000004</c:v>
                </c:pt>
                <c:pt idx="439">
                  <c:v>651.13699999999994</c:v>
                </c:pt>
                <c:pt idx="440">
                  <c:v>647.255</c:v>
                </c:pt>
                <c:pt idx="441">
                  <c:v>643.42399999999998</c:v>
                </c:pt>
                <c:pt idx="442">
                  <c:v>639.63400000000001</c:v>
                </c:pt>
                <c:pt idx="443">
                  <c:v>635.899</c:v>
                </c:pt>
                <c:pt idx="444">
                  <c:v>632.14200000000005</c:v>
                </c:pt>
                <c:pt idx="445">
                  <c:v>628.447</c:v>
                </c:pt>
                <c:pt idx="446">
                  <c:v>624.86699999999996</c:v>
                </c:pt>
                <c:pt idx="447">
                  <c:v>621.38300000000004</c:v>
                </c:pt>
                <c:pt idx="448">
                  <c:v>617.83399999999995</c:v>
                </c:pt>
                <c:pt idx="449">
                  <c:v>614.18700000000001</c:v>
                </c:pt>
                <c:pt idx="450">
                  <c:v>610.57100000000003</c:v>
                </c:pt>
                <c:pt idx="451">
                  <c:v>607.00699999999995</c:v>
                </c:pt>
                <c:pt idx="452">
                  <c:v>603.43600000000004</c:v>
                </c:pt>
                <c:pt idx="453">
                  <c:v>599.86500000000001</c:v>
                </c:pt>
                <c:pt idx="454">
                  <c:v>596.404</c:v>
                </c:pt>
                <c:pt idx="455">
                  <c:v>592.94899999999996</c:v>
                </c:pt>
                <c:pt idx="456">
                  <c:v>589.48099999999999</c:v>
                </c:pt>
                <c:pt idx="457">
                  <c:v>586.10699999999997</c:v>
                </c:pt>
                <c:pt idx="458">
                  <c:v>582.77300000000002</c:v>
                </c:pt>
                <c:pt idx="459">
                  <c:v>579.45399999999995</c:v>
                </c:pt>
                <c:pt idx="460">
                  <c:v>576.101</c:v>
                </c:pt>
                <c:pt idx="461">
                  <c:v>572.70100000000002</c:v>
                </c:pt>
                <c:pt idx="462">
                  <c:v>569.22900000000004</c:v>
                </c:pt>
                <c:pt idx="463">
                  <c:v>565.77099999999996</c:v>
                </c:pt>
                <c:pt idx="464">
                  <c:v>562.44200000000001</c:v>
                </c:pt>
                <c:pt idx="465">
                  <c:v>559.24099999999999</c:v>
                </c:pt>
                <c:pt idx="466">
                  <c:v>556.08199999999999</c:v>
                </c:pt>
                <c:pt idx="467">
                  <c:v>552.81299999999999</c:v>
                </c:pt>
                <c:pt idx="468">
                  <c:v>549.62800000000004</c:v>
                </c:pt>
                <c:pt idx="469">
                  <c:v>546.48199999999997</c:v>
                </c:pt>
                <c:pt idx="470">
                  <c:v>543.20799999999997</c:v>
                </c:pt>
                <c:pt idx="471">
                  <c:v>539.97400000000005</c:v>
                </c:pt>
                <c:pt idx="472">
                  <c:v>536.71199999999999</c:v>
                </c:pt>
                <c:pt idx="473">
                  <c:v>533.44000000000005</c:v>
                </c:pt>
                <c:pt idx="474">
                  <c:v>530.30600000000004</c:v>
                </c:pt>
                <c:pt idx="475">
                  <c:v>527.27099999999996</c:v>
                </c:pt>
                <c:pt idx="476">
                  <c:v>524.19000000000005</c:v>
                </c:pt>
                <c:pt idx="477">
                  <c:v>521.11800000000005</c:v>
                </c:pt>
                <c:pt idx="478">
                  <c:v>518.14700000000005</c:v>
                </c:pt>
                <c:pt idx="479">
                  <c:v>515.16399999999999</c:v>
                </c:pt>
                <c:pt idx="480">
                  <c:v>512.11300000000006</c:v>
                </c:pt>
                <c:pt idx="481">
                  <c:v>508.99599999999998</c:v>
                </c:pt>
                <c:pt idx="482">
                  <c:v>505.81400000000002</c:v>
                </c:pt>
                <c:pt idx="483">
                  <c:v>502.66399999999999</c:v>
                </c:pt>
                <c:pt idx="484">
                  <c:v>499.54700000000003</c:v>
                </c:pt>
                <c:pt idx="485">
                  <c:v>496.44600000000003</c:v>
                </c:pt>
                <c:pt idx="486">
                  <c:v>493.38200000000001</c:v>
                </c:pt>
                <c:pt idx="487">
                  <c:v>490.44799999999998</c:v>
                </c:pt>
                <c:pt idx="488">
                  <c:v>487.57100000000003</c:v>
                </c:pt>
                <c:pt idx="489">
                  <c:v>484.803</c:v>
                </c:pt>
                <c:pt idx="490">
                  <c:v>482.09500000000003</c:v>
                </c:pt>
                <c:pt idx="491">
                  <c:v>479.505</c:v>
                </c:pt>
                <c:pt idx="492">
                  <c:v>477.11900000000003</c:v>
                </c:pt>
                <c:pt idx="493">
                  <c:v>474.78300000000002</c:v>
                </c:pt>
                <c:pt idx="494">
                  <c:v>472.51100000000002</c:v>
                </c:pt>
                <c:pt idx="495">
                  <c:v>470.44600000000003</c:v>
                </c:pt>
                <c:pt idx="496">
                  <c:v>468.45100000000002</c:v>
                </c:pt>
                <c:pt idx="497">
                  <c:v>466.584</c:v>
                </c:pt>
                <c:pt idx="498">
                  <c:v>464.91899999999998</c:v>
                </c:pt>
                <c:pt idx="499">
                  <c:v>463.37700000000001</c:v>
                </c:pt>
                <c:pt idx="500">
                  <c:v>461.87299999999999</c:v>
                </c:pt>
              </c:numCache>
            </c:numRef>
          </c:yVal>
          <c:smooth val="1"/>
          <c:extLst>
            <c:ext xmlns:c16="http://schemas.microsoft.com/office/drawing/2014/chart" uri="{C3380CC4-5D6E-409C-BE32-E72D297353CC}">
              <c16:uniqueId val="{00000001-5D61-3449-9667-58588BDF454C}"/>
            </c:ext>
          </c:extLst>
        </c:ser>
        <c:ser>
          <c:idx val="3"/>
          <c:order val="2"/>
          <c:tx>
            <c:strRef>
              <c:f>Sheet1!$F$3:$F$4</c:f>
              <c:strCache>
                <c:ptCount val="1"/>
                <c:pt idx="0">
                  <c:v>20 μM</c:v>
                </c:pt>
              </c:strCache>
            </c:strRef>
          </c:tx>
          <c:spPr>
            <a:ln w="19050"/>
          </c:spPr>
          <c:marker>
            <c:symbol val="none"/>
          </c:marker>
          <c:xVal>
            <c:numRef>
              <c:f>Sheet1!$B$5:$B$505</c:f>
              <c:numCache>
                <c:formatCode>General</c:formatCode>
                <c:ptCount val="501"/>
                <c:pt idx="31">
                  <c:v>306</c:v>
                </c:pt>
                <c:pt idx="32">
                  <c:v>306.2</c:v>
                </c:pt>
                <c:pt idx="33">
                  <c:v>306.39999999999998</c:v>
                </c:pt>
                <c:pt idx="34">
                  <c:v>306.60000000000002</c:v>
                </c:pt>
                <c:pt idx="35">
                  <c:v>306.8</c:v>
                </c:pt>
                <c:pt idx="36">
                  <c:v>307</c:v>
                </c:pt>
                <c:pt idx="37">
                  <c:v>307.39999999999998</c:v>
                </c:pt>
                <c:pt idx="38">
                  <c:v>307.60000000000002</c:v>
                </c:pt>
                <c:pt idx="39">
                  <c:v>307.8</c:v>
                </c:pt>
                <c:pt idx="40">
                  <c:v>308</c:v>
                </c:pt>
                <c:pt idx="41">
                  <c:v>308.2</c:v>
                </c:pt>
                <c:pt idx="42">
                  <c:v>308.39999999999998</c:v>
                </c:pt>
                <c:pt idx="43">
                  <c:v>308.60000000000002</c:v>
                </c:pt>
                <c:pt idx="44">
                  <c:v>308.8</c:v>
                </c:pt>
                <c:pt idx="45">
                  <c:v>309</c:v>
                </c:pt>
                <c:pt idx="46">
                  <c:v>309.2</c:v>
                </c:pt>
                <c:pt idx="47">
                  <c:v>309.39999999999998</c:v>
                </c:pt>
                <c:pt idx="48">
                  <c:v>309.60000000000002</c:v>
                </c:pt>
                <c:pt idx="49">
                  <c:v>309.8</c:v>
                </c:pt>
                <c:pt idx="50">
                  <c:v>310</c:v>
                </c:pt>
                <c:pt idx="51">
                  <c:v>310.2</c:v>
                </c:pt>
                <c:pt idx="52">
                  <c:v>310.39999999999998</c:v>
                </c:pt>
                <c:pt idx="53">
                  <c:v>310.60000000000002</c:v>
                </c:pt>
                <c:pt idx="54">
                  <c:v>310.8</c:v>
                </c:pt>
                <c:pt idx="55">
                  <c:v>311</c:v>
                </c:pt>
                <c:pt idx="56">
                  <c:v>311.2</c:v>
                </c:pt>
                <c:pt idx="57">
                  <c:v>311.39999999999998</c:v>
                </c:pt>
                <c:pt idx="58">
                  <c:v>311.60000000000002</c:v>
                </c:pt>
                <c:pt idx="59">
                  <c:v>311.8</c:v>
                </c:pt>
                <c:pt idx="60">
                  <c:v>312</c:v>
                </c:pt>
                <c:pt idx="61">
                  <c:v>312.2</c:v>
                </c:pt>
                <c:pt idx="62">
                  <c:v>312.39999999999998</c:v>
                </c:pt>
                <c:pt idx="63">
                  <c:v>312.60000000000002</c:v>
                </c:pt>
                <c:pt idx="64">
                  <c:v>312.8</c:v>
                </c:pt>
                <c:pt idx="65">
                  <c:v>313</c:v>
                </c:pt>
                <c:pt idx="66">
                  <c:v>313.2</c:v>
                </c:pt>
                <c:pt idx="67">
                  <c:v>313.39999999999998</c:v>
                </c:pt>
                <c:pt idx="68">
                  <c:v>313.60000000000002</c:v>
                </c:pt>
                <c:pt idx="69">
                  <c:v>313.8</c:v>
                </c:pt>
                <c:pt idx="70">
                  <c:v>314</c:v>
                </c:pt>
                <c:pt idx="71">
                  <c:v>314.2</c:v>
                </c:pt>
                <c:pt idx="72">
                  <c:v>314.39999999999998</c:v>
                </c:pt>
                <c:pt idx="73">
                  <c:v>314.60000000000002</c:v>
                </c:pt>
                <c:pt idx="74">
                  <c:v>314.8</c:v>
                </c:pt>
                <c:pt idx="75">
                  <c:v>315</c:v>
                </c:pt>
                <c:pt idx="76">
                  <c:v>315.2</c:v>
                </c:pt>
                <c:pt idx="77">
                  <c:v>315.39999999999998</c:v>
                </c:pt>
                <c:pt idx="78">
                  <c:v>315.60000000000002</c:v>
                </c:pt>
                <c:pt idx="79">
                  <c:v>315.8</c:v>
                </c:pt>
                <c:pt idx="80">
                  <c:v>316</c:v>
                </c:pt>
                <c:pt idx="81">
                  <c:v>316.2</c:v>
                </c:pt>
                <c:pt idx="82">
                  <c:v>316.39999999999998</c:v>
                </c:pt>
                <c:pt idx="83">
                  <c:v>316.60000000000002</c:v>
                </c:pt>
                <c:pt idx="84">
                  <c:v>316.8</c:v>
                </c:pt>
                <c:pt idx="85">
                  <c:v>317</c:v>
                </c:pt>
                <c:pt idx="86">
                  <c:v>317.2</c:v>
                </c:pt>
                <c:pt idx="87">
                  <c:v>317.39999999999998</c:v>
                </c:pt>
                <c:pt idx="88">
                  <c:v>317.60000000000002</c:v>
                </c:pt>
                <c:pt idx="89">
                  <c:v>317.8</c:v>
                </c:pt>
                <c:pt idx="90">
                  <c:v>318</c:v>
                </c:pt>
                <c:pt idx="91">
                  <c:v>318.2</c:v>
                </c:pt>
                <c:pt idx="92">
                  <c:v>318.39999999999998</c:v>
                </c:pt>
                <c:pt idx="93">
                  <c:v>318.60000000000002</c:v>
                </c:pt>
                <c:pt idx="94">
                  <c:v>318.8</c:v>
                </c:pt>
                <c:pt idx="95">
                  <c:v>319</c:v>
                </c:pt>
                <c:pt idx="96">
                  <c:v>319.2</c:v>
                </c:pt>
                <c:pt idx="97">
                  <c:v>319.39999999999998</c:v>
                </c:pt>
                <c:pt idx="98">
                  <c:v>319.60000000000002</c:v>
                </c:pt>
                <c:pt idx="99">
                  <c:v>319.8</c:v>
                </c:pt>
                <c:pt idx="100">
                  <c:v>320</c:v>
                </c:pt>
                <c:pt idx="101">
                  <c:v>320.2</c:v>
                </c:pt>
                <c:pt idx="102">
                  <c:v>320.39999999999998</c:v>
                </c:pt>
                <c:pt idx="103">
                  <c:v>320.60000000000002</c:v>
                </c:pt>
                <c:pt idx="104">
                  <c:v>320.8</c:v>
                </c:pt>
                <c:pt idx="105">
                  <c:v>321</c:v>
                </c:pt>
                <c:pt idx="106">
                  <c:v>321.2</c:v>
                </c:pt>
                <c:pt idx="107">
                  <c:v>321.39999999999998</c:v>
                </c:pt>
                <c:pt idx="108">
                  <c:v>321.60000000000002</c:v>
                </c:pt>
                <c:pt idx="109">
                  <c:v>321.8</c:v>
                </c:pt>
                <c:pt idx="110">
                  <c:v>322</c:v>
                </c:pt>
                <c:pt idx="111">
                  <c:v>322.2</c:v>
                </c:pt>
                <c:pt idx="112">
                  <c:v>322.39999999999998</c:v>
                </c:pt>
                <c:pt idx="113">
                  <c:v>322.60000000000002</c:v>
                </c:pt>
                <c:pt idx="114">
                  <c:v>322.8</c:v>
                </c:pt>
                <c:pt idx="115">
                  <c:v>323</c:v>
                </c:pt>
                <c:pt idx="116">
                  <c:v>323.2</c:v>
                </c:pt>
                <c:pt idx="117">
                  <c:v>323.39999999999998</c:v>
                </c:pt>
                <c:pt idx="118">
                  <c:v>323.60000000000002</c:v>
                </c:pt>
                <c:pt idx="119">
                  <c:v>323.8</c:v>
                </c:pt>
                <c:pt idx="120">
                  <c:v>324</c:v>
                </c:pt>
                <c:pt idx="121">
                  <c:v>324.2</c:v>
                </c:pt>
                <c:pt idx="122">
                  <c:v>324.39999999999998</c:v>
                </c:pt>
                <c:pt idx="123">
                  <c:v>324.60000000000002</c:v>
                </c:pt>
                <c:pt idx="124">
                  <c:v>324.8</c:v>
                </c:pt>
                <c:pt idx="125">
                  <c:v>325</c:v>
                </c:pt>
                <c:pt idx="126">
                  <c:v>325.2</c:v>
                </c:pt>
                <c:pt idx="127">
                  <c:v>325.39999999999998</c:v>
                </c:pt>
                <c:pt idx="128">
                  <c:v>325.60000000000002</c:v>
                </c:pt>
                <c:pt idx="129">
                  <c:v>325.8</c:v>
                </c:pt>
                <c:pt idx="130">
                  <c:v>326</c:v>
                </c:pt>
                <c:pt idx="131">
                  <c:v>326.2</c:v>
                </c:pt>
                <c:pt idx="132">
                  <c:v>326.39999999999998</c:v>
                </c:pt>
                <c:pt idx="133">
                  <c:v>326.60000000000002</c:v>
                </c:pt>
                <c:pt idx="134">
                  <c:v>326.8</c:v>
                </c:pt>
                <c:pt idx="135">
                  <c:v>327</c:v>
                </c:pt>
                <c:pt idx="136">
                  <c:v>327.2</c:v>
                </c:pt>
                <c:pt idx="137">
                  <c:v>327.39999999999998</c:v>
                </c:pt>
                <c:pt idx="138">
                  <c:v>327.60000000000002</c:v>
                </c:pt>
                <c:pt idx="139">
                  <c:v>327.8</c:v>
                </c:pt>
                <c:pt idx="140">
                  <c:v>328</c:v>
                </c:pt>
                <c:pt idx="141">
                  <c:v>328.2</c:v>
                </c:pt>
                <c:pt idx="142">
                  <c:v>328.4</c:v>
                </c:pt>
                <c:pt idx="143">
                  <c:v>328.6</c:v>
                </c:pt>
                <c:pt idx="144">
                  <c:v>328.8</c:v>
                </c:pt>
                <c:pt idx="145">
                  <c:v>329</c:v>
                </c:pt>
                <c:pt idx="146">
                  <c:v>329.2</c:v>
                </c:pt>
                <c:pt idx="147">
                  <c:v>329.4</c:v>
                </c:pt>
                <c:pt idx="148">
                  <c:v>329.6</c:v>
                </c:pt>
                <c:pt idx="149">
                  <c:v>329.8</c:v>
                </c:pt>
                <c:pt idx="150">
                  <c:v>330</c:v>
                </c:pt>
                <c:pt idx="151">
                  <c:v>330.2</c:v>
                </c:pt>
                <c:pt idx="152">
                  <c:v>330.4</c:v>
                </c:pt>
                <c:pt idx="153">
                  <c:v>330.6</c:v>
                </c:pt>
                <c:pt idx="154">
                  <c:v>330.8</c:v>
                </c:pt>
                <c:pt idx="155">
                  <c:v>331</c:v>
                </c:pt>
                <c:pt idx="156">
                  <c:v>331.2</c:v>
                </c:pt>
                <c:pt idx="157">
                  <c:v>331.4</c:v>
                </c:pt>
                <c:pt idx="158">
                  <c:v>331.6</c:v>
                </c:pt>
                <c:pt idx="159">
                  <c:v>331.8</c:v>
                </c:pt>
                <c:pt idx="160">
                  <c:v>332</c:v>
                </c:pt>
                <c:pt idx="161">
                  <c:v>332.2</c:v>
                </c:pt>
                <c:pt idx="162">
                  <c:v>332.4</c:v>
                </c:pt>
                <c:pt idx="163">
                  <c:v>332.6</c:v>
                </c:pt>
                <c:pt idx="164">
                  <c:v>332.8</c:v>
                </c:pt>
                <c:pt idx="165">
                  <c:v>333</c:v>
                </c:pt>
                <c:pt idx="166">
                  <c:v>333.2</c:v>
                </c:pt>
                <c:pt idx="167">
                  <c:v>333.4</c:v>
                </c:pt>
                <c:pt idx="168">
                  <c:v>333.6</c:v>
                </c:pt>
                <c:pt idx="169">
                  <c:v>333.8</c:v>
                </c:pt>
                <c:pt idx="170">
                  <c:v>334</c:v>
                </c:pt>
                <c:pt idx="171">
                  <c:v>334.2</c:v>
                </c:pt>
                <c:pt idx="172">
                  <c:v>334.4</c:v>
                </c:pt>
                <c:pt idx="173">
                  <c:v>334.6</c:v>
                </c:pt>
                <c:pt idx="174">
                  <c:v>334.8</c:v>
                </c:pt>
                <c:pt idx="175">
                  <c:v>335</c:v>
                </c:pt>
                <c:pt idx="176">
                  <c:v>335.2</c:v>
                </c:pt>
                <c:pt idx="177">
                  <c:v>335.4</c:v>
                </c:pt>
                <c:pt idx="178">
                  <c:v>335.6</c:v>
                </c:pt>
                <c:pt idx="179">
                  <c:v>335.8</c:v>
                </c:pt>
                <c:pt idx="180">
                  <c:v>336</c:v>
                </c:pt>
                <c:pt idx="181">
                  <c:v>336.2</c:v>
                </c:pt>
                <c:pt idx="182">
                  <c:v>336.4</c:v>
                </c:pt>
                <c:pt idx="183">
                  <c:v>336.6</c:v>
                </c:pt>
                <c:pt idx="184">
                  <c:v>336.8</c:v>
                </c:pt>
                <c:pt idx="185">
                  <c:v>337</c:v>
                </c:pt>
                <c:pt idx="186">
                  <c:v>337.2</c:v>
                </c:pt>
                <c:pt idx="187">
                  <c:v>337.4</c:v>
                </c:pt>
                <c:pt idx="188">
                  <c:v>337.6</c:v>
                </c:pt>
                <c:pt idx="189">
                  <c:v>337.8</c:v>
                </c:pt>
                <c:pt idx="190">
                  <c:v>338</c:v>
                </c:pt>
                <c:pt idx="191">
                  <c:v>338.2</c:v>
                </c:pt>
                <c:pt idx="192">
                  <c:v>338.4</c:v>
                </c:pt>
                <c:pt idx="193">
                  <c:v>338.6</c:v>
                </c:pt>
                <c:pt idx="194">
                  <c:v>338.8</c:v>
                </c:pt>
                <c:pt idx="195">
                  <c:v>339</c:v>
                </c:pt>
                <c:pt idx="196">
                  <c:v>339.2</c:v>
                </c:pt>
                <c:pt idx="197">
                  <c:v>339.4</c:v>
                </c:pt>
                <c:pt idx="198">
                  <c:v>339.6</c:v>
                </c:pt>
                <c:pt idx="199">
                  <c:v>339.8</c:v>
                </c:pt>
                <c:pt idx="200">
                  <c:v>340</c:v>
                </c:pt>
                <c:pt idx="201">
                  <c:v>340.2</c:v>
                </c:pt>
                <c:pt idx="202">
                  <c:v>340.4</c:v>
                </c:pt>
                <c:pt idx="203">
                  <c:v>340.6</c:v>
                </c:pt>
                <c:pt idx="204">
                  <c:v>340.8</c:v>
                </c:pt>
                <c:pt idx="205">
                  <c:v>341</c:v>
                </c:pt>
                <c:pt idx="206">
                  <c:v>341.2</c:v>
                </c:pt>
                <c:pt idx="207">
                  <c:v>341.4</c:v>
                </c:pt>
                <c:pt idx="208">
                  <c:v>341.6</c:v>
                </c:pt>
                <c:pt idx="209">
                  <c:v>341.8</c:v>
                </c:pt>
                <c:pt idx="210">
                  <c:v>342</c:v>
                </c:pt>
                <c:pt idx="211">
                  <c:v>342.2</c:v>
                </c:pt>
                <c:pt idx="212">
                  <c:v>342.4</c:v>
                </c:pt>
                <c:pt idx="213">
                  <c:v>342.6</c:v>
                </c:pt>
                <c:pt idx="214">
                  <c:v>342.8</c:v>
                </c:pt>
                <c:pt idx="215">
                  <c:v>343</c:v>
                </c:pt>
                <c:pt idx="216">
                  <c:v>343.2</c:v>
                </c:pt>
                <c:pt idx="217">
                  <c:v>343.4</c:v>
                </c:pt>
                <c:pt idx="218">
                  <c:v>343.6</c:v>
                </c:pt>
                <c:pt idx="219">
                  <c:v>343.8</c:v>
                </c:pt>
                <c:pt idx="220">
                  <c:v>344</c:v>
                </c:pt>
                <c:pt idx="221">
                  <c:v>344.2</c:v>
                </c:pt>
                <c:pt idx="222">
                  <c:v>344.4</c:v>
                </c:pt>
                <c:pt idx="223">
                  <c:v>344.6</c:v>
                </c:pt>
                <c:pt idx="224">
                  <c:v>344.8</c:v>
                </c:pt>
                <c:pt idx="225">
                  <c:v>345</c:v>
                </c:pt>
                <c:pt idx="226">
                  <c:v>345.2</c:v>
                </c:pt>
                <c:pt idx="227">
                  <c:v>345.4</c:v>
                </c:pt>
                <c:pt idx="228">
                  <c:v>345.6</c:v>
                </c:pt>
                <c:pt idx="229">
                  <c:v>345.8</c:v>
                </c:pt>
                <c:pt idx="230">
                  <c:v>346</c:v>
                </c:pt>
                <c:pt idx="231">
                  <c:v>346.2</c:v>
                </c:pt>
                <c:pt idx="232">
                  <c:v>346.4</c:v>
                </c:pt>
                <c:pt idx="233">
                  <c:v>346.6</c:v>
                </c:pt>
                <c:pt idx="234">
                  <c:v>346.8</c:v>
                </c:pt>
                <c:pt idx="235">
                  <c:v>347</c:v>
                </c:pt>
                <c:pt idx="236">
                  <c:v>347.2</c:v>
                </c:pt>
                <c:pt idx="237">
                  <c:v>347.4</c:v>
                </c:pt>
                <c:pt idx="238">
                  <c:v>347.6</c:v>
                </c:pt>
                <c:pt idx="239">
                  <c:v>347.8</c:v>
                </c:pt>
                <c:pt idx="240">
                  <c:v>348</c:v>
                </c:pt>
                <c:pt idx="241">
                  <c:v>348.2</c:v>
                </c:pt>
                <c:pt idx="242">
                  <c:v>348.4</c:v>
                </c:pt>
                <c:pt idx="243">
                  <c:v>348.6</c:v>
                </c:pt>
                <c:pt idx="244">
                  <c:v>348.8</c:v>
                </c:pt>
                <c:pt idx="245">
                  <c:v>349</c:v>
                </c:pt>
                <c:pt idx="246">
                  <c:v>349.2</c:v>
                </c:pt>
                <c:pt idx="247">
                  <c:v>349.4</c:v>
                </c:pt>
                <c:pt idx="248">
                  <c:v>349.6</c:v>
                </c:pt>
                <c:pt idx="249">
                  <c:v>349.8</c:v>
                </c:pt>
                <c:pt idx="250">
                  <c:v>350</c:v>
                </c:pt>
                <c:pt idx="251">
                  <c:v>350.2</c:v>
                </c:pt>
                <c:pt idx="252">
                  <c:v>350.4</c:v>
                </c:pt>
                <c:pt idx="253">
                  <c:v>350.6</c:v>
                </c:pt>
                <c:pt idx="254">
                  <c:v>350.8</c:v>
                </c:pt>
                <c:pt idx="255">
                  <c:v>351</c:v>
                </c:pt>
                <c:pt idx="256">
                  <c:v>351.2</c:v>
                </c:pt>
                <c:pt idx="257">
                  <c:v>351.4</c:v>
                </c:pt>
                <c:pt idx="258">
                  <c:v>351.6</c:v>
                </c:pt>
                <c:pt idx="259">
                  <c:v>351.8</c:v>
                </c:pt>
                <c:pt idx="260">
                  <c:v>352</c:v>
                </c:pt>
                <c:pt idx="261">
                  <c:v>352.2</c:v>
                </c:pt>
                <c:pt idx="262">
                  <c:v>352.4</c:v>
                </c:pt>
                <c:pt idx="263">
                  <c:v>352.6</c:v>
                </c:pt>
                <c:pt idx="264">
                  <c:v>352.8</c:v>
                </c:pt>
                <c:pt idx="265">
                  <c:v>353</c:v>
                </c:pt>
                <c:pt idx="266">
                  <c:v>353.2</c:v>
                </c:pt>
                <c:pt idx="267">
                  <c:v>353.4</c:v>
                </c:pt>
                <c:pt idx="268">
                  <c:v>353.6</c:v>
                </c:pt>
                <c:pt idx="269">
                  <c:v>353.8</c:v>
                </c:pt>
                <c:pt idx="270">
                  <c:v>354</c:v>
                </c:pt>
                <c:pt idx="271">
                  <c:v>354.2</c:v>
                </c:pt>
                <c:pt idx="272">
                  <c:v>354.4</c:v>
                </c:pt>
                <c:pt idx="273">
                  <c:v>354.6</c:v>
                </c:pt>
                <c:pt idx="274">
                  <c:v>354.8</c:v>
                </c:pt>
                <c:pt idx="275">
                  <c:v>355</c:v>
                </c:pt>
                <c:pt idx="276">
                  <c:v>355.2</c:v>
                </c:pt>
                <c:pt idx="277">
                  <c:v>355.4</c:v>
                </c:pt>
                <c:pt idx="278">
                  <c:v>355.6</c:v>
                </c:pt>
                <c:pt idx="279">
                  <c:v>355.8</c:v>
                </c:pt>
                <c:pt idx="280">
                  <c:v>356</c:v>
                </c:pt>
                <c:pt idx="281">
                  <c:v>356.2</c:v>
                </c:pt>
                <c:pt idx="282">
                  <c:v>356.4</c:v>
                </c:pt>
                <c:pt idx="283">
                  <c:v>356.6</c:v>
                </c:pt>
                <c:pt idx="284">
                  <c:v>356.8</c:v>
                </c:pt>
                <c:pt idx="285">
                  <c:v>357</c:v>
                </c:pt>
                <c:pt idx="286">
                  <c:v>357.2</c:v>
                </c:pt>
                <c:pt idx="287">
                  <c:v>357.4</c:v>
                </c:pt>
                <c:pt idx="288">
                  <c:v>357.6</c:v>
                </c:pt>
                <c:pt idx="289">
                  <c:v>357.8</c:v>
                </c:pt>
                <c:pt idx="290">
                  <c:v>358</c:v>
                </c:pt>
                <c:pt idx="291">
                  <c:v>358.2</c:v>
                </c:pt>
                <c:pt idx="292">
                  <c:v>358.4</c:v>
                </c:pt>
                <c:pt idx="293">
                  <c:v>358.6</c:v>
                </c:pt>
                <c:pt idx="294">
                  <c:v>358.8</c:v>
                </c:pt>
                <c:pt idx="295">
                  <c:v>359</c:v>
                </c:pt>
                <c:pt idx="296">
                  <c:v>359.2</c:v>
                </c:pt>
                <c:pt idx="297">
                  <c:v>359.4</c:v>
                </c:pt>
                <c:pt idx="298">
                  <c:v>359.6</c:v>
                </c:pt>
                <c:pt idx="299">
                  <c:v>359.8</c:v>
                </c:pt>
                <c:pt idx="300">
                  <c:v>360</c:v>
                </c:pt>
                <c:pt idx="301">
                  <c:v>360.2</c:v>
                </c:pt>
                <c:pt idx="302">
                  <c:v>360.4</c:v>
                </c:pt>
                <c:pt idx="303">
                  <c:v>360.6</c:v>
                </c:pt>
                <c:pt idx="304">
                  <c:v>360.8</c:v>
                </c:pt>
                <c:pt idx="305">
                  <c:v>361</c:v>
                </c:pt>
                <c:pt idx="306">
                  <c:v>361.2</c:v>
                </c:pt>
                <c:pt idx="307">
                  <c:v>361.4</c:v>
                </c:pt>
                <c:pt idx="308">
                  <c:v>361.6</c:v>
                </c:pt>
                <c:pt idx="309">
                  <c:v>361.8</c:v>
                </c:pt>
                <c:pt idx="310">
                  <c:v>362</c:v>
                </c:pt>
                <c:pt idx="311">
                  <c:v>362.2</c:v>
                </c:pt>
                <c:pt idx="312">
                  <c:v>362.4</c:v>
                </c:pt>
                <c:pt idx="313">
                  <c:v>362.6</c:v>
                </c:pt>
                <c:pt idx="314">
                  <c:v>362.8</c:v>
                </c:pt>
                <c:pt idx="315">
                  <c:v>363</c:v>
                </c:pt>
                <c:pt idx="316">
                  <c:v>363.2</c:v>
                </c:pt>
                <c:pt idx="317">
                  <c:v>363.4</c:v>
                </c:pt>
                <c:pt idx="318">
                  <c:v>363.6</c:v>
                </c:pt>
                <c:pt idx="319">
                  <c:v>363.8</c:v>
                </c:pt>
                <c:pt idx="320">
                  <c:v>364</c:v>
                </c:pt>
                <c:pt idx="321">
                  <c:v>364.2</c:v>
                </c:pt>
                <c:pt idx="322">
                  <c:v>364.4</c:v>
                </c:pt>
                <c:pt idx="323">
                  <c:v>364.6</c:v>
                </c:pt>
                <c:pt idx="324">
                  <c:v>364.8</c:v>
                </c:pt>
                <c:pt idx="325">
                  <c:v>365</c:v>
                </c:pt>
                <c:pt idx="326">
                  <c:v>365.2</c:v>
                </c:pt>
                <c:pt idx="327">
                  <c:v>365.4</c:v>
                </c:pt>
                <c:pt idx="328">
                  <c:v>365.6</c:v>
                </c:pt>
                <c:pt idx="329">
                  <c:v>365.8</c:v>
                </c:pt>
                <c:pt idx="330">
                  <c:v>366</c:v>
                </c:pt>
                <c:pt idx="331">
                  <c:v>366.2</c:v>
                </c:pt>
                <c:pt idx="332">
                  <c:v>366.4</c:v>
                </c:pt>
                <c:pt idx="333">
                  <c:v>366.6</c:v>
                </c:pt>
                <c:pt idx="334">
                  <c:v>366.8</c:v>
                </c:pt>
                <c:pt idx="335">
                  <c:v>367</c:v>
                </c:pt>
                <c:pt idx="336">
                  <c:v>367.2</c:v>
                </c:pt>
                <c:pt idx="337">
                  <c:v>367.4</c:v>
                </c:pt>
                <c:pt idx="338">
                  <c:v>367.6</c:v>
                </c:pt>
                <c:pt idx="339">
                  <c:v>367.8</c:v>
                </c:pt>
                <c:pt idx="340">
                  <c:v>368</c:v>
                </c:pt>
                <c:pt idx="341">
                  <c:v>368.2</c:v>
                </c:pt>
                <c:pt idx="342">
                  <c:v>368.4</c:v>
                </c:pt>
                <c:pt idx="343">
                  <c:v>368.6</c:v>
                </c:pt>
                <c:pt idx="344">
                  <c:v>368.8</c:v>
                </c:pt>
                <c:pt idx="345">
                  <c:v>369</c:v>
                </c:pt>
                <c:pt idx="346">
                  <c:v>369.2</c:v>
                </c:pt>
                <c:pt idx="347">
                  <c:v>369.4</c:v>
                </c:pt>
                <c:pt idx="348">
                  <c:v>369.6</c:v>
                </c:pt>
                <c:pt idx="349">
                  <c:v>369.8</c:v>
                </c:pt>
                <c:pt idx="350">
                  <c:v>370</c:v>
                </c:pt>
                <c:pt idx="351">
                  <c:v>370.2</c:v>
                </c:pt>
                <c:pt idx="352">
                  <c:v>370.4</c:v>
                </c:pt>
                <c:pt idx="353">
                  <c:v>370.6</c:v>
                </c:pt>
                <c:pt idx="354">
                  <c:v>370.8</c:v>
                </c:pt>
                <c:pt idx="355">
                  <c:v>371</c:v>
                </c:pt>
                <c:pt idx="356">
                  <c:v>371.2</c:v>
                </c:pt>
                <c:pt idx="357">
                  <c:v>371.4</c:v>
                </c:pt>
                <c:pt idx="358">
                  <c:v>371.6</c:v>
                </c:pt>
                <c:pt idx="359">
                  <c:v>371.8</c:v>
                </c:pt>
                <c:pt idx="360">
                  <c:v>372</c:v>
                </c:pt>
                <c:pt idx="361">
                  <c:v>372.2</c:v>
                </c:pt>
                <c:pt idx="362">
                  <c:v>372.4</c:v>
                </c:pt>
                <c:pt idx="363">
                  <c:v>372.6</c:v>
                </c:pt>
                <c:pt idx="364">
                  <c:v>372.8</c:v>
                </c:pt>
                <c:pt idx="365">
                  <c:v>373</c:v>
                </c:pt>
                <c:pt idx="366">
                  <c:v>373.2</c:v>
                </c:pt>
                <c:pt idx="367">
                  <c:v>373.4</c:v>
                </c:pt>
                <c:pt idx="368">
                  <c:v>373.6</c:v>
                </c:pt>
                <c:pt idx="369">
                  <c:v>373.8</c:v>
                </c:pt>
                <c:pt idx="370">
                  <c:v>374</c:v>
                </c:pt>
                <c:pt idx="371">
                  <c:v>374.2</c:v>
                </c:pt>
                <c:pt idx="372">
                  <c:v>374.4</c:v>
                </c:pt>
                <c:pt idx="373">
                  <c:v>374.6</c:v>
                </c:pt>
                <c:pt idx="374">
                  <c:v>374.8</c:v>
                </c:pt>
                <c:pt idx="375">
                  <c:v>375</c:v>
                </c:pt>
                <c:pt idx="376">
                  <c:v>375.2</c:v>
                </c:pt>
                <c:pt idx="377">
                  <c:v>375.4</c:v>
                </c:pt>
                <c:pt idx="378">
                  <c:v>375.6</c:v>
                </c:pt>
                <c:pt idx="379">
                  <c:v>375.8</c:v>
                </c:pt>
                <c:pt idx="380">
                  <c:v>376</c:v>
                </c:pt>
                <c:pt idx="381">
                  <c:v>376.2</c:v>
                </c:pt>
                <c:pt idx="382">
                  <c:v>376.4</c:v>
                </c:pt>
                <c:pt idx="383">
                  <c:v>376.6</c:v>
                </c:pt>
                <c:pt idx="384">
                  <c:v>376.8</c:v>
                </c:pt>
                <c:pt idx="385">
                  <c:v>377</c:v>
                </c:pt>
                <c:pt idx="386">
                  <c:v>377.2</c:v>
                </c:pt>
                <c:pt idx="387">
                  <c:v>377.4</c:v>
                </c:pt>
                <c:pt idx="388">
                  <c:v>377.6</c:v>
                </c:pt>
                <c:pt idx="389">
                  <c:v>377.8</c:v>
                </c:pt>
                <c:pt idx="390">
                  <c:v>378</c:v>
                </c:pt>
                <c:pt idx="391">
                  <c:v>378.2</c:v>
                </c:pt>
                <c:pt idx="392">
                  <c:v>378.4</c:v>
                </c:pt>
                <c:pt idx="393">
                  <c:v>378.6</c:v>
                </c:pt>
                <c:pt idx="394">
                  <c:v>378.8</c:v>
                </c:pt>
                <c:pt idx="395">
                  <c:v>379</c:v>
                </c:pt>
                <c:pt idx="396">
                  <c:v>379.2</c:v>
                </c:pt>
                <c:pt idx="397">
                  <c:v>379.4</c:v>
                </c:pt>
                <c:pt idx="398">
                  <c:v>379.6</c:v>
                </c:pt>
                <c:pt idx="399">
                  <c:v>379.8</c:v>
                </c:pt>
                <c:pt idx="400">
                  <c:v>380</c:v>
                </c:pt>
                <c:pt idx="401">
                  <c:v>380.2</c:v>
                </c:pt>
                <c:pt idx="402">
                  <c:v>380.4</c:v>
                </c:pt>
                <c:pt idx="403">
                  <c:v>380.6</c:v>
                </c:pt>
                <c:pt idx="404">
                  <c:v>380.8</c:v>
                </c:pt>
                <c:pt idx="405">
                  <c:v>381</c:v>
                </c:pt>
                <c:pt idx="406">
                  <c:v>381.2</c:v>
                </c:pt>
                <c:pt idx="407">
                  <c:v>381.4</c:v>
                </c:pt>
                <c:pt idx="408">
                  <c:v>381.6</c:v>
                </c:pt>
                <c:pt idx="409">
                  <c:v>381.8</c:v>
                </c:pt>
                <c:pt idx="410">
                  <c:v>382</c:v>
                </c:pt>
                <c:pt idx="411">
                  <c:v>382.2</c:v>
                </c:pt>
                <c:pt idx="412">
                  <c:v>382.4</c:v>
                </c:pt>
                <c:pt idx="413">
                  <c:v>382.6</c:v>
                </c:pt>
                <c:pt idx="414">
                  <c:v>382.8</c:v>
                </c:pt>
                <c:pt idx="415">
                  <c:v>383</c:v>
                </c:pt>
                <c:pt idx="416">
                  <c:v>383.2</c:v>
                </c:pt>
                <c:pt idx="417">
                  <c:v>383.4</c:v>
                </c:pt>
                <c:pt idx="418">
                  <c:v>383.6</c:v>
                </c:pt>
                <c:pt idx="419">
                  <c:v>383.8</c:v>
                </c:pt>
                <c:pt idx="420">
                  <c:v>384</c:v>
                </c:pt>
                <c:pt idx="421">
                  <c:v>384.2</c:v>
                </c:pt>
                <c:pt idx="422">
                  <c:v>384.4</c:v>
                </c:pt>
                <c:pt idx="423">
                  <c:v>384.6</c:v>
                </c:pt>
                <c:pt idx="424">
                  <c:v>384.8</c:v>
                </c:pt>
                <c:pt idx="425">
                  <c:v>385</c:v>
                </c:pt>
                <c:pt idx="426">
                  <c:v>385.2</c:v>
                </c:pt>
                <c:pt idx="427">
                  <c:v>385.4</c:v>
                </c:pt>
                <c:pt idx="428">
                  <c:v>385.6</c:v>
                </c:pt>
                <c:pt idx="429">
                  <c:v>385.8</c:v>
                </c:pt>
                <c:pt idx="430">
                  <c:v>386</c:v>
                </c:pt>
                <c:pt idx="431">
                  <c:v>386.2</c:v>
                </c:pt>
                <c:pt idx="432">
                  <c:v>386.4</c:v>
                </c:pt>
                <c:pt idx="433">
                  <c:v>386.6</c:v>
                </c:pt>
                <c:pt idx="434">
                  <c:v>386.8</c:v>
                </c:pt>
                <c:pt idx="435">
                  <c:v>387</c:v>
                </c:pt>
                <c:pt idx="436">
                  <c:v>387.2</c:v>
                </c:pt>
                <c:pt idx="437">
                  <c:v>387.4</c:v>
                </c:pt>
                <c:pt idx="438">
                  <c:v>387.6</c:v>
                </c:pt>
                <c:pt idx="439">
                  <c:v>387.8</c:v>
                </c:pt>
                <c:pt idx="440">
                  <c:v>388</c:v>
                </c:pt>
                <c:pt idx="441">
                  <c:v>388.2</c:v>
                </c:pt>
                <c:pt idx="442">
                  <c:v>388.4</c:v>
                </c:pt>
                <c:pt idx="443">
                  <c:v>388.6</c:v>
                </c:pt>
                <c:pt idx="444">
                  <c:v>388.8</c:v>
                </c:pt>
                <c:pt idx="445">
                  <c:v>389</c:v>
                </c:pt>
                <c:pt idx="446">
                  <c:v>389.2</c:v>
                </c:pt>
                <c:pt idx="447">
                  <c:v>389.4</c:v>
                </c:pt>
                <c:pt idx="448">
                  <c:v>389.6</c:v>
                </c:pt>
                <c:pt idx="449">
                  <c:v>389.8</c:v>
                </c:pt>
                <c:pt idx="450">
                  <c:v>390</c:v>
                </c:pt>
                <c:pt idx="451">
                  <c:v>390.2</c:v>
                </c:pt>
                <c:pt idx="452">
                  <c:v>390.4</c:v>
                </c:pt>
                <c:pt idx="453">
                  <c:v>390.6</c:v>
                </c:pt>
                <c:pt idx="454">
                  <c:v>390.8</c:v>
                </c:pt>
                <c:pt idx="455">
                  <c:v>391</c:v>
                </c:pt>
                <c:pt idx="456">
                  <c:v>391.2</c:v>
                </c:pt>
                <c:pt idx="457">
                  <c:v>391.4</c:v>
                </c:pt>
                <c:pt idx="458">
                  <c:v>391.6</c:v>
                </c:pt>
                <c:pt idx="459">
                  <c:v>391.8</c:v>
                </c:pt>
                <c:pt idx="460">
                  <c:v>392</c:v>
                </c:pt>
                <c:pt idx="461">
                  <c:v>392.2</c:v>
                </c:pt>
                <c:pt idx="462">
                  <c:v>392.4</c:v>
                </c:pt>
                <c:pt idx="463">
                  <c:v>392.6</c:v>
                </c:pt>
                <c:pt idx="464">
                  <c:v>392.8</c:v>
                </c:pt>
                <c:pt idx="465">
                  <c:v>393</c:v>
                </c:pt>
                <c:pt idx="466">
                  <c:v>393.2</c:v>
                </c:pt>
                <c:pt idx="467">
                  <c:v>393.4</c:v>
                </c:pt>
                <c:pt idx="468">
                  <c:v>393.6</c:v>
                </c:pt>
                <c:pt idx="469">
                  <c:v>393.8</c:v>
                </c:pt>
                <c:pt idx="470">
                  <c:v>394</c:v>
                </c:pt>
                <c:pt idx="471">
                  <c:v>394.2</c:v>
                </c:pt>
                <c:pt idx="472">
                  <c:v>394.4</c:v>
                </c:pt>
                <c:pt idx="473">
                  <c:v>394.6</c:v>
                </c:pt>
                <c:pt idx="474">
                  <c:v>394.8</c:v>
                </c:pt>
                <c:pt idx="475">
                  <c:v>395</c:v>
                </c:pt>
                <c:pt idx="476">
                  <c:v>395.2</c:v>
                </c:pt>
                <c:pt idx="477">
                  <c:v>395.4</c:v>
                </c:pt>
                <c:pt idx="478">
                  <c:v>395.6</c:v>
                </c:pt>
                <c:pt idx="479">
                  <c:v>395.8</c:v>
                </c:pt>
                <c:pt idx="480">
                  <c:v>396</c:v>
                </c:pt>
                <c:pt idx="481">
                  <c:v>396.2</c:v>
                </c:pt>
                <c:pt idx="482">
                  <c:v>396.4</c:v>
                </c:pt>
                <c:pt idx="483">
                  <c:v>396.6</c:v>
                </c:pt>
                <c:pt idx="484">
                  <c:v>396.8</c:v>
                </c:pt>
                <c:pt idx="485">
                  <c:v>397</c:v>
                </c:pt>
                <c:pt idx="486">
                  <c:v>397.2</c:v>
                </c:pt>
                <c:pt idx="487">
                  <c:v>397.4</c:v>
                </c:pt>
                <c:pt idx="488">
                  <c:v>397.6</c:v>
                </c:pt>
                <c:pt idx="489">
                  <c:v>397.8</c:v>
                </c:pt>
                <c:pt idx="490">
                  <c:v>398</c:v>
                </c:pt>
                <c:pt idx="491">
                  <c:v>398.2</c:v>
                </c:pt>
                <c:pt idx="492">
                  <c:v>398.4</c:v>
                </c:pt>
                <c:pt idx="493">
                  <c:v>398.6</c:v>
                </c:pt>
                <c:pt idx="494">
                  <c:v>398.8</c:v>
                </c:pt>
                <c:pt idx="495">
                  <c:v>399</c:v>
                </c:pt>
                <c:pt idx="496">
                  <c:v>399.2</c:v>
                </c:pt>
                <c:pt idx="497">
                  <c:v>399.4</c:v>
                </c:pt>
                <c:pt idx="498">
                  <c:v>399.6</c:v>
                </c:pt>
                <c:pt idx="499">
                  <c:v>399.8</c:v>
                </c:pt>
                <c:pt idx="500">
                  <c:v>400</c:v>
                </c:pt>
              </c:numCache>
            </c:numRef>
          </c:xVal>
          <c:yVal>
            <c:numRef>
              <c:f>Sheet1!$F$5:$F$505</c:f>
              <c:numCache>
                <c:formatCode>General</c:formatCode>
                <c:ptCount val="501"/>
                <c:pt idx="31">
                  <c:v>319.51900000000001</c:v>
                </c:pt>
                <c:pt idx="32">
                  <c:v>318.04599999999999</c:v>
                </c:pt>
                <c:pt idx="33">
                  <c:v>318.56099999999998</c:v>
                </c:pt>
                <c:pt idx="34">
                  <c:v>320.62200000000001</c:v>
                </c:pt>
                <c:pt idx="35">
                  <c:v>323.88200000000001</c:v>
                </c:pt>
                <c:pt idx="36">
                  <c:v>328.00799999999998</c:v>
                </c:pt>
                <c:pt idx="37">
                  <c:v>338.09</c:v>
                </c:pt>
                <c:pt idx="38">
                  <c:v>343.78399999999999</c:v>
                </c:pt>
                <c:pt idx="39">
                  <c:v>349.654</c:v>
                </c:pt>
                <c:pt idx="40">
                  <c:v>355.68799999999999</c:v>
                </c:pt>
                <c:pt idx="41">
                  <c:v>362.005</c:v>
                </c:pt>
                <c:pt idx="42">
                  <c:v>368.45100000000002</c:v>
                </c:pt>
                <c:pt idx="43">
                  <c:v>374.86099999999999</c:v>
                </c:pt>
                <c:pt idx="44">
                  <c:v>381.46100000000001</c:v>
                </c:pt>
                <c:pt idx="45">
                  <c:v>388.19400000000002</c:v>
                </c:pt>
                <c:pt idx="46">
                  <c:v>394.87400000000002</c:v>
                </c:pt>
                <c:pt idx="47">
                  <c:v>401.63099999999997</c:v>
                </c:pt>
                <c:pt idx="48">
                  <c:v>408.45699999999999</c:v>
                </c:pt>
                <c:pt idx="49">
                  <c:v>415.33199999999999</c:v>
                </c:pt>
                <c:pt idx="50">
                  <c:v>422.24700000000001</c:v>
                </c:pt>
                <c:pt idx="51">
                  <c:v>429.22500000000002</c:v>
                </c:pt>
                <c:pt idx="52">
                  <c:v>436.35700000000003</c:v>
                </c:pt>
                <c:pt idx="53">
                  <c:v>443.49799999999999</c:v>
                </c:pt>
                <c:pt idx="54">
                  <c:v>450.65300000000002</c:v>
                </c:pt>
                <c:pt idx="55">
                  <c:v>457.904</c:v>
                </c:pt>
                <c:pt idx="56">
                  <c:v>465.19900000000001</c:v>
                </c:pt>
                <c:pt idx="57">
                  <c:v>472.55799999999999</c:v>
                </c:pt>
                <c:pt idx="58">
                  <c:v>480.017</c:v>
                </c:pt>
                <c:pt idx="59">
                  <c:v>487.48899999999998</c:v>
                </c:pt>
                <c:pt idx="60">
                  <c:v>494.87</c:v>
                </c:pt>
                <c:pt idx="61">
                  <c:v>502.27300000000002</c:v>
                </c:pt>
                <c:pt idx="62">
                  <c:v>509.75599999999997</c:v>
                </c:pt>
                <c:pt idx="63">
                  <c:v>517.298</c:v>
                </c:pt>
                <c:pt idx="64">
                  <c:v>524.86300000000006</c:v>
                </c:pt>
                <c:pt idx="65">
                  <c:v>532.49199999999996</c:v>
                </c:pt>
                <c:pt idx="66">
                  <c:v>540.101</c:v>
                </c:pt>
                <c:pt idx="67">
                  <c:v>547.70799999999997</c:v>
                </c:pt>
                <c:pt idx="68">
                  <c:v>555.42999999999995</c:v>
                </c:pt>
                <c:pt idx="69">
                  <c:v>563.12</c:v>
                </c:pt>
                <c:pt idx="70">
                  <c:v>570.77599999999995</c:v>
                </c:pt>
                <c:pt idx="71">
                  <c:v>578.41499999999996</c:v>
                </c:pt>
                <c:pt idx="72">
                  <c:v>586.09500000000003</c:v>
                </c:pt>
                <c:pt idx="73">
                  <c:v>593.798</c:v>
                </c:pt>
                <c:pt idx="74">
                  <c:v>601.38199999999995</c:v>
                </c:pt>
                <c:pt idx="75">
                  <c:v>608.96199999999999</c:v>
                </c:pt>
                <c:pt idx="76">
                  <c:v>616.55399999999997</c:v>
                </c:pt>
                <c:pt idx="77">
                  <c:v>624.10799999999995</c:v>
                </c:pt>
                <c:pt idx="78">
                  <c:v>631.72400000000005</c:v>
                </c:pt>
                <c:pt idx="79">
                  <c:v>639.46600000000001</c:v>
                </c:pt>
                <c:pt idx="80">
                  <c:v>647.26400000000001</c:v>
                </c:pt>
                <c:pt idx="81">
                  <c:v>655.00300000000004</c:v>
                </c:pt>
                <c:pt idx="82">
                  <c:v>662.68799999999999</c:v>
                </c:pt>
                <c:pt idx="83">
                  <c:v>670.35900000000004</c:v>
                </c:pt>
                <c:pt idx="84">
                  <c:v>677.98299999999995</c:v>
                </c:pt>
                <c:pt idx="85">
                  <c:v>685.71699999999998</c:v>
                </c:pt>
                <c:pt idx="86">
                  <c:v>693.62599999999998</c:v>
                </c:pt>
                <c:pt idx="87">
                  <c:v>701.42700000000002</c:v>
                </c:pt>
                <c:pt idx="88">
                  <c:v>709.14800000000002</c:v>
                </c:pt>
                <c:pt idx="89">
                  <c:v>716.93100000000004</c:v>
                </c:pt>
                <c:pt idx="90">
                  <c:v>724.77099999999996</c:v>
                </c:pt>
                <c:pt idx="91">
                  <c:v>732.60900000000004</c:v>
                </c:pt>
                <c:pt idx="92">
                  <c:v>740.52200000000005</c:v>
                </c:pt>
                <c:pt idx="93">
                  <c:v>748.58900000000006</c:v>
                </c:pt>
                <c:pt idx="94">
                  <c:v>756.71799999999996</c:v>
                </c:pt>
                <c:pt idx="95">
                  <c:v>764.89800000000002</c:v>
                </c:pt>
                <c:pt idx="96">
                  <c:v>773.23199999999997</c:v>
                </c:pt>
                <c:pt idx="97">
                  <c:v>781.56700000000001</c:v>
                </c:pt>
                <c:pt idx="98">
                  <c:v>789.92899999999997</c:v>
                </c:pt>
                <c:pt idx="99">
                  <c:v>798.45500000000004</c:v>
                </c:pt>
                <c:pt idx="100">
                  <c:v>807.02</c:v>
                </c:pt>
                <c:pt idx="101">
                  <c:v>815.7</c:v>
                </c:pt>
                <c:pt idx="102">
                  <c:v>824.44600000000003</c:v>
                </c:pt>
                <c:pt idx="103">
                  <c:v>833.27200000000005</c:v>
                </c:pt>
                <c:pt idx="104">
                  <c:v>842.10400000000004</c:v>
                </c:pt>
                <c:pt idx="105">
                  <c:v>850.89400000000001</c:v>
                </c:pt>
                <c:pt idx="106">
                  <c:v>859.80799999999999</c:v>
                </c:pt>
                <c:pt idx="107">
                  <c:v>868.90200000000004</c:v>
                </c:pt>
                <c:pt idx="108">
                  <c:v>878.08199999999999</c:v>
                </c:pt>
                <c:pt idx="109">
                  <c:v>887.43299999999999</c:v>
                </c:pt>
                <c:pt idx="110">
                  <c:v>896.81299999999999</c:v>
                </c:pt>
                <c:pt idx="111">
                  <c:v>906.02200000000005</c:v>
                </c:pt>
                <c:pt idx="112">
                  <c:v>915.33500000000004</c:v>
                </c:pt>
                <c:pt idx="113">
                  <c:v>924.779</c:v>
                </c:pt>
                <c:pt idx="114">
                  <c:v>934.21799999999996</c:v>
                </c:pt>
                <c:pt idx="115">
                  <c:v>943.625</c:v>
                </c:pt>
                <c:pt idx="116">
                  <c:v>953.23800000000006</c:v>
                </c:pt>
                <c:pt idx="117">
                  <c:v>962.81299999999999</c:v>
                </c:pt>
                <c:pt idx="118">
                  <c:v>972.17700000000002</c:v>
                </c:pt>
                <c:pt idx="119">
                  <c:v>981.45100000000002</c:v>
                </c:pt>
                <c:pt idx="120">
                  <c:v>990.77800000000002</c:v>
                </c:pt>
                <c:pt idx="121">
                  <c:v>1000.11</c:v>
                </c:pt>
                <c:pt idx="122">
                  <c:v>1009.24</c:v>
                </c:pt>
                <c:pt idx="123">
                  <c:v>1018.32</c:v>
                </c:pt>
                <c:pt idx="124">
                  <c:v>1027.33</c:v>
                </c:pt>
                <c:pt idx="125">
                  <c:v>1036.42</c:v>
                </c:pt>
                <c:pt idx="126">
                  <c:v>1045.3499999999999</c:v>
                </c:pt>
                <c:pt idx="127">
                  <c:v>1053.98</c:v>
                </c:pt>
                <c:pt idx="128">
                  <c:v>1062.52</c:v>
                </c:pt>
                <c:pt idx="129">
                  <c:v>1070.95</c:v>
                </c:pt>
                <c:pt idx="130">
                  <c:v>1079.28</c:v>
                </c:pt>
                <c:pt idx="131">
                  <c:v>1087.47</c:v>
                </c:pt>
                <c:pt idx="132">
                  <c:v>1095.52</c:v>
                </c:pt>
                <c:pt idx="133">
                  <c:v>1103.4000000000001</c:v>
                </c:pt>
                <c:pt idx="134">
                  <c:v>1111.0899999999999</c:v>
                </c:pt>
                <c:pt idx="135">
                  <c:v>1118.6199999999999</c:v>
                </c:pt>
                <c:pt idx="136">
                  <c:v>1125.99</c:v>
                </c:pt>
                <c:pt idx="137">
                  <c:v>1133.1400000000001</c:v>
                </c:pt>
                <c:pt idx="138">
                  <c:v>1140.02</c:v>
                </c:pt>
                <c:pt idx="139">
                  <c:v>1146.74</c:v>
                </c:pt>
                <c:pt idx="140">
                  <c:v>1153.33</c:v>
                </c:pt>
                <c:pt idx="141">
                  <c:v>1159.53</c:v>
                </c:pt>
                <c:pt idx="142">
                  <c:v>1165.75</c:v>
                </c:pt>
                <c:pt idx="143">
                  <c:v>1171.94</c:v>
                </c:pt>
                <c:pt idx="144">
                  <c:v>1177.77</c:v>
                </c:pt>
                <c:pt idx="145">
                  <c:v>1183.46</c:v>
                </c:pt>
                <c:pt idx="146">
                  <c:v>1189.04</c:v>
                </c:pt>
                <c:pt idx="147">
                  <c:v>1194.52</c:v>
                </c:pt>
                <c:pt idx="148">
                  <c:v>1199.75</c:v>
                </c:pt>
                <c:pt idx="149">
                  <c:v>1204.8499999999999</c:v>
                </c:pt>
                <c:pt idx="150">
                  <c:v>1209.76</c:v>
                </c:pt>
                <c:pt idx="151">
                  <c:v>1214.68</c:v>
                </c:pt>
                <c:pt idx="152">
                  <c:v>1219.68</c:v>
                </c:pt>
                <c:pt idx="153">
                  <c:v>1224.3900000000001</c:v>
                </c:pt>
                <c:pt idx="154">
                  <c:v>1228.9100000000001</c:v>
                </c:pt>
                <c:pt idx="155">
                  <c:v>1233.3</c:v>
                </c:pt>
                <c:pt idx="156">
                  <c:v>1237.6199999999999</c:v>
                </c:pt>
                <c:pt idx="157">
                  <c:v>1241.8399999999999</c:v>
                </c:pt>
                <c:pt idx="158">
                  <c:v>1245.95</c:v>
                </c:pt>
                <c:pt idx="159">
                  <c:v>1249.99</c:v>
                </c:pt>
                <c:pt idx="160">
                  <c:v>1253.98</c:v>
                </c:pt>
                <c:pt idx="161">
                  <c:v>1258.0999999999999</c:v>
                </c:pt>
                <c:pt idx="162">
                  <c:v>1262.21</c:v>
                </c:pt>
                <c:pt idx="163">
                  <c:v>1266.1199999999999</c:v>
                </c:pt>
                <c:pt idx="164">
                  <c:v>1269.98</c:v>
                </c:pt>
                <c:pt idx="165">
                  <c:v>1273.8399999999999</c:v>
                </c:pt>
                <c:pt idx="166">
                  <c:v>1277.8699999999999</c:v>
                </c:pt>
                <c:pt idx="167">
                  <c:v>1281.7</c:v>
                </c:pt>
                <c:pt idx="168">
                  <c:v>1285.27</c:v>
                </c:pt>
                <c:pt idx="169">
                  <c:v>1288.99</c:v>
                </c:pt>
                <c:pt idx="170">
                  <c:v>1292.6500000000001</c:v>
                </c:pt>
                <c:pt idx="171">
                  <c:v>1296.22</c:v>
                </c:pt>
                <c:pt idx="172">
                  <c:v>1299.8900000000001</c:v>
                </c:pt>
                <c:pt idx="173">
                  <c:v>1303.72</c:v>
                </c:pt>
                <c:pt idx="174">
                  <c:v>1307.43</c:v>
                </c:pt>
                <c:pt idx="175">
                  <c:v>1310.88</c:v>
                </c:pt>
                <c:pt idx="176">
                  <c:v>1314.28</c:v>
                </c:pt>
                <c:pt idx="177">
                  <c:v>1317.59</c:v>
                </c:pt>
                <c:pt idx="178">
                  <c:v>1320.88</c:v>
                </c:pt>
                <c:pt idx="179">
                  <c:v>1324.15</c:v>
                </c:pt>
                <c:pt idx="180">
                  <c:v>1327.39</c:v>
                </c:pt>
                <c:pt idx="181">
                  <c:v>1330.72</c:v>
                </c:pt>
                <c:pt idx="182">
                  <c:v>1333.98</c:v>
                </c:pt>
                <c:pt idx="183">
                  <c:v>1337.24</c:v>
                </c:pt>
                <c:pt idx="184">
                  <c:v>1340.42</c:v>
                </c:pt>
                <c:pt idx="185">
                  <c:v>1343.48</c:v>
                </c:pt>
                <c:pt idx="186">
                  <c:v>1346.31</c:v>
                </c:pt>
                <c:pt idx="187">
                  <c:v>1348.97</c:v>
                </c:pt>
                <c:pt idx="188">
                  <c:v>1351.64</c:v>
                </c:pt>
                <c:pt idx="189">
                  <c:v>1354.32</c:v>
                </c:pt>
                <c:pt idx="190">
                  <c:v>1357</c:v>
                </c:pt>
                <c:pt idx="191">
                  <c:v>1359.41</c:v>
                </c:pt>
                <c:pt idx="192">
                  <c:v>1361.65</c:v>
                </c:pt>
                <c:pt idx="193">
                  <c:v>1363.87</c:v>
                </c:pt>
                <c:pt idx="194">
                  <c:v>1366.1</c:v>
                </c:pt>
                <c:pt idx="195">
                  <c:v>1368.37</c:v>
                </c:pt>
                <c:pt idx="196">
                  <c:v>1370.43</c:v>
                </c:pt>
                <c:pt idx="197">
                  <c:v>1372.35</c:v>
                </c:pt>
                <c:pt idx="198">
                  <c:v>1374.07</c:v>
                </c:pt>
                <c:pt idx="199">
                  <c:v>1375.57</c:v>
                </c:pt>
                <c:pt idx="200">
                  <c:v>1377.19</c:v>
                </c:pt>
                <c:pt idx="201">
                  <c:v>1378.78</c:v>
                </c:pt>
                <c:pt idx="202">
                  <c:v>1380.26</c:v>
                </c:pt>
                <c:pt idx="203">
                  <c:v>1381.57</c:v>
                </c:pt>
                <c:pt idx="204">
                  <c:v>1382.98</c:v>
                </c:pt>
                <c:pt idx="205">
                  <c:v>1384.37</c:v>
                </c:pt>
                <c:pt idx="206">
                  <c:v>1385.44</c:v>
                </c:pt>
                <c:pt idx="207">
                  <c:v>1386.25</c:v>
                </c:pt>
                <c:pt idx="208">
                  <c:v>1386.78</c:v>
                </c:pt>
                <c:pt idx="209">
                  <c:v>1387.27</c:v>
                </c:pt>
                <c:pt idx="210">
                  <c:v>1387.8</c:v>
                </c:pt>
                <c:pt idx="211">
                  <c:v>1388.3</c:v>
                </c:pt>
                <c:pt idx="212">
                  <c:v>1388.69</c:v>
                </c:pt>
                <c:pt idx="213">
                  <c:v>1389.08</c:v>
                </c:pt>
                <c:pt idx="214">
                  <c:v>1389.35</c:v>
                </c:pt>
                <c:pt idx="215">
                  <c:v>1389.39</c:v>
                </c:pt>
                <c:pt idx="216">
                  <c:v>1389.43</c:v>
                </c:pt>
                <c:pt idx="217">
                  <c:v>1389.55</c:v>
                </c:pt>
                <c:pt idx="218">
                  <c:v>1389.67</c:v>
                </c:pt>
                <c:pt idx="219">
                  <c:v>1389.46</c:v>
                </c:pt>
                <c:pt idx="220">
                  <c:v>1389.05</c:v>
                </c:pt>
                <c:pt idx="221">
                  <c:v>1388.66</c:v>
                </c:pt>
                <c:pt idx="222">
                  <c:v>1388.14</c:v>
                </c:pt>
                <c:pt idx="223">
                  <c:v>1387.57</c:v>
                </c:pt>
                <c:pt idx="224">
                  <c:v>1387.14</c:v>
                </c:pt>
                <c:pt idx="225">
                  <c:v>1386.71</c:v>
                </c:pt>
                <c:pt idx="226">
                  <c:v>1386.12</c:v>
                </c:pt>
                <c:pt idx="227">
                  <c:v>1385.32</c:v>
                </c:pt>
                <c:pt idx="228">
                  <c:v>1384.47</c:v>
                </c:pt>
                <c:pt idx="229">
                  <c:v>1383.57</c:v>
                </c:pt>
                <c:pt idx="230">
                  <c:v>1382.55</c:v>
                </c:pt>
                <c:pt idx="231">
                  <c:v>1381.47</c:v>
                </c:pt>
                <c:pt idx="232">
                  <c:v>1380.49</c:v>
                </c:pt>
                <c:pt idx="233">
                  <c:v>1379.62</c:v>
                </c:pt>
                <c:pt idx="234">
                  <c:v>1378.68</c:v>
                </c:pt>
                <c:pt idx="235">
                  <c:v>1377.41</c:v>
                </c:pt>
                <c:pt idx="236">
                  <c:v>1376.08</c:v>
                </c:pt>
                <c:pt idx="237">
                  <c:v>1375.01</c:v>
                </c:pt>
                <c:pt idx="238">
                  <c:v>1373.92</c:v>
                </c:pt>
                <c:pt idx="239">
                  <c:v>1372.65</c:v>
                </c:pt>
                <c:pt idx="240">
                  <c:v>1371.27</c:v>
                </c:pt>
                <c:pt idx="241">
                  <c:v>1369.85</c:v>
                </c:pt>
                <c:pt idx="242">
                  <c:v>1368.19</c:v>
                </c:pt>
                <c:pt idx="243">
                  <c:v>1366.54</c:v>
                </c:pt>
                <c:pt idx="244">
                  <c:v>1365.15</c:v>
                </c:pt>
                <c:pt idx="245">
                  <c:v>1363.86</c:v>
                </c:pt>
                <c:pt idx="246">
                  <c:v>1362.59</c:v>
                </c:pt>
                <c:pt idx="247">
                  <c:v>1361.21</c:v>
                </c:pt>
                <c:pt idx="248">
                  <c:v>1359.74</c:v>
                </c:pt>
                <c:pt idx="249">
                  <c:v>1358.15</c:v>
                </c:pt>
                <c:pt idx="250">
                  <c:v>1356.29</c:v>
                </c:pt>
                <c:pt idx="251">
                  <c:v>1354.3</c:v>
                </c:pt>
                <c:pt idx="252">
                  <c:v>1352.49</c:v>
                </c:pt>
                <c:pt idx="253">
                  <c:v>1350.73</c:v>
                </c:pt>
                <c:pt idx="254">
                  <c:v>1348.86</c:v>
                </c:pt>
                <c:pt idx="255">
                  <c:v>1346.97</c:v>
                </c:pt>
                <c:pt idx="256">
                  <c:v>1345.07</c:v>
                </c:pt>
                <c:pt idx="257">
                  <c:v>1343.03</c:v>
                </c:pt>
                <c:pt idx="258">
                  <c:v>1340.85</c:v>
                </c:pt>
                <c:pt idx="259">
                  <c:v>1338.61</c:v>
                </c:pt>
                <c:pt idx="260">
                  <c:v>1336.45</c:v>
                </c:pt>
                <c:pt idx="261">
                  <c:v>1334.27</c:v>
                </c:pt>
                <c:pt idx="262">
                  <c:v>1331.98</c:v>
                </c:pt>
                <c:pt idx="263">
                  <c:v>1329.7</c:v>
                </c:pt>
                <c:pt idx="264">
                  <c:v>1327.38</c:v>
                </c:pt>
                <c:pt idx="265">
                  <c:v>1324.92</c:v>
                </c:pt>
                <c:pt idx="266">
                  <c:v>1322.27</c:v>
                </c:pt>
                <c:pt idx="267">
                  <c:v>1319.64</c:v>
                </c:pt>
                <c:pt idx="268">
                  <c:v>1317</c:v>
                </c:pt>
                <c:pt idx="269">
                  <c:v>1314.28</c:v>
                </c:pt>
                <c:pt idx="270">
                  <c:v>1311.41</c:v>
                </c:pt>
                <c:pt idx="271">
                  <c:v>1308.4000000000001</c:v>
                </c:pt>
                <c:pt idx="272">
                  <c:v>1305.3399999999999</c:v>
                </c:pt>
                <c:pt idx="273">
                  <c:v>1302.21</c:v>
                </c:pt>
                <c:pt idx="274">
                  <c:v>1299.1199999999999</c:v>
                </c:pt>
                <c:pt idx="275">
                  <c:v>1296.1199999999999</c:v>
                </c:pt>
                <c:pt idx="276">
                  <c:v>1293.19</c:v>
                </c:pt>
                <c:pt idx="277">
                  <c:v>1290.18</c:v>
                </c:pt>
                <c:pt idx="278">
                  <c:v>1287.1600000000001</c:v>
                </c:pt>
                <c:pt idx="279">
                  <c:v>1284.04</c:v>
                </c:pt>
                <c:pt idx="280">
                  <c:v>1280.8</c:v>
                </c:pt>
                <c:pt idx="281">
                  <c:v>1277.54</c:v>
                </c:pt>
                <c:pt idx="282">
                  <c:v>1274.23</c:v>
                </c:pt>
                <c:pt idx="283">
                  <c:v>1270.99</c:v>
                </c:pt>
                <c:pt idx="284">
                  <c:v>1267.71</c:v>
                </c:pt>
                <c:pt idx="285">
                  <c:v>1264.3900000000001</c:v>
                </c:pt>
                <c:pt idx="286">
                  <c:v>1261.1600000000001</c:v>
                </c:pt>
                <c:pt idx="287">
                  <c:v>1257.73</c:v>
                </c:pt>
                <c:pt idx="288">
                  <c:v>1254.1400000000001</c:v>
                </c:pt>
                <c:pt idx="289">
                  <c:v>1248.9100000000001</c:v>
                </c:pt>
                <c:pt idx="290">
                  <c:v>1243.8800000000001</c:v>
                </c:pt>
                <c:pt idx="291">
                  <c:v>1238.8399999999999</c:v>
                </c:pt>
                <c:pt idx="292">
                  <c:v>1233.72</c:v>
                </c:pt>
                <c:pt idx="293">
                  <c:v>1228.48</c:v>
                </c:pt>
                <c:pt idx="294">
                  <c:v>1223.1500000000001</c:v>
                </c:pt>
                <c:pt idx="295">
                  <c:v>1217.7</c:v>
                </c:pt>
                <c:pt idx="296">
                  <c:v>1212.21</c:v>
                </c:pt>
                <c:pt idx="297">
                  <c:v>1206.81</c:v>
                </c:pt>
                <c:pt idx="298">
                  <c:v>1201.51</c:v>
                </c:pt>
                <c:pt idx="299">
                  <c:v>1196.26</c:v>
                </c:pt>
                <c:pt idx="300">
                  <c:v>1190.92</c:v>
                </c:pt>
                <c:pt idx="301">
                  <c:v>1185.49</c:v>
                </c:pt>
                <c:pt idx="302">
                  <c:v>1180.04</c:v>
                </c:pt>
                <c:pt idx="303">
                  <c:v>1174.5</c:v>
                </c:pt>
                <c:pt idx="304">
                  <c:v>1168.8699999999999</c:v>
                </c:pt>
                <c:pt idx="305">
                  <c:v>1163.17</c:v>
                </c:pt>
                <c:pt idx="306">
                  <c:v>1157.48</c:v>
                </c:pt>
                <c:pt idx="307">
                  <c:v>1151.77</c:v>
                </c:pt>
                <c:pt idx="308">
                  <c:v>1145.99</c:v>
                </c:pt>
                <c:pt idx="309">
                  <c:v>1140.27</c:v>
                </c:pt>
                <c:pt idx="310">
                  <c:v>1134.6199999999999</c:v>
                </c:pt>
                <c:pt idx="311">
                  <c:v>1128.8</c:v>
                </c:pt>
                <c:pt idx="312">
                  <c:v>1122.9100000000001</c:v>
                </c:pt>
                <c:pt idx="313">
                  <c:v>1117.22</c:v>
                </c:pt>
                <c:pt idx="314">
                  <c:v>1113.24</c:v>
                </c:pt>
                <c:pt idx="315">
                  <c:v>1109.06</c:v>
                </c:pt>
                <c:pt idx="316">
                  <c:v>1105.04</c:v>
                </c:pt>
                <c:pt idx="317">
                  <c:v>1101.1600000000001</c:v>
                </c:pt>
                <c:pt idx="318">
                  <c:v>1097.22</c:v>
                </c:pt>
                <c:pt idx="319">
                  <c:v>1093.1600000000001</c:v>
                </c:pt>
                <c:pt idx="320">
                  <c:v>1089.18</c:v>
                </c:pt>
                <c:pt idx="321">
                  <c:v>1085.28</c:v>
                </c:pt>
                <c:pt idx="322">
                  <c:v>1081.24</c:v>
                </c:pt>
                <c:pt idx="323">
                  <c:v>1077.0999999999999</c:v>
                </c:pt>
                <c:pt idx="324">
                  <c:v>1072.9000000000001</c:v>
                </c:pt>
                <c:pt idx="325">
                  <c:v>1068.76</c:v>
                </c:pt>
                <c:pt idx="326">
                  <c:v>1064.6300000000001</c:v>
                </c:pt>
                <c:pt idx="327">
                  <c:v>1060.46</c:v>
                </c:pt>
                <c:pt idx="328">
                  <c:v>1056.3499999999999</c:v>
                </c:pt>
                <c:pt idx="329">
                  <c:v>1052.29</c:v>
                </c:pt>
                <c:pt idx="330">
                  <c:v>1048.3</c:v>
                </c:pt>
                <c:pt idx="331">
                  <c:v>1044.27</c:v>
                </c:pt>
                <c:pt idx="332">
                  <c:v>1040.3</c:v>
                </c:pt>
                <c:pt idx="333">
                  <c:v>1036.27</c:v>
                </c:pt>
                <c:pt idx="334">
                  <c:v>1032.23</c:v>
                </c:pt>
                <c:pt idx="335">
                  <c:v>1028.28</c:v>
                </c:pt>
                <c:pt idx="336">
                  <c:v>1024.28</c:v>
                </c:pt>
                <c:pt idx="337">
                  <c:v>1020.34</c:v>
                </c:pt>
                <c:pt idx="338">
                  <c:v>1016.24</c:v>
                </c:pt>
                <c:pt idx="339">
                  <c:v>1012.11</c:v>
                </c:pt>
                <c:pt idx="340">
                  <c:v>1008.17</c:v>
                </c:pt>
                <c:pt idx="341">
                  <c:v>1004.05</c:v>
                </c:pt>
                <c:pt idx="342">
                  <c:v>999.65800000000002</c:v>
                </c:pt>
                <c:pt idx="343">
                  <c:v>995.26700000000005</c:v>
                </c:pt>
                <c:pt idx="344">
                  <c:v>991.02099999999996</c:v>
                </c:pt>
                <c:pt idx="345">
                  <c:v>986.83500000000004</c:v>
                </c:pt>
                <c:pt idx="346">
                  <c:v>982.70799999999997</c:v>
                </c:pt>
                <c:pt idx="347">
                  <c:v>978.73199999999997</c:v>
                </c:pt>
                <c:pt idx="348">
                  <c:v>974.71</c:v>
                </c:pt>
                <c:pt idx="349">
                  <c:v>970.67</c:v>
                </c:pt>
                <c:pt idx="350">
                  <c:v>966.61199999999997</c:v>
                </c:pt>
                <c:pt idx="351">
                  <c:v>962.41499999999996</c:v>
                </c:pt>
                <c:pt idx="352">
                  <c:v>958.29200000000003</c:v>
                </c:pt>
                <c:pt idx="353">
                  <c:v>954.12099999999998</c:v>
                </c:pt>
                <c:pt idx="354">
                  <c:v>949.90300000000002</c:v>
                </c:pt>
                <c:pt idx="355">
                  <c:v>945.76300000000003</c:v>
                </c:pt>
                <c:pt idx="356">
                  <c:v>941.60799999999995</c:v>
                </c:pt>
                <c:pt idx="357">
                  <c:v>937.40899999999999</c:v>
                </c:pt>
                <c:pt idx="358">
                  <c:v>933.36199999999997</c:v>
                </c:pt>
                <c:pt idx="359">
                  <c:v>929.31299999999999</c:v>
                </c:pt>
                <c:pt idx="360">
                  <c:v>925.07799999999997</c:v>
                </c:pt>
                <c:pt idx="361">
                  <c:v>920.88300000000004</c:v>
                </c:pt>
                <c:pt idx="362">
                  <c:v>916.67100000000005</c:v>
                </c:pt>
                <c:pt idx="363">
                  <c:v>912.55399999999997</c:v>
                </c:pt>
                <c:pt idx="364">
                  <c:v>908.49900000000002</c:v>
                </c:pt>
                <c:pt idx="365">
                  <c:v>904.27099999999996</c:v>
                </c:pt>
                <c:pt idx="366">
                  <c:v>900.03200000000004</c:v>
                </c:pt>
                <c:pt idx="367">
                  <c:v>896.06700000000001</c:v>
                </c:pt>
                <c:pt idx="368">
                  <c:v>892.35</c:v>
                </c:pt>
                <c:pt idx="369">
                  <c:v>888.56600000000003</c:v>
                </c:pt>
                <c:pt idx="370">
                  <c:v>884.57</c:v>
                </c:pt>
                <c:pt idx="371">
                  <c:v>880.46100000000001</c:v>
                </c:pt>
                <c:pt idx="372">
                  <c:v>876.30700000000002</c:v>
                </c:pt>
                <c:pt idx="373">
                  <c:v>872.20799999999997</c:v>
                </c:pt>
                <c:pt idx="374">
                  <c:v>868.25599999999997</c:v>
                </c:pt>
                <c:pt idx="375">
                  <c:v>864.33399999999995</c:v>
                </c:pt>
                <c:pt idx="376">
                  <c:v>860.36400000000003</c:v>
                </c:pt>
                <c:pt idx="377">
                  <c:v>856.31799999999998</c:v>
                </c:pt>
                <c:pt idx="378">
                  <c:v>852.37900000000002</c:v>
                </c:pt>
                <c:pt idx="379">
                  <c:v>848.51499999999999</c:v>
                </c:pt>
                <c:pt idx="380">
                  <c:v>844.45799999999997</c:v>
                </c:pt>
                <c:pt idx="381">
                  <c:v>840.38599999999997</c:v>
                </c:pt>
                <c:pt idx="382">
                  <c:v>836.51599999999996</c:v>
                </c:pt>
                <c:pt idx="383">
                  <c:v>832.52599999999995</c:v>
                </c:pt>
                <c:pt idx="384">
                  <c:v>828.40700000000004</c:v>
                </c:pt>
                <c:pt idx="385">
                  <c:v>824.48500000000001</c:v>
                </c:pt>
                <c:pt idx="386">
                  <c:v>820.62</c:v>
                </c:pt>
                <c:pt idx="387">
                  <c:v>816.78499999999997</c:v>
                </c:pt>
                <c:pt idx="388">
                  <c:v>812.86900000000003</c:v>
                </c:pt>
                <c:pt idx="389">
                  <c:v>808.91899999999998</c:v>
                </c:pt>
                <c:pt idx="390">
                  <c:v>805.10799999999995</c:v>
                </c:pt>
                <c:pt idx="391">
                  <c:v>801.303</c:v>
                </c:pt>
                <c:pt idx="392">
                  <c:v>797.39</c:v>
                </c:pt>
                <c:pt idx="393">
                  <c:v>793.39599999999996</c:v>
                </c:pt>
                <c:pt idx="394">
                  <c:v>789.48299999999995</c:v>
                </c:pt>
                <c:pt idx="395">
                  <c:v>785.64</c:v>
                </c:pt>
                <c:pt idx="396">
                  <c:v>781.75900000000001</c:v>
                </c:pt>
                <c:pt idx="397">
                  <c:v>777.94200000000001</c:v>
                </c:pt>
                <c:pt idx="398">
                  <c:v>774.15800000000002</c:v>
                </c:pt>
                <c:pt idx="399">
                  <c:v>770.21</c:v>
                </c:pt>
                <c:pt idx="400">
                  <c:v>766.27800000000002</c:v>
                </c:pt>
                <c:pt idx="401">
                  <c:v>762.52200000000005</c:v>
                </c:pt>
                <c:pt idx="402">
                  <c:v>758.76300000000003</c:v>
                </c:pt>
                <c:pt idx="403">
                  <c:v>754.94</c:v>
                </c:pt>
                <c:pt idx="404">
                  <c:v>751.14400000000001</c:v>
                </c:pt>
                <c:pt idx="405">
                  <c:v>747.51900000000001</c:v>
                </c:pt>
                <c:pt idx="406">
                  <c:v>743.995</c:v>
                </c:pt>
                <c:pt idx="407">
                  <c:v>740.28800000000001</c:v>
                </c:pt>
                <c:pt idx="408">
                  <c:v>736.53300000000002</c:v>
                </c:pt>
                <c:pt idx="409">
                  <c:v>732.90599999999995</c:v>
                </c:pt>
                <c:pt idx="410">
                  <c:v>729.28099999999995</c:v>
                </c:pt>
                <c:pt idx="411">
                  <c:v>725.66</c:v>
                </c:pt>
                <c:pt idx="412">
                  <c:v>722.01300000000003</c:v>
                </c:pt>
                <c:pt idx="413">
                  <c:v>718.36599999999999</c:v>
                </c:pt>
                <c:pt idx="414">
                  <c:v>714.80200000000002</c:v>
                </c:pt>
                <c:pt idx="415">
                  <c:v>711.21100000000001</c:v>
                </c:pt>
                <c:pt idx="416">
                  <c:v>707.59900000000005</c:v>
                </c:pt>
                <c:pt idx="417">
                  <c:v>704.07799999999997</c:v>
                </c:pt>
                <c:pt idx="418">
                  <c:v>700.62</c:v>
                </c:pt>
                <c:pt idx="419">
                  <c:v>697.06899999999996</c:v>
                </c:pt>
                <c:pt idx="420">
                  <c:v>693.54600000000005</c:v>
                </c:pt>
                <c:pt idx="421">
                  <c:v>690.04300000000001</c:v>
                </c:pt>
                <c:pt idx="422">
                  <c:v>686.43799999999999</c:v>
                </c:pt>
                <c:pt idx="423">
                  <c:v>682.98299999999995</c:v>
                </c:pt>
                <c:pt idx="424">
                  <c:v>679.601</c:v>
                </c:pt>
                <c:pt idx="425">
                  <c:v>676.08600000000001</c:v>
                </c:pt>
                <c:pt idx="426">
                  <c:v>672.61500000000001</c:v>
                </c:pt>
                <c:pt idx="427">
                  <c:v>669.24699999999996</c:v>
                </c:pt>
                <c:pt idx="428">
                  <c:v>665.87400000000002</c:v>
                </c:pt>
                <c:pt idx="429">
                  <c:v>662.49900000000002</c:v>
                </c:pt>
                <c:pt idx="430">
                  <c:v>659.16099999999994</c:v>
                </c:pt>
                <c:pt idx="431">
                  <c:v>655.82299999999998</c:v>
                </c:pt>
                <c:pt idx="432">
                  <c:v>652.55399999999997</c:v>
                </c:pt>
                <c:pt idx="433">
                  <c:v>649.45000000000005</c:v>
                </c:pt>
                <c:pt idx="434">
                  <c:v>646.28899999999999</c:v>
                </c:pt>
                <c:pt idx="435">
                  <c:v>643.06100000000004</c:v>
                </c:pt>
                <c:pt idx="436">
                  <c:v>639.90700000000004</c:v>
                </c:pt>
                <c:pt idx="437">
                  <c:v>636.77300000000002</c:v>
                </c:pt>
                <c:pt idx="438">
                  <c:v>633.63300000000004</c:v>
                </c:pt>
                <c:pt idx="439">
                  <c:v>630.39800000000002</c:v>
                </c:pt>
                <c:pt idx="440">
                  <c:v>627.14099999999996</c:v>
                </c:pt>
                <c:pt idx="441">
                  <c:v>624.01900000000001</c:v>
                </c:pt>
                <c:pt idx="442">
                  <c:v>620.89200000000005</c:v>
                </c:pt>
                <c:pt idx="443">
                  <c:v>617.745</c:v>
                </c:pt>
                <c:pt idx="444">
                  <c:v>614.68100000000004</c:v>
                </c:pt>
                <c:pt idx="445">
                  <c:v>611.6</c:v>
                </c:pt>
                <c:pt idx="446">
                  <c:v>608.54999999999995</c:v>
                </c:pt>
                <c:pt idx="447">
                  <c:v>605.61400000000003</c:v>
                </c:pt>
                <c:pt idx="448">
                  <c:v>602.63599999999997</c:v>
                </c:pt>
                <c:pt idx="449">
                  <c:v>599.62400000000002</c:v>
                </c:pt>
                <c:pt idx="450">
                  <c:v>596.75599999999997</c:v>
                </c:pt>
                <c:pt idx="451">
                  <c:v>593.84299999999996</c:v>
                </c:pt>
                <c:pt idx="452">
                  <c:v>590.85599999999999</c:v>
                </c:pt>
                <c:pt idx="453">
                  <c:v>587.92600000000004</c:v>
                </c:pt>
                <c:pt idx="454">
                  <c:v>584.95299999999997</c:v>
                </c:pt>
                <c:pt idx="455">
                  <c:v>581.99599999999998</c:v>
                </c:pt>
                <c:pt idx="456">
                  <c:v>579.09100000000001</c:v>
                </c:pt>
                <c:pt idx="457">
                  <c:v>576.178</c:v>
                </c:pt>
                <c:pt idx="458">
                  <c:v>573.21600000000001</c:v>
                </c:pt>
                <c:pt idx="459">
                  <c:v>570.33000000000004</c:v>
                </c:pt>
                <c:pt idx="460">
                  <c:v>567.51700000000005</c:v>
                </c:pt>
                <c:pt idx="461">
                  <c:v>564.577</c:v>
                </c:pt>
                <c:pt idx="462">
                  <c:v>561.649</c:v>
                </c:pt>
                <c:pt idx="463">
                  <c:v>558.80999999999995</c:v>
                </c:pt>
                <c:pt idx="464">
                  <c:v>556.08799999999997</c:v>
                </c:pt>
                <c:pt idx="465">
                  <c:v>553.43799999999999</c:v>
                </c:pt>
                <c:pt idx="466">
                  <c:v>550.71299999999997</c:v>
                </c:pt>
                <c:pt idx="467">
                  <c:v>548.01300000000003</c:v>
                </c:pt>
                <c:pt idx="468">
                  <c:v>545.29300000000001</c:v>
                </c:pt>
                <c:pt idx="469">
                  <c:v>542.62</c:v>
                </c:pt>
                <c:pt idx="470">
                  <c:v>540.01499999999999</c:v>
                </c:pt>
                <c:pt idx="471">
                  <c:v>537.37300000000005</c:v>
                </c:pt>
                <c:pt idx="472">
                  <c:v>534.69600000000003</c:v>
                </c:pt>
                <c:pt idx="473">
                  <c:v>531.93499999999995</c:v>
                </c:pt>
                <c:pt idx="474">
                  <c:v>529.21600000000001</c:v>
                </c:pt>
                <c:pt idx="475">
                  <c:v>526.54300000000001</c:v>
                </c:pt>
                <c:pt idx="476">
                  <c:v>523.92600000000004</c:v>
                </c:pt>
                <c:pt idx="477">
                  <c:v>521.37400000000002</c:v>
                </c:pt>
                <c:pt idx="478">
                  <c:v>518.79999999999995</c:v>
                </c:pt>
                <c:pt idx="479">
                  <c:v>516.23299999999995</c:v>
                </c:pt>
                <c:pt idx="480">
                  <c:v>513.529</c:v>
                </c:pt>
                <c:pt idx="481">
                  <c:v>510.84500000000003</c:v>
                </c:pt>
                <c:pt idx="482">
                  <c:v>508.358</c:v>
                </c:pt>
                <c:pt idx="483">
                  <c:v>505.88900000000001</c:v>
                </c:pt>
                <c:pt idx="484">
                  <c:v>503.41399999999999</c:v>
                </c:pt>
                <c:pt idx="485">
                  <c:v>500.83499999999998</c:v>
                </c:pt>
                <c:pt idx="486">
                  <c:v>498.255</c:v>
                </c:pt>
                <c:pt idx="487">
                  <c:v>495.779</c:v>
                </c:pt>
                <c:pt idx="488">
                  <c:v>493.32299999999998</c:v>
                </c:pt>
                <c:pt idx="489">
                  <c:v>490.91399999999999</c:v>
                </c:pt>
                <c:pt idx="490">
                  <c:v>488.58199999999999</c:v>
                </c:pt>
                <c:pt idx="491">
                  <c:v>486.43400000000003</c:v>
                </c:pt>
                <c:pt idx="492">
                  <c:v>484.35300000000001</c:v>
                </c:pt>
                <c:pt idx="493">
                  <c:v>482.35</c:v>
                </c:pt>
                <c:pt idx="494">
                  <c:v>480.399</c:v>
                </c:pt>
                <c:pt idx="495">
                  <c:v>478.52499999999998</c:v>
                </c:pt>
                <c:pt idx="496">
                  <c:v>476.81299999999999</c:v>
                </c:pt>
                <c:pt idx="497">
                  <c:v>475.25900000000001</c:v>
                </c:pt>
                <c:pt idx="498">
                  <c:v>473.88600000000002</c:v>
                </c:pt>
                <c:pt idx="499">
                  <c:v>472.61500000000001</c:v>
                </c:pt>
                <c:pt idx="500">
                  <c:v>471.39600000000002</c:v>
                </c:pt>
              </c:numCache>
            </c:numRef>
          </c:yVal>
          <c:smooth val="1"/>
          <c:extLst>
            <c:ext xmlns:c16="http://schemas.microsoft.com/office/drawing/2014/chart" uri="{C3380CC4-5D6E-409C-BE32-E72D297353CC}">
              <c16:uniqueId val="{00000002-5D61-3449-9667-58588BDF454C}"/>
            </c:ext>
          </c:extLst>
        </c:ser>
        <c:ser>
          <c:idx val="4"/>
          <c:order val="3"/>
          <c:tx>
            <c:strRef>
              <c:f>Sheet1!$G$3:$G$4</c:f>
              <c:strCache>
                <c:ptCount val="1"/>
                <c:pt idx="0">
                  <c:v>50μM</c:v>
                </c:pt>
              </c:strCache>
            </c:strRef>
          </c:tx>
          <c:spPr>
            <a:ln w="19050"/>
          </c:spPr>
          <c:marker>
            <c:symbol val="none"/>
          </c:marker>
          <c:xVal>
            <c:numRef>
              <c:f>Sheet1!$B$5:$B$505</c:f>
              <c:numCache>
                <c:formatCode>General</c:formatCode>
                <c:ptCount val="501"/>
                <c:pt idx="31">
                  <c:v>306</c:v>
                </c:pt>
                <c:pt idx="32">
                  <c:v>306.2</c:v>
                </c:pt>
                <c:pt idx="33">
                  <c:v>306.39999999999998</c:v>
                </c:pt>
                <c:pt idx="34">
                  <c:v>306.60000000000002</c:v>
                </c:pt>
                <c:pt idx="35">
                  <c:v>306.8</c:v>
                </c:pt>
                <c:pt idx="36">
                  <c:v>307</c:v>
                </c:pt>
                <c:pt idx="37">
                  <c:v>307.39999999999998</c:v>
                </c:pt>
                <c:pt idx="38">
                  <c:v>307.60000000000002</c:v>
                </c:pt>
                <c:pt idx="39">
                  <c:v>307.8</c:v>
                </c:pt>
                <c:pt idx="40">
                  <c:v>308</c:v>
                </c:pt>
                <c:pt idx="41">
                  <c:v>308.2</c:v>
                </c:pt>
                <c:pt idx="42">
                  <c:v>308.39999999999998</c:v>
                </c:pt>
                <c:pt idx="43">
                  <c:v>308.60000000000002</c:v>
                </c:pt>
                <c:pt idx="44">
                  <c:v>308.8</c:v>
                </c:pt>
                <c:pt idx="45">
                  <c:v>309</c:v>
                </c:pt>
                <c:pt idx="46">
                  <c:v>309.2</c:v>
                </c:pt>
                <c:pt idx="47">
                  <c:v>309.39999999999998</c:v>
                </c:pt>
                <c:pt idx="48">
                  <c:v>309.60000000000002</c:v>
                </c:pt>
                <c:pt idx="49">
                  <c:v>309.8</c:v>
                </c:pt>
                <c:pt idx="50">
                  <c:v>310</c:v>
                </c:pt>
                <c:pt idx="51">
                  <c:v>310.2</c:v>
                </c:pt>
                <c:pt idx="52">
                  <c:v>310.39999999999998</c:v>
                </c:pt>
                <c:pt idx="53">
                  <c:v>310.60000000000002</c:v>
                </c:pt>
                <c:pt idx="54">
                  <c:v>310.8</c:v>
                </c:pt>
                <c:pt idx="55">
                  <c:v>311</c:v>
                </c:pt>
                <c:pt idx="56">
                  <c:v>311.2</c:v>
                </c:pt>
                <c:pt idx="57">
                  <c:v>311.39999999999998</c:v>
                </c:pt>
                <c:pt idx="58">
                  <c:v>311.60000000000002</c:v>
                </c:pt>
                <c:pt idx="59">
                  <c:v>311.8</c:v>
                </c:pt>
                <c:pt idx="60">
                  <c:v>312</c:v>
                </c:pt>
                <c:pt idx="61">
                  <c:v>312.2</c:v>
                </c:pt>
                <c:pt idx="62">
                  <c:v>312.39999999999998</c:v>
                </c:pt>
                <c:pt idx="63">
                  <c:v>312.60000000000002</c:v>
                </c:pt>
                <c:pt idx="64">
                  <c:v>312.8</c:v>
                </c:pt>
                <c:pt idx="65">
                  <c:v>313</c:v>
                </c:pt>
                <c:pt idx="66">
                  <c:v>313.2</c:v>
                </c:pt>
                <c:pt idx="67">
                  <c:v>313.39999999999998</c:v>
                </c:pt>
                <c:pt idx="68">
                  <c:v>313.60000000000002</c:v>
                </c:pt>
                <c:pt idx="69">
                  <c:v>313.8</c:v>
                </c:pt>
                <c:pt idx="70">
                  <c:v>314</c:v>
                </c:pt>
                <c:pt idx="71">
                  <c:v>314.2</c:v>
                </c:pt>
                <c:pt idx="72">
                  <c:v>314.39999999999998</c:v>
                </c:pt>
                <c:pt idx="73">
                  <c:v>314.60000000000002</c:v>
                </c:pt>
                <c:pt idx="74">
                  <c:v>314.8</c:v>
                </c:pt>
                <c:pt idx="75">
                  <c:v>315</c:v>
                </c:pt>
                <c:pt idx="76">
                  <c:v>315.2</c:v>
                </c:pt>
                <c:pt idx="77">
                  <c:v>315.39999999999998</c:v>
                </c:pt>
                <c:pt idx="78">
                  <c:v>315.60000000000002</c:v>
                </c:pt>
                <c:pt idx="79">
                  <c:v>315.8</c:v>
                </c:pt>
                <c:pt idx="80">
                  <c:v>316</c:v>
                </c:pt>
                <c:pt idx="81">
                  <c:v>316.2</c:v>
                </c:pt>
                <c:pt idx="82">
                  <c:v>316.39999999999998</c:v>
                </c:pt>
                <c:pt idx="83">
                  <c:v>316.60000000000002</c:v>
                </c:pt>
                <c:pt idx="84">
                  <c:v>316.8</c:v>
                </c:pt>
                <c:pt idx="85">
                  <c:v>317</c:v>
                </c:pt>
                <c:pt idx="86">
                  <c:v>317.2</c:v>
                </c:pt>
                <c:pt idx="87">
                  <c:v>317.39999999999998</c:v>
                </c:pt>
                <c:pt idx="88">
                  <c:v>317.60000000000002</c:v>
                </c:pt>
                <c:pt idx="89">
                  <c:v>317.8</c:v>
                </c:pt>
                <c:pt idx="90">
                  <c:v>318</c:v>
                </c:pt>
                <c:pt idx="91">
                  <c:v>318.2</c:v>
                </c:pt>
                <c:pt idx="92">
                  <c:v>318.39999999999998</c:v>
                </c:pt>
                <c:pt idx="93">
                  <c:v>318.60000000000002</c:v>
                </c:pt>
                <c:pt idx="94">
                  <c:v>318.8</c:v>
                </c:pt>
                <c:pt idx="95">
                  <c:v>319</c:v>
                </c:pt>
                <c:pt idx="96">
                  <c:v>319.2</c:v>
                </c:pt>
                <c:pt idx="97">
                  <c:v>319.39999999999998</c:v>
                </c:pt>
                <c:pt idx="98">
                  <c:v>319.60000000000002</c:v>
                </c:pt>
                <c:pt idx="99">
                  <c:v>319.8</c:v>
                </c:pt>
                <c:pt idx="100">
                  <c:v>320</c:v>
                </c:pt>
                <c:pt idx="101">
                  <c:v>320.2</c:v>
                </c:pt>
                <c:pt idx="102">
                  <c:v>320.39999999999998</c:v>
                </c:pt>
                <c:pt idx="103">
                  <c:v>320.60000000000002</c:v>
                </c:pt>
                <c:pt idx="104">
                  <c:v>320.8</c:v>
                </c:pt>
                <c:pt idx="105">
                  <c:v>321</c:v>
                </c:pt>
                <c:pt idx="106">
                  <c:v>321.2</c:v>
                </c:pt>
                <c:pt idx="107">
                  <c:v>321.39999999999998</c:v>
                </c:pt>
                <c:pt idx="108">
                  <c:v>321.60000000000002</c:v>
                </c:pt>
                <c:pt idx="109">
                  <c:v>321.8</c:v>
                </c:pt>
                <c:pt idx="110">
                  <c:v>322</c:v>
                </c:pt>
                <c:pt idx="111">
                  <c:v>322.2</c:v>
                </c:pt>
                <c:pt idx="112">
                  <c:v>322.39999999999998</c:v>
                </c:pt>
                <c:pt idx="113">
                  <c:v>322.60000000000002</c:v>
                </c:pt>
                <c:pt idx="114">
                  <c:v>322.8</c:v>
                </c:pt>
                <c:pt idx="115">
                  <c:v>323</c:v>
                </c:pt>
                <c:pt idx="116">
                  <c:v>323.2</c:v>
                </c:pt>
                <c:pt idx="117">
                  <c:v>323.39999999999998</c:v>
                </c:pt>
                <c:pt idx="118">
                  <c:v>323.60000000000002</c:v>
                </c:pt>
                <c:pt idx="119">
                  <c:v>323.8</c:v>
                </c:pt>
                <c:pt idx="120">
                  <c:v>324</c:v>
                </c:pt>
                <c:pt idx="121">
                  <c:v>324.2</c:v>
                </c:pt>
                <c:pt idx="122">
                  <c:v>324.39999999999998</c:v>
                </c:pt>
                <c:pt idx="123">
                  <c:v>324.60000000000002</c:v>
                </c:pt>
                <c:pt idx="124">
                  <c:v>324.8</c:v>
                </c:pt>
                <c:pt idx="125">
                  <c:v>325</c:v>
                </c:pt>
                <c:pt idx="126">
                  <c:v>325.2</c:v>
                </c:pt>
                <c:pt idx="127">
                  <c:v>325.39999999999998</c:v>
                </c:pt>
                <c:pt idx="128">
                  <c:v>325.60000000000002</c:v>
                </c:pt>
                <c:pt idx="129">
                  <c:v>325.8</c:v>
                </c:pt>
                <c:pt idx="130">
                  <c:v>326</c:v>
                </c:pt>
                <c:pt idx="131">
                  <c:v>326.2</c:v>
                </c:pt>
                <c:pt idx="132">
                  <c:v>326.39999999999998</c:v>
                </c:pt>
                <c:pt idx="133">
                  <c:v>326.60000000000002</c:v>
                </c:pt>
                <c:pt idx="134">
                  <c:v>326.8</c:v>
                </c:pt>
                <c:pt idx="135">
                  <c:v>327</c:v>
                </c:pt>
                <c:pt idx="136">
                  <c:v>327.2</c:v>
                </c:pt>
                <c:pt idx="137">
                  <c:v>327.39999999999998</c:v>
                </c:pt>
                <c:pt idx="138">
                  <c:v>327.60000000000002</c:v>
                </c:pt>
                <c:pt idx="139">
                  <c:v>327.8</c:v>
                </c:pt>
                <c:pt idx="140">
                  <c:v>328</c:v>
                </c:pt>
                <c:pt idx="141">
                  <c:v>328.2</c:v>
                </c:pt>
                <c:pt idx="142">
                  <c:v>328.4</c:v>
                </c:pt>
                <c:pt idx="143">
                  <c:v>328.6</c:v>
                </c:pt>
                <c:pt idx="144">
                  <c:v>328.8</c:v>
                </c:pt>
                <c:pt idx="145">
                  <c:v>329</c:v>
                </c:pt>
                <c:pt idx="146">
                  <c:v>329.2</c:v>
                </c:pt>
                <c:pt idx="147">
                  <c:v>329.4</c:v>
                </c:pt>
                <c:pt idx="148">
                  <c:v>329.6</c:v>
                </c:pt>
                <c:pt idx="149">
                  <c:v>329.8</c:v>
                </c:pt>
                <c:pt idx="150">
                  <c:v>330</c:v>
                </c:pt>
                <c:pt idx="151">
                  <c:v>330.2</c:v>
                </c:pt>
                <c:pt idx="152">
                  <c:v>330.4</c:v>
                </c:pt>
                <c:pt idx="153">
                  <c:v>330.6</c:v>
                </c:pt>
                <c:pt idx="154">
                  <c:v>330.8</c:v>
                </c:pt>
                <c:pt idx="155">
                  <c:v>331</c:v>
                </c:pt>
                <c:pt idx="156">
                  <c:v>331.2</c:v>
                </c:pt>
                <c:pt idx="157">
                  <c:v>331.4</c:v>
                </c:pt>
                <c:pt idx="158">
                  <c:v>331.6</c:v>
                </c:pt>
                <c:pt idx="159">
                  <c:v>331.8</c:v>
                </c:pt>
                <c:pt idx="160">
                  <c:v>332</c:v>
                </c:pt>
                <c:pt idx="161">
                  <c:v>332.2</c:v>
                </c:pt>
                <c:pt idx="162">
                  <c:v>332.4</c:v>
                </c:pt>
                <c:pt idx="163">
                  <c:v>332.6</c:v>
                </c:pt>
                <c:pt idx="164">
                  <c:v>332.8</c:v>
                </c:pt>
                <c:pt idx="165">
                  <c:v>333</c:v>
                </c:pt>
                <c:pt idx="166">
                  <c:v>333.2</c:v>
                </c:pt>
                <c:pt idx="167">
                  <c:v>333.4</c:v>
                </c:pt>
                <c:pt idx="168">
                  <c:v>333.6</c:v>
                </c:pt>
                <c:pt idx="169">
                  <c:v>333.8</c:v>
                </c:pt>
                <c:pt idx="170">
                  <c:v>334</c:v>
                </c:pt>
                <c:pt idx="171">
                  <c:v>334.2</c:v>
                </c:pt>
                <c:pt idx="172">
                  <c:v>334.4</c:v>
                </c:pt>
                <c:pt idx="173">
                  <c:v>334.6</c:v>
                </c:pt>
                <c:pt idx="174">
                  <c:v>334.8</c:v>
                </c:pt>
                <c:pt idx="175">
                  <c:v>335</c:v>
                </c:pt>
                <c:pt idx="176">
                  <c:v>335.2</c:v>
                </c:pt>
                <c:pt idx="177">
                  <c:v>335.4</c:v>
                </c:pt>
                <c:pt idx="178">
                  <c:v>335.6</c:v>
                </c:pt>
                <c:pt idx="179">
                  <c:v>335.8</c:v>
                </c:pt>
                <c:pt idx="180">
                  <c:v>336</c:v>
                </c:pt>
                <c:pt idx="181">
                  <c:v>336.2</c:v>
                </c:pt>
                <c:pt idx="182">
                  <c:v>336.4</c:v>
                </c:pt>
                <c:pt idx="183">
                  <c:v>336.6</c:v>
                </c:pt>
                <c:pt idx="184">
                  <c:v>336.8</c:v>
                </c:pt>
                <c:pt idx="185">
                  <c:v>337</c:v>
                </c:pt>
                <c:pt idx="186">
                  <c:v>337.2</c:v>
                </c:pt>
                <c:pt idx="187">
                  <c:v>337.4</c:v>
                </c:pt>
                <c:pt idx="188">
                  <c:v>337.6</c:v>
                </c:pt>
                <c:pt idx="189">
                  <c:v>337.8</c:v>
                </c:pt>
                <c:pt idx="190">
                  <c:v>338</c:v>
                </c:pt>
                <c:pt idx="191">
                  <c:v>338.2</c:v>
                </c:pt>
                <c:pt idx="192">
                  <c:v>338.4</c:v>
                </c:pt>
                <c:pt idx="193">
                  <c:v>338.6</c:v>
                </c:pt>
                <c:pt idx="194">
                  <c:v>338.8</c:v>
                </c:pt>
                <c:pt idx="195">
                  <c:v>339</c:v>
                </c:pt>
                <c:pt idx="196">
                  <c:v>339.2</c:v>
                </c:pt>
                <c:pt idx="197">
                  <c:v>339.4</c:v>
                </c:pt>
                <c:pt idx="198">
                  <c:v>339.6</c:v>
                </c:pt>
                <c:pt idx="199">
                  <c:v>339.8</c:v>
                </c:pt>
                <c:pt idx="200">
                  <c:v>340</c:v>
                </c:pt>
                <c:pt idx="201">
                  <c:v>340.2</c:v>
                </c:pt>
                <c:pt idx="202">
                  <c:v>340.4</c:v>
                </c:pt>
                <c:pt idx="203">
                  <c:v>340.6</c:v>
                </c:pt>
                <c:pt idx="204">
                  <c:v>340.8</c:v>
                </c:pt>
                <c:pt idx="205">
                  <c:v>341</c:v>
                </c:pt>
                <c:pt idx="206">
                  <c:v>341.2</c:v>
                </c:pt>
                <c:pt idx="207">
                  <c:v>341.4</c:v>
                </c:pt>
                <c:pt idx="208">
                  <c:v>341.6</c:v>
                </c:pt>
                <c:pt idx="209">
                  <c:v>341.8</c:v>
                </c:pt>
                <c:pt idx="210">
                  <c:v>342</c:v>
                </c:pt>
                <c:pt idx="211">
                  <c:v>342.2</c:v>
                </c:pt>
                <c:pt idx="212">
                  <c:v>342.4</c:v>
                </c:pt>
                <c:pt idx="213">
                  <c:v>342.6</c:v>
                </c:pt>
                <c:pt idx="214">
                  <c:v>342.8</c:v>
                </c:pt>
                <c:pt idx="215">
                  <c:v>343</c:v>
                </c:pt>
                <c:pt idx="216">
                  <c:v>343.2</c:v>
                </c:pt>
                <c:pt idx="217">
                  <c:v>343.4</c:v>
                </c:pt>
                <c:pt idx="218">
                  <c:v>343.6</c:v>
                </c:pt>
                <c:pt idx="219">
                  <c:v>343.8</c:v>
                </c:pt>
                <c:pt idx="220">
                  <c:v>344</c:v>
                </c:pt>
                <c:pt idx="221">
                  <c:v>344.2</c:v>
                </c:pt>
                <c:pt idx="222">
                  <c:v>344.4</c:v>
                </c:pt>
                <c:pt idx="223">
                  <c:v>344.6</c:v>
                </c:pt>
                <c:pt idx="224">
                  <c:v>344.8</c:v>
                </c:pt>
                <c:pt idx="225">
                  <c:v>345</c:v>
                </c:pt>
                <c:pt idx="226">
                  <c:v>345.2</c:v>
                </c:pt>
                <c:pt idx="227">
                  <c:v>345.4</c:v>
                </c:pt>
                <c:pt idx="228">
                  <c:v>345.6</c:v>
                </c:pt>
                <c:pt idx="229">
                  <c:v>345.8</c:v>
                </c:pt>
                <c:pt idx="230">
                  <c:v>346</c:v>
                </c:pt>
                <c:pt idx="231">
                  <c:v>346.2</c:v>
                </c:pt>
                <c:pt idx="232">
                  <c:v>346.4</c:v>
                </c:pt>
                <c:pt idx="233">
                  <c:v>346.6</c:v>
                </c:pt>
                <c:pt idx="234">
                  <c:v>346.8</c:v>
                </c:pt>
                <c:pt idx="235">
                  <c:v>347</c:v>
                </c:pt>
                <c:pt idx="236">
                  <c:v>347.2</c:v>
                </c:pt>
                <c:pt idx="237">
                  <c:v>347.4</c:v>
                </c:pt>
                <c:pt idx="238">
                  <c:v>347.6</c:v>
                </c:pt>
                <c:pt idx="239">
                  <c:v>347.8</c:v>
                </c:pt>
                <c:pt idx="240">
                  <c:v>348</c:v>
                </c:pt>
                <c:pt idx="241">
                  <c:v>348.2</c:v>
                </c:pt>
                <c:pt idx="242">
                  <c:v>348.4</c:v>
                </c:pt>
                <c:pt idx="243">
                  <c:v>348.6</c:v>
                </c:pt>
                <c:pt idx="244">
                  <c:v>348.8</c:v>
                </c:pt>
                <c:pt idx="245">
                  <c:v>349</c:v>
                </c:pt>
                <c:pt idx="246">
                  <c:v>349.2</c:v>
                </c:pt>
                <c:pt idx="247">
                  <c:v>349.4</c:v>
                </c:pt>
                <c:pt idx="248">
                  <c:v>349.6</c:v>
                </c:pt>
                <c:pt idx="249">
                  <c:v>349.8</c:v>
                </c:pt>
                <c:pt idx="250">
                  <c:v>350</c:v>
                </c:pt>
                <c:pt idx="251">
                  <c:v>350.2</c:v>
                </c:pt>
                <c:pt idx="252">
                  <c:v>350.4</c:v>
                </c:pt>
                <c:pt idx="253">
                  <c:v>350.6</c:v>
                </c:pt>
                <c:pt idx="254">
                  <c:v>350.8</c:v>
                </c:pt>
                <c:pt idx="255">
                  <c:v>351</c:v>
                </c:pt>
                <c:pt idx="256">
                  <c:v>351.2</c:v>
                </c:pt>
                <c:pt idx="257">
                  <c:v>351.4</c:v>
                </c:pt>
                <c:pt idx="258">
                  <c:v>351.6</c:v>
                </c:pt>
                <c:pt idx="259">
                  <c:v>351.8</c:v>
                </c:pt>
                <c:pt idx="260">
                  <c:v>352</c:v>
                </c:pt>
                <c:pt idx="261">
                  <c:v>352.2</c:v>
                </c:pt>
                <c:pt idx="262">
                  <c:v>352.4</c:v>
                </c:pt>
                <c:pt idx="263">
                  <c:v>352.6</c:v>
                </c:pt>
                <c:pt idx="264">
                  <c:v>352.8</c:v>
                </c:pt>
                <c:pt idx="265">
                  <c:v>353</c:v>
                </c:pt>
                <c:pt idx="266">
                  <c:v>353.2</c:v>
                </c:pt>
                <c:pt idx="267">
                  <c:v>353.4</c:v>
                </c:pt>
                <c:pt idx="268">
                  <c:v>353.6</c:v>
                </c:pt>
                <c:pt idx="269">
                  <c:v>353.8</c:v>
                </c:pt>
                <c:pt idx="270">
                  <c:v>354</c:v>
                </c:pt>
                <c:pt idx="271">
                  <c:v>354.2</c:v>
                </c:pt>
                <c:pt idx="272">
                  <c:v>354.4</c:v>
                </c:pt>
                <c:pt idx="273">
                  <c:v>354.6</c:v>
                </c:pt>
                <c:pt idx="274">
                  <c:v>354.8</c:v>
                </c:pt>
                <c:pt idx="275">
                  <c:v>355</c:v>
                </c:pt>
                <c:pt idx="276">
                  <c:v>355.2</c:v>
                </c:pt>
                <c:pt idx="277">
                  <c:v>355.4</c:v>
                </c:pt>
                <c:pt idx="278">
                  <c:v>355.6</c:v>
                </c:pt>
                <c:pt idx="279">
                  <c:v>355.8</c:v>
                </c:pt>
                <c:pt idx="280">
                  <c:v>356</c:v>
                </c:pt>
                <c:pt idx="281">
                  <c:v>356.2</c:v>
                </c:pt>
                <c:pt idx="282">
                  <c:v>356.4</c:v>
                </c:pt>
                <c:pt idx="283">
                  <c:v>356.6</c:v>
                </c:pt>
                <c:pt idx="284">
                  <c:v>356.8</c:v>
                </c:pt>
                <c:pt idx="285">
                  <c:v>357</c:v>
                </c:pt>
                <c:pt idx="286">
                  <c:v>357.2</c:v>
                </c:pt>
                <c:pt idx="287">
                  <c:v>357.4</c:v>
                </c:pt>
                <c:pt idx="288">
                  <c:v>357.6</c:v>
                </c:pt>
                <c:pt idx="289">
                  <c:v>357.8</c:v>
                </c:pt>
                <c:pt idx="290">
                  <c:v>358</c:v>
                </c:pt>
                <c:pt idx="291">
                  <c:v>358.2</c:v>
                </c:pt>
                <c:pt idx="292">
                  <c:v>358.4</c:v>
                </c:pt>
                <c:pt idx="293">
                  <c:v>358.6</c:v>
                </c:pt>
                <c:pt idx="294">
                  <c:v>358.8</c:v>
                </c:pt>
                <c:pt idx="295">
                  <c:v>359</c:v>
                </c:pt>
                <c:pt idx="296">
                  <c:v>359.2</c:v>
                </c:pt>
                <c:pt idx="297">
                  <c:v>359.4</c:v>
                </c:pt>
                <c:pt idx="298">
                  <c:v>359.6</c:v>
                </c:pt>
                <c:pt idx="299">
                  <c:v>359.8</c:v>
                </c:pt>
                <c:pt idx="300">
                  <c:v>360</c:v>
                </c:pt>
                <c:pt idx="301">
                  <c:v>360.2</c:v>
                </c:pt>
                <c:pt idx="302">
                  <c:v>360.4</c:v>
                </c:pt>
                <c:pt idx="303">
                  <c:v>360.6</c:v>
                </c:pt>
                <c:pt idx="304">
                  <c:v>360.8</c:v>
                </c:pt>
                <c:pt idx="305">
                  <c:v>361</c:v>
                </c:pt>
                <c:pt idx="306">
                  <c:v>361.2</c:v>
                </c:pt>
                <c:pt idx="307">
                  <c:v>361.4</c:v>
                </c:pt>
                <c:pt idx="308">
                  <c:v>361.6</c:v>
                </c:pt>
                <c:pt idx="309">
                  <c:v>361.8</c:v>
                </c:pt>
                <c:pt idx="310">
                  <c:v>362</c:v>
                </c:pt>
                <c:pt idx="311">
                  <c:v>362.2</c:v>
                </c:pt>
                <c:pt idx="312">
                  <c:v>362.4</c:v>
                </c:pt>
                <c:pt idx="313">
                  <c:v>362.6</c:v>
                </c:pt>
                <c:pt idx="314">
                  <c:v>362.8</c:v>
                </c:pt>
                <c:pt idx="315">
                  <c:v>363</c:v>
                </c:pt>
                <c:pt idx="316">
                  <c:v>363.2</c:v>
                </c:pt>
                <c:pt idx="317">
                  <c:v>363.4</c:v>
                </c:pt>
                <c:pt idx="318">
                  <c:v>363.6</c:v>
                </c:pt>
                <c:pt idx="319">
                  <c:v>363.8</c:v>
                </c:pt>
                <c:pt idx="320">
                  <c:v>364</c:v>
                </c:pt>
                <c:pt idx="321">
                  <c:v>364.2</c:v>
                </c:pt>
                <c:pt idx="322">
                  <c:v>364.4</c:v>
                </c:pt>
                <c:pt idx="323">
                  <c:v>364.6</c:v>
                </c:pt>
                <c:pt idx="324">
                  <c:v>364.8</c:v>
                </c:pt>
                <c:pt idx="325">
                  <c:v>365</c:v>
                </c:pt>
                <c:pt idx="326">
                  <c:v>365.2</c:v>
                </c:pt>
                <c:pt idx="327">
                  <c:v>365.4</c:v>
                </c:pt>
                <c:pt idx="328">
                  <c:v>365.6</c:v>
                </c:pt>
                <c:pt idx="329">
                  <c:v>365.8</c:v>
                </c:pt>
                <c:pt idx="330">
                  <c:v>366</c:v>
                </c:pt>
                <c:pt idx="331">
                  <c:v>366.2</c:v>
                </c:pt>
                <c:pt idx="332">
                  <c:v>366.4</c:v>
                </c:pt>
                <c:pt idx="333">
                  <c:v>366.6</c:v>
                </c:pt>
                <c:pt idx="334">
                  <c:v>366.8</c:v>
                </c:pt>
                <c:pt idx="335">
                  <c:v>367</c:v>
                </c:pt>
                <c:pt idx="336">
                  <c:v>367.2</c:v>
                </c:pt>
                <c:pt idx="337">
                  <c:v>367.4</c:v>
                </c:pt>
                <c:pt idx="338">
                  <c:v>367.6</c:v>
                </c:pt>
                <c:pt idx="339">
                  <c:v>367.8</c:v>
                </c:pt>
                <c:pt idx="340">
                  <c:v>368</c:v>
                </c:pt>
                <c:pt idx="341">
                  <c:v>368.2</c:v>
                </c:pt>
                <c:pt idx="342">
                  <c:v>368.4</c:v>
                </c:pt>
                <c:pt idx="343">
                  <c:v>368.6</c:v>
                </c:pt>
                <c:pt idx="344">
                  <c:v>368.8</c:v>
                </c:pt>
                <c:pt idx="345">
                  <c:v>369</c:v>
                </c:pt>
                <c:pt idx="346">
                  <c:v>369.2</c:v>
                </c:pt>
                <c:pt idx="347">
                  <c:v>369.4</c:v>
                </c:pt>
                <c:pt idx="348">
                  <c:v>369.6</c:v>
                </c:pt>
                <c:pt idx="349">
                  <c:v>369.8</c:v>
                </c:pt>
                <c:pt idx="350">
                  <c:v>370</c:v>
                </c:pt>
                <c:pt idx="351">
                  <c:v>370.2</c:v>
                </c:pt>
                <c:pt idx="352">
                  <c:v>370.4</c:v>
                </c:pt>
                <c:pt idx="353">
                  <c:v>370.6</c:v>
                </c:pt>
                <c:pt idx="354">
                  <c:v>370.8</c:v>
                </c:pt>
                <c:pt idx="355">
                  <c:v>371</c:v>
                </c:pt>
                <c:pt idx="356">
                  <c:v>371.2</c:v>
                </c:pt>
                <c:pt idx="357">
                  <c:v>371.4</c:v>
                </c:pt>
                <c:pt idx="358">
                  <c:v>371.6</c:v>
                </c:pt>
                <c:pt idx="359">
                  <c:v>371.8</c:v>
                </c:pt>
                <c:pt idx="360">
                  <c:v>372</c:v>
                </c:pt>
                <c:pt idx="361">
                  <c:v>372.2</c:v>
                </c:pt>
                <c:pt idx="362">
                  <c:v>372.4</c:v>
                </c:pt>
                <c:pt idx="363">
                  <c:v>372.6</c:v>
                </c:pt>
                <c:pt idx="364">
                  <c:v>372.8</c:v>
                </c:pt>
                <c:pt idx="365">
                  <c:v>373</c:v>
                </c:pt>
                <c:pt idx="366">
                  <c:v>373.2</c:v>
                </c:pt>
                <c:pt idx="367">
                  <c:v>373.4</c:v>
                </c:pt>
                <c:pt idx="368">
                  <c:v>373.6</c:v>
                </c:pt>
                <c:pt idx="369">
                  <c:v>373.8</c:v>
                </c:pt>
                <c:pt idx="370">
                  <c:v>374</c:v>
                </c:pt>
                <c:pt idx="371">
                  <c:v>374.2</c:v>
                </c:pt>
                <c:pt idx="372">
                  <c:v>374.4</c:v>
                </c:pt>
                <c:pt idx="373">
                  <c:v>374.6</c:v>
                </c:pt>
                <c:pt idx="374">
                  <c:v>374.8</c:v>
                </c:pt>
                <c:pt idx="375">
                  <c:v>375</c:v>
                </c:pt>
                <c:pt idx="376">
                  <c:v>375.2</c:v>
                </c:pt>
                <c:pt idx="377">
                  <c:v>375.4</c:v>
                </c:pt>
                <c:pt idx="378">
                  <c:v>375.6</c:v>
                </c:pt>
                <c:pt idx="379">
                  <c:v>375.8</c:v>
                </c:pt>
                <c:pt idx="380">
                  <c:v>376</c:v>
                </c:pt>
                <c:pt idx="381">
                  <c:v>376.2</c:v>
                </c:pt>
                <c:pt idx="382">
                  <c:v>376.4</c:v>
                </c:pt>
                <c:pt idx="383">
                  <c:v>376.6</c:v>
                </c:pt>
                <c:pt idx="384">
                  <c:v>376.8</c:v>
                </c:pt>
                <c:pt idx="385">
                  <c:v>377</c:v>
                </c:pt>
                <c:pt idx="386">
                  <c:v>377.2</c:v>
                </c:pt>
                <c:pt idx="387">
                  <c:v>377.4</c:v>
                </c:pt>
                <c:pt idx="388">
                  <c:v>377.6</c:v>
                </c:pt>
                <c:pt idx="389">
                  <c:v>377.8</c:v>
                </c:pt>
                <c:pt idx="390">
                  <c:v>378</c:v>
                </c:pt>
                <c:pt idx="391">
                  <c:v>378.2</c:v>
                </c:pt>
                <c:pt idx="392">
                  <c:v>378.4</c:v>
                </c:pt>
                <c:pt idx="393">
                  <c:v>378.6</c:v>
                </c:pt>
                <c:pt idx="394">
                  <c:v>378.8</c:v>
                </c:pt>
                <c:pt idx="395">
                  <c:v>379</c:v>
                </c:pt>
                <c:pt idx="396">
                  <c:v>379.2</c:v>
                </c:pt>
                <c:pt idx="397">
                  <c:v>379.4</c:v>
                </c:pt>
                <c:pt idx="398">
                  <c:v>379.6</c:v>
                </c:pt>
                <c:pt idx="399">
                  <c:v>379.8</c:v>
                </c:pt>
                <c:pt idx="400">
                  <c:v>380</c:v>
                </c:pt>
                <c:pt idx="401">
                  <c:v>380.2</c:v>
                </c:pt>
                <c:pt idx="402">
                  <c:v>380.4</c:v>
                </c:pt>
                <c:pt idx="403">
                  <c:v>380.6</c:v>
                </c:pt>
                <c:pt idx="404">
                  <c:v>380.8</c:v>
                </c:pt>
                <c:pt idx="405">
                  <c:v>381</c:v>
                </c:pt>
                <c:pt idx="406">
                  <c:v>381.2</c:v>
                </c:pt>
                <c:pt idx="407">
                  <c:v>381.4</c:v>
                </c:pt>
                <c:pt idx="408">
                  <c:v>381.6</c:v>
                </c:pt>
                <c:pt idx="409">
                  <c:v>381.8</c:v>
                </c:pt>
                <c:pt idx="410">
                  <c:v>382</c:v>
                </c:pt>
                <c:pt idx="411">
                  <c:v>382.2</c:v>
                </c:pt>
                <c:pt idx="412">
                  <c:v>382.4</c:v>
                </c:pt>
                <c:pt idx="413">
                  <c:v>382.6</c:v>
                </c:pt>
                <c:pt idx="414">
                  <c:v>382.8</c:v>
                </c:pt>
                <c:pt idx="415">
                  <c:v>383</c:v>
                </c:pt>
                <c:pt idx="416">
                  <c:v>383.2</c:v>
                </c:pt>
                <c:pt idx="417">
                  <c:v>383.4</c:v>
                </c:pt>
                <c:pt idx="418">
                  <c:v>383.6</c:v>
                </c:pt>
                <c:pt idx="419">
                  <c:v>383.8</c:v>
                </c:pt>
                <c:pt idx="420">
                  <c:v>384</c:v>
                </c:pt>
                <c:pt idx="421">
                  <c:v>384.2</c:v>
                </c:pt>
                <c:pt idx="422">
                  <c:v>384.4</c:v>
                </c:pt>
                <c:pt idx="423">
                  <c:v>384.6</c:v>
                </c:pt>
                <c:pt idx="424">
                  <c:v>384.8</c:v>
                </c:pt>
                <c:pt idx="425">
                  <c:v>385</c:v>
                </c:pt>
                <c:pt idx="426">
                  <c:v>385.2</c:v>
                </c:pt>
                <c:pt idx="427">
                  <c:v>385.4</c:v>
                </c:pt>
                <c:pt idx="428">
                  <c:v>385.6</c:v>
                </c:pt>
                <c:pt idx="429">
                  <c:v>385.8</c:v>
                </c:pt>
                <c:pt idx="430">
                  <c:v>386</c:v>
                </c:pt>
                <c:pt idx="431">
                  <c:v>386.2</c:v>
                </c:pt>
                <c:pt idx="432">
                  <c:v>386.4</c:v>
                </c:pt>
                <c:pt idx="433">
                  <c:v>386.6</c:v>
                </c:pt>
                <c:pt idx="434">
                  <c:v>386.8</c:v>
                </c:pt>
                <c:pt idx="435">
                  <c:v>387</c:v>
                </c:pt>
                <c:pt idx="436">
                  <c:v>387.2</c:v>
                </c:pt>
                <c:pt idx="437">
                  <c:v>387.4</c:v>
                </c:pt>
                <c:pt idx="438">
                  <c:v>387.6</c:v>
                </c:pt>
                <c:pt idx="439">
                  <c:v>387.8</c:v>
                </c:pt>
                <c:pt idx="440">
                  <c:v>388</c:v>
                </c:pt>
                <c:pt idx="441">
                  <c:v>388.2</c:v>
                </c:pt>
                <c:pt idx="442">
                  <c:v>388.4</c:v>
                </c:pt>
                <c:pt idx="443">
                  <c:v>388.6</c:v>
                </c:pt>
                <c:pt idx="444">
                  <c:v>388.8</c:v>
                </c:pt>
                <c:pt idx="445">
                  <c:v>389</c:v>
                </c:pt>
                <c:pt idx="446">
                  <c:v>389.2</c:v>
                </c:pt>
                <c:pt idx="447">
                  <c:v>389.4</c:v>
                </c:pt>
                <c:pt idx="448">
                  <c:v>389.6</c:v>
                </c:pt>
                <c:pt idx="449">
                  <c:v>389.8</c:v>
                </c:pt>
                <c:pt idx="450">
                  <c:v>390</c:v>
                </c:pt>
                <c:pt idx="451">
                  <c:v>390.2</c:v>
                </c:pt>
                <c:pt idx="452">
                  <c:v>390.4</c:v>
                </c:pt>
                <c:pt idx="453">
                  <c:v>390.6</c:v>
                </c:pt>
                <c:pt idx="454">
                  <c:v>390.8</c:v>
                </c:pt>
                <c:pt idx="455">
                  <c:v>391</c:v>
                </c:pt>
                <c:pt idx="456">
                  <c:v>391.2</c:v>
                </c:pt>
                <c:pt idx="457">
                  <c:v>391.4</c:v>
                </c:pt>
                <c:pt idx="458">
                  <c:v>391.6</c:v>
                </c:pt>
                <c:pt idx="459">
                  <c:v>391.8</c:v>
                </c:pt>
                <c:pt idx="460">
                  <c:v>392</c:v>
                </c:pt>
                <c:pt idx="461">
                  <c:v>392.2</c:v>
                </c:pt>
                <c:pt idx="462">
                  <c:v>392.4</c:v>
                </c:pt>
                <c:pt idx="463">
                  <c:v>392.6</c:v>
                </c:pt>
                <c:pt idx="464">
                  <c:v>392.8</c:v>
                </c:pt>
                <c:pt idx="465">
                  <c:v>393</c:v>
                </c:pt>
                <c:pt idx="466">
                  <c:v>393.2</c:v>
                </c:pt>
                <c:pt idx="467">
                  <c:v>393.4</c:v>
                </c:pt>
                <c:pt idx="468">
                  <c:v>393.6</c:v>
                </c:pt>
                <c:pt idx="469">
                  <c:v>393.8</c:v>
                </c:pt>
                <c:pt idx="470">
                  <c:v>394</c:v>
                </c:pt>
                <c:pt idx="471">
                  <c:v>394.2</c:v>
                </c:pt>
                <c:pt idx="472">
                  <c:v>394.4</c:v>
                </c:pt>
                <c:pt idx="473">
                  <c:v>394.6</c:v>
                </c:pt>
                <c:pt idx="474">
                  <c:v>394.8</c:v>
                </c:pt>
                <c:pt idx="475">
                  <c:v>395</c:v>
                </c:pt>
                <c:pt idx="476">
                  <c:v>395.2</c:v>
                </c:pt>
                <c:pt idx="477">
                  <c:v>395.4</c:v>
                </c:pt>
                <c:pt idx="478">
                  <c:v>395.6</c:v>
                </c:pt>
                <c:pt idx="479">
                  <c:v>395.8</c:v>
                </c:pt>
                <c:pt idx="480">
                  <c:v>396</c:v>
                </c:pt>
                <c:pt idx="481">
                  <c:v>396.2</c:v>
                </c:pt>
                <c:pt idx="482">
                  <c:v>396.4</c:v>
                </c:pt>
                <c:pt idx="483">
                  <c:v>396.6</c:v>
                </c:pt>
                <c:pt idx="484">
                  <c:v>396.8</c:v>
                </c:pt>
                <c:pt idx="485">
                  <c:v>397</c:v>
                </c:pt>
                <c:pt idx="486">
                  <c:v>397.2</c:v>
                </c:pt>
                <c:pt idx="487">
                  <c:v>397.4</c:v>
                </c:pt>
                <c:pt idx="488">
                  <c:v>397.6</c:v>
                </c:pt>
                <c:pt idx="489">
                  <c:v>397.8</c:v>
                </c:pt>
                <c:pt idx="490">
                  <c:v>398</c:v>
                </c:pt>
                <c:pt idx="491">
                  <c:v>398.2</c:v>
                </c:pt>
                <c:pt idx="492">
                  <c:v>398.4</c:v>
                </c:pt>
                <c:pt idx="493">
                  <c:v>398.6</c:v>
                </c:pt>
                <c:pt idx="494">
                  <c:v>398.8</c:v>
                </c:pt>
                <c:pt idx="495">
                  <c:v>399</c:v>
                </c:pt>
                <c:pt idx="496">
                  <c:v>399.2</c:v>
                </c:pt>
                <c:pt idx="497">
                  <c:v>399.4</c:v>
                </c:pt>
                <c:pt idx="498">
                  <c:v>399.6</c:v>
                </c:pt>
                <c:pt idx="499">
                  <c:v>399.8</c:v>
                </c:pt>
                <c:pt idx="500">
                  <c:v>400</c:v>
                </c:pt>
              </c:numCache>
            </c:numRef>
          </c:xVal>
          <c:yVal>
            <c:numRef>
              <c:f>Sheet1!$G$5:$G$505</c:f>
              <c:numCache>
                <c:formatCode>General</c:formatCode>
                <c:ptCount val="501"/>
                <c:pt idx="31">
                  <c:v>312.83999999999997</c:v>
                </c:pt>
                <c:pt idx="32">
                  <c:v>301.565</c:v>
                </c:pt>
                <c:pt idx="33">
                  <c:v>294.48500000000001</c:v>
                </c:pt>
                <c:pt idx="34">
                  <c:v>290.49900000000002</c:v>
                </c:pt>
                <c:pt idx="35">
                  <c:v>288.709</c:v>
                </c:pt>
                <c:pt idx="36">
                  <c:v>288.625</c:v>
                </c:pt>
                <c:pt idx="37">
                  <c:v>291.96800000000002</c:v>
                </c:pt>
                <c:pt idx="38">
                  <c:v>294.93400000000003</c:v>
                </c:pt>
                <c:pt idx="39">
                  <c:v>298.35500000000002</c:v>
                </c:pt>
                <c:pt idx="40">
                  <c:v>302.15199999999999</c:v>
                </c:pt>
                <c:pt idx="41">
                  <c:v>306.27199999999999</c:v>
                </c:pt>
                <c:pt idx="42">
                  <c:v>310.60899999999998</c:v>
                </c:pt>
                <c:pt idx="43">
                  <c:v>315.03300000000002</c:v>
                </c:pt>
                <c:pt idx="44">
                  <c:v>319.51799999999997</c:v>
                </c:pt>
                <c:pt idx="45">
                  <c:v>324.10199999999998</c:v>
                </c:pt>
                <c:pt idx="46">
                  <c:v>328.82400000000001</c:v>
                </c:pt>
                <c:pt idx="47">
                  <c:v>333.55500000000001</c:v>
                </c:pt>
                <c:pt idx="48">
                  <c:v>338.351</c:v>
                </c:pt>
                <c:pt idx="49">
                  <c:v>343.24</c:v>
                </c:pt>
                <c:pt idx="50">
                  <c:v>348.10599999999999</c:v>
                </c:pt>
                <c:pt idx="51">
                  <c:v>353.03300000000002</c:v>
                </c:pt>
                <c:pt idx="52">
                  <c:v>358.036</c:v>
                </c:pt>
                <c:pt idx="53">
                  <c:v>363.09199999999998</c:v>
                </c:pt>
                <c:pt idx="54">
                  <c:v>368.12900000000002</c:v>
                </c:pt>
                <c:pt idx="55">
                  <c:v>373.21300000000002</c:v>
                </c:pt>
                <c:pt idx="56">
                  <c:v>378.28500000000003</c:v>
                </c:pt>
                <c:pt idx="57">
                  <c:v>383.31700000000001</c:v>
                </c:pt>
                <c:pt idx="58">
                  <c:v>388.38</c:v>
                </c:pt>
                <c:pt idx="59">
                  <c:v>393.41800000000001</c:v>
                </c:pt>
                <c:pt idx="60">
                  <c:v>398.5</c:v>
                </c:pt>
                <c:pt idx="61">
                  <c:v>403.62</c:v>
                </c:pt>
                <c:pt idx="62">
                  <c:v>408.71</c:v>
                </c:pt>
                <c:pt idx="63">
                  <c:v>413.767</c:v>
                </c:pt>
                <c:pt idx="64">
                  <c:v>418.779</c:v>
                </c:pt>
                <c:pt idx="65">
                  <c:v>423.81799999999998</c:v>
                </c:pt>
                <c:pt idx="66">
                  <c:v>428.91399999999999</c:v>
                </c:pt>
                <c:pt idx="67">
                  <c:v>433.97899999999998</c:v>
                </c:pt>
                <c:pt idx="68">
                  <c:v>439.03800000000001</c:v>
                </c:pt>
                <c:pt idx="69">
                  <c:v>444.09399999999999</c:v>
                </c:pt>
                <c:pt idx="70">
                  <c:v>449.06700000000001</c:v>
                </c:pt>
                <c:pt idx="71">
                  <c:v>453.93</c:v>
                </c:pt>
                <c:pt idx="72">
                  <c:v>458.79700000000003</c:v>
                </c:pt>
                <c:pt idx="73">
                  <c:v>463.7</c:v>
                </c:pt>
                <c:pt idx="74">
                  <c:v>468.59899999999999</c:v>
                </c:pt>
                <c:pt idx="75">
                  <c:v>473.41300000000001</c:v>
                </c:pt>
                <c:pt idx="76">
                  <c:v>478.13099999999997</c:v>
                </c:pt>
                <c:pt idx="77">
                  <c:v>482.90899999999999</c:v>
                </c:pt>
                <c:pt idx="78">
                  <c:v>487.64699999999999</c:v>
                </c:pt>
                <c:pt idx="79">
                  <c:v>492.423</c:v>
                </c:pt>
                <c:pt idx="80">
                  <c:v>497.2</c:v>
                </c:pt>
                <c:pt idx="81">
                  <c:v>501.97399999999999</c:v>
                </c:pt>
                <c:pt idx="82">
                  <c:v>506.78199999999998</c:v>
                </c:pt>
                <c:pt idx="83">
                  <c:v>511.471</c:v>
                </c:pt>
                <c:pt idx="84">
                  <c:v>516.32500000000005</c:v>
                </c:pt>
                <c:pt idx="85">
                  <c:v>521.23299999999995</c:v>
                </c:pt>
                <c:pt idx="86">
                  <c:v>526.11</c:v>
                </c:pt>
                <c:pt idx="87">
                  <c:v>531.12699999999995</c:v>
                </c:pt>
                <c:pt idx="88">
                  <c:v>536.13599999999997</c:v>
                </c:pt>
                <c:pt idx="89">
                  <c:v>541.15200000000004</c:v>
                </c:pt>
                <c:pt idx="90">
                  <c:v>546.17100000000005</c:v>
                </c:pt>
                <c:pt idx="91">
                  <c:v>551.16200000000003</c:v>
                </c:pt>
                <c:pt idx="92">
                  <c:v>556.12199999999996</c:v>
                </c:pt>
                <c:pt idx="93">
                  <c:v>561.13800000000003</c:v>
                </c:pt>
                <c:pt idx="94">
                  <c:v>566.33900000000006</c:v>
                </c:pt>
                <c:pt idx="95">
                  <c:v>571.71900000000005</c:v>
                </c:pt>
                <c:pt idx="96">
                  <c:v>577.303</c:v>
                </c:pt>
                <c:pt idx="97">
                  <c:v>583.05399999999997</c:v>
                </c:pt>
                <c:pt idx="98">
                  <c:v>588.86500000000001</c:v>
                </c:pt>
                <c:pt idx="99">
                  <c:v>594.86500000000001</c:v>
                </c:pt>
                <c:pt idx="100">
                  <c:v>601.05899999999997</c:v>
                </c:pt>
                <c:pt idx="101">
                  <c:v>607.22799999999995</c:v>
                </c:pt>
                <c:pt idx="102">
                  <c:v>613.38699999999994</c:v>
                </c:pt>
                <c:pt idx="103">
                  <c:v>619.654</c:v>
                </c:pt>
                <c:pt idx="104">
                  <c:v>625.96699999999998</c:v>
                </c:pt>
                <c:pt idx="105">
                  <c:v>632.34</c:v>
                </c:pt>
                <c:pt idx="106">
                  <c:v>638.80100000000004</c:v>
                </c:pt>
                <c:pt idx="107">
                  <c:v>645.44399999999996</c:v>
                </c:pt>
                <c:pt idx="108">
                  <c:v>652.38</c:v>
                </c:pt>
                <c:pt idx="109">
                  <c:v>659.47699999999998</c:v>
                </c:pt>
                <c:pt idx="110">
                  <c:v>666.62400000000002</c:v>
                </c:pt>
                <c:pt idx="111">
                  <c:v>673.822</c:v>
                </c:pt>
                <c:pt idx="112">
                  <c:v>681.09</c:v>
                </c:pt>
                <c:pt idx="113">
                  <c:v>688.43499999999995</c:v>
                </c:pt>
                <c:pt idx="114">
                  <c:v>695.91</c:v>
                </c:pt>
                <c:pt idx="115">
                  <c:v>703.51599999999996</c:v>
                </c:pt>
                <c:pt idx="116">
                  <c:v>711.18499999999995</c:v>
                </c:pt>
                <c:pt idx="117">
                  <c:v>718.93399999999997</c:v>
                </c:pt>
                <c:pt idx="118">
                  <c:v>726.66700000000003</c:v>
                </c:pt>
                <c:pt idx="119">
                  <c:v>734.24199999999996</c:v>
                </c:pt>
                <c:pt idx="120">
                  <c:v>741.74599999999998</c:v>
                </c:pt>
                <c:pt idx="121">
                  <c:v>749.18499999999995</c:v>
                </c:pt>
                <c:pt idx="122">
                  <c:v>756.59799999999996</c:v>
                </c:pt>
                <c:pt idx="123">
                  <c:v>764.08600000000001</c:v>
                </c:pt>
                <c:pt idx="124">
                  <c:v>771.39700000000005</c:v>
                </c:pt>
                <c:pt idx="125">
                  <c:v>778.51300000000003</c:v>
                </c:pt>
                <c:pt idx="126">
                  <c:v>785.69799999999998</c:v>
                </c:pt>
                <c:pt idx="127">
                  <c:v>792.85400000000004</c:v>
                </c:pt>
                <c:pt idx="128">
                  <c:v>799.90899999999999</c:v>
                </c:pt>
                <c:pt idx="129">
                  <c:v>806.88699999999994</c:v>
                </c:pt>
                <c:pt idx="130">
                  <c:v>813.78499999999997</c:v>
                </c:pt>
                <c:pt idx="131">
                  <c:v>820.57399999999996</c:v>
                </c:pt>
                <c:pt idx="132">
                  <c:v>827.15300000000002</c:v>
                </c:pt>
                <c:pt idx="133">
                  <c:v>833.577</c:v>
                </c:pt>
                <c:pt idx="134">
                  <c:v>839.66200000000003</c:v>
                </c:pt>
                <c:pt idx="135">
                  <c:v>845.48400000000004</c:v>
                </c:pt>
                <c:pt idx="136">
                  <c:v>851.31700000000001</c:v>
                </c:pt>
                <c:pt idx="137">
                  <c:v>857.00199999999995</c:v>
                </c:pt>
                <c:pt idx="138">
                  <c:v>862.46600000000001</c:v>
                </c:pt>
                <c:pt idx="139">
                  <c:v>867.68600000000004</c:v>
                </c:pt>
                <c:pt idx="140">
                  <c:v>872.62400000000002</c:v>
                </c:pt>
                <c:pt idx="141">
                  <c:v>877.41899999999998</c:v>
                </c:pt>
                <c:pt idx="142">
                  <c:v>882.11300000000006</c:v>
                </c:pt>
                <c:pt idx="143">
                  <c:v>886.70899999999995</c:v>
                </c:pt>
                <c:pt idx="144">
                  <c:v>891.26700000000005</c:v>
                </c:pt>
                <c:pt idx="145">
                  <c:v>895.65700000000004</c:v>
                </c:pt>
                <c:pt idx="146">
                  <c:v>899.81700000000001</c:v>
                </c:pt>
                <c:pt idx="147">
                  <c:v>903.76900000000001</c:v>
                </c:pt>
                <c:pt idx="148">
                  <c:v>907.54399999999998</c:v>
                </c:pt>
                <c:pt idx="149">
                  <c:v>911.27</c:v>
                </c:pt>
                <c:pt idx="150">
                  <c:v>914.947</c:v>
                </c:pt>
                <c:pt idx="151">
                  <c:v>918.35900000000004</c:v>
                </c:pt>
                <c:pt idx="152">
                  <c:v>921.65200000000004</c:v>
                </c:pt>
                <c:pt idx="153">
                  <c:v>924.99699999999996</c:v>
                </c:pt>
                <c:pt idx="154">
                  <c:v>928.15499999999997</c:v>
                </c:pt>
                <c:pt idx="155">
                  <c:v>931.13599999999997</c:v>
                </c:pt>
                <c:pt idx="156">
                  <c:v>934.10799999999995</c:v>
                </c:pt>
                <c:pt idx="157">
                  <c:v>937.18799999999999</c:v>
                </c:pt>
                <c:pt idx="158">
                  <c:v>940.23500000000001</c:v>
                </c:pt>
                <c:pt idx="159">
                  <c:v>943.25800000000004</c:v>
                </c:pt>
                <c:pt idx="160">
                  <c:v>946.46</c:v>
                </c:pt>
                <c:pt idx="161">
                  <c:v>949.53399999999999</c:v>
                </c:pt>
                <c:pt idx="162">
                  <c:v>952.49599999999998</c:v>
                </c:pt>
                <c:pt idx="163">
                  <c:v>955.61400000000003</c:v>
                </c:pt>
                <c:pt idx="164">
                  <c:v>958.74400000000003</c:v>
                </c:pt>
                <c:pt idx="165">
                  <c:v>961.64800000000002</c:v>
                </c:pt>
                <c:pt idx="166">
                  <c:v>964.44500000000005</c:v>
                </c:pt>
                <c:pt idx="167">
                  <c:v>967.30799999999999</c:v>
                </c:pt>
                <c:pt idx="168">
                  <c:v>970.19299999999998</c:v>
                </c:pt>
                <c:pt idx="169">
                  <c:v>973.01900000000001</c:v>
                </c:pt>
                <c:pt idx="170">
                  <c:v>975.79300000000001</c:v>
                </c:pt>
                <c:pt idx="171">
                  <c:v>978.69200000000001</c:v>
                </c:pt>
                <c:pt idx="172">
                  <c:v>981.61699999999996</c:v>
                </c:pt>
                <c:pt idx="173">
                  <c:v>984.44799999999998</c:v>
                </c:pt>
                <c:pt idx="174">
                  <c:v>987.2</c:v>
                </c:pt>
                <c:pt idx="175">
                  <c:v>989.99300000000005</c:v>
                </c:pt>
                <c:pt idx="176">
                  <c:v>992.95299999999997</c:v>
                </c:pt>
                <c:pt idx="177">
                  <c:v>995.92</c:v>
                </c:pt>
                <c:pt idx="178">
                  <c:v>998.77099999999996</c:v>
                </c:pt>
                <c:pt idx="179">
                  <c:v>1001.76</c:v>
                </c:pt>
                <c:pt idx="180">
                  <c:v>1004.87</c:v>
                </c:pt>
                <c:pt idx="181">
                  <c:v>1007.78</c:v>
                </c:pt>
                <c:pt idx="182">
                  <c:v>1010.38</c:v>
                </c:pt>
                <c:pt idx="183">
                  <c:v>1012.88</c:v>
                </c:pt>
                <c:pt idx="184">
                  <c:v>1015.46</c:v>
                </c:pt>
                <c:pt idx="185">
                  <c:v>1017.89</c:v>
                </c:pt>
                <c:pt idx="186">
                  <c:v>1020.31</c:v>
                </c:pt>
                <c:pt idx="187">
                  <c:v>1022.81</c:v>
                </c:pt>
                <c:pt idx="188">
                  <c:v>1025.05</c:v>
                </c:pt>
                <c:pt idx="189">
                  <c:v>1027.21</c:v>
                </c:pt>
                <c:pt idx="190">
                  <c:v>1029.57</c:v>
                </c:pt>
                <c:pt idx="191">
                  <c:v>1031.8499999999999</c:v>
                </c:pt>
                <c:pt idx="192">
                  <c:v>1033.98</c:v>
                </c:pt>
                <c:pt idx="193">
                  <c:v>1035.96</c:v>
                </c:pt>
                <c:pt idx="194">
                  <c:v>1037.83</c:v>
                </c:pt>
                <c:pt idx="195">
                  <c:v>1039.69</c:v>
                </c:pt>
                <c:pt idx="196">
                  <c:v>1041.47</c:v>
                </c:pt>
                <c:pt idx="197">
                  <c:v>1043.26</c:v>
                </c:pt>
                <c:pt idx="198">
                  <c:v>1045.0899999999999</c:v>
                </c:pt>
                <c:pt idx="199">
                  <c:v>1046.75</c:v>
                </c:pt>
                <c:pt idx="200">
                  <c:v>1048.1400000000001</c:v>
                </c:pt>
                <c:pt idx="201">
                  <c:v>1049.52</c:v>
                </c:pt>
                <c:pt idx="202">
                  <c:v>1050.83</c:v>
                </c:pt>
                <c:pt idx="203">
                  <c:v>1051.99</c:v>
                </c:pt>
                <c:pt idx="204">
                  <c:v>1052.97</c:v>
                </c:pt>
                <c:pt idx="205">
                  <c:v>1053.9000000000001</c:v>
                </c:pt>
                <c:pt idx="206">
                  <c:v>1054.94</c:v>
                </c:pt>
                <c:pt idx="207">
                  <c:v>1056</c:v>
                </c:pt>
                <c:pt idx="208">
                  <c:v>1056.83</c:v>
                </c:pt>
                <c:pt idx="209">
                  <c:v>1057.47</c:v>
                </c:pt>
                <c:pt idx="210">
                  <c:v>1058.02</c:v>
                </c:pt>
                <c:pt idx="211">
                  <c:v>1058.46</c:v>
                </c:pt>
                <c:pt idx="212">
                  <c:v>1058.73</c:v>
                </c:pt>
                <c:pt idx="213">
                  <c:v>1059.0999999999999</c:v>
                </c:pt>
                <c:pt idx="214">
                  <c:v>1059.3599999999999</c:v>
                </c:pt>
                <c:pt idx="215">
                  <c:v>1059.44</c:v>
                </c:pt>
                <c:pt idx="216">
                  <c:v>1059.6199999999999</c:v>
                </c:pt>
                <c:pt idx="217">
                  <c:v>1059.77</c:v>
                </c:pt>
                <c:pt idx="218">
                  <c:v>1059.8599999999999</c:v>
                </c:pt>
                <c:pt idx="219">
                  <c:v>1059.95</c:v>
                </c:pt>
                <c:pt idx="220">
                  <c:v>1060.06</c:v>
                </c:pt>
                <c:pt idx="221">
                  <c:v>1060.03</c:v>
                </c:pt>
                <c:pt idx="222">
                  <c:v>1059.81</c:v>
                </c:pt>
                <c:pt idx="223">
                  <c:v>1059.33</c:v>
                </c:pt>
                <c:pt idx="224">
                  <c:v>1058.92</c:v>
                </c:pt>
                <c:pt idx="225">
                  <c:v>1058.6300000000001</c:v>
                </c:pt>
                <c:pt idx="226">
                  <c:v>1058.04</c:v>
                </c:pt>
                <c:pt idx="227">
                  <c:v>1057.3699999999999</c:v>
                </c:pt>
                <c:pt idx="228">
                  <c:v>1056.78</c:v>
                </c:pt>
                <c:pt idx="229">
                  <c:v>1056.21</c:v>
                </c:pt>
                <c:pt idx="230">
                  <c:v>1055.56</c:v>
                </c:pt>
                <c:pt idx="231">
                  <c:v>1054.77</c:v>
                </c:pt>
                <c:pt idx="232">
                  <c:v>1053.92</c:v>
                </c:pt>
                <c:pt idx="233">
                  <c:v>1053.17</c:v>
                </c:pt>
                <c:pt idx="234">
                  <c:v>1052.3900000000001</c:v>
                </c:pt>
                <c:pt idx="235">
                  <c:v>1051.5</c:v>
                </c:pt>
                <c:pt idx="236">
                  <c:v>1050.6400000000001</c:v>
                </c:pt>
                <c:pt idx="237">
                  <c:v>1049.78</c:v>
                </c:pt>
                <c:pt idx="238">
                  <c:v>1048.75</c:v>
                </c:pt>
                <c:pt idx="239">
                  <c:v>1047.8399999999999</c:v>
                </c:pt>
                <c:pt idx="240">
                  <c:v>1047.01</c:v>
                </c:pt>
                <c:pt idx="241">
                  <c:v>1046.01</c:v>
                </c:pt>
                <c:pt idx="242">
                  <c:v>1044.8499999999999</c:v>
                </c:pt>
                <c:pt idx="243">
                  <c:v>1043.57</c:v>
                </c:pt>
                <c:pt idx="244">
                  <c:v>1042.32</c:v>
                </c:pt>
                <c:pt idx="245">
                  <c:v>1041.01</c:v>
                </c:pt>
                <c:pt idx="246">
                  <c:v>1039.58</c:v>
                </c:pt>
                <c:pt idx="247">
                  <c:v>1038.1099999999999</c:v>
                </c:pt>
                <c:pt idx="248">
                  <c:v>1036.71</c:v>
                </c:pt>
                <c:pt idx="249">
                  <c:v>1035.3</c:v>
                </c:pt>
                <c:pt idx="250">
                  <c:v>1033.96</c:v>
                </c:pt>
                <c:pt idx="251">
                  <c:v>1032.76</c:v>
                </c:pt>
                <c:pt idx="252">
                  <c:v>1031.48</c:v>
                </c:pt>
                <c:pt idx="253">
                  <c:v>1030.04</c:v>
                </c:pt>
                <c:pt idx="254">
                  <c:v>1028.47</c:v>
                </c:pt>
                <c:pt idx="255">
                  <c:v>1026.8</c:v>
                </c:pt>
                <c:pt idx="256">
                  <c:v>1025.18</c:v>
                </c:pt>
                <c:pt idx="257">
                  <c:v>1023.54</c:v>
                </c:pt>
                <c:pt idx="258">
                  <c:v>1021.77</c:v>
                </c:pt>
                <c:pt idx="259">
                  <c:v>1019.88</c:v>
                </c:pt>
                <c:pt idx="260">
                  <c:v>1018.06</c:v>
                </c:pt>
                <c:pt idx="261">
                  <c:v>1016.31</c:v>
                </c:pt>
                <c:pt idx="262">
                  <c:v>1014.46</c:v>
                </c:pt>
                <c:pt idx="263">
                  <c:v>1012.66</c:v>
                </c:pt>
                <c:pt idx="264">
                  <c:v>1010.89</c:v>
                </c:pt>
                <c:pt idx="265">
                  <c:v>1009.08</c:v>
                </c:pt>
                <c:pt idx="266">
                  <c:v>1007.18</c:v>
                </c:pt>
                <c:pt idx="267">
                  <c:v>1005.32</c:v>
                </c:pt>
                <c:pt idx="268">
                  <c:v>1003.46</c:v>
                </c:pt>
                <c:pt idx="269">
                  <c:v>1001.46</c:v>
                </c:pt>
                <c:pt idx="270">
                  <c:v>999.35699999999997</c:v>
                </c:pt>
                <c:pt idx="271">
                  <c:v>997.32</c:v>
                </c:pt>
                <c:pt idx="272">
                  <c:v>995.26400000000001</c:v>
                </c:pt>
                <c:pt idx="273">
                  <c:v>993.10699999999997</c:v>
                </c:pt>
                <c:pt idx="274">
                  <c:v>990.904</c:v>
                </c:pt>
                <c:pt idx="275">
                  <c:v>988.68700000000001</c:v>
                </c:pt>
                <c:pt idx="276">
                  <c:v>986.35500000000002</c:v>
                </c:pt>
                <c:pt idx="277">
                  <c:v>983.99900000000002</c:v>
                </c:pt>
                <c:pt idx="278">
                  <c:v>981.75300000000004</c:v>
                </c:pt>
                <c:pt idx="279">
                  <c:v>979.53300000000002</c:v>
                </c:pt>
                <c:pt idx="280">
                  <c:v>977.30700000000002</c:v>
                </c:pt>
                <c:pt idx="281">
                  <c:v>974.94399999999996</c:v>
                </c:pt>
                <c:pt idx="282">
                  <c:v>972.57799999999997</c:v>
                </c:pt>
                <c:pt idx="283">
                  <c:v>970.31399999999996</c:v>
                </c:pt>
                <c:pt idx="284">
                  <c:v>968.10299999999995</c:v>
                </c:pt>
                <c:pt idx="285">
                  <c:v>965.75099999999998</c:v>
                </c:pt>
                <c:pt idx="286">
                  <c:v>963.28700000000003</c:v>
                </c:pt>
                <c:pt idx="287">
                  <c:v>960.77599999999995</c:v>
                </c:pt>
                <c:pt idx="288">
                  <c:v>958.14099999999996</c:v>
                </c:pt>
                <c:pt idx="289">
                  <c:v>953.98099999999999</c:v>
                </c:pt>
                <c:pt idx="290">
                  <c:v>949.91</c:v>
                </c:pt>
                <c:pt idx="291">
                  <c:v>945.93700000000001</c:v>
                </c:pt>
                <c:pt idx="292">
                  <c:v>941.899</c:v>
                </c:pt>
                <c:pt idx="293">
                  <c:v>937.85900000000004</c:v>
                </c:pt>
                <c:pt idx="294">
                  <c:v>933.95100000000002</c:v>
                </c:pt>
                <c:pt idx="295">
                  <c:v>930.23800000000006</c:v>
                </c:pt>
                <c:pt idx="296">
                  <c:v>926.55</c:v>
                </c:pt>
                <c:pt idx="297">
                  <c:v>922.70500000000004</c:v>
                </c:pt>
                <c:pt idx="298">
                  <c:v>918.77200000000005</c:v>
                </c:pt>
                <c:pt idx="299">
                  <c:v>914.846</c:v>
                </c:pt>
                <c:pt idx="300">
                  <c:v>910.79399999999998</c:v>
                </c:pt>
                <c:pt idx="301">
                  <c:v>906.81100000000004</c:v>
                </c:pt>
                <c:pt idx="302">
                  <c:v>902.86599999999999</c:v>
                </c:pt>
                <c:pt idx="303">
                  <c:v>898.827</c:v>
                </c:pt>
                <c:pt idx="304">
                  <c:v>894.803</c:v>
                </c:pt>
                <c:pt idx="305">
                  <c:v>890.74699999999996</c:v>
                </c:pt>
                <c:pt idx="306">
                  <c:v>886.75699999999995</c:v>
                </c:pt>
                <c:pt idx="307">
                  <c:v>882.78200000000004</c:v>
                </c:pt>
                <c:pt idx="308">
                  <c:v>878.67399999999998</c:v>
                </c:pt>
                <c:pt idx="309">
                  <c:v>874.63300000000004</c:v>
                </c:pt>
                <c:pt idx="310">
                  <c:v>870.69200000000001</c:v>
                </c:pt>
                <c:pt idx="311">
                  <c:v>866.58299999999997</c:v>
                </c:pt>
                <c:pt idx="312">
                  <c:v>862.50099999999998</c:v>
                </c:pt>
                <c:pt idx="313">
                  <c:v>858.57600000000002</c:v>
                </c:pt>
                <c:pt idx="314">
                  <c:v>856.07100000000003</c:v>
                </c:pt>
                <c:pt idx="315">
                  <c:v>853.52099999999996</c:v>
                </c:pt>
                <c:pt idx="316">
                  <c:v>850.91300000000001</c:v>
                </c:pt>
                <c:pt idx="317">
                  <c:v>848.26599999999996</c:v>
                </c:pt>
                <c:pt idx="318">
                  <c:v>845.55200000000002</c:v>
                </c:pt>
                <c:pt idx="319">
                  <c:v>842.72199999999998</c:v>
                </c:pt>
                <c:pt idx="320">
                  <c:v>839.75599999999997</c:v>
                </c:pt>
                <c:pt idx="321">
                  <c:v>836.78700000000003</c:v>
                </c:pt>
                <c:pt idx="322">
                  <c:v>834.06100000000004</c:v>
                </c:pt>
                <c:pt idx="323">
                  <c:v>831.45299999999997</c:v>
                </c:pt>
                <c:pt idx="324">
                  <c:v>828.78899999999999</c:v>
                </c:pt>
                <c:pt idx="325">
                  <c:v>826.10799999999995</c:v>
                </c:pt>
                <c:pt idx="326">
                  <c:v>823.33</c:v>
                </c:pt>
                <c:pt idx="327">
                  <c:v>820.572</c:v>
                </c:pt>
                <c:pt idx="328">
                  <c:v>817.84699999999998</c:v>
                </c:pt>
                <c:pt idx="329">
                  <c:v>815.072</c:v>
                </c:pt>
                <c:pt idx="330">
                  <c:v>812.36099999999999</c:v>
                </c:pt>
                <c:pt idx="331">
                  <c:v>809.64599999999996</c:v>
                </c:pt>
                <c:pt idx="332">
                  <c:v>806.779</c:v>
                </c:pt>
                <c:pt idx="333">
                  <c:v>803.88900000000001</c:v>
                </c:pt>
                <c:pt idx="334">
                  <c:v>801.14</c:v>
                </c:pt>
                <c:pt idx="335">
                  <c:v>798.45299999999997</c:v>
                </c:pt>
                <c:pt idx="336">
                  <c:v>795.88</c:v>
                </c:pt>
                <c:pt idx="337">
                  <c:v>793.33199999999999</c:v>
                </c:pt>
                <c:pt idx="338">
                  <c:v>790.60299999999995</c:v>
                </c:pt>
                <c:pt idx="339">
                  <c:v>787.73299999999995</c:v>
                </c:pt>
                <c:pt idx="340">
                  <c:v>784.81399999999996</c:v>
                </c:pt>
                <c:pt idx="341">
                  <c:v>781.95399999999995</c:v>
                </c:pt>
                <c:pt idx="342">
                  <c:v>779.13599999999997</c:v>
                </c:pt>
                <c:pt idx="343">
                  <c:v>776.46600000000001</c:v>
                </c:pt>
                <c:pt idx="344">
                  <c:v>773.84299999999996</c:v>
                </c:pt>
                <c:pt idx="345">
                  <c:v>771.20299999999997</c:v>
                </c:pt>
                <c:pt idx="346">
                  <c:v>768.53599999999994</c:v>
                </c:pt>
                <c:pt idx="347">
                  <c:v>765.77300000000002</c:v>
                </c:pt>
                <c:pt idx="348">
                  <c:v>763.05799999999999</c:v>
                </c:pt>
                <c:pt idx="349">
                  <c:v>760.29499999999996</c:v>
                </c:pt>
                <c:pt idx="350">
                  <c:v>757.53099999999995</c:v>
                </c:pt>
                <c:pt idx="351">
                  <c:v>754.947</c:v>
                </c:pt>
                <c:pt idx="352">
                  <c:v>752.41800000000001</c:v>
                </c:pt>
                <c:pt idx="353">
                  <c:v>749.77499999999998</c:v>
                </c:pt>
                <c:pt idx="354">
                  <c:v>747.15599999999995</c:v>
                </c:pt>
                <c:pt idx="355">
                  <c:v>744.53499999999997</c:v>
                </c:pt>
                <c:pt idx="356">
                  <c:v>741.851</c:v>
                </c:pt>
                <c:pt idx="357">
                  <c:v>739.43</c:v>
                </c:pt>
                <c:pt idx="358">
                  <c:v>737.12900000000002</c:v>
                </c:pt>
                <c:pt idx="359">
                  <c:v>734.649</c:v>
                </c:pt>
                <c:pt idx="360">
                  <c:v>732.096</c:v>
                </c:pt>
                <c:pt idx="361">
                  <c:v>729.45799999999997</c:v>
                </c:pt>
                <c:pt idx="362">
                  <c:v>726.81299999999999</c:v>
                </c:pt>
                <c:pt idx="363">
                  <c:v>724.31</c:v>
                </c:pt>
                <c:pt idx="364">
                  <c:v>721.84799999999996</c:v>
                </c:pt>
                <c:pt idx="365">
                  <c:v>719.34500000000003</c:v>
                </c:pt>
                <c:pt idx="366">
                  <c:v>716.89300000000003</c:v>
                </c:pt>
                <c:pt idx="367">
                  <c:v>714.548</c:v>
                </c:pt>
                <c:pt idx="368">
                  <c:v>712.149</c:v>
                </c:pt>
                <c:pt idx="369">
                  <c:v>709.71900000000005</c:v>
                </c:pt>
                <c:pt idx="370">
                  <c:v>707.32100000000003</c:v>
                </c:pt>
                <c:pt idx="371">
                  <c:v>704.91300000000001</c:v>
                </c:pt>
                <c:pt idx="372">
                  <c:v>702.40899999999999</c:v>
                </c:pt>
                <c:pt idx="373">
                  <c:v>699.83900000000006</c:v>
                </c:pt>
                <c:pt idx="374">
                  <c:v>697.44399999999996</c:v>
                </c:pt>
                <c:pt idx="375">
                  <c:v>695.08600000000001</c:v>
                </c:pt>
                <c:pt idx="376">
                  <c:v>692.65300000000002</c:v>
                </c:pt>
                <c:pt idx="377">
                  <c:v>690.202</c:v>
                </c:pt>
                <c:pt idx="378">
                  <c:v>687.79399999999998</c:v>
                </c:pt>
                <c:pt idx="379">
                  <c:v>685.34500000000003</c:v>
                </c:pt>
                <c:pt idx="380">
                  <c:v>682.78700000000003</c:v>
                </c:pt>
                <c:pt idx="381">
                  <c:v>680.38699999999994</c:v>
                </c:pt>
                <c:pt idx="382">
                  <c:v>677.91899999999998</c:v>
                </c:pt>
                <c:pt idx="383">
                  <c:v>675.30100000000004</c:v>
                </c:pt>
                <c:pt idx="384">
                  <c:v>672.72400000000005</c:v>
                </c:pt>
                <c:pt idx="385">
                  <c:v>670.29200000000003</c:v>
                </c:pt>
                <c:pt idx="386">
                  <c:v>667.94600000000003</c:v>
                </c:pt>
                <c:pt idx="387">
                  <c:v>665.48800000000006</c:v>
                </c:pt>
                <c:pt idx="388">
                  <c:v>663.06500000000005</c:v>
                </c:pt>
                <c:pt idx="389">
                  <c:v>660.7</c:v>
                </c:pt>
                <c:pt idx="390">
                  <c:v>658.34100000000001</c:v>
                </c:pt>
                <c:pt idx="391">
                  <c:v>655.88199999999995</c:v>
                </c:pt>
                <c:pt idx="392">
                  <c:v>653.33799999999997</c:v>
                </c:pt>
                <c:pt idx="393">
                  <c:v>650.86900000000003</c:v>
                </c:pt>
                <c:pt idx="394">
                  <c:v>648.41099999999994</c:v>
                </c:pt>
                <c:pt idx="395">
                  <c:v>645.91</c:v>
                </c:pt>
                <c:pt idx="396">
                  <c:v>643.48199999999997</c:v>
                </c:pt>
                <c:pt idx="397">
                  <c:v>641.23900000000003</c:v>
                </c:pt>
                <c:pt idx="398">
                  <c:v>639.072</c:v>
                </c:pt>
                <c:pt idx="399">
                  <c:v>636.83799999999997</c:v>
                </c:pt>
                <c:pt idx="400">
                  <c:v>634.62900000000002</c:v>
                </c:pt>
                <c:pt idx="401">
                  <c:v>632.30799999999999</c:v>
                </c:pt>
                <c:pt idx="402">
                  <c:v>629.923</c:v>
                </c:pt>
                <c:pt idx="403">
                  <c:v>627.62300000000005</c:v>
                </c:pt>
                <c:pt idx="404">
                  <c:v>625.30399999999997</c:v>
                </c:pt>
                <c:pt idx="405">
                  <c:v>623.07899999999995</c:v>
                </c:pt>
                <c:pt idx="406">
                  <c:v>620.82600000000002</c:v>
                </c:pt>
                <c:pt idx="407">
                  <c:v>618.51700000000005</c:v>
                </c:pt>
                <c:pt idx="408">
                  <c:v>616.29499999999996</c:v>
                </c:pt>
                <c:pt idx="409">
                  <c:v>614.12</c:v>
                </c:pt>
                <c:pt idx="410">
                  <c:v>611.89400000000001</c:v>
                </c:pt>
                <c:pt idx="411">
                  <c:v>609.70799999999997</c:v>
                </c:pt>
                <c:pt idx="412">
                  <c:v>607.63400000000001</c:v>
                </c:pt>
                <c:pt idx="413">
                  <c:v>605.529</c:v>
                </c:pt>
                <c:pt idx="414">
                  <c:v>603.45000000000005</c:v>
                </c:pt>
                <c:pt idx="415">
                  <c:v>601.34199999999998</c:v>
                </c:pt>
                <c:pt idx="416">
                  <c:v>599.20600000000002</c:v>
                </c:pt>
                <c:pt idx="417">
                  <c:v>597.10900000000004</c:v>
                </c:pt>
                <c:pt idx="418">
                  <c:v>594.96100000000001</c:v>
                </c:pt>
                <c:pt idx="419">
                  <c:v>592.82399999999996</c:v>
                </c:pt>
                <c:pt idx="420">
                  <c:v>590.73800000000006</c:v>
                </c:pt>
                <c:pt idx="421">
                  <c:v>588.61599999999999</c:v>
                </c:pt>
                <c:pt idx="422">
                  <c:v>586.37</c:v>
                </c:pt>
                <c:pt idx="423">
                  <c:v>584.08399999999995</c:v>
                </c:pt>
                <c:pt idx="424">
                  <c:v>581.73900000000003</c:v>
                </c:pt>
                <c:pt idx="425">
                  <c:v>579.33500000000004</c:v>
                </c:pt>
                <c:pt idx="426">
                  <c:v>577.15099999999995</c:v>
                </c:pt>
                <c:pt idx="427">
                  <c:v>575.03200000000004</c:v>
                </c:pt>
                <c:pt idx="428">
                  <c:v>572.91700000000003</c:v>
                </c:pt>
                <c:pt idx="429">
                  <c:v>570.93899999999996</c:v>
                </c:pt>
                <c:pt idx="430">
                  <c:v>568.928</c:v>
                </c:pt>
                <c:pt idx="431">
                  <c:v>566.85299999999995</c:v>
                </c:pt>
                <c:pt idx="432">
                  <c:v>564.86800000000005</c:v>
                </c:pt>
                <c:pt idx="433">
                  <c:v>562.94600000000003</c:v>
                </c:pt>
                <c:pt idx="434">
                  <c:v>560.89499999999998</c:v>
                </c:pt>
                <c:pt idx="435">
                  <c:v>558.78399999999999</c:v>
                </c:pt>
                <c:pt idx="436">
                  <c:v>556.63800000000003</c:v>
                </c:pt>
                <c:pt idx="437">
                  <c:v>554.41999999999996</c:v>
                </c:pt>
                <c:pt idx="438">
                  <c:v>552.21400000000006</c:v>
                </c:pt>
                <c:pt idx="439">
                  <c:v>550.03800000000001</c:v>
                </c:pt>
                <c:pt idx="440">
                  <c:v>547.94899999999996</c:v>
                </c:pt>
                <c:pt idx="441">
                  <c:v>545.96400000000006</c:v>
                </c:pt>
                <c:pt idx="442">
                  <c:v>543.98099999999999</c:v>
                </c:pt>
                <c:pt idx="443">
                  <c:v>542.02099999999996</c:v>
                </c:pt>
                <c:pt idx="444">
                  <c:v>540.07399999999996</c:v>
                </c:pt>
                <c:pt idx="445">
                  <c:v>538.1</c:v>
                </c:pt>
                <c:pt idx="446">
                  <c:v>536.23500000000001</c:v>
                </c:pt>
                <c:pt idx="447">
                  <c:v>534.49300000000005</c:v>
                </c:pt>
                <c:pt idx="448">
                  <c:v>532.68100000000004</c:v>
                </c:pt>
                <c:pt idx="449">
                  <c:v>530.84199999999998</c:v>
                </c:pt>
                <c:pt idx="450">
                  <c:v>529.06700000000001</c:v>
                </c:pt>
                <c:pt idx="451">
                  <c:v>527.19899999999996</c:v>
                </c:pt>
                <c:pt idx="452">
                  <c:v>525.29499999999996</c:v>
                </c:pt>
                <c:pt idx="453">
                  <c:v>523.35</c:v>
                </c:pt>
                <c:pt idx="454">
                  <c:v>521.32100000000003</c:v>
                </c:pt>
                <c:pt idx="455">
                  <c:v>519.375</c:v>
                </c:pt>
                <c:pt idx="456">
                  <c:v>517.50099999999998</c:v>
                </c:pt>
                <c:pt idx="457">
                  <c:v>515.53399999999999</c:v>
                </c:pt>
                <c:pt idx="458">
                  <c:v>513.49199999999996</c:v>
                </c:pt>
                <c:pt idx="459">
                  <c:v>511.55599999999998</c:v>
                </c:pt>
                <c:pt idx="460">
                  <c:v>509.67599999999999</c:v>
                </c:pt>
                <c:pt idx="461">
                  <c:v>507.80099999999999</c:v>
                </c:pt>
                <c:pt idx="462">
                  <c:v>505.90300000000002</c:v>
                </c:pt>
                <c:pt idx="463">
                  <c:v>504.02800000000002</c:v>
                </c:pt>
                <c:pt idx="464">
                  <c:v>502.18900000000002</c:v>
                </c:pt>
                <c:pt idx="465">
                  <c:v>500.32400000000001</c:v>
                </c:pt>
                <c:pt idx="466">
                  <c:v>498.41500000000002</c:v>
                </c:pt>
                <c:pt idx="467">
                  <c:v>496.52300000000002</c:v>
                </c:pt>
                <c:pt idx="468">
                  <c:v>494.685</c:v>
                </c:pt>
                <c:pt idx="469">
                  <c:v>492.82499999999999</c:v>
                </c:pt>
                <c:pt idx="470">
                  <c:v>490.95100000000002</c:v>
                </c:pt>
                <c:pt idx="471">
                  <c:v>488.98200000000003</c:v>
                </c:pt>
                <c:pt idx="472">
                  <c:v>486.971</c:v>
                </c:pt>
                <c:pt idx="473">
                  <c:v>485.03800000000001</c:v>
                </c:pt>
                <c:pt idx="474">
                  <c:v>483.16500000000002</c:v>
                </c:pt>
                <c:pt idx="475">
                  <c:v>481.27600000000001</c:v>
                </c:pt>
                <c:pt idx="476">
                  <c:v>479.43700000000001</c:v>
                </c:pt>
                <c:pt idx="477">
                  <c:v>477.63099999999997</c:v>
                </c:pt>
                <c:pt idx="478">
                  <c:v>475.85500000000002</c:v>
                </c:pt>
                <c:pt idx="479">
                  <c:v>474.12700000000001</c:v>
                </c:pt>
                <c:pt idx="480">
                  <c:v>472.39</c:v>
                </c:pt>
                <c:pt idx="481">
                  <c:v>470.67500000000001</c:v>
                </c:pt>
                <c:pt idx="482">
                  <c:v>468.93200000000002</c:v>
                </c:pt>
                <c:pt idx="483">
                  <c:v>467.19400000000002</c:v>
                </c:pt>
                <c:pt idx="484">
                  <c:v>465.42399999999998</c:v>
                </c:pt>
                <c:pt idx="485">
                  <c:v>463.59</c:v>
                </c:pt>
                <c:pt idx="486">
                  <c:v>461.76100000000002</c:v>
                </c:pt>
                <c:pt idx="487">
                  <c:v>459.94799999999998</c:v>
                </c:pt>
                <c:pt idx="488">
                  <c:v>458.108</c:v>
                </c:pt>
                <c:pt idx="489">
                  <c:v>456.315</c:v>
                </c:pt>
                <c:pt idx="490">
                  <c:v>454.57900000000001</c:v>
                </c:pt>
                <c:pt idx="491">
                  <c:v>452.94200000000001</c:v>
                </c:pt>
                <c:pt idx="492">
                  <c:v>451.387</c:v>
                </c:pt>
                <c:pt idx="493">
                  <c:v>449.84699999999998</c:v>
                </c:pt>
                <c:pt idx="494">
                  <c:v>448.40199999999999</c:v>
                </c:pt>
                <c:pt idx="495">
                  <c:v>447.04599999999999</c:v>
                </c:pt>
                <c:pt idx="496">
                  <c:v>445.774</c:v>
                </c:pt>
                <c:pt idx="497">
                  <c:v>444.55700000000002</c:v>
                </c:pt>
                <c:pt idx="498">
                  <c:v>443.42500000000001</c:v>
                </c:pt>
                <c:pt idx="499">
                  <c:v>442.392</c:v>
                </c:pt>
                <c:pt idx="500">
                  <c:v>441.41899999999998</c:v>
                </c:pt>
              </c:numCache>
            </c:numRef>
          </c:yVal>
          <c:smooth val="1"/>
          <c:extLst>
            <c:ext xmlns:c16="http://schemas.microsoft.com/office/drawing/2014/chart" uri="{C3380CC4-5D6E-409C-BE32-E72D297353CC}">
              <c16:uniqueId val="{00000003-5D61-3449-9667-58588BDF454C}"/>
            </c:ext>
          </c:extLst>
        </c:ser>
        <c:dLbls>
          <c:showLegendKey val="0"/>
          <c:showVal val="0"/>
          <c:showCatName val="0"/>
          <c:showSerName val="0"/>
          <c:showPercent val="0"/>
          <c:showBubbleSize val="0"/>
        </c:dLbls>
        <c:axId val="160456936"/>
        <c:axId val="90351968"/>
      </c:scatterChart>
      <c:valAx>
        <c:axId val="160456936"/>
        <c:scaling>
          <c:orientation val="minMax"/>
          <c:max val="400"/>
          <c:min val="300"/>
        </c:scaling>
        <c:delete val="0"/>
        <c:axPos val="b"/>
        <c:numFmt formatCode="General" sourceLinked="1"/>
        <c:majorTickMark val="out"/>
        <c:minorTickMark val="none"/>
        <c:tickLblPos val="nextTo"/>
        <c:spPr>
          <a:ln w="12700">
            <a:solidFill>
              <a:schemeClr val="tx1"/>
            </a:solidFill>
          </a:ln>
        </c:spPr>
        <c:txPr>
          <a:bodyPr/>
          <a:lstStyle/>
          <a:p>
            <a:pPr>
              <a:defRPr sz="1200" b="1">
                <a:latin typeface="Arial" panose="020B0604020202020204" pitchFamily="34" charset="0"/>
                <a:cs typeface="Arial" panose="020B0604020202020204" pitchFamily="34" charset="0"/>
              </a:defRPr>
            </a:pPr>
            <a:endParaRPr lang="en-ES"/>
          </a:p>
        </c:txPr>
        <c:crossAx val="90351968"/>
        <c:crosses val="autoZero"/>
        <c:crossBetween val="midCat"/>
        <c:majorUnit val="100"/>
      </c:valAx>
      <c:valAx>
        <c:axId val="90351968"/>
        <c:scaling>
          <c:orientation val="minMax"/>
        </c:scaling>
        <c:delete val="0"/>
        <c:axPos val="l"/>
        <c:numFmt formatCode="General" sourceLinked="1"/>
        <c:majorTickMark val="out"/>
        <c:minorTickMark val="none"/>
        <c:tickLblPos val="nextTo"/>
        <c:spPr>
          <a:ln w="12700">
            <a:solidFill>
              <a:schemeClr val="tx1"/>
            </a:solidFill>
          </a:ln>
        </c:spPr>
        <c:txPr>
          <a:bodyPr/>
          <a:lstStyle/>
          <a:p>
            <a:pPr>
              <a:defRPr sz="1200" b="1">
                <a:latin typeface="Arial" panose="020B0604020202020204" pitchFamily="34" charset="0"/>
                <a:cs typeface="Arial" panose="020B0604020202020204" pitchFamily="34" charset="0"/>
              </a:defRPr>
            </a:pPr>
            <a:endParaRPr lang="en-ES"/>
          </a:p>
        </c:txPr>
        <c:crossAx val="160456936"/>
        <c:crosses val="autoZero"/>
        <c:crossBetween val="midCat"/>
        <c:majorUnit val="1000"/>
      </c:valAx>
    </c:plotArea>
    <c:legend>
      <c:legendPos val="l"/>
      <c:legendEntry>
        <c:idx val="0"/>
        <c:txPr>
          <a:bodyPr/>
          <a:lstStyle/>
          <a:p>
            <a:pPr>
              <a:defRPr sz="1200" b="1">
                <a:latin typeface="Arial" panose="020B0604020202020204" pitchFamily="34" charset="0"/>
                <a:cs typeface="Arial" panose="020B0604020202020204" pitchFamily="34" charset="0"/>
              </a:defRPr>
            </a:pPr>
            <a:endParaRPr lang="en-ES"/>
          </a:p>
        </c:txPr>
      </c:legendEntry>
      <c:legendEntry>
        <c:idx val="1"/>
        <c:txPr>
          <a:bodyPr/>
          <a:lstStyle/>
          <a:p>
            <a:pPr>
              <a:defRPr sz="1200" b="1">
                <a:latin typeface="Arial" panose="020B0604020202020204" pitchFamily="34" charset="0"/>
                <a:cs typeface="Arial" panose="020B0604020202020204" pitchFamily="34" charset="0"/>
              </a:defRPr>
            </a:pPr>
            <a:endParaRPr lang="en-ES"/>
          </a:p>
        </c:txPr>
      </c:legendEntry>
      <c:legendEntry>
        <c:idx val="2"/>
        <c:txPr>
          <a:bodyPr/>
          <a:lstStyle/>
          <a:p>
            <a:pPr>
              <a:defRPr sz="1200" b="1">
                <a:latin typeface="Arial" panose="020B0604020202020204" pitchFamily="34" charset="0"/>
                <a:cs typeface="Arial" panose="020B0604020202020204" pitchFamily="34" charset="0"/>
              </a:defRPr>
            </a:pPr>
            <a:endParaRPr lang="en-ES"/>
          </a:p>
        </c:txPr>
      </c:legendEntry>
      <c:legendEntry>
        <c:idx val="3"/>
        <c:txPr>
          <a:bodyPr/>
          <a:lstStyle/>
          <a:p>
            <a:pPr>
              <a:defRPr sz="1200" b="1">
                <a:latin typeface="Arial" panose="020B0604020202020204" pitchFamily="34" charset="0"/>
                <a:cs typeface="Arial" panose="020B0604020202020204" pitchFamily="34" charset="0"/>
              </a:defRPr>
            </a:pPr>
            <a:endParaRPr lang="en-ES"/>
          </a:p>
        </c:txPr>
      </c:legendEntry>
      <c:layout>
        <c:manualLayout>
          <c:xMode val="edge"/>
          <c:yMode val="edge"/>
          <c:x val="0.76293995360671663"/>
          <c:y val="3.6698016914552506E-3"/>
          <c:w val="0.23319896939488069"/>
          <c:h val="0.35279045068605003"/>
        </c:manualLayout>
      </c:layout>
      <c:overlay val="0"/>
      <c:txPr>
        <a:bodyPr/>
        <a:lstStyle/>
        <a:p>
          <a:pPr>
            <a:defRPr sz="1000" b="1">
              <a:latin typeface="Times New Roman" panose="02020603050405020304" pitchFamily="18" charset="0"/>
              <a:cs typeface="Times New Roman" panose="02020603050405020304" pitchFamily="18" charset="0"/>
            </a:defRPr>
          </a:pPr>
          <a:endParaRPr lang="en-ES"/>
        </a:p>
      </c:txPr>
    </c:legend>
    <c:plotVisOnly val="1"/>
    <c:dispBlanksAs val="gap"/>
    <c:showDLblsOverMax val="0"/>
  </c:chart>
  <c:spPr>
    <a:solidFill>
      <a:schemeClr val="bg1"/>
    </a:solidFill>
    <a:ln>
      <a:noFill/>
    </a:ln>
  </c:spPr>
  <c:externalData r:id="rId1">
    <c:autoUpdate val="0"/>
  </c:externalData>
  <c:userShapes r:id="rId2"/>
</c:chartSpace>
</file>

<file path=ppt/drawings/drawing1.xml><?xml version="1.0" encoding="utf-8"?>
<c:userShapes xmlns:c="http://schemas.openxmlformats.org/drawingml/2006/chart">
  <cdr:relSizeAnchor xmlns:cdr="http://schemas.openxmlformats.org/drawingml/2006/chartDrawing">
    <cdr:from>
      <cdr:x>0.03761</cdr:x>
      <cdr:y>0.10328</cdr:y>
    </cdr:from>
    <cdr:to>
      <cdr:x>0.10011</cdr:x>
      <cdr:y>0.71564</cdr:y>
    </cdr:to>
    <cdr:sp macro="" textlink="">
      <cdr:nvSpPr>
        <cdr:cNvPr id="2" name="TextBox 1"/>
        <cdr:cNvSpPr txBox="1"/>
      </cdr:nvSpPr>
      <cdr:spPr>
        <a:xfrm xmlns:a="http://schemas.openxmlformats.org/drawingml/2006/main" rot="16200000">
          <a:off x="-640843" y="1099820"/>
          <a:ext cx="1831339" cy="249443"/>
        </a:xfrm>
        <a:prstGeom xmlns:a="http://schemas.openxmlformats.org/drawingml/2006/main" prst="rect">
          <a:avLst/>
        </a:prstGeom>
        <a:solidFill xmlns:a="http://schemas.openxmlformats.org/drawingml/2006/main">
          <a:schemeClr val="bg1"/>
        </a:solidFill>
      </cdr:spPr>
      <cdr:txBody>
        <a:bodyPr xmlns:a="http://schemas.openxmlformats.org/drawingml/2006/main" vertOverflow="clip" wrap="square" rtlCol="0"/>
        <a:lstStyle xmlns:a="http://schemas.openxmlformats.org/drawingml/2006/main"/>
        <a:p xmlns:a="http://schemas.openxmlformats.org/drawingml/2006/main">
          <a:pPr algn="ctr"/>
          <a:r>
            <a:rPr lang="en-US" sz="1400" b="1" dirty="0">
              <a:latin typeface="Arial" panose="020B0604020202020204" pitchFamily="34" charset="0"/>
              <a:cs typeface="Arial" panose="020B0604020202020204" pitchFamily="34" charset="0"/>
            </a:rPr>
            <a:t>Fluorescence intensity (</a:t>
          </a:r>
          <a:r>
            <a:rPr lang="en-US" sz="1400" b="1" dirty="0" err="1">
              <a:latin typeface="Arial" panose="020B0604020202020204" pitchFamily="34" charset="0"/>
              <a:cs typeface="Arial" panose="020B0604020202020204" pitchFamily="34" charset="0"/>
            </a:rPr>
            <a:t>a.u</a:t>
          </a:r>
          <a:r>
            <a:rPr lang="en-US" sz="1400" b="1" dirty="0">
              <a:latin typeface="Arial" panose="020B0604020202020204" pitchFamily="34" charset="0"/>
              <a:cs typeface="Arial" panose="020B0604020202020204" pitchFamily="34" charset="0"/>
            </a:rPr>
            <a:t>)</a:t>
          </a:r>
        </a:p>
      </cdr:txBody>
    </cdr:sp>
  </cdr:relSizeAnchor>
  <cdr:relSizeAnchor xmlns:cdr="http://schemas.openxmlformats.org/drawingml/2006/chartDrawing">
    <cdr:from>
      <cdr:x>0.34098</cdr:x>
      <cdr:y>0.85865</cdr:y>
    </cdr:from>
    <cdr:to>
      <cdr:x>0.7517</cdr:x>
      <cdr:y>0.92435</cdr:y>
    </cdr:to>
    <cdr:sp macro="" textlink="">
      <cdr:nvSpPr>
        <cdr:cNvPr id="3" name="TextBox 2"/>
        <cdr:cNvSpPr txBox="1"/>
      </cdr:nvSpPr>
      <cdr:spPr>
        <a:xfrm xmlns:a="http://schemas.openxmlformats.org/drawingml/2006/main">
          <a:off x="1625643" y="3078590"/>
          <a:ext cx="1958132" cy="235559"/>
        </a:xfrm>
        <a:prstGeom xmlns:a="http://schemas.openxmlformats.org/drawingml/2006/main" prst="rect">
          <a:avLst/>
        </a:prstGeom>
        <a:solidFill xmlns:a="http://schemas.openxmlformats.org/drawingml/2006/main">
          <a:schemeClr val="bg1"/>
        </a:solidFill>
      </cdr:spPr>
      <cdr:txBody>
        <a:bodyPr xmlns:a="http://schemas.openxmlformats.org/drawingml/2006/main" vertOverflow="clip" wrap="square" rtlCol="0"/>
        <a:lstStyle xmlns:a="http://schemas.openxmlformats.org/drawingml/2006/main"/>
        <a:p xmlns:a="http://schemas.openxmlformats.org/drawingml/2006/main">
          <a:pPr algn="ctr"/>
          <a:r>
            <a:rPr lang="en-US" sz="1400" b="1" dirty="0">
              <a:latin typeface="Arial" panose="020B0604020202020204" pitchFamily="34" charset="0"/>
              <a:cs typeface="Arial" panose="020B0604020202020204" pitchFamily="34" charset="0"/>
            </a:rPr>
            <a:t>Wavelength</a:t>
          </a:r>
          <a:r>
            <a:rPr lang="en-US" sz="1200" b="1" baseline="0" dirty="0">
              <a:latin typeface="Times New Roman" panose="02020603050405020304" pitchFamily="18" charset="0"/>
              <a:cs typeface="Times New Roman" panose="02020603050405020304" pitchFamily="18" charset="0"/>
            </a:rPr>
            <a:t> (nm)</a:t>
          </a:r>
          <a:endParaRPr lang="en-US" sz="1200" b="1" dirty="0">
            <a:latin typeface="Times New Roman" panose="02020603050405020304" pitchFamily="18" charset="0"/>
            <a:cs typeface="Times New Roman" panose="02020603050405020304" pitchFamily="18" charset="0"/>
          </a:endParaRPr>
        </a:p>
      </cdr:txBody>
    </cdr:sp>
  </cdr:relSizeAnchor>
</c:userShap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a:t>Haga clic para modificar el estilo de subtítulo del patrón</a:t>
            </a:r>
            <a:endParaRPr lang="en-US" dirty="0"/>
          </a:p>
        </p:txBody>
      </p:sp>
      <p:sp>
        <p:nvSpPr>
          <p:cNvPr id="4" name="Date Placeholder 3"/>
          <p:cNvSpPr>
            <a:spLocks noGrp="1"/>
          </p:cNvSpPr>
          <p:nvPr>
            <p:ph type="dt" sz="half" idx="10"/>
          </p:nvPr>
        </p:nvSpPr>
        <p:spPr/>
        <p:txBody>
          <a:bodyPr/>
          <a:lstStyle/>
          <a:p>
            <a:fld id="{15E8555E-A19E-41AC-A1CA-F3E250AFE791}" type="datetimeFigureOut">
              <a:rPr lang="es-ES" smtClean="0"/>
              <a:t>25/1/22</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A255E152-C35D-4805-B6C3-9AA80BFCC586}" type="slidenum">
              <a:rPr lang="es-ES" smtClean="0"/>
              <a:t>‹#›</a:t>
            </a:fld>
            <a:endParaRPr lang="es-ES"/>
          </a:p>
        </p:txBody>
      </p:sp>
    </p:spTree>
    <p:extLst>
      <p:ext uri="{BB962C8B-B14F-4D97-AF65-F5344CB8AC3E}">
        <p14:creationId xmlns:p14="http://schemas.microsoft.com/office/powerpoint/2010/main" val="7142166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15E8555E-A19E-41AC-A1CA-F3E250AFE791}" type="datetimeFigureOut">
              <a:rPr lang="es-ES" smtClean="0"/>
              <a:t>25/1/22</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A255E152-C35D-4805-B6C3-9AA80BFCC586}" type="slidenum">
              <a:rPr lang="es-ES" smtClean="0"/>
              <a:t>‹#›</a:t>
            </a:fld>
            <a:endParaRPr lang="es-ES"/>
          </a:p>
        </p:txBody>
      </p:sp>
    </p:spTree>
    <p:extLst>
      <p:ext uri="{BB962C8B-B14F-4D97-AF65-F5344CB8AC3E}">
        <p14:creationId xmlns:p14="http://schemas.microsoft.com/office/powerpoint/2010/main" val="224384522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15E8555E-A19E-41AC-A1CA-F3E250AFE791}" type="datetimeFigureOut">
              <a:rPr lang="es-ES" smtClean="0"/>
              <a:t>25/1/22</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A255E152-C35D-4805-B6C3-9AA80BFCC586}" type="slidenum">
              <a:rPr lang="es-ES" smtClean="0"/>
              <a:t>‹#›</a:t>
            </a:fld>
            <a:endParaRPr lang="es-ES"/>
          </a:p>
        </p:txBody>
      </p:sp>
    </p:spTree>
    <p:extLst>
      <p:ext uri="{BB962C8B-B14F-4D97-AF65-F5344CB8AC3E}">
        <p14:creationId xmlns:p14="http://schemas.microsoft.com/office/powerpoint/2010/main" val="203374287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15E8555E-A19E-41AC-A1CA-F3E250AFE791}" type="datetimeFigureOut">
              <a:rPr lang="es-ES" smtClean="0"/>
              <a:t>25/1/22</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A255E152-C35D-4805-B6C3-9AA80BFCC586}" type="slidenum">
              <a:rPr lang="es-ES" smtClean="0"/>
              <a:t>‹#›</a:t>
            </a:fld>
            <a:endParaRPr lang="es-ES"/>
          </a:p>
        </p:txBody>
      </p:sp>
    </p:spTree>
    <p:extLst>
      <p:ext uri="{BB962C8B-B14F-4D97-AF65-F5344CB8AC3E}">
        <p14:creationId xmlns:p14="http://schemas.microsoft.com/office/powerpoint/2010/main" val="35128033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s-ES"/>
              <a:t>Haga clic para modificar el estilo de texto del patrón</a:t>
            </a:r>
          </a:p>
        </p:txBody>
      </p:sp>
      <p:sp>
        <p:nvSpPr>
          <p:cNvPr id="4" name="Date Placeholder 3"/>
          <p:cNvSpPr>
            <a:spLocks noGrp="1"/>
          </p:cNvSpPr>
          <p:nvPr>
            <p:ph type="dt" sz="half" idx="10"/>
          </p:nvPr>
        </p:nvSpPr>
        <p:spPr/>
        <p:txBody>
          <a:bodyPr/>
          <a:lstStyle/>
          <a:p>
            <a:fld id="{15E8555E-A19E-41AC-A1CA-F3E250AFE791}" type="datetimeFigureOut">
              <a:rPr lang="es-ES" smtClean="0"/>
              <a:t>25/1/22</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A255E152-C35D-4805-B6C3-9AA80BFCC586}" type="slidenum">
              <a:rPr lang="es-ES" smtClean="0"/>
              <a:t>‹#›</a:t>
            </a:fld>
            <a:endParaRPr lang="es-ES"/>
          </a:p>
        </p:txBody>
      </p:sp>
    </p:spTree>
    <p:extLst>
      <p:ext uri="{BB962C8B-B14F-4D97-AF65-F5344CB8AC3E}">
        <p14:creationId xmlns:p14="http://schemas.microsoft.com/office/powerpoint/2010/main" val="406836419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15E8555E-A19E-41AC-A1CA-F3E250AFE791}" type="datetimeFigureOut">
              <a:rPr lang="es-ES" smtClean="0"/>
              <a:t>25/1/22</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A255E152-C35D-4805-B6C3-9AA80BFCC586}" type="slidenum">
              <a:rPr lang="es-ES" smtClean="0"/>
              <a:t>‹#›</a:t>
            </a:fld>
            <a:endParaRPr lang="es-ES"/>
          </a:p>
        </p:txBody>
      </p:sp>
    </p:spTree>
    <p:extLst>
      <p:ext uri="{BB962C8B-B14F-4D97-AF65-F5344CB8AC3E}">
        <p14:creationId xmlns:p14="http://schemas.microsoft.com/office/powerpoint/2010/main" val="23593173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Haga clic para modificar el estilo de texto del patrón</a:t>
            </a:r>
          </a:p>
        </p:txBody>
      </p:sp>
      <p:sp>
        <p:nvSpPr>
          <p:cNvPr id="4" name="Content Placeholder 3"/>
          <p:cNvSpPr>
            <a:spLocks noGrp="1"/>
          </p:cNvSpPr>
          <p:nvPr>
            <p:ph sz="half" idx="2"/>
          </p:nvPr>
        </p:nvSpPr>
        <p:spPr>
          <a:xfrm>
            <a:off x="472381" y="3618442"/>
            <a:ext cx="2901255" cy="5322183"/>
          </a:xfrm>
        </p:spPr>
        <p:txBody>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Haga clic para modificar el estilo de texto del patrón</a:t>
            </a:r>
          </a:p>
        </p:txBody>
      </p:sp>
      <p:sp>
        <p:nvSpPr>
          <p:cNvPr id="6" name="Content Placeholder 5"/>
          <p:cNvSpPr>
            <a:spLocks noGrp="1"/>
          </p:cNvSpPr>
          <p:nvPr>
            <p:ph sz="quarter" idx="4"/>
          </p:nvPr>
        </p:nvSpPr>
        <p:spPr>
          <a:xfrm>
            <a:off x="3471863" y="3618442"/>
            <a:ext cx="2915543" cy="5322183"/>
          </a:xfrm>
        </p:spPr>
        <p:txBody>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15E8555E-A19E-41AC-A1CA-F3E250AFE791}" type="datetimeFigureOut">
              <a:rPr lang="es-ES" smtClean="0"/>
              <a:t>25/1/22</a:t>
            </a:fld>
            <a:endParaRPr lang="es-ES"/>
          </a:p>
        </p:txBody>
      </p:sp>
      <p:sp>
        <p:nvSpPr>
          <p:cNvPr id="8" name="Footer Placeholder 7"/>
          <p:cNvSpPr>
            <a:spLocks noGrp="1"/>
          </p:cNvSpPr>
          <p:nvPr>
            <p:ph type="ftr" sz="quarter" idx="11"/>
          </p:nvPr>
        </p:nvSpPr>
        <p:spPr/>
        <p:txBody>
          <a:bodyPr/>
          <a:lstStyle/>
          <a:p>
            <a:endParaRPr lang="es-ES"/>
          </a:p>
        </p:txBody>
      </p:sp>
      <p:sp>
        <p:nvSpPr>
          <p:cNvPr id="9" name="Slide Number Placeholder 8"/>
          <p:cNvSpPr>
            <a:spLocks noGrp="1"/>
          </p:cNvSpPr>
          <p:nvPr>
            <p:ph type="sldNum" sz="quarter" idx="12"/>
          </p:nvPr>
        </p:nvSpPr>
        <p:spPr/>
        <p:txBody>
          <a:bodyPr/>
          <a:lstStyle/>
          <a:p>
            <a:fld id="{A255E152-C35D-4805-B6C3-9AA80BFCC586}" type="slidenum">
              <a:rPr lang="es-ES" smtClean="0"/>
              <a:t>‹#›</a:t>
            </a:fld>
            <a:endParaRPr lang="es-ES"/>
          </a:p>
        </p:txBody>
      </p:sp>
    </p:spTree>
    <p:extLst>
      <p:ext uri="{BB962C8B-B14F-4D97-AF65-F5344CB8AC3E}">
        <p14:creationId xmlns:p14="http://schemas.microsoft.com/office/powerpoint/2010/main" val="284582724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15E8555E-A19E-41AC-A1CA-F3E250AFE791}" type="datetimeFigureOut">
              <a:rPr lang="es-ES" smtClean="0"/>
              <a:t>25/1/22</a:t>
            </a:fld>
            <a:endParaRPr lang="es-ES"/>
          </a:p>
        </p:txBody>
      </p:sp>
      <p:sp>
        <p:nvSpPr>
          <p:cNvPr id="4" name="Footer Placeholder 3"/>
          <p:cNvSpPr>
            <a:spLocks noGrp="1"/>
          </p:cNvSpPr>
          <p:nvPr>
            <p:ph type="ftr" sz="quarter" idx="11"/>
          </p:nvPr>
        </p:nvSpPr>
        <p:spPr/>
        <p:txBody>
          <a:bodyPr/>
          <a:lstStyle/>
          <a:p>
            <a:endParaRPr lang="es-ES"/>
          </a:p>
        </p:txBody>
      </p:sp>
      <p:sp>
        <p:nvSpPr>
          <p:cNvPr id="5" name="Slide Number Placeholder 4"/>
          <p:cNvSpPr>
            <a:spLocks noGrp="1"/>
          </p:cNvSpPr>
          <p:nvPr>
            <p:ph type="sldNum" sz="quarter" idx="12"/>
          </p:nvPr>
        </p:nvSpPr>
        <p:spPr/>
        <p:txBody>
          <a:bodyPr/>
          <a:lstStyle/>
          <a:p>
            <a:fld id="{A255E152-C35D-4805-B6C3-9AA80BFCC586}" type="slidenum">
              <a:rPr lang="es-ES" smtClean="0"/>
              <a:t>‹#›</a:t>
            </a:fld>
            <a:endParaRPr lang="es-ES"/>
          </a:p>
        </p:txBody>
      </p:sp>
    </p:spTree>
    <p:extLst>
      <p:ext uri="{BB962C8B-B14F-4D97-AF65-F5344CB8AC3E}">
        <p14:creationId xmlns:p14="http://schemas.microsoft.com/office/powerpoint/2010/main" val="322234537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5E8555E-A19E-41AC-A1CA-F3E250AFE791}" type="datetimeFigureOut">
              <a:rPr lang="es-ES" smtClean="0"/>
              <a:t>25/1/22</a:t>
            </a:fld>
            <a:endParaRPr lang="es-ES"/>
          </a:p>
        </p:txBody>
      </p:sp>
      <p:sp>
        <p:nvSpPr>
          <p:cNvPr id="3" name="Footer Placeholder 2"/>
          <p:cNvSpPr>
            <a:spLocks noGrp="1"/>
          </p:cNvSpPr>
          <p:nvPr>
            <p:ph type="ftr" sz="quarter" idx="11"/>
          </p:nvPr>
        </p:nvSpPr>
        <p:spPr/>
        <p:txBody>
          <a:bodyPr/>
          <a:lstStyle/>
          <a:p>
            <a:endParaRPr lang="es-ES"/>
          </a:p>
        </p:txBody>
      </p:sp>
      <p:sp>
        <p:nvSpPr>
          <p:cNvPr id="4" name="Slide Number Placeholder 3"/>
          <p:cNvSpPr>
            <a:spLocks noGrp="1"/>
          </p:cNvSpPr>
          <p:nvPr>
            <p:ph type="sldNum" sz="quarter" idx="12"/>
          </p:nvPr>
        </p:nvSpPr>
        <p:spPr/>
        <p:txBody>
          <a:bodyPr/>
          <a:lstStyle/>
          <a:p>
            <a:fld id="{A255E152-C35D-4805-B6C3-9AA80BFCC586}" type="slidenum">
              <a:rPr lang="es-ES" smtClean="0"/>
              <a:t>‹#›</a:t>
            </a:fld>
            <a:endParaRPr lang="es-ES"/>
          </a:p>
        </p:txBody>
      </p:sp>
    </p:spTree>
    <p:extLst>
      <p:ext uri="{BB962C8B-B14F-4D97-AF65-F5344CB8AC3E}">
        <p14:creationId xmlns:p14="http://schemas.microsoft.com/office/powerpoint/2010/main" val="98374108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Haga clic para modificar el estilo de texto del patrón</a:t>
            </a:r>
          </a:p>
        </p:txBody>
      </p:sp>
      <p:sp>
        <p:nvSpPr>
          <p:cNvPr id="5" name="Date Placeholder 4"/>
          <p:cNvSpPr>
            <a:spLocks noGrp="1"/>
          </p:cNvSpPr>
          <p:nvPr>
            <p:ph type="dt" sz="half" idx="10"/>
          </p:nvPr>
        </p:nvSpPr>
        <p:spPr/>
        <p:txBody>
          <a:bodyPr/>
          <a:lstStyle/>
          <a:p>
            <a:fld id="{15E8555E-A19E-41AC-A1CA-F3E250AFE791}" type="datetimeFigureOut">
              <a:rPr lang="es-ES" smtClean="0"/>
              <a:t>25/1/22</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A255E152-C35D-4805-B6C3-9AA80BFCC586}" type="slidenum">
              <a:rPr lang="es-ES" smtClean="0"/>
              <a:t>‹#›</a:t>
            </a:fld>
            <a:endParaRPr lang="es-ES"/>
          </a:p>
        </p:txBody>
      </p:sp>
    </p:spTree>
    <p:extLst>
      <p:ext uri="{BB962C8B-B14F-4D97-AF65-F5344CB8AC3E}">
        <p14:creationId xmlns:p14="http://schemas.microsoft.com/office/powerpoint/2010/main" val="36903924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a:t>Haga clic en el icono para agregar una ima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Haga clic para modificar el estilo de texto del patrón</a:t>
            </a:r>
          </a:p>
        </p:txBody>
      </p:sp>
      <p:sp>
        <p:nvSpPr>
          <p:cNvPr id="5" name="Date Placeholder 4"/>
          <p:cNvSpPr>
            <a:spLocks noGrp="1"/>
          </p:cNvSpPr>
          <p:nvPr>
            <p:ph type="dt" sz="half" idx="10"/>
          </p:nvPr>
        </p:nvSpPr>
        <p:spPr/>
        <p:txBody>
          <a:bodyPr/>
          <a:lstStyle/>
          <a:p>
            <a:fld id="{15E8555E-A19E-41AC-A1CA-F3E250AFE791}" type="datetimeFigureOut">
              <a:rPr lang="es-ES" smtClean="0"/>
              <a:t>25/1/22</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A255E152-C35D-4805-B6C3-9AA80BFCC586}" type="slidenum">
              <a:rPr lang="es-ES" smtClean="0"/>
              <a:t>‹#›</a:t>
            </a:fld>
            <a:endParaRPr lang="es-ES"/>
          </a:p>
        </p:txBody>
      </p:sp>
    </p:spTree>
    <p:extLst>
      <p:ext uri="{BB962C8B-B14F-4D97-AF65-F5344CB8AC3E}">
        <p14:creationId xmlns:p14="http://schemas.microsoft.com/office/powerpoint/2010/main" val="19367122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15E8555E-A19E-41AC-A1CA-F3E250AFE791}" type="datetimeFigureOut">
              <a:rPr lang="es-ES" smtClean="0"/>
              <a:t>25/1/22</a:t>
            </a:fld>
            <a:endParaRPr lang="es-E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s-E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A255E152-C35D-4805-B6C3-9AA80BFCC586}" type="slidenum">
              <a:rPr lang="es-ES" smtClean="0"/>
              <a:t>‹#›</a:t>
            </a:fld>
            <a:endParaRPr lang="es-ES"/>
          </a:p>
        </p:txBody>
      </p:sp>
    </p:spTree>
    <p:extLst>
      <p:ext uri="{BB962C8B-B14F-4D97-AF65-F5344CB8AC3E}">
        <p14:creationId xmlns:p14="http://schemas.microsoft.com/office/powerpoint/2010/main" val="14644183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image" Target="../media/image1.tiff"/><Relationship Id="rId1" Type="http://schemas.openxmlformats.org/officeDocument/2006/relationships/slideLayout" Target="../slideLayouts/slideLayout1.xml"/><Relationship Id="rId4" Type="http://schemas.openxmlformats.org/officeDocument/2006/relationships/image" Target="../media/image2.tiff"/></Relationships>
</file>

<file path=ppt/slides/_rels/slide2.xml.rels><?xml version="1.0" encoding="UTF-8" standalone="yes"?>
<Relationships xmlns="http://schemas.openxmlformats.org/package/2006/relationships"><Relationship Id="rId3" Type="http://schemas.openxmlformats.org/officeDocument/2006/relationships/image" Target="../media/image4.tif"/><Relationship Id="rId2" Type="http://schemas.openxmlformats.org/officeDocument/2006/relationships/image" Target="../media/image3.tif"/><Relationship Id="rId1" Type="http://schemas.openxmlformats.org/officeDocument/2006/relationships/slideLayout" Target="../slideLayouts/slideLayout2.xml"/><Relationship Id="rId4" Type="http://schemas.openxmlformats.org/officeDocument/2006/relationships/image" Target="../media/image5.tif"/></Relationships>
</file>

<file path=ppt/slides/_rels/slide3.xml.rels><?xml version="1.0" encoding="UTF-8" standalone="yes"?>
<Relationships xmlns="http://schemas.openxmlformats.org/package/2006/relationships"><Relationship Id="rId2" Type="http://schemas.openxmlformats.org/officeDocument/2006/relationships/chart" Target="../charts/chart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7.tiff"/><Relationship Id="rId2" Type="http://schemas.openxmlformats.org/officeDocument/2006/relationships/image" Target="../media/image6.tif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8.ti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 name="Imagen 14"/>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75027" y="3764124"/>
            <a:ext cx="3813048" cy="3302508"/>
          </a:xfrm>
          <a:prstGeom prst="rect">
            <a:avLst/>
          </a:prstGeom>
        </p:spPr>
      </p:pic>
      <p:grpSp>
        <p:nvGrpSpPr>
          <p:cNvPr id="4" name="Group 647">
            <a:extLst>
              <a:ext uri="{FF2B5EF4-FFF2-40B4-BE49-F238E27FC236}">
                <a16:creationId xmlns:a16="http://schemas.microsoft.com/office/drawing/2014/main" id="{BD6C0A6E-7B95-454D-9DE1-1D9B42870027}"/>
              </a:ext>
            </a:extLst>
          </p:cNvPr>
          <p:cNvGrpSpPr/>
          <p:nvPr/>
        </p:nvGrpSpPr>
        <p:grpSpPr>
          <a:xfrm>
            <a:off x="75027" y="408083"/>
            <a:ext cx="6654266" cy="2989152"/>
            <a:chOff x="539234" y="72512"/>
            <a:chExt cx="3232661" cy="2288239"/>
          </a:xfrm>
        </p:grpSpPr>
        <p:graphicFrame>
          <p:nvGraphicFramePr>
            <p:cNvPr id="5" name="Chart 662">
              <a:extLst>
                <a:ext uri="{FF2B5EF4-FFF2-40B4-BE49-F238E27FC236}">
                  <a16:creationId xmlns:a16="http://schemas.microsoft.com/office/drawing/2014/main" id="{F800B192-D51B-434A-A53D-0DE2908F50F1}"/>
                </a:ext>
              </a:extLst>
            </p:cNvPr>
            <p:cNvGraphicFramePr/>
            <p:nvPr>
              <p:extLst>
                <p:ext uri="{D42A27DB-BD31-4B8C-83A1-F6EECF244321}">
                  <p14:modId xmlns:p14="http://schemas.microsoft.com/office/powerpoint/2010/main" val="3495704861"/>
                </p:ext>
              </p:extLst>
            </p:nvPr>
          </p:nvGraphicFramePr>
          <p:xfrm>
            <a:off x="539234" y="384831"/>
            <a:ext cx="3232661" cy="1975920"/>
          </p:xfrm>
          <a:graphic>
            <a:graphicData uri="http://schemas.openxmlformats.org/drawingml/2006/chart">
              <c:chart xmlns:c="http://schemas.openxmlformats.org/drawingml/2006/chart" xmlns:r="http://schemas.openxmlformats.org/officeDocument/2006/relationships" r:id="rId3"/>
            </a:graphicData>
          </a:graphic>
        </p:graphicFrame>
        <p:sp>
          <p:nvSpPr>
            <p:cNvPr id="6" name="TextBox 1">
              <a:extLst>
                <a:ext uri="{FF2B5EF4-FFF2-40B4-BE49-F238E27FC236}">
                  <a16:creationId xmlns:a16="http://schemas.microsoft.com/office/drawing/2014/main" id="{A6735490-0427-E14F-A0A1-B07E1E44D2E9}"/>
                </a:ext>
              </a:extLst>
            </p:cNvPr>
            <p:cNvSpPr txBox="1"/>
            <p:nvPr/>
          </p:nvSpPr>
          <p:spPr>
            <a:xfrm rot="16200000">
              <a:off x="-210052" y="853621"/>
              <a:ext cx="1787651" cy="225434"/>
            </a:xfrm>
            <a:prstGeom prst="rect">
              <a:avLst/>
            </a:prstGeom>
            <a:ln>
              <a:noFill/>
            </a:ln>
          </p:spPr>
          <p:txBody>
            <a:bodyPr wrap="square" rtlCol="0">
              <a:noAutofit/>
            </a:bodyPr>
            <a:lstStyle/>
            <a:p>
              <a:r>
                <a:rPr lang="en-US" sz="1200" b="1" dirty="0" err="1">
                  <a:effectLst/>
                  <a:latin typeface="Arial" panose="020B0604020202020204" pitchFamily="34" charset="0"/>
                  <a:ea typeface="Times New Roman" panose="02020603050405020304" pitchFamily="18" charset="0"/>
                  <a:cs typeface="Arial" panose="020B0604020202020204" pitchFamily="34" charset="0"/>
                </a:rPr>
                <a:t>Luminiscence</a:t>
              </a:r>
              <a:r>
                <a:rPr lang="en-US" sz="1200" b="1" dirty="0">
                  <a:effectLst/>
                  <a:latin typeface="Arial" panose="020B0604020202020204" pitchFamily="34" charset="0"/>
                  <a:ea typeface="Times New Roman" panose="02020603050405020304" pitchFamily="18" charset="0"/>
                  <a:cs typeface="Arial" panose="020B0604020202020204" pitchFamily="34" charset="0"/>
                </a:rPr>
                <a:t> (</a:t>
              </a:r>
              <a:r>
                <a:rPr lang="en-US" sz="1200" b="1" dirty="0" err="1">
                  <a:effectLst/>
                  <a:latin typeface="Arial" panose="020B0604020202020204" pitchFamily="34" charset="0"/>
                  <a:ea typeface="Times New Roman" panose="02020603050405020304" pitchFamily="18" charset="0"/>
                  <a:cs typeface="Arial" panose="020B0604020202020204" pitchFamily="34" charset="0"/>
                </a:rPr>
                <a:t>a.u</a:t>
              </a:r>
              <a:r>
                <a:rPr lang="en-US" sz="1200" b="1" dirty="0">
                  <a:effectLst/>
                  <a:latin typeface="Arial" panose="020B0604020202020204" pitchFamily="34" charset="0"/>
                  <a:ea typeface="Times New Roman" panose="02020603050405020304" pitchFamily="18" charset="0"/>
                  <a:cs typeface="Arial" panose="020B0604020202020204" pitchFamily="34" charset="0"/>
                </a:rPr>
                <a:t>) </a:t>
              </a:r>
              <a:endParaRPr lang="x-none" sz="1200" dirty="0">
                <a:effectLst/>
                <a:latin typeface="Arial" panose="020B0604020202020204" pitchFamily="34" charset="0"/>
                <a:ea typeface="Times New Roman" panose="02020603050405020304" pitchFamily="18" charset="0"/>
                <a:cs typeface="Arial" panose="020B0604020202020204" pitchFamily="34" charset="0"/>
              </a:endParaRPr>
            </a:p>
          </p:txBody>
        </p:sp>
      </p:grpSp>
      <p:sp>
        <p:nvSpPr>
          <p:cNvPr id="3" name="CuadroTexto 2"/>
          <p:cNvSpPr txBox="1"/>
          <p:nvPr/>
        </p:nvSpPr>
        <p:spPr>
          <a:xfrm>
            <a:off x="75029" y="400182"/>
            <a:ext cx="356188" cy="400110"/>
          </a:xfrm>
          <a:prstGeom prst="rect">
            <a:avLst/>
          </a:prstGeom>
          <a:noFill/>
        </p:spPr>
        <p:txBody>
          <a:bodyPr wrap="none" rtlCol="0">
            <a:spAutoFit/>
          </a:bodyPr>
          <a:lstStyle/>
          <a:p>
            <a:r>
              <a:rPr lang="es-ES" sz="2000" dirty="0">
                <a:latin typeface="Arial" panose="020B0604020202020204" pitchFamily="34" charset="0"/>
                <a:cs typeface="Arial" panose="020B0604020202020204" pitchFamily="34" charset="0"/>
              </a:rPr>
              <a:t>A</a:t>
            </a:r>
          </a:p>
        </p:txBody>
      </p:sp>
      <p:sp>
        <p:nvSpPr>
          <p:cNvPr id="11" name="CuadroTexto 10"/>
          <p:cNvSpPr txBox="1"/>
          <p:nvPr/>
        </p:nvSpPr>
        <p:spPr>
          <a:xfrm>
            <a:off x="75029" y="3377933"/>
            <a:ext cx="356188" cy="400110"/>
          </a:xfrm>
          <a:prstGeom prst="rect">
            <a:avLst/>
          </a:prstGeom>
          <a:noFill/>
        </p:spPr>
        <p:txBody>
          <a:bodyPr wrap="none" rtlCol="0">
            <a:spAutoFit/>
          </a:bodyPr>
          <a:lstStyle/>
          <a:p>
            <a:r>
              <a:rPr lang="es-ES" sz="2000" dirty="0">
                <a:latin typeface="Arial" panose="020B0604020202020204" pitchFamily="34" charset="0"/>
                <a:cs typeface="Arial" panose="020B0604020202020204" pitchFamily="34" charset="0"/>
              </a:rPr>
              <a:t>B</a:t>
            </a:r>
          </a:p>
        </p:txBody>
      </p:sp>
      <p:sp>
        <p:nvSpPr>
          <p:cNvPr id="12" name="CuadroTexto 11"/>
          <p:cNvSpPr txBox="1"/>
          <p:nvPr/>
        </p:nvSpPr>
        <p:spPr>
          <a:xfrm>
            <a:off x="3717726" y="3377933"/>
            <a:ext cx="370614" cy="400110"/>
          </a:xfrm>
          <a:prstGeom prst="rect">
            <a:avLst/>
          </a:prstGeom>
          <a:noFill/>
        </p:spPr>
        <p:txBody>
          <a:bodyPr wrap="none" rtlCol="0">
            <a:spAutoFit/>
          </a:bodyPr>
          <a:lstStyle/>
          <a:p>
            <a:r>
              <a:rPr lang="es-ES" sz="2000" dirty="0">
                <a:latin typeface="Arial" panose="020B0604020202020204" pitchFamily="34" charset="0"/>
                <a:cs typeface="Arial" panose="020B0604020202020204" pitchFamily="34" charset="0"/>
              </a:rPr>
              <a:t>C</a:t>
            </a:r>
          </a:p>
        </p:txBody>
      </p:sp>
      <p:sp>
        <p:nvSpPr>
          <p:cNvPr id="14" name="TextBox 11">
            <a:extLst>
              <a:ext uri="{FF2B5EF4-FFF2-40B4-BE49-F238E27FC236}">
                <a16:creationId xmlns:a16="http://schemas.microsoft.com/office/drawing/2014/main" id="{CC8414A5-8C32-5746-A24D-FD866305AAB8}"/>
              </a:ext>
            </a:extLst>
          </p:cNvPr>
          <p:cNvSpPr txBox="1"/>
          <p:nvPr/>
        </p:nvSpPr>
        <p:spPr>
          <a:xfrm>
            <a:off x="16791" y="14325"/>
            <a:ext cx="1226372" cy="338554"/>
          </a:xfrm>
          <a:prstGeom prst="rect">
            <a:avLst/>
          </a:prstGeom>
          <a:noFill/>
          <a:ln>
            <a:noFill/>
          </a:ln>
        </p:spPr>
        <p:txBody>
          <a:bodyPr wrap="square" rtlCol="0">
            <a:spAutoFit/>
          </a:bodyPr>
          <a:lstStyle/>
          <a:p>
            <a:r>
              <a:rPr lang="en-US" sz="1600" b="1" dirty="0">
                <a:latin typeface="Arial" panose="020B0604020202020204" pitchFamily="34" charset="0"/>
                <a:cs typeface="Arial" panose="020B0604020202020204" pitchFamily="34" charset="0"/>
              </a:rPr>
              <a:t>Figure S1</a:t>
            </a:r>
            <a:r>
              <a:rPr lang="en-US" sz="1600" dirty="0">
                <a:latin typeface="Arial" panose="020B0604020202020204" pitchFamily="34" charset="0"/>
                <a:cs typeface="Arial" panose="020B0604020202020204" pitchFamily="34" charset="0"/>
              </a:rPr>
              <a:t> </a:t>
            </a:r>
            <a:endParaRPr lang="x-none" sz="1600" dirty="0">
              <a:latin typeface="Arial" panose="020B0604020202020204" pitchFamily="34" charset="0"/>
              <a:cs typeface="Arial" panose="020B0604020202020204" pitchFamily="34" charset="0"/>
            </a:endParaRPr>
          </a:p>
        </p:txBody>
      </p:sp>
      <p:pic>
        <p:nvPicPr>
          <p:cNvPr id="10" name="Imagen 9"/>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700772" y="3756421"/>
            <a:ext cx="3113532" cy="2834640"/>
          </a:xfrm>
          <a:prstGeom prst="rect">
            <a:avLst/>
          </a:prstGeom>
        </p:spPr>
      </p:pic>
      <p:sp>
        <p:nvSpPr>
          <p:cNvPr id="16" name="CuadroTexto 15">
            <a:extLst>
              <a:ext uri="{FF2B5EF4-FFF2-40B4-BE49-F238E27FC236}">
                <a16:creationId xmlns:a16="http://schemas.microsoft.com/office/drawing/2014/main" id="{9F747650-9499-4626-B7D3-B3730E7292A6}"/>
              </a:ext>
            </a:extLst>
          </p:cNvPr>
          <p:cNvSpPr txBox="1"/>
          <p:nvPr/>
        </p:nvSpPr>
        <p:spPr>
          <a:xfrm>
            <a:off x="90670" y="7140747"/>
            <a:ext cx="6614930" cy="2637710"/>
          </a:xfrm>
          <a:prstGeom prst="rect">
            <a:avLst/>
          </a:prstGeom>
          <a:noFill/>
        </p:spPr>
        <p:txBody>
          <a:bodyPr wrap="square">
            <a:spAutoFit/>
          </a:bodyPr>
          <a:lstStyle/>
          <a:p>
            <a:pPr algn="just">
              <a:lnSpc>
                <a:spcPct val="150000"/>
              </a:lnSpc>
            </a:pPr>
            <a:r>
              <a:rPr lang="en-US" sz="1400" b="1" dirty="0">
                <a:latin typeface="Arial" panose="020B0604020202020204" pitchFamily="34" charset="0"/>
                <a:cs typeface="Arial" panose="020B0604020202020204" pitchFamily="34" charset="0"/>
              </a:rPr>
              <a:t>Figure S1.</a:t>
            </a:r>
            <a:r>
              <a:rPr lang="en-US" sz="1400" dirty="0">
                <a:latin typeface="Arial" panose="020B0604020202020204" pitchFamily="34" charset="0"/>
                <a:cs typeface="Arial" panose="020B0604020202020204" pitchFamily="34" charset="0"/>
              </a:rPr>
              <a:t> Identification of NLRP3</a:t>
            </a:r>
            <a:r>
              <a:rPr lang="en-US" sz="1400" baseline="30000" dirty="0">
                <a:latin typeface="Arial" panose="020B0604020202020204" pitchFamily="34" charset="0"/>
                <a:cs typeface="Arial" panose="020B0604020202020204" pitchFamily="34" charset="0"/>
              </a:rPr>
              <a:t>PYD</a:t>
            </a:r>
            <a:r>
              <a:rPr lang="en-US" sz="1400" dirty="0">
                <a:latin typeface="Arial" panose="020B0604020202020204" pitchFamily="34" charset="0"/>
                <a:cs typeface="Arial" panose="020B0604020202020204" pitchFamily="34" charset="0"/>
              </a:rPr>
              <a:t> homo-oligomerization inhibitors by using split-luciferase complementation assay. A) Summary of the luciferase activity obtained for all the compounds tested in the first screening round. B) Confirmation assay of the 11 compounds identified in A. Identification of three compounds which cause the reduce activity of luciferase. C) Secondary screening to discard compounds acting directly on luciferase. Selection of two active compounds, QM380 and QM381, as NLRP3</a:t>
            </a:r>
            <a:r>
              <a:rPr lang="en-US" sz="1400" baseline="30000" dirty="0">
                <a:latin typeface="Arial" panose="020B0604020202020204" pitchFamily="34" charset="0"/>
                <a:cs typeface="Arial" panose="020B0604020202020204" pitchFamily="34" charset="0"/>
              </a:rPr>
              <a:t>PYD</a:t>
            </a:r>
            <a:r>
              <a:rPr lang="en-US" sz="1400" dirty="0">
                <a:latin typeface="Arial" panose="020B0604020202020204" pitchFamily="34" charset="0"/>
                <a:cs typeface="Arial" panose="020B0604020202020204" pitchFamily="34" charset="0"/>
              </a:rPr>
              <a:t> inhibitors after specificity validation by analysis of interactions of these compounds with full-length firefly luciferase protein. </a:t>
            </a:r>
            <a:endParaRPr lang="es-E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87753501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11">
            <a:extLst>
              <a:ext uri="{FF2B5EF4-FFF2-40B4-BE49-F238E27FC236}">
                <a16:creationId xmlns:a16="http://schemas.microsoft.com/office/drawing/2014/main" id="{CC8414A5-8C32-5746-A24D-FD866305AAB8}"/>
              </a:ext>
            </a:extLst>
          </p:cNvPr>
          <p:cNvSpPr txBox="1"/>
          <p:nvPr/>
        </p:nvSpPr>
        <p:spPr>
          <a:xfrm>
            <a:off x="14319" y="23007"/>
            <a:ext cx="1226372" cy="338554"/>
          </a:xfrm>
          <a:prstGeom prst="rect">
            <a:avLst/>
          </a:prstGeom>
          <a:noFill/>
          <a:ln>
            <a:noFill/>
          </a:ln>
        </p:spPr>
        <p:txBody>
          <a:bodyPr wrap="square" rtlCol="0">
            <a:spAutoFit/>
          </a:bodyPr>
          <a:lstStyle/>
          <a:p>
            <a:r>
              <a:rPr lang="en-US" sz="1600" b="1" dirty="0">
                <a:latin typeface="Arial" panose="020B0604020202020204" pitchFamily="34" charset="0"/>
                <a:cs typeface="Arial" panose="020B0604020202020204" pitchFamily="34" charset="0"/>
              </a:rPr>
              <a:t>Figure S2</a:t>
            </a:r>
            <a:r>
              <a:rPr lang="en-US" sz="1600" dirty="0">
                <a:latin typeface="Arial" panose="020B0604020202020204" pitchFamily="34" charset="0"/>
                <a:cs typeface="Arial" panose="020B0604020202020204" pitchFamily="34" charset="0"/>
              </a:rPr>
              <a:t> </a:t>
            </a:r>
            <a:endParaRPr lang="x-none" sz="1600" dirty="0">
              <a:latin typeface="Arial" panose="020B0604020202020204" pitchFamily="34" charset="0"/>
              <a:cs typeface="Arial" panose="020B0604020202020204" pitchFamily="34" charset="0"/>
            </a:endParaRPr>
          </a:p>
        </p:txBody>
      </p:sp>
      <p:sp>
        <p:nvSpPr>
          <p:cNvPr id="11" name="Text Box 525">
            <a:extLst>
              <a:ext uri="{FF2B5EF4-FFF2-40B4-BE49-F238E27FC236}">
                <a16:creationId xmlns:a16="http://schemas.microsoft.com/office/drawing/2014/main" id="{0C981755-AA95-834C-93A6-015167F802FB}"/>
              </a:ext>
            </a:extLst>
          </p:cNvPr>
          <p:cNvSpPr txBox="1"/>
          <p:nvPr/>
        </p:nvSpPr>
        <p:spPr>
          <a:xfrm>
            <a:off x="851667" y="677784"/>
            <a:ext cx="320020" cy="276860"/>
          </a:xfrm>
          <a:prstGeom prst="rect">
            <a:avLst/>
          </a:prstGeom>
          <a:solidFill>
            <a:schemeClr val="lt1"/>
          </a:solid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r>
              <a:rPr lang="en-US" sz="2000" dirty="0">
                <a:effectLst/>
                <a:latin typeface="Arial" panose="020B0604020202020204" pitchFamily="34" charset="0"/>
                <a:ea typeface="Times New Roman" panose="02020603050405020304" pitchFamily="18" charset="0"/>
                <a:cs typeface="Arial" panose="020B0604020202020204" pitchFamily="34" charset="0"/>
              </a:rPr>
              <a:t>A</a:t>
            </a:r>
            <a:endParaRPr lang="x-none" sz="2000" dirty="0">
              <a:effectLst/>
              <a:latin typeface="Arial" panose="020B0604020202020204" pitchFamily="34" charset="0"/>
              <a:ea typeface="Times New Roman" panose="02020603050405020304" pitchFamily="18" charset="0"/>
              <a:cs typeface="Arial" panose="020B0604020202020204" pitchFamily="34" charset="0"/>
            </a:endParaRPr>
          </a:p>
        </p:txBody>
      </p:sp>
      <p:sp>
        <p:nvSpPr>
          <p:cNvPr id="12" name="Text Box 526">
            <a:extLst>
              <a:ext uri="{FF2B5EF4-FFF2-40B4-BE49-F238E27FC236}">
                <a16:creationId xmlns:a16="http://schemas.microsoft.com/office/drawing/2014/main" id="{8181355A-561E-434C-93A9-F6709C539376}"/>
              </a:ext>
            </a:extLst>
          </p:cNvPr>
          <p:cNvSpPr txBox="1"/>
          <p:nvPr/>
        </p:nvSpPr>
        <p:spPr>
          <a:xfrm>
            <a:off x="851667" y="2775628"/>
            <a:ext cx="320020" cy="276860"/>
          </a:xfrm>
          <a:prstGeom prst="rect">
            <a:avLst/>
          </a:prstGeom>
          <a:solidFill>
            <a:schemeClr val="lt1"/>
          </a:solid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r>
              <a:rPr lang="en-US" sz="2000">
                <a:effectLst/>
                <a:latin typeface="Arial" panose="020B0604020202020204" pitchFamily="34" charset="0"/>
                <a:ea typeface="Times New Roman" panose="02020603050405020304" pitchFamily="18" charset="0"/>
                <a:cs typeface="Arial" panose="020B0604020202020204" pitchFamily="34" charset="0"/>
              </a:rPr>
              <a:t>B</a:t>
            </a:r>
            <a:endParaRPr lang="x-none" sz="2000">
              <a:effectLst/>
              <a:latin typeface="Arial" panose="020B0604020202020204" pitchFamily="34" charset="0"/>
              <a:ea typeface="Times New Roman" panose="02020603050405020304" pitchFamily="18" charset="0"/>
              <a:cs typeface="Arial" panose="020B0604020202020204" pitchFamily="34" charset="0"/>
            </a:endParaRPr>
          </a:p>
        </p:txBody>
      </p:sp>
      <p:sp>
        <p:nvSpPr>
          <p:cNvPr id="13" name="Text Box 529">
            <a:extLst>
              <a:ext uri="{FF2B5EF4-FFF2-40B4-BE49-F238E27FC236}">
                <a16:creationId xmlns:a16="http://schemas.microsoft.com/office/drawing/2014/main" id="{60ABB44C-43E2-FA4E-B928-1DD36770BDC9}"/>
              </a:ext>
            </a:extLst>
          </p:cNvPr>
          <p:cNvSpPr txBox="1"/>
          <p:nvPr/>
        </p:nvSpPr>
        <p:spPr>
          <a:xfrm>
            <a:off x="851667" y="5793622"/>
            <a:ext cx="320020" cy="259715"/>
          </a:xfrm>
          <a:prstGeom prst="rect">
            <a:avLst/>
          </a:prstGeom>
          <a:solidFill>
            <a:schemeClr val="lt1"/>
          </a:solid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r>
              <a:rPr lang="en-US" sz="2000" dirty="0">
                <a:effectLst/>
                <a:latin typeface="Arial" panose="020B0604020202020204" pitchFamily="34" charset="0"/>
                <a:ea typeface="Times New Roman" panose="02020603050405020304" pitchFamily="18" charset="0"/>
                <a:cs typeface="Arial" panose="020B0604020202020204" pitchFamily="34" charset="0"/>
              </a:rPr>
              <a:t>C</a:t>
            </a:r>
            <a:endParaRPr lang="x-none" sz="2000" dirty="0">
              <a:effectLst/>
              <a:latin typeface="Arial" panose="020B0604020202020204" pitchFamily="34" charset="0"/>
              <a:ea typeface="Times New Roman" panose="02020603050405020304" pitchFamily="18" charset="0"/>
              <a:cs typeface="Arial" panose="020B0604020202020204" pitchFamily="34" charset="0"/>
            </a:endParaRPr>
          </a:p>
        </p:txBody>
      </p:sp>
      <p:pic>
        <p:nvPicPr>
          <p:cNvPr id="14" name="Imagen 1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909818" y="1072565"/>
            <a:ext cx="3134634" cy="1440000"/>
          </a:xfrm>
          <a:prstGeom prst="rect">
            <a:avLst/>
          </a:prstGeom>
        </p:spPr>
      </p:pic>
      <p:pic>
        <p:nvPicPr>
          <p:cNvPr id="15" name="Imagen 1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329370" y="3165622"/>
            <a:ext cx="2295530" cy="2628000"/>
          </a:xfrm>
          <a:prstGeom prst="rect">
            <a:avLst/>
          </a:prstGeom>
        </p:spPr>
      </p:pic>
      <p:pic>
        <p:nvPicPr>
          <p:cNvPr id="16" name="Imagen 1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219835" y="5913012"/>
            <a:ext cx="2514600" cy="2095500"/>
          </a:xfrm>
          <a:prstGeom prst="rect">
            <a:avLst/>
          </a:prstGeom>
        </p:spPr>
      </p:pic>
      <p:sp>
        <p:nvSpPr>
          <p:cNvPr id="17" name="CuadroTexto 16"/>
          <p:cNvSpPr txBox="1"/>
          <p:nvPr/>
        </p:nvSpPr>
        <p:spPr>
          <a:xfrm>
            <a:off x="3963011" y="687809"/>
            <a:ext cx="1163329" cy="307777"/>
          </a:xfrm>
          <a:prstGeom prst="rect">
            <a:avLst/>
          </a:prstGeom>
          <a:noFill/>
        </p:spPr>
        <p:txBody>
          <a:bodyPr wrap="square" rtlCol="0">
            <a:spAutoFit/>
          </a:bodyPr>
          <a:lstStyle/>
          <a:p>
            <a:r>
              <a:rPr lang="es-ES" sz="1400" dirty="0">
                <a:latin typeface="Arial" panose="020B0604020202020204" pitchFamily="34" charset="0"/>
                <a:cs typeface="Arial" panose="020B0604020202020204" pitchFamily="34" charset="0"/>
              </a:rPr>
              <a:t>QM380</a:t>
            </a:r>
          </a:p>
        </p:txBody>
      </p:sp>
      <p:sp>
        <p:nvSpPr>
          <p:cNvPr id="18" name="CuadroTexto 17"/>
          <p:cNvSpPr txBox="1"/>
          <p:nvPr/>
        </p:nvSpPr>
        <p:spPr>
          <a:xfrm>
            <a:off x="3963011" y="3432138"/>
            <a:ext cx="1163329" cy="307777"/>
          </a:xfrm>
          <a:prstGeom prst="rect">
            <a:avLst/>
          </a:prstGeom>
          <a:noFill/>
        </p:spPr>
        <p:txBody>
          <a:bodyPr wrap="square" rtlCol="0">
            <a:spAutoFit/>
          </a:bodyPr>
          <a:lstStyle/>
          <a:p>
            <a:r>
              <a:rPr lang="es-ES" sz="1400" dirty="0">
                <a:latin typeface="Arial" panose="020B0604020202020204" pitchFamily="34" charset="0"/>
                <a:cs typeface="Arial" panose="020B0604020202020204" pitchFamily="34" charset="0"/>
              </a:rPr>
              <a:t>QM381</a:t>
            </a:r>
          </a:p>
        </p:txBody>
      </p:sp>
      <p:sp>
        <p:nvSpPr>
          <p:cNvPr id="19" name="CuadroTexto 18"/>
          <p:cNvSpPr txBox="1"/>
          <p:nvPr/>
        </p:nvSpPr>
        <p:spPr>
          <a:xfrm>
            <a:off x="3963011" y="6176468"/>
            <a:ext cx="1163329" cy="307777"/>
          </a:xfrm>
          <a:prstGeom prst="rect">
            <a:avLst/>
          </a:prstGeom>
          <a:noFill/>
        </p:spPr>
        <p:txBody>
          <a:bodyPr wrap="square" rtlCol="0">
            <a:spAutoFit/>
          </a:bodyPr>
          <a:lstStyle/>
          <a:p>
            <a:r>
              <a:rPr lang="es-ES" sz="1400" dirty="0">
                <a:latin typeface="Arial" panose="020B0604020202020204" pitchFamily="34" charset="0"/>
                <a:cs typeface="Arial" panose="020B0604020202020204" pitchFamily="34" charset="0"/>
              </a:rPr>
              <a:t>B05</a:t>
            </a:r>
          </a:p>
        </p:txBody>
      </p:sp>
      <p:sp>
        <p:nvSpPr>
          <p:cNvPr id="21" name="CuadroTexto 20">
            <a:extLst>
              <a:ext uri="{FF2B5EF4-FFF2-40B4-BE49-F238E27FC236}">
                <a16:creationId xmlns:a16="http://schemas.microsoft.com/office/drawing/2014/main" id="{5B1B1BEC-F845-49FE-842E-F977FD20FBFD}"/>
              </a:ext>
            </a:extLst>
          </p:cNvPr>
          <p:cNvSpPr txBox="1"/>
          <p:nvPr/>
        </p:nvSpPr>
        <p:spPr>
          <a:xfrm>
            <a:off x="144518" y="8438079"/>
            <a:ext cx="6510282" cy="698717"/>
          </a:xfrm>
          <a:prstGeom prst="rect">
            <a:avLst/>
          </a:prstGeom>
          <a:noFill/>
        </p:spPr>
        <p:txBody>
          <a:bodyPr wrap="square">
            <a:spAutoFit/>
          </a:bodyPr>
          <a:lstStyle/>
          <a:p>
            <a:pPr algn="just">
              <a:lnSpc>
                <a:spcPct val="150000"/>
              </a:lnSpc>
            </a:pPr>
            <a:r>
              <a:rPr lang="en-US" sz="1400" b="1" dirty="0">
                <a:latin typeface="Arial" panose="020B0604020202020204" pitchFamily="34" charset="0"/>
                <a:cs typeface="Arial" panose="020B0604020202020204" pitchFamily="34" charset="0"/>
              </a:rPr>
              <a:t>Figure S2.</a:t>
            </a:r>
            <a:r>
              <a:rPr lang="en-US" sz="1400" dirty="0">
                <a:latin typeface="Arial" panose="020B0604020202020204" pitchFamily="34" charset="0"/>
                <a:cs typeface="Arial" panose="020B0604020202020204" pitchFamily="34" charset="0"/>
              </a:rPr>
              <a:t> The chemical structures of A) QM380, B) QM381 and C) B05 (as a negative control) used as ligands in docking procedure.</a:t>
            </a:r>
            <a:endParaRPr lang="es-E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15471879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a:extLst>
              <a:ext uri="{FF2B5EF4-FFF2-40B4-BE49-F238E27FC236}">
                <a16:creationId xmlns:a16="http://schemas.microsoft.com/office/drawing/2014/main" id="{C530EC83-07CF-A040-8947-D136E20B2D9A}"/>
              </a:ext>
            </a:extLst>
          </p:cNvPr>
          <p:cNvGraphicFramePr>
            <a:graphicFrameLocks noChangeAspect="1"/>
          </p:cNvGraphicFramePr>
          <p:nvPr>
            <p:extLst>
              <p:ext uri="{D42A27DB-BD31-4B8C-83A1-F6EECF244321}">
                <p14:modId xmlns:p14="http://schemas.microsoft.com/office/powerpoint/2010/main" val="4270088878"/>
              </p:ext>
            </p:extLst>
          </p:nvPr>
        </p:nvGraphicFramePr>
        <p:xfrm>
          <a:off x="948146" y="948997"/>
          <a:ext cx="4349459" cy="3240000"/>
        </p:xfrm>
        <a:graphic>
          <a:graphicData uri="http://schemas.openxmlformats.org/drawingml/2006/chart">
            <c:chart xmlns:c="http://schemas.openxmlformats.org/drawingml/2006/chart" xmlns:r="http://schemas.openxmlformats.org/officeDocument/2006/relationships" r:id="rId2"/>
          </a:graphicData>
        </a:graphic>
      </p:graphicFrame>
      <p:sp>
        <p:nvSpPr>
          <p:cNvPr id="5" name="TextBox 4">
            <a:extLst>
              <a:ext uri="{FF2B5EF4-FFF2-40B4-BE49-F238E27FC236}">
                <a16:creationId xmlns:a16="http://schemas.microsoft.com/office/drawing/2014/main" id="{3A068093-7B9E-E149-9823-E6A9A7531064}"/>
              </a:ext>
            </a:extLst>
          </p:cNvPr>
          <p:cNvSpPr txBox="1"/>
          <p:nvPr/>
        </p:nvSpPr>
        <p:spPr>
          <a:xfrm>
            <a:off x="25400" y="26035"/>
            <a:ext cx="1226372" cy="338554"/>
          </a:xfrm>
          <a:prstGeom prst="rect">
            <a:avLst/>
          </a:prstGeom>
          <a:noFill/>
          <a:ln>
            <a:noFill/>
          </a:ln>
        </p:spPr>
        <p:txBody>
          <a:bodyPr wrap="square" rtlCol="0">
            <a:spAutoFit/>
          </a:bodyPr>
          <a:lstStyle/>
          <a:p>
            <a:r>
              <a:rPr lang="en-US" sz="1600" b="1" dirty="0">
                <a:latin typeface="Arial" panose="020B0604020202020204" pitchFamily="34" charset="0"/>
                <a:cs typeface="Arial" panose="020B0604020202020204" pitchFamily="34" charset="0"/>
              </a:rPr>
              <a:t>Figure S3</a:t>
            </a:r>
            <a:r>
              <a:rPr lang="en-US" sz="1600" dirty="0">
                <a:latin typeface="Arial" panose="020B0604020202020204" pitchFamily="34" charset="0"/>
                <a:cs typeface="Arial" panose="020B0604020202020204" pitchFamily="34" charset="0"/>
              </a:rPr>
              <a:t> </a:t>
            </a:r>
            <a:endParaRPr lang="x-none" sz="1600" dirty="0">
              <a:latin typeface="Arial" panose="020B0604020202020204" pitchFamily="34" charset="0"/>
              <a:cs typeface="Arial" panose="020B0604020202020204" pitchFamily="34" charset="0"/>
            </a:endParaRPr>
          </a:p>
        </p:txBody>
      </p:sp>
      <p:sp>
        <p:nvSpPr>
          <p:cNvPr id="12" name="CuadroTexto 11">
            <a:extLst>
              <a:ext uri="{FF2B5EF4-FFF2-40B4-BE49-F238E27FC236}">
                <a16:creationId xmlns:a16="http://schemas.microsoft.com/office/drawing/2014/main" id="{DF888B7E-8B28-4867-8B28-E6D19A1BE9D4}"/>
              </a:ext>
            </a:extLst>
          </p:cNvPr>
          <p:cNvSpPr txBox="1"/>
          <p:nvPr/>
        </p:nvSpPr>
        <p:spPr>
          <a:xfrm>
            <a:off x="190500" y="4194147"/>
            <a:ext cx="6451600" cy="1021883"/>
          </a:xfrm>
          <a:prstGeom prst="rect">
            <a:avLst/>
          </a:prstGeom>
          <a:noFill/>
        </p:spPr>
        <p:txBody>
          <a:bodyPr wrap="square">
            <a:spAutoFit/>
          </a:bodyPr>
          <a:lstStyle/>
          <a:p>
            <a:pPr algn="just">
              <a:lnSpc>
                <a:spcPct val="150000"/>
              </a:lnSpc>
            </a:pPr>
            <a:r>
              <a:rPr lang="en-US" sz="1400" b="1" dirty="0">
                <a:latin typeface="Arial" panose="020B0604020202020204" pitchFamily="34" charset="0"/>
                <a:cs typeface="Arial" panose="020B0604020202020204" pitchFamily="34" charset="0"/>
              </a:rPr>
              <a:t>Figure S3.</a:t>
            </a:r>
            <a:r>
              <a:rPr lang="en-US" sz="1400" dirty="0">
                <a:latin typeface="Arial" panose="020B0604020202020204" pitchFamily="34" charset="0"/>
                <a:cs typeface="Arial" panose="020B0604020202020204" pitchFamily="34" charset="0"/>
              </a:rPr>
              <a:t> The tryptophan-based fluorescence intensity of Cluc-NLRP3</a:t>
            </a:r>
            <a:r>
              <a:rPr lang="en-US" sz="1400" baseline="30000" dirty="0">
                <a:latin typeface="Arial" panose="020B0604020202020204" pitchFamily="34" charset="0"/>
                <a:cs typeface="Arial" panose="020B0604020202020204" pitchFamily="34" charset="0"/>
              </a:rPr>
              <a:t>PYD</a:t>
            </a:r>
            <a:r>
              <a:rPr lang="en-US" sz="1400" dirty="0">
                <a:latin typeface="Arial" panose="020B0604020202020204" pitchFamily="34" charset="0"/>
                <a:cs typeface="Arial" panose="020B0604020202020204" pitchFamily="34" charset="0"/>
              </a:rPr>
              <a:t> protein in the presence of different concentrations of QM381 at exciting wavelength of 280 nm.</a:t>
            </a:r>
            <a:endParaRPr lang="es-E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46913440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uadroTexto 1">
            <a:extLst>
              <a:ext uri="{FF2B5EF4-FFF2-40B4-BE49-F238E27FC236}">
                <a16:creationId xmlns:a16="http://schemas.microsoft.com/office/drawing/2014/main" id="{AB786178-AED3-4CFF-97B3-0FCE9A98E1EE}"/>
              </a:ext>
            </a:extLst>
          </p:cNvPr>
          <p:cNvSpPr txBox="1"/>
          <p:nvPr/>
        </p:nvSpPr>
        <p:spPr>
          <a:xfrm>
            <a:off x="124719" y="4640186"/>
            <a:ext cx="6557763" cy="4576702"/>
          </a:xfrm>
          <a:prstGeom prst="rect">
            <a:avLst/>
          </a:prstGeom>
          <a:noFill/>
        </p:spPr>
        <p:txBody>
          <a:bodyPr wrap="square">
            <a:spAutoFit/>
          </a:bodyPr>
          <a:lstStyle/>
          <a:p>
            <a:pPr algn="just">
              <a:lnSpc>
                <a:spcPct val="150000"/>
              </a:lnSpc>
            </a:pPr>
            <a:r>
              <a:rPr lang="en-US" sz="1400" b="1" dirty="0">
                <a:effectLst/>
                <a:latin typeface="Arial" panose="020B0604020202020204" pitchFamily="34" charset="0"/>
                <a:ea typeface="Calibri" panose="020F0502020204030204" pitchFamily="34" charset="0"/>
                <a:cs typeface="Arial" panose="020B0604020202020204" pitchFamily="34" charset="0"/>
              </a:rPr>
              <a:t>Figure S4.</a:t>
            </a:r>
            <a:r>
              <a:rPr lang="en-US" sz="1400" dirty="0">
                <a:effectLst/>
                <a:latin typeface="Arial" panose="020B0604020202020204" pitchFamily="34" charset="0"/>
                <a:ea typeface="Calibri" panose="020F0502020204030204" pitchFamily="34" charset="0"/>
                <a:cs typeface="Arial" panose="020B0604020202020204" pitchFamily="34" charset="0"/>
              </a:rPr>
              <a:t> A) </a:t>
            </a:r>
            <a:r>
              <a:rPr lang="en-GB" sz="1400" dirty="0" err="1">
                <a:effectLst/>
                <a:latin typeface="Arial" panose="020B0604020202020204" pitchFamily="34" charset="0"/>
                <a:ea typeface="Calibri" panose="020F0502020204030204" pitchFamily="34" charset="0"/>
                <a:cs typeface="Arial" panose="020B0604020202020204" pitchFamily="34" charset="0"/>
              </a:rPr>
              <a:t>WaterLOGSY</a:t>
            </a:r>
            <a:r>
              <a:rPr lang="en-GB" sz="1400" dirty="0">
                <a:effectLst/>
                <a:latin typeface="Arial" panose="020B0604020202020204" pitchFamily="34" charset="0"/>
                <a:ea typeface="Calibri" panose="020F0502020204030204" pitchFamily="34" charset="0"/>
                <a:cs typeface="Arial" panose="020B0604020202020204" pitchFamily="34" charset="0"/>
              </a:rPr>
              <a:t> and STD interaction spectra. a) 1H NMR spectrum of compound QM380 (150 µM) in Tris buffer</a:t>
            </a:r>
            <a:r>
              <a:rPr lang="en-GB" sz="1400" u="sng" dirty="0">
                <a:effectLst/>
                <a:latin typeface="Arial" panose="020B0604020202020204" pitchFamily="34" charset="0"/>
                <a:ea typeface="Calibri" panose="020F0502020204030204" pitchFamily="34" charset="0"/>
                <a:cs typeface="Arial" panose="020B0604020202020204" pitchFamily="34" charset="0"/>
              </a:rPr>
              <a:t>,</a:t>
            </a:r>
            <a:r>
              <a:rPr lang="en-GB" sz="1400" dirty="0">
                <a:effectLst/>
                <a:latin typeface="Arial" panose="020B0604020202020204" pitchFamily="34" charset="0"/>
                <a:ea typeface="Calibri" panose="020F0502020204030204" pitchFamily="34" charset="0"/>
                <a:cs typeface="Arial" panose="020B0604020202020204" pitchFamily="34" charset="0"/>
              </a:rPr>
              <a:t> b) </a:t>
            </a:r>
            <a:r>
              <a:rPr lang="en-GB" sz="1400" dirty="0" err="1">
                <a:effectLst/>
                <a:latin typeface="Arial" panose="020B0604020202020204" pitchFamily="34" charset="0"/>
                <a:ea typeface="Calibri" panose="020F0502020204030204" pitchFamily="34" charset="0"/>
                <a:cs typeface="Arial" panose="020B0604020202020204" pitchFamily="34" charset="0"/>
              </a:rPr>
              <a:t>WaterLOGSY</a:t>
            </a:r>
            <a:r>
              <a:rPr lang="en-GB" sz="1400" dirty="0">
                <a:effectLst/>
                <a:latin typeface="Arial" panose="020B0604020202020204" pitchFamily="34" charset="0"/>
                <a:ea typeface="Calibri" panose="020F0502020204030204" pitchFamily="34" charset="0"/>
                <a:cs typeface="Arial" panose="020B0604020202020204" pitchFamily="34" charset="0"/>
              </a:rPr>
              <a:t> spectrum of protein (5 µM) with compound QM380 (150 µM) in Tris buffer, c) Reference </a:t>
            </a:r>
            <a:r>
              <a:rPr lang="en-GB" sz="1400" dirty="0" err="1">
                <a:effectLst/>
                <a:latin typeface="Arial" panose="020B0604020202020204" pitchFamily="34" charset="0"/>
                <a:ea typeface="Calibri" panose="020F0502020204030204" pitchFamily="34" charset="0"/>
                <a:cs typeface="Arial" panose="020B0604020202020204" pitchFamily="34" charset="0"/>
              </a:rPr>
              <a:t>WaterLOGSY</a:t>
            </a:r>
            <a:r>
              <a:rPr lang="en-GB" sz="1400" dirty="0">
                <a:effectLst/>
                <a:latin typeface="Arial" panose="020B0604020202020204" pitchFamily="34" charset="0"/>
                <a:ea typeface="Calibri" panose="020F0502020204030204" pitchFamily="34" charset="0"/>
                <a:cs typeface="Arial" panose="020B0604020202020204" pitchFamily="34" charset="0"/>
              </a:rPr>
              <a:t> spectrum with compound QM380 (150 µM) in Tris buffer, d) 1H NMR spectrum of protein (5 µM) with compound QM380 (150 µM) in Tris buffer, e) STD spectrum of protein (5 µM) with compound QM380 (150 µM) in Tris buffer, f) STD reference spectrum of compound QM380 (150 µM) in Tris buffer. B) </a:t>
            </a:r>
            <a:r>
              <a:rPr lang="en-GB" sz="1400" dirty="0" err="1">
                <a:effectLst/>
                <a:latin typeface="Arial" panose="020B0604020202020204" pitchFamily="34" charset="0"/>
                <a:ea typeface="Calibri" panose="020F0502020204030204" pitchFamily="34" charset="0"/>
                <a:cs typeface="Arial" panose="020B0604020202020204" pitchFamily="34" charset="0"/>
              </a:rPr>
              <a:t>WaterLOGSY</a:t>
            </a:r>
            <a:r>
              <a:rPr lang="en-GB" sz="1400" dirty="0">
                <a:effectLst/>
                <a:latin typeface="Arial" panose="020B0604020202020204" pitchFamily="34" charset="0"/>
                <a:ea typeface="Calibri" panose="020F0502020204030204" pitchFamily="34" charset="0"/>
                <a:cs typeface="Arial" panose="020B0604020202020204" pitchFamily="34" charset="0"/>
              </a:rPr>
              <a:t> and STD interaction spectra. a) 1H NMR spectrum of compound QM381 (150 µM theoretically, solubility problems) in Tris buffer, b) 1H NMR spectrum of protein (5 µM) with compound QM381 (150 µM theoretically, solubility problems) in Tris buffer, c) STD spectrum of protein (5 µM) with compound QM381 (150 µM theoretically, solubility problems) in Tris buffer, d) reference STD spectrum of compound QM381 (150 µM theoretically, solubility problems) in Tris buffer. </a:t>
            </a:r>
            <a:endParaRPr lang="es-ES" sz="1400" dirty="0">
              <a:effectLst/>
              <a:latin typeface="Arial" panose="020B0604020202020204" pitchFamily="34" charset="0"/>
              <a:ea typeface="Calibri" panose="020F0502020204030204" pitchFamily="34" charset="0"/>
              <a:cs typeface="Arial" panose="020B0604020202020204" pitchFamily="34" charset="0"/>
            </a:endParaRPr>
          </a:p>
        </p:txBody>
      </p:sp>
      <p:grpSp>
        <p:nvGrpSpPr>
          <p:cNvPr id="9" name="Grupo 8">
            <a:extLst>
              <a:ext uri="{FF2B5EF4-FFF2-40B4-BE49-F238E27FC236}">
                <a16:creationId xmlns:a16="http://schemas.microsoft.com/office/drawing/2014/main" id="{A3263F30-B228-44B7-92B4-6191562FE067}"/>
              </a:ext>
            </a:extLst>
          </p:cNvPr>
          <p:cNvGrpSpPr>
            <a:grpSpLocks noChangeAspect="1"/>
          </p:cNvGrpSpPr>
          <p:nvPr/>
        </p:nvGrpSpPr>
        <p:grpSpPr>
          <a:xfrm>
            <a:off x="581918" y="1095000"/>
            <a:ext cx="5652000" cy="3283790"/>
            <a:chOff x="175518" y="904500"/>
            <a:chExt cx="6587779" cy="3827477"/>
          </a:xfrm>
        </p:grpSpPr>
        <p:pic>
          <p:nvPicPr>
            <p:cNvPr id="4" name="0 Imagen">
              <a:extLst>
                <a:ext uri="{FF2B5EF4-FFF2-40B4-BE49-F238E27FC236}">
                  <a16:creationId xmlns:a16="http://schemas.microsoft.com/office/drawing/2014/main" id="{41AC2986-5C9A-4F71-82FE-1DFABF88F6DD}"/>
                </a:ext>
              </a:extLst>
            </p:cNvPr>
            <p:cNvPicPr/>
            <p:nvPr/>
          </p:nvPicPr>
          <p:blipFill>
            <a:blip r:embed="rId2" cstate="print">
              <a:extLst>
                <a:ext uri="{28A0092B-C50C-407E-A947-70E740481C1C}">
                  <a14:useLocalDpi xmlns:a14="http://schemas.microsoft.com/office/drawing/2010/main" val="0"/>
                </a:ext>
              </a:extLst>
            </a:blip>
            <a:stretch>
              <a:fillRect/>
            </a:stretch>
          </p:blipFill>
          <p:spPr>
            <a:xfrm>
              <a:off x="175518" y="904500"/>
              <a:ext cx="3834531" cy="3802809"/>
            </a:xfrm>
            <a:prstGeom prst="rect">
              <a:avLst/>
            </a:prstGeom>
          </p:spPr>
        </p:pic>
        <p:pic>
          <p:nvPicPr>
            <p:cNvPr id="5" name="0 Imagen">
              <a:extLst>
                <a:ext uri="{FF2B5EF4-FFF2-40B4-BE49-F238E27FC236}">
                  <a16:creationId xmlns:a16="http://schemas.microsoft.com/office/drawing/2014/main" id="{DE6E04F0-EF8A-4801-A069-D6CC8CF64F6E}"/>
                </a:ext>
              </a:extLst>
            </p:cNvPr>
            <p:cNvPicPr/>
            <p:nvPr/>
          </p:nvPicPr>
          <p:blipFill>
            <a:blip r:embed="rId3" cstate="print">
              <a:extLst>
                <a:ext uri="{28A0092B-C50C-407E-A947-70E740481C1C}">
                  <a14:useLocalDpi xmlns:a14="http://schemas.microsoft.com/office/drawing/2010/main" val="0"/>
                </a:ext>
              </a:extLst>
            </a:blip>
            <a:stretch>
              <a:fillRect/>
            </a:stretch>
          </p:blipFill>
          <p:spPr>
            <a:xfrm>
              <a:off x="4228542" y="904500"/>
              <a:ext cx="2534755" cy="3827477"/>
            </a:xfrm>
            <a:prstGeom prst="rect">
              <a:avLst/>
            </a:prstGeom>
          </p:spPr>
        </p:pic>
      </p:grpSp>
      <p:sp>
        <p:nvSpPr>
          <p:cNvPr id="6" name="Text Box 371">
            <a:extLst>
              <a:ext uri="{FF2B5EF4-FFF2-40B4-BE49-F238E27FC236}">
                <a16:creationId xmlns:a16="http://schemas.microsoft.com/office/drawing/2014/main" id="{879C4093-88AB-4FB7-901D-B10A65D3CD68}"/>
              </a:ext>
            </a:extLst>
          </p:cNvPr>
          <p:cNvSpPr txBox="1"/>
          <p:nvPr/>
        </p:nvSpPr>
        <p:spPr>
          <a:xfrm>
            <a:off x="342900" y="621940"/>
            <a:ext cx="527070" cy="588086"/>
          </a:xfrm>
          <a:prstGeom prst="rect">
            <a:avLst/>
          </a:prstGeom>
          <a:solidFill>
            <a:schemeClr val="lt1"/>
          </a:solid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r>
              <a:rPr lang="en-US" sz="1600" dirty="0">
                <a:effectLst/>
                <a:latin typeface="Arial" panose="020B0604020202020204" pitchFamily="34" charset="0"/>
                <a:ea typeface="Times New Roman" panose="02020603050405020304" pitchFamily="18" charset="0"/>
                <a:cs typeface="Arial" panose="020B0604020202020204" pitchFamily="34" charset="0"/>
              </a:rPr>
              <a:t>A</a:t>
            </a:r>
            <a:endParaRPr lang="x-none" sz="1600" dirty="0">
              <a:effectLst/>
              <a:latin typeface="Arial" panose="020B0604020202020204" pitchFamily="34" charset="0"/>
              <a:ea typeface="Times New Roman" panose="02020603050405020304" pitchFamily="18" charset="0"/>
              <a:cs typeface="Arial" panose="020B0604020202020204" pitchFamily="34" charset="0"/>
            </a:endParaRPr>
          </a:p>
        </p:txBody>
      </p:sp>
      <p:sp>
        <p:nvSpPr>
          <p:cNvPr id="7" name="Text Box 372">
            <a:extLst>
              <a:ext uri="{FF2B5EF4-FFF2-40B4-BE49-F238E27FC236}">
                <a16:creationId xmlns:a16="http://schemas.microsoft.com/office/drawing/2014/main" id="{06DC33B3-1F4C-4988-8D8B-5BEEE99A326C}"/>
              </a:ext>
            </a:extLst>
          </p:cNvPr>
          <p:cNvSpPr txBox="1"/>
          <p:nvPr/>
        </p:nvSpPr>
        <p:spPr>
          <a:xfrm>
            <a:off x="3786423" y="621940"/>
            <a:ext cx="527070" cy="588086"/>
          </a:xfrm>
          <a:prstGeom prst="rect">
            <a:avLst/>
          </a:prstGeom>
          <a:solidFill>
            <a:schemeClr val="lt1"/>
          </a:solid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r>
              <a:rPr lang="en-US" sz="1600" dirty="0">
                <a:effectLst/>
                <a:latin typeface="Arial" panose="020B0604020202020204" pitchFamily="34" charset="0"/>
                <a:ea typeface="Times New Roman" panose="02020603050405020304" pitchFamily="18" charset="0"/>
                <a:cs typeface="Arial" panose="020B0604020202020204" pitchFamily="34" charset="0"/>
              </a:rPr>
              <a:t>B</a:t>
            </a:r>
            <a:endParaRPr lang="x-none" sz="1600" dirty="0">
              <a:effectLst/>
              <a:latin typeface="Arial" panose="020B0604020202020204" pitchFamily="34" charset="0"/>
              <a:ea typeface="Times New Roman" panose="02020603050405020304" pitchFamily="18" charset="0"/>
              <a:cs typeface="Arial" panose="020B0604020202020204" pitchFamily="34" charset="0"/>
            </a:endParaRPr>
          </a:p>
        </p:txBody>
      </p:sp>
      <p:sp>
        <p:nvSpPr>
          <p:cNvPr id="8" name="TextBox 8">
            <a:extLst>
              <a:ext uri="{FF2B5EF4-FFF2-40B4-BE49-F238E27FC236}">
                <a16:creationId xmlns:a16="http://schemas.microsoft.com/office/drawing/2014/main" id="{996CF079-C47A-405F-8D02-077F2E37DE1A}"/>
              </a:ext>
            </a:extLst>
          </p:cNvPr>
          <p:cNvSpPr txBox="1"/>
          <p:nvPr/>
        </p:nvSpPr>
        <p:spPr>
          <a:xfrm>
            <a:off x="131" y="32125"/>
            <a:ext cx="1226372" cy="338554"/>
          </a:xfrm>
          <a:prstGeom prst="rect">
            <a:avLst/>
          </a:prstGeom>
          <a:noFill/>
          <a:ln>
            <a:noFill/>
          </a:ln>
        </p:spPr>
        <p:txBody>
          <a:bodyPr wrap="square" rtlCol="0">
            <a:spAutoFit/>
          </a:bodyPr>
          <a:lstStyle/>
          <a:p>
            <a:r>
              <a:rPr lang="en-US" sz="1600" b="1" dirty="0">
                <a:latin typeface="Arial" panose="020B0604020202020204" pitchFamily="34" charset="0"/>
                <a:cs typeface="Arial" panose="020B0604020202020204" pitchFamily="34" charset="0"/>
              </a:rPr>
              <a:t>Figure S4</a:t>
            </a:r>
            <a:r>
              <a:rPr lang="en-US" sz="1600" dirty="0">
                <a:latin typeface="Arial" panose="020B0604020202020204" pitchFamily="34" charset="0"/>
                <a:cs typeface="Arial" panose="020B0604020202020204" pitchFamily="34" charset="0"/>
              </a:rPr>
              <a:t> </a:t>
            </a:r>
            <a:endParaRPr lang="x-none" sz="16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52936808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8">
            <a:extLst>
              <a:ext uri="{FF2B5EF4-FFF2-40B4-BE49-F238E27FC236}">
                <a16:creationId xmlns:a16="http://schemas.microsoft.com/office/drawing/2014/main" id="{996CF079-C47A-405F-8D02-077F2E37DE1A}"/>
              </a:ext>
            </a:extLst>
          </p:cNvPr>
          <p:cNvSpPr txBox="1"/>
          <p:nvPr/>
        </p:nvSpPr>
        <p:spPr>
          <a:xfrm>
            <a:off x="131" y="32125"/>
            <a:ext cx="1226372" cy="338554"/>
          </a:xfrm>
          <a:prstGeom prst="rect">
            <a:avLst/>
          </a:prstGeom>
          <a:noFill/>
          <a:ln>
            <a:noFill/>
          </a:ln>
        </p:spPr>
        <p:txBody>
          <a:bodyPr wrap="square" rtlCol="0">
            <a:spAutoFit/>
          </a:bodyPr>
          <a:lstStyle/>
          <a:p>
            <a:r>
              <a:rPr lang="en-US" sz="1600" b="1" dirty="0">
                <a:latin typeface="Arial" panose="020B0604020202020204" pitchFamily="34" charset="0"/>
                <a:cs typeface="Arial" panose="020B0604020202020204" pitchFamily="34" charset="0"/>
              </a:rPr>
              <a:t>Figure S5</a:t>
            </a:r>
            <a:r>
              <a:rPr lang="en-US" sz="1600" dirty="0">
                <a:latin typeface="Arial" panose="020B0604020202020204" pitchFamily="34" charset="0"/>
                <a:cs typeface="Arial" panose="020B0604020202020204" pitchFamily="34" charset="0"/>
              </a:rPr>
              <a:t> </a:t>
            </a:r>
            <a:endParaRPr lang="x-none" sz="1600" dirty="0">
              <a:latin typeface="Arial" panose="020B0604020202020204" pitchFamily="34" charset="0"/>
              <a:cs typeface="Arial" panose="020B0604020202020204" pitchFamily="34" charset="0"/>
            </a:endParaRPr>
          </a:p>
        </p:txBody>
      </p:sp>
      <p:sp>
        <p:nvSpPr>
          <p:cNvPr id="3" name="CuadroTexto 2">
            <a:extLst>
              <a:ext uri="{FF2B5EF4-FFF2-40B4-BE49-F238E27FC236}">
                <a16:creationId xmlns:a16="http://schemas.microsoft.com/office/drawing/2014/main" id="{9F747650-9499-4626-B7D3-B3730E7292A6}"/>
              </a:ext>
            </a:extLst>
          </p:cNvPr>
          <p:cNvSpPr txBox="1"/>
          <p:nvPr/>
        </p:nvSpPr>
        <p:spPr>
          <a:xfrm>
            <a:off x="90670" y="7140747"/>
            <a:ext cx="6614930" cy="1384995"/>
          </a:xfrm>
          <a:prstGeom prst="rect">
            <a:avLst/>
          </a:prstGeom>
          <a:noFill/>
        </p:spPr>
        <p:txBody>
          <a:bodyPr wrap="square">
            <a:spAutoFit/>
          </a:bodyPr>
          <a:lstStyle/>
          <a:p>
            <a:pPr algn="just">
              <a:lnSpc>
                <a:spcPct val="150000"/>
              </a:lnSpc>
            </a:pPr>
            <a:r>
              <a:rPr lang="en-US" sz="1400" b="1" dirty="0">
                <a:latin typeface="Arial" panose="020B0604020202020204" pitchFamily="34" charset="0"/>
                <a:cs typeface="Arial" panose="020B0604020202020204" pitchFamily="34" charset="0"/>
              </a:rPr>
              <a:t>Figure S5.</a:t>
            </a:r>
            <a:r>
              <a:rPr lang="en-US" sz="1400" dirty="0">
                <a:latin typeface="Arial" panose="020B0604020202020204" pitchFamily="34" charset="0"/>
                <a:cs typeface="Arial" panose="020B0604020202020204" pitchFamily="34" charset="0"/>
              </a:rPr>
              <a:t> QM380 and QM381 protect THP-1 cells from LPS/</a:t>
            </a:r>
            <a:r>
              <a:rPr lang="en-US" sz="1400" dirty="0" err="1">
                <a:latin typeface="Arial" panose="020B0604020202020204" pitchFamily="34" charset="0"/>
                <a:cs typeface="Arial" panose="020B0604020202020204" pitchFamily="34" charset="0"/>
              </a:rPr>
              <a:t>nigericin</a:t>
            </a:r>
            <a:r>
              <a:rPr lang="en-US" sz="1400" dirty="0">
                <a:latin typeface="Arial" panose="020B0604020202020204" pitchFamily="34" charset="0"/>
                <a:cs typeface="Arial" panose="020B0604020202020204" pitchFamily="34" charset="0"/>
              </a:rPr>
              <a:t>-induced cell death. Quantification of cell death by Trypan Blue in THP1 cells upon activation of the NLRP3 inflammasome with LPS (100 ng/ml) and </a:t>
            </a:r>
            <a:r>
              <a:rPr lang="en-US" sz="1400" dirty="0" err="1">
                <a:latin typeface="Arial" panose="020B0604020202020204" pitchFamily="34" charset="0"/>
                <a:cs typeface="Arial" panose="020B0604020202020204" pitchFamily="34" charset="0"/>
              </a:rPr>
              <a:t>nigericin</a:t>
            </a:r>
            <a:r>
              <a:rPr lang="en-US" sz="1400" dirty="0">
                <a:latin typeface="Arial" panose="020B0604020202020204" pitchFamily="34" charset="0"/>
                <a:cs typeface="Arial" panose="020B0604020202020204" pitchFamily="34" charset="0"/>
              </a:rPr>
              <a:t> (20 µM) and treatment or not with QM380 or QM381 (20 µM) (n≥ 3).</a:t>
            </a:r>
            <a:endParaRPr lang="es-ES" sz="1400" dirty="0">
              <a:latin typeface="Arial" panose="020B0604020202020204" pitchFamily="34" charset="0"/>
              <a:cs typeface="Arial" panose="020B0604020202020204" pitchFamily="34" charset="0"/>
            </a:endParaRPr>
          </a:p>
        </p:txBody>
      </p:sp>
      <p:pic>
        <p:nvPicPr>
          <p:cNvPr id="4" name="Imagen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645920" y="3113532"/>
            <a:ext cx="3566160" cy="3678936"/>
          </a:xfrm>
          <a:prstGeom prst="rect">
            <a:avLst/>
          </a:prstGeom>
        </p:spPr>
      </p:pic>
    </p:spTree>
    <p:extLst>
      <p:ext uri="{BB962C8B-B14F-4D97-AF65-F5344CB8AC3E}">
        <p14:creationId xmlns:p14="http://schemas.microsoft.com/office/powerpoint/2010/main" val="2477002779"/>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ema de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80</TotalTime>
  <Words>477</Words>
  <Application>Microsoft Macintosh PowerPoint</Application>
  <PresentationFormat>A4 Paper (210x297 mm)</PresentationFormat>
  <Paragraphs>24</Paragraphs>
  <Slides>5</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5</vt:i4>
      </vt:variant>
    </vt:vector>
  </HeadingPairs>
  <TitlesOfParts>
    <vt:vector size="10" baseType="lpstr">
      <vt:lpstr>Arial</vt:lpstr>
      <vt:lpstr>Calibri</vt:lpstr>
      <vt:lpstr>Calibri Light</vt:lpstr>
      <vt:lpstr>Times New Roman</vt:lpstr>
      <vt:lpstr>Tema de Offic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Maria del Mar Orzaez Calatayud</dc:creator>
  <cp:lastModifiedBy>Microsoft Office User</cp:lastModifiedBy>
  <cp:revision>27</cp:revision>
  <cp:lastPrinted>2022-01-03T14:46:34Z</cp:lastPrinted>
  <dcterms:created xsi:type="dcterms:W3CDTF">2021-11-05T15:37:02Z</dcterms:created>
  <dcterms:modified xsi:type="dcterms:W3CDTF">2022-01-25T19:24:07Z</dcterms:modified>
</cp:coreProperties>
</file>